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4"/>
  </p:notesMasterIdLst>
  <p:sldIdLst>
    <p:sldId id="284" r:id="rId2"/>
    <p:sldId id="285" r:id="rId3"/>
    <p:sldId id="287" r:id="rId4"/>
    <p:sldId id="270" r:id="rId5"/>
    <p:sldId id="267" r:id="rId6"/>
    <p:sldId id="268" r:id="rId7"/>
    <p:sldId id="269" r:id="rId8"/>
    <p:sldId id="276" r:id="rId9"/>
    <p:sldId id="278" r:id="rId10"/>
    <p:sldId id="280" r:id="rId11"/>
    <p:sldId id="282" r:id="rId12"/>
    <p:sldId id="271" r:id="rId13"/>
    <p:sldId id="272" r:id="rId14"/>
    <p:sldId id="273" r:id="rId15"/>
    <p:sldId id="274" r:id="rId16"/>
    <p:sldId id="275" r:id="rId17"/>
    <p:sldId id="277" r:id="rId18"/>
    <p:sldId id="279" r:id="rId19"/>
    <p:sldId id="281" r:id="rId20"/>
    <p:sldId id="283" r:id="rId21"/>
    <p:sldId id="286" r:id="rId22"/>
    <p:sldId id="288" r:id="rId23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Vergara, Javier (CIAT)" initials="VJ(" lastIdx="1" clrIdx="0">
    <p:extLst>
      <p:ext uri="{19B8F6BF-5375-455C-9EA6-DF929625EA0E}">
        <p15:presenceInfo xmlns:p15="http://schemas.microsoft.com/office/powerpoint/2012/main" userId="S-1-5-21-1606980848-162531612-839522115-3809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6EBFF"/>
    <a:srgbClr val="99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4A3F957-80F5-411E-ACAE-8321A9B839DD}" v="134" dt="2024-02-23T19:39:52.110"/>
    <p1510:client id="{F1480259-50A5-46B3-9145-8ECDAE4FEE01}" v="6" dt="2024-02-23T18:54:33.30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slideViewPr>
    <p:cSldViewPr snapToGrid="0">
      <p:cViewPr>
        <p:scale>
          <a:sx n="1" d="2"/>
          <a:sy n="1" d="2"/>
        </p:scale>
        <p:origin x="0" y="0"/>
      </p:cViewPr>
      <p:guideLst/>
    </p:cSldViewPr>
  </p:slide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viewProps" Target="viewProps.xml"/><Relationship Id="rId30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omez, Daniela (Alliance Bioversity-CIAT)" userId="c94e5fda-a43d-46f7-b351-499384532572" providerId="ADAL" clId="{3259796A-8793-4E76-89FA-1E618C1BC8DD}"/>
    <pc:docChg chg="undo redo custSel addSld delSld modSld sldOrd">
      <pc:chgData name="Gomez, Daniela (Alliance Bioversity-CIAT)" userId="c94e5fda-a43d-46f7-b351-499384532572" providerId="ADAL" clId="{3259796A-8793-4E76-89FA-1E618C1BC8DD}" dt="2023-11-16T16:34:57.364" v="382" actId="20577"/>
      <pc:docMkLst>
        <pc:docMk/>
      </pc:docMkLst>
      <pc:sldChg chg="addSp delSp modSp del mod ord">
        <pc:chgData name="Gomez, Daniela (Alliance Bioversity-CIAT)" userId="c94e5fda-a43d-46f7-b351-499384532572" providerId="ADAL" clId="{3259796A-8793-4E76-89FA-1E618C1BC8DD}" dt="2023-11-16T15:58:52.570" v="309" actId="2696"/>
        <pc:sldMkLst>
          <pc:docMk/>
          <pc:sldMk cId="1935425303" sldId="265"/>
        </pc:sldMkLst>
        <pc:spChg chg="add del mod">
          <ac:chgData name="Gomez, Daniela (Alliance Bioversity-CIAT)" userId="c94e5fda-a43d-46f7-b351-499384532572" providerId="ADAL" clId="{3259796A-8793-4E76-89FA-1E618C1BC8DD}" dt="2023-10-30T15:53:41.308" v="3" actId="478"/>
          <ac:spMkLst>
            <pc:docMk/>
            <pc:sldMk cId="1935425303" sldId="265"/>
            <ac:spMk id="4" creationId="{88C5B932-8D1A-6DCE-EFC1-5EF155ACC240}"/>
          </ac:spMkLst>
        </pc:spChg>
        <pc:spChg chg="mod">
          <ac:chgData name="Gomez, Daniela (Alliance Bioversity-CIAT)" userId="c94e5fda-a43d-46f7-b351-499384532572" providerId="ADAL" clId="{3259796A-8793-4E76-89FA-1E618C1BC8DD}" dt="2023-10-30T16:00:42.735" v="82" actId="20577"/>
          <ac:spMkLst>
            <pc:docMk/>
            <pc:sldMk cId="1935425303" sldId="265"/>
            <ac:spMk id="15" creationId="{A331AB26-56D8-4BCA-8AAB-C188316A8DF2}"/>
          </ac:spMkLst>
        </pc:spChg>
        <pc:picChg chg="del">
          <ac:chgData name="Gomez, Daniela (Alliance Bioversity-CIAT)" userId="c94e5fda-a43d-46f7-b351-499384532572" providerId="ADAL" clId="{3259796A-8793-4E76-89FA-1E618C1BC8DD}" dt="2023-10-30T15:53:37.903" v="0" actId="478"/>
          <ac:picMkLst>
            <pc:docMk/>
            <pc:sldMk cId="1935425303" sldId="265"/>
            <ac:picMk id="6" creationId="{55B65189-6C90-404A-9EB8-23F7D8B7D084}"/>
          </ac:picMkLst>
        </pc:picChg>
        <pc:picChg chg="add mod modCrop">
          <ac:chgData name="Gomez, Daniela (Alliance Bioversity-CIAT)" userId="c94e5fda-a43d-46f7-b351-499384532572" providerId="ADAL" clId="{3259796A-8793-4E76-89FA-1E618C1BC8DD}" dt="2023-10-30T15:55:03.899" v="25" actId="1076"/>
          <ac:picMkLst>
            <pc:docMk/>
            <pc:sldMk cId="1935425303" sldId="265"/>
            <ac:picMk id="7" creationId="{EDCCE56A-A61C-D008-C0F0-C52B741DA541}"/>
          </ac:picMkLst>
        </pc:picChg>
        <pc:picChg chg="del">
          <ac:chgData name="Gomez, Daniela (Alliance Bioversity-CIAT)" userId="c94e5fda-a43d-46f7-b351-499384532572" providerId="ADAL" clId="{3259796A-8793-4E76-89FA-1E618C1BC8DD}" dt="2023-10-30T15:53:38.398" v="1" actId="478"/>
          <ac:picMkLst>
            <pc:docMk/>
            <pc:sldMk cId="1935425303" sldId="265"/>
            <ac:picMk id="8" creationId="{C993572A-8FA3-4108-BDE7-52A86C99E9D1}"/>
          </ac:picMkLst>
        </pc:picChg>
        <pc:picChg chg="del">
          <ac:chgData name="Gomez, Daniela (Alliance Bioversity-CIAT)" userId="c94e5fda-a43d-46f7-b351-499384532572" providerId="ADAL" clId="{3259796A-8793-4E76-89FA-1E618C1BC8DD}" dt="2023-10-30T15:53:39.008" v="2" actId="478"/>
          <ac:picMkLst>
            <pc:docMk/>
            <pc:sldMk cId="1935425303" sldId="265"/>
            <ac:picMk id="12" creationId="{A49E7808-AD64-4700-92B0-3D2562173D0E}"/>
          </ac:picMkLst>
        </pc:picChg>
        <pc:picChg chg="add mod modCrop">
          <ac:chgData name="Gomez, Daniela (Alliance Bioversity-CIAT)" userId="c94e5fda-a43d-46f7-b351-499384532572" providerId="ADAL" clId="{3259796A-8793-4E76-89FA-1E618C1BC8DD}" dt="2023-10-30T15:55:14.655" v="29" actId="1076"/>
          <ac:picMkLst>
            <pc:docMk/>
            <pc:sldMk cId="1935425303" sldId="265"/>
            <ac:picMk id="14" creationId="{055FCCE4-C0EC-19A1-E0E8-01F486922E67}"/>
          </ac:picMkLst>
        </pc:picChg>
        <pc:picChg chg="del">
          <ac:chgData name="Gomez, Daniela (Alliance Bioversity-CIAT)" userId="c94e5fda-a43d-46f7-b351-499384532572" providerId="ADAL" clId="{3259796A-8793-4E76-89FA-1E618C1BC8DD}" dt="2023-10-30T15:53:46.554" v="4" actId="478"/>
          <ac:picMkLst>
            <pc:docMk/>
            <pc:sldMk cId="1935425303" sldId="265"/>
            <ac:picMk id="16" creationId="{10F85A64-7C91-4D25-AB98-06A38BB840B9}"/>
          </ac:picMkLst>
        </pc:picChg>
        <pc:picChg chg="add mod modCrop">
          <ac:chgData name="Gomez, Daniela (Alliance Bioversity-CIAT)" userId="c94e5fda-a43d-46f7-b351-499384532572" providerId="ADAL" clId="{3259796A-8793-4E76-89FA-1E618C1BC8DD}" dt="2023-10-30T15:55:32.719" v="35" actId="1076"/>
          <ac:picMkLst>
            <pc:docMk/>
            <pc:sldMk cId="1935425303" sldId="265"/>
            <ac:picMk id="18" creationId="{3E0F24C0-BC4D-2EA4-B580-87E25DEF7C90}"/>
          </ac:picMkLst>
        </pc:picChg>
        <pc:picChg chg="add mod modCrop">
          <ac:chgData name="Gomez, Daniela (Alliance Bioversity-CIAT)" userId="c94e5fda-a43d-46f7-b351-499384532572" providerId="ADAL" clId="{3259796A-8793-4E76-89FA-1E618C1BC8DD}" dt="2023-10-30T15:55:44.039" v="39" actId="1076"/>
          <ac:picMkLst>
            <pc:docMk/>
            <pc:sldMk cId="1935425303" sldId="265"/>
            <ac:picMk id="20" creationId="{E73A2626-F059-BA08-5BE9-40F86D74E53D}"/>
          </ac:picMkLst>
        </pc:picChg>
      </pc:sldChg>
      <pc:sldChg chg="modSp mod">
        <pc:chgData name="Gomez, Daniela (Alliance Bioversity-CIAT)" userId="c94e5fda-a43d-46f7-b351-499384532572" providerId="ADAL" clId="{3259796A-8793-4E76-89FA-1E618C1BC8DD}" dt="2023-11-16T16:02:50.912" v="342" actId="20577"/>
        <pc:sldMkLst>
          <pc:docMk/>
          <pc:sldMk cId="1307993186" sldId="268"/>
        </pc:sldMkLst>
        <pc:spChg chg="mod">
          <ac:chgData name="Gomez, Daniela (Alliance Bioversity-CIAT)" userId="c94e5fda-a43d-46f7-b351-499384532572" providerId="ADAL" clId="{3259796A-8793-4E76-89FA-1E618C1BC8DD}" dt="2023-11-16T16:02:50.912" v="342" actId="20577"/>
          <ac:spMkLst>
            <pc:docMk/>
            <pc:sldMk cId="1307993186" sldId="268"/>
            <ac:spMk id="15" creationId="{A331AB26-56D8-4BCA-8AAB-C188316A8DF2}"/>
          </ac:spMkLst>
        </pc:spChg>
      </pc:sldChg>
      <pc:sldChg chg="modSp mod">
        <pc:chgData name="Gomez, Daniela (Alliance Bioversity-CIAT)" userId="c94e5fda-a43d-46f7-b351-499384532572" providerId="ADAL" clId="{3259796A-8793-4E76-89FA-1E618C1BC8DD}" dt="2023-11-16T16:02:54.611" v="344" actId="20577"/>
        <pc:sldMkLst>
          <pc:docMk/>
          <pc:sldMk cId="1495302232" sldId="269"/>
        </pc:sldMkLst>
        <pc:spChg chg="mod">
          <ac:chgData name="Gomez, Daniela (Alliance Bioversity-CIAT)" userId="c94e5fda-a43d-46f7-b351-499384532572" providerId="ADAL" clId="{3259796A-8793-4E76-89FA-1E618C1BC8DD}" dt="2023-11-16T16:02:54.611" v="344" actId="20577"/>
          <ac:spMkLst>
            <pc:docMk/>
            <pc:sldMk cId="1495302232" sldId="269"/>
            <ac:spMk id="15" creationId="{A331AB26-56D8-4BCA-8AAB-C188316A8DF2}"/>
          </ac:spMkLst>
        </pc:spChg>
      </pc:sldChg>
      <pc:sldChg chg="modSp mod">
        <pc:chgData name="Gomez, Daniela (Alliance Bioversity-CIAT)" userId="c94e5fda-a43d-46f7-b351-499384532572" providerId="ADAL" clId="{3259796A-8793-4E76-89FA-1E618C1BC8DD}" dt="2023-11-16T16:02:39.337" v="340" actId="20577"/>
        <pc:sldMkLst>
          <pc:docMk/>
          <pc:sldMk cId="2995284397" sldId="270"/>
        </pc:sldMkLst>
        <pc:spChg chg="mod">
          <ac:chgData name="Gomez, Daniela (Alliance Bioversity-CIAT)" userId="c94e5fda-a43d-46f7-b351-499384532572" providerId="ADAL" clId="{3259796A-8793-4E76-89FA-1E618C1BC8DD}" dt="2023-11-16T16:02:39.337" v="340" actId="20577"/>
          <ac:spMkLst>
            <pc:docMk/>
            <pc:sldMk cId="2995284397" sldId="270"/>
            <ac:spMk id="15" creationId="{A331AB26-56D8-4BCA-8AAB-C188316A8DF2}"/>
          </ac:spMkLst>
        </pc:spChg>
      </pc:sldChg>
      <pc:sldChg chg="addSp delSp modSp mod ord">
        <pc:chgData name="Gomez, Daniela (Alliance Bioversity-CIAT)" userId="c94e5fda-a43d-46f7-b351-499384532572" providerId="ADAL" clId="{3259796A-8793-4E76-89FA-1E618C1BC8DD}" dt="2023-11-16T16:03:15.035" v="356" actId="20577"/>
        <pc:sldMkLst>
          <pc:docMk/>
          <pc:sldMk cId="3649580678" sldId="271"/>
        </pc:sldMkLst>
        <pc:spChg chg="mod">
          <ac:chgData name="Gomez, Daniela (Alliance Bioversity-CIAT)" userId="c94e5fda-a43d-46f7-b351-499384532572" providerId="ADAL" clId="{3259796A-8793-4E76-89FA-1E618C1BC8DD}" dt="2023-11-16T16:03:15.035" v="356" actId="20577"/>
          <ac:spMkLst>
            <pc:docMk/>
            <pc:sldMk cId="3649580678" sldId="271"/>
            <ac:spMk id="30" creationId="{D43F6902-EE86-346C-7DE6-0C27CD23F9E4}"/>
          </ac:spMkLst>
        </pc:spChg>
        <pc:grpChg chg="add mod">
          <ac:chgData name="Gomez, Daniela (Alliance Bioversity-CIAT)" userId="c94e5fda-a43d-46f7-b351-499384532572" providerId="ADAL" clId="{3259796A-8793-4E76-89FA-1E618C1BC8DD}" dt="2023-11-15T16:38:19.632" v="240" actId="1076"/>
          <ac:grpSpMkLst>
            <pc:docMk/>
            <pc:sldMk cId="3649580678" sldId="271"/>
            <ac:grpSpMk id="4" creationId="{9BD602EE-7E4F-842E-0588-A6179CE8AF45}"/>
          </ac:grpSpMkLst>
        </pc:grpChg>
        <pc:grpChg chg="add mod">
          <ac:chgData name="Gomez, Daniela (Alliance Bioversity-CIAT)" userId="c94e5fda-a43d-46f7-b351-499384532572" providerId="ADAL" clId="{3259796A-8793-4E76-89FA-1E618C1BC8DD}" dt="2023-11-15T16:41:00.114" v="253" actId="164"/>
          <ac:grpSpMkLst>
            <pc:docMk/>
            <pc:sldMk cId="3649580678" sldId="271"/>
            <ac:grpSpMk id="7" creationId="{483E2120-27EF-9714-DC95-D96141929E1C}"/>
          </ac:grpSpMkLst>
        </pc:grpChg>
        <pc:grpChg chg="add mod">
          <ac:chgData name="Gomez, Daniela (Alliance Bioversity-CIAT)" userId="c94e5fda-a43d-46f7-b351-499384532572" providerId="ADAL" clId="{3259796A-8793-4E76-89FA-1E618C1BC8DD}" dt="2023-11-15T16:41:08.103" v="255" actId="164"/>
          <ac:grpSpMkLst>
            <pc:docMk/>
            <pc:sldMk cId="3649580678" sldId="271"/>
            <ac:grpSpMk id="8" creationId="{2BCA7B22-84EC-8811-2DD7-0717922A6E81}"/>
          </ac:grpSpMkLst>
        </pc:grpChg>
        <pc:grpChg chg="add del mod">
          <ac:chgData name="Gomez, Daniela (Alliance Bioversity-CIAT)" userId="c94e5fda-a43d-46f7-b351-499384532572" providerId="ADAL" clId="{3259796A-8793-4E76-89FA-1E618C1BC8DD}" dt="2023-11-15T16:42:36.699" v="272" actId="165"/>
          <ac:grpSpMkLst>
            <pc:docMk/>
            <pc:sldMk cId="3649580678" sldId="271"/>
            <ac:grpSpMk id="10" creationId="{04DD3845-548E-8348-62DD-47F3E7EE7C59}"/>
          </ac:grpSpMkLst>
        </pc:grpChg>
        <pc:grpChg chg="del">
          <ac:chgData name="Gomez, Daniela (Alliance Bioversity-CIAT)" userId="c94e5fda-a43d-46f7-b351-499384532572" providerId="ADAL" clId="{3259796A-8793-4E76-89FA-1E618C1BC8DD}" dt="2023-11-15T16:39:58.104" v="241" actId="165"/>
          <ac:grpSpMkLst>
            <pc:docMk/>
            <pc:sldMk cId="3649580678" sldId="271"/>
            <ac:grpSpMk id="25" creationId="{48A8DCA0-F2A9-CC2A-B2CA-36E864AE8EB3}"/>
          </ac:grpSpMkLst>
        </pc:grpChg>
        <pc:grpChg chg="add del mod">
          <ac:chgData name="Gomez, Daniela (Alliance Bioversity-CIAT)" userId="c94e5fda-a43d-46f7-b351-499384532572" providerId="ADAL" clId="{3259796A-8793-4E76-89FA-1E618C1BC8DD}" dt="2023-11-15T16:53:05.729" v="300" actId="165"/>
          <ac:grpSpMkLst>
            <pc:docMk/>
            <pc:sldMk cId="3649580678" sldId="271"/>
            <ac:grpSpMk id="26" creationId="{5CD34AEE-F1C2-0FF7-40F0-B1198A8B61CA}"/>
          </ac:grpSpMkLst>
        </pc:grpChg>
        <pc:grpChg chg="add mod">
          <ac:chgData name="Gomez, Daniela (Alliance Bioversity-CIAT)" userId="c94e5fda-a43d-46f7-b351-499384532572" providerId="ADAL" clId="{3259796A-8793-4E76-89FA-1E618C1BC8DD}" dt="2023-11-15T16:53:35.767" v="307" actId="1076"/>
          <ac:grpSpMkLst>
            <pc:docMk/>
            <pc:sldMk cId="3649580678" sldId="271"/>
            <ac:grpSpMk id="29" creationId="{D6F9AFED-EBA8-6CBF-6025-0AAD34311BAA}"/>
          </ac:grpSpMkLst>
        </pc:grpChg>
        <pc:picChg chg="add mod">
          <ac:chgData name="Gomez, Daniela (Alliance Bioversity-CIAT)" userId="c94e5fda-a43d-46f7-b351-499384532572" providerId="ADAL" clId="{3259796A-8793-4E76-89FA-1E618C1BC8DD}" dt="2023-11-15T16:38:03.023" v="237" actId="164"/>
          <ac:picMkLst>
            <pc:docMk/>
            <pc:sldMk cId="3649580678" sldId="271"/>
            <ac:picMk id="3" creationId="{EC581DAF-D684-37DE-5611-00425234BC8D}"/>
          </ac:picMkLst>
        </pc:picChg>
        <pc:picChg chg="add del mod topLvl">
          <ac:chgData name="Gomez, Daniela (Alliance Bioversity-CIAT)" userId="c94e5fda-a43d-46f7-b351-499384532572" providerId="ADAL" clId="{3259796A-8793-4E76-89FA-1E618C1BC8DD}" dt="2023-11-15T16:50:28.120" v="288" actId="478"/>
          <ac:picMkLst>
            <pc:docMk/>
            <pc:sldMk cId="3649580678" sldId="271"/>
            <ac:picMk id="6" creationId="{C80A7E49-9D69-743C-CC11-0CF1D5E8D2C5}"/>
          </ac:picMkLst>
        </pc:picChg>
        <pc:picChg chg="mod">
          <ac:chgData name="Gomez, Daniela (Alliance Bioversity-CIAT)" userId="c94e5fda-a43d-46f7-b351-499384532572" providerId="ADAL" clId="{3259796A-8793-4E76-89FA-1E618C1BC8DD}" dt="2023-11-15T16:51:22.760" v="298" actId="14100"/>
          <ac:picMkLst>
            <pc:docMk/>
            <pc:sldMk cId="3649580678" sldId="271"/>
            <ac:picMk id="11" creationId="{F3650E86-0410-1B96-BEB8-A81AD6EC9399}"/>
          </ac:picMkLst>
        </pc:picChg>
        <pc:picChg chg="add mod topLvl modCrop">
          <ac:chgData name="Gomez, Daniela (Alliance Bioversity-CIAT)" userId="c94e5fda-a43d-46f7-b351-499384532572" providerId="ADAL" clId="{3259796A-8793-4E76-89FA-1E618C1BC8DD}" dt="2023-11-15T16:53:25.285" v="305" actId="164"/>
          <ac:picMkLst>
            <pc:docMk/>
            <pc:sldMk cId="3649580678" sldId="271"/>
            <ac:picMk id="12" creationId="{DCAD54F4-A48B-F56C-B684-FD437FD4FB09}"/>
          </ac:picMkLst>
        </pc:picChg>
        <pc:picChg chg="mod modCrop">
          <ac:chgData name="Gomez, Daniela (Alliance Bioversity-CIAT)" userId="c94e5fda-a43d-46f7-b351-499384532572" providerId="ADAL" clId="{3259796A-8793-4E76-89FA-1E618C1BC8DD}" dt="2023-11-15T16:38:03.023" v="237" actId="164"/>
          <ac:picMkLst>
            <pc:docMk/>
            <pc:sldMk cId="3649580678" sldId="271"/>
            <ac:picMk id="13" creationId="{7AF75264-BDAB-0EFF-5441-05C76C354198}"/>
          </ac:picMkLst>
        </pc:picChg>
        <pc:picChg chg="add del mod">
          <ac:chgData name="Gomez, Daniela (Alliance Bioversity-CIAT)" userId="c94e5fda-a43d-46f7-b351-499384532572" providerId="ADAL" clId="{3259796A-8793-4E76-89FA-1E618C1BC8DD}" dt="2023-11-15T16:44:27.698" v="283" actId="478"/>
          <ac:picMkLst>
            <pc:docMk/>
            <pc:sldMk cId="3649580678" sldId="271"/>
            <ac:picMk id="17" creationId="{DA41AD2F-1BEF-C4BC-79FF-CF6CEA501975}"/>
          </ac:picMkLst>
        </pc:picChg>
        <pc:picChg chg="add del mod">
          <ac:chgData name="Gomez, Daniela (Alliance Bioversity-CIAT)" userId="c94e5fda-a43d-46f7-b351-499384532572" providerId="ADAL" clId="{3259796A-8793-4E76-89FA-1E618C1BC8DD}" dt="2023-11-15T16:45:03.404" v="287" actId="478"/>
          <ac:picMkLst>
            <pc:docMk/>
            <pc:sldMk cId="3649580678" sldId="271"/>
            <ac:picMk id="20" creationId="{9821A5C0-C6D8-6B27-011C-9458E98D5020}"/>
          </ac:picMkLst>
        </pc:picChg>
        <pc:picChg chg="add mod topLvl">
          <ac:chgData name="Gomez, Daniela (Alliance Bioversity-CIAT)" userId="c94e5fda-a43d-46f7-b351-499384532572" providerId="ADAL" clId="{3259796A-8793-4E76-89FA-1E618C1BC8DD}" dt="2023-11-15T16:53:25.285" v="305" actId="164"/>
          <ac:picMkLst>
            <pc:docMk/>
            <pc:sldMk cId="3649580678" sldId="271"/>
            <ac:picMk id="22" creationId="{D761F4E3-3444-8E18-212A-8D009974B38A}"/>
          </ac:picMkLst>
        </pc:picChg>
        <pc:picChg chg="del mod topLvl">
          <ac:chgData name="Gomez, Daniela (Alliance Bioversity-CIAT)" userId="c94e5fda-a43d-46f7-b351-499384532572" providerId="ADAL" clId="{3259796A-8793-4E76-89FA-1E618C1BC8DD}" dt="2023-11-15T16:40:00.994" v="242" actId="478"/>
          <ac:picMkLst>
            <pc:docMk/>
            <pc:sldMk cId="3649580678" sldId="271"/>
            <ac:picMk id="23" creationId="{57248CD0-94B5-71CF-5E4C-C48AA1CB3829}"/>
          </ac:picMkLst>
        </pc:picChg>
        <pc:picChg chg="del mod topLvl">
          <ac:chgData name="Gomez, Daniela (Alliance Bioversity-CIAT)" userId="c94e5fda-a43d-46f7-b351-499384532572" providerId="ADAL" clId="{3259796A-8793-4E76-89FA-1E618C1BC8DD}" dt="2023-11-15T16:42:39.517" v="273" actId="478"/>
          <ac:picMkLst>
            <pc:docMk/>
            <pc:sldMk cId="3649580678" sldId="271"/>
            <ac:picMk id="24" creationId="{E9AC10E1-F84E-70D5-D6E2-71B5096B8493}"/>
          </ac:picMkLst>
        </pc:picChg>
        <pc:picChg chg="mod">
          <ac:chgData name="Gomez, Daniela (Alliance Bioversity-CIAT)" userId="c94e5fda-a43d-46f7-b351-499384532572" providerId="ADAL" clId="{3259796A-8793-4E76-89FA-1E618C1BC8DD}" dt="2023-11-15T16:53:45.785" v="308" actId="1076"/>
          <ac:picMkLst>
            <pc:docMk/>
            <pc:sldMk cId="3649580678" sldId="271"/>
            <ac:picMk id="28" creationId="{19F6F117-39AA-ED17-83A4-8A6CCA8D4A32}"/>
          </ac:picMkLst>
        </pc:picChg>
      </pc:sldChg>
      <pc:sldChg chg="modSp mod ord">
        <pc:chgData name="Gomez, Daniela (Alliance Bioversity-CIAT)" userId="c94e5fda-a43d-46f7-b351-499384532572" providerId="ADAL" clId="{3259796A-8793-4E76-89FA-1E618C1BC8DD}" dt="2023-11-16T16:03:20.755" v="358" actId="20577"/>
        <pc:sldMkLst>
          <pc:docMk/>
          <pc:sldMk cId="717926230" sldId="272"/>
        </pc:sldMkLst>
        <pc:spChg chg="mod">
          <ac:chgData name="Gomez, Daniela (Alliance Bioversity-CIAT)" userId="c94e5fda-a43d-46f7-b351-499384532572" providerId="ADAL" clId="{3259796A-8793-4E76-89FA-1E618C1BC8DD}" dt="2023-11-16T16:03:20.755" v="358" actId="20577"/>
          <ac:spMkLst>
            <pc:docMk/>
            <pc:sldMk cId="717926230" sldId="272"/>
            <ac:spMk id="15" creationId="{A331AB26-56D8-4BCA-8AAB-C188316A8DF2}"/>
          </ac:spMkLst>
        </pc:spChg>
      </pc:sldChg>
      <pc:sldChg chg="modSp mod ord">
        <pc:chgData name="Gomez, Daniela (Alliance Bioversity-CIAT)" userId="c94e5fda-a43d-46f7-b351-499384532572" providerId="ADAL" clId="{3259796A-8793-4E76-89FA-1E618C1BC8DD}" dt="2023-11-16T16:03:23.502" v="360" actId="20577"/>
        <pc:sldMkLst>
          <pc:docMk/>
          <pc:sldMk cId="4012007636" sldId="273"/>
        </pc:sldMkLst>
        <pc:spChg chg="mod">
          <ac:chgData name="Gomez, Daniela (Alliance Bioversity-CIAT)" userId="c94e5fda-a43d-46f7-b351-499384532572" providerId="ADAL" clId="{3259796A-8793-4E76-89FA-1E618C1BC8DD}" dt="2023-11-16T16:03:23.502" v="360" actId="20577"/>
          <ac:spMkLst>
            <pc:docMk/>
            <pc:sldMk cId="4012007636" sldId="273"/>
            <ac:spMk id="15" creationId="{A331AB26-56D8-4BCA-8AAB-C188316A8DF2}"/>
          </ac:spMkLst>
        </pc:spChg>
      </pc:sldChg>
      <pc:sldChg chg="modSp mod ord">
        <pc:chgData name="Gomez, Daniela (Alliance Bioversity-CIAT)" userId="c94e5fda-a43d-46f7-b351-499384532572" providerId="ADAL" clId="{3259796A-8793-4E76-89FA-1E618C1BC8DD}" dt="2023-11-16T16:03:26.802" v="362" actId="20577"/>
        <pc:sldMkLst>
          <pc:docMk/>
          <pc:sldMk cId="4260030243" sldId="274"/>
        </pc:sldMkLst>
        <pc:spChg chg="mod">
          <ac:chgData name="Gomez, Daniela (Alliance Bioversity-CIAT)" userId="c94e5fda-a43d-46f7-b351-499384532572" providerId="ADAL" clId="{3259796A-8793-4E76-89FA-1E618C1BC8DD}" dt="2023-11-16T16:03:26.802" v="362" actId="20577"/>
          <ac:spMkLst>
            <pc:docMk/>
            <pc:sldMk cId="4260030243" sldId="274"/>
            <ac:spMk id="15" creationId="{A331AB26-56D8-4BCA-8AAB-C188316A8DF2}"/>
          </ac:spMkLst>
        </pc:spChg>
      </pc:sldChg>
      <pc:sldChg chg="modSp mod ord">
        <pc:chgData name="Gomez, Daniela (Alliance Bioversity-CIAT)" userId="c94e5fda-a43d-46f7-b351-499384532572" providerId="ADAL" clId="{3259796A-8793-4E76-89FA-1E618C1BC8DD}" dt="2023-11-16T16:03:29.964" v="364" actId="20577"/>
        <pc:sldMkLst>
          <pc:docMk/>
          <pc:sldMk cId="1946445284" sldId="275"/>
        </pc:sldMkLst>
        <pc:spChg chg="mod">
          <ac:chgData name="Gomez, Daniela (Alliance Bioversity-CIAT)" userId="c94e5fda-a43d-46f7-b351-499384532572" providerId="ADAL" clId="{3259796A-8793-4E76-89FA-1E618C1BC8DD}" dt="2023-11-16T16:03:29.964" v="364" actId="20577"/>
          <ac:spMkLst>
            <pc:docMk/>
            <pc:sldMk cId="1946445284" sldId="275"/>
            <ac:spMk id="15" creationId="{A331AB26-56D8-4BCA-8AAB-C188316A8DF2}"/>
          </ac:spMkLst>
        </pc:spChg>
      </pc:sldChg>
      <pc:sldChg chg="modSp mod">
        <pc:chgData name="Gomez, Daniela (Alliance Bioversity-CIAT)" userId="c94e5fda-a43d-46f7-b351-499384532572" providerId="ADAL" clId="{3259796A-8793-4E76-89FA-1E618C1BC8DD}" dt="2023-11-16T16:03:00.106" v="351" actId="20577"/>
        <pc:sldMkLst>
          <pc:docMk/>
          <pc:sldMk cId="1605347520" sldId="276"/>
        </pc:sldMkLst>
        <pc:spChg chg="mod">
          <ac:chgData name="Gomez, Daniela (Alliance Bioversity-CIAT)" userId="c94e5fda-a43d-46f7-b351-499384532572" providerId="ADAL" clId="{3259796A-8793-4E76-89FA-1E618C1BC8DD}" dt="2023-11-16T16:03:00.106" v="351" actId="20577"/>
          <ac:spMkLst>
            <pc:docMk/>
            <pc:sldMk cId="1605347520" sldId="276"/>
            <ac:spMk id="3" creationId="{7407D766-0A41-2817-44C1-014E1233DBD8}"/>
          </ac:spMkLst>
        </pc:spChg>
      </pc:sldChg>
      <pc:sldChg chg="modSp mod ord">
        <pc:chgData name="Gomez, Daniela (Alliance Bioversity-CIAT)" userId="c94e5fda-a43d-46f7-b351-499384532572" providerId="ADAL" clId="{3259796A-8793-4E76-89FA-1E618C1BC8DD}" dt="2023-11-16T16:03:36.354" v="366" actId="20577"/>
        <pc:sldMkLst>
          <pc:docMk/>
          <pc:sldMk cId="529526858" sldId="277"/>
        </pc:sldMkLst>
        <pc:spChg chg="mod">
          <ac:chgData name="Gomez, Daniela (Alliance Bioversity-CIAT)" userId="c94e5fda-a43d-46f7-b351-499384532572" providerId="ADAL" clId="{3259796A-8793-4E76-89FA-1E618C1BC8DD}" dt="2023-11-16T16:03:36.354" v="366" actId="20577"/>
          <ac:spMkLst>
            <pc:docMk/>
            <pc:sldMk cId="529526858" sldId="277"/>
            <ac:spMk id="15" creationId="{31521B25-5F28-A1FE-D2B4-E274D0C959D6}"/>
          </ac:spMkLst>
        </pc:spChg>
      </pc:sldChg>
      <pc:sldChg chg="modSp mod">
        <pc:chgData name="Gomez, Daniela (Alliance Bioversity-CIAT)" userId="c94e5fda-a43d-46f7-b351-499384532572" providerId="ADAL" clId="{3259796A-8793-4E76-89FA-1E618C1BC8DD}" dt="2023-11-16T16:03:03.989" v="352" actId="20577"/>
        <pc:sldMkLst>
          <pc:docMk/>
          <pc:sldMk cId="2349917634" sldId="278"/>
        </pc:sldMkLst>
        <pc:spChg chg="mod">
          <ac:chgData name="Gomez, Daniela (Alliance Bioversity-CIAT)" userId="c94e5fda-a43d-46f7-b351-499384532572" providerId="ADAL" clId="{3259796A-8793-4E76-89FA-1E618C1BC8DD}" dt="2023-11-16T16:03:03.989" v="352" actId="20577"/>
          <ac:spMkLst>
            <pc:docMk/>
            <pc:sldMk cId="2349917634" sldId="278"/>
            <ac:spMk id="4" creationId="{C72D4F93-3114-72B0-0158-44D107EEA4BC}"/>
          </ac:spMkLst>
        </pc:spChg>
      </pc:sldChg>
      <pc:sldChg chg="modSp mod ord">
        <pc:chgData name="Gomez, Daniela (Alliance Bioversity-CIAT)" userId="c94e5fda-a43d-46f7-b351-499384532572" providerId="ADAL" clId="{3259796A-8793-4E76-89FA-1E618C1BC8DD}" dt="2023-11-16T16:03:40.929" v="368" actId="20577"/>
        <pc:sldMkLst>
          <pc:docMk/>
          <pc:sldMk cId="1807957567" sldId="279"/>
        </pc:sldMkLst>
        <pc:spChg chg="mod">
          <ac:chgData name="Gomez, Daniela (Alliance Bioversity-CIAT)" userId="c94e5fda-a43d-46f7-b351-499384532572" providerId="ADAL" clId="{3259796A-8793-4E76-89FA-1E618C1BC8DD}" dt="2023-11-16T16:03:40.929" v="368" actId="20577"/>
          <ac:spMkLst>
            <pc:docMk/>
            <pc:sldMk cId="1807957567" sldId="279"/>
            <ac:spMk id="15" creationId="{91066358-8536-0832-6CC0-D39F72B4FDE1}"/>
          </ac:spMkLst>
        </pc:spChg>
      </pc:sldChg>
      <pc:sldChg chg="modSp mod">
        <pc:chgData name="Gomez, Daniela (Alliance Bioversity-CIAT)" userId="c94e5fda-a43d-46f7-b351-499384532572" providerId="ADAL" clId="{3259796A-8793-4E76-89FA-1E618C1BC8DD}" dt="2023-11-16T16:03:07.019" v="354" actId="20577"/>
        <pc:sldMkLst>
          <pc:docMk/>
          <pc:sldMk cId="2805558929" sldId="280"/>
        </pc:sldMkLst>
        <pc:spChg chg="mod">
          <ac:chgData name="Gomez, Daniela (Alliance Bioversity-CIAT)" userId="c94e5fda-a43d-46f7-b351-499384532572" providerId="ADAL" clId="{3259796A-8793-4E76-89FA-1E618C1BC8DD}" dt="2023-11-16T16:03:07.019" v="354" actId="20577"/>
          <ac:spMkLst>
            <pc:docMk/>
            <pc:sldMk cId="2805558929" sldId="280"/>
            <ac:spMk id="4" creationId="{590AD048-76EC-C177-43E5-9AD8C3E167C3}"/>
          </ac:spMkLst>
        </pc:spChg>
      </pc:sldChg>
      <pc:sldChg chg="modSp mod ord">
        <pc:chgData name="Gomez, Daniela (Alliance Bioversity-CIAT)" userId="c94e5fda-a43d-46f7-b351-499384532572" providerId="ADAL" clId="{3259796A-8793-4E76-89FA-1E618C1BC8DD}" dt="2023-11-16T16:03:44.099" v="370" actId="20577"/>
        <pc:sldMkLst>
          <pc:docMk/>
          <pc:sldMk cId="4087503730" sldId="281"/>
        </pc:sldMkLst>
        <pc:spChg chg="mod">
          <ac:chgData name="Gomez, Daniela (Alliance Bioversity-CIAT)" userId="c94e5fda-a43d-46f7-b351-499384532572" providerId="ADAL" clId="{3259796A-8793-4E76-89FA-1E618C1BC8DD}" dt="2023-11-16T16:03:44.099" v="370" actId="20577"/>
          <ac:spMkLst>
            <pc:docMk/>
            <pc:sldMk cId="4087503730" sldId="281"/>
            <ac:spMk id="15" creationId="{D81AF051-742B-510D-A937-84ABE8E2177F}"/>
          </ac:spMkLst>
        </pc:spChg>
      </pc:sldChg>
      <pc:sldChg chg="modSp mod">
        <pc:chgData name="Gomez, Daniela (Alliance Bioversity-CIAT)" userId="c94e5fda-a43d-46f7-b351-499384532572" providerId="ADAL" clId="{3259796A-8793-4E76-89FA-1E618C1BC8DD}" dt="2023-11-16T16:03:12.678" v="355" actId="20577"/>
        <pc:sldMkLst>
          <pc:docMk/>
          <pc:sldMk cId="3263789347" sldId="282"/>
        </pc:sldMkLst>
        <pc:spChg chg="mod">
          <ac:chgData name="Gomez, Daniela (Alliance Bioversity-CIAT)" userId="c94e5fda-a43d-46f7-b351-499384532572" providerId="ADAL" clId="{3259796A-8793-4E76-89FA-1E618C1BC8DD}" dt="2023-11-16T16:03:12.678" v="355" actId="20577"/>
          <ac:spMkLst>
            <pc:docMk/>
            <pc:sldMk cId="3263789347" sldId="282"/>
            <ac:spMk id="4" creationId="{D6EE8DF7-A8F4-1113-5585-FD01B8158FB7}"/>
          </ac:spMkLst>
        </pc:spChg>
      </pc:sldChg>
      <pc:sldChg chg="modSp mod ord">
        <pc:chgData name="Gomez, Daniela (Alliance Bioversity-CIAT)" userId="c94e5fda-a43d-46f7-b351-499384532572" providerId="ADAL" clId="{3259796A-8793-4E76-89FA-1E618C1BC8DD}" dt="2023-11-16T16:03:47.586" v="372" actId="20577"/>
        <pc:sldMkLst>
          <pc:docMk/>
          <pc:sldMk cId="92458492" sldId="283"/>
        </pc:sldMkLst>
        <pc:spChg chg="mod">
          <ac:chgData name="Gomez, Daniela (Alliance Bioversity-CIAT)" userId="c94e5fda-a43d-46f7-b351-499384532572" providerId="ADAL" clId="{3259796A-8793-4E76-89FA-1E618C1BC8DD}" dt="2023-11-16T16:03:47.586" v="372" actId="20577"/>
          <ac:spMkLst>
            <pc:docMk/>
            <pc:sldMk cId="92458492" sldId="283"/>
            <ac:spMk id="17" creationId="{D2B59B80-0F54-4137-EF91-DEB5CA313D11}"/>
          </ac:spMkLst>
        </pc:spChg>
      </pc:sldChg>
      <pc:sldChg chg="addSp delSp modSp add mod ord">
        <pc:chgData name="Gomez, Daniela (Alliance Bioversity-CIAT)" userId="c94e5fda-a43d-46f7-b351-499384532572" providerId="ADAL" clId="{3259796A-8793-4E76-89FA-1E618C1BC8DD}" dt="2023-11-16T16:34:50.291" v="378" actId="20577"/>
        <pc:sldMkLst>
          <pc:docMk/>
          <pc:sldMk cId="4287176161" sldId="284"/>
        </pc:sldMkLst>
        <pc:spChg chg="del">
          <ac:chgData name="Gomez, Daniela (Alliance Bioversity-CIAT)" userId="c94e5fda-a43d-46f7-b351-499384532572" providerId="ADAL" clId="{3259796A-8793-4E76-89FA-1E618C1BC8DD}" dt="2023-10-30T17:59:28.168" v="84" actId="478"/>
          <ac:spMkLst>
            <pc:docMk/>
            <pc:sldMk cId="4287176161" sldId="284"/>
            <ac:spMk id="9" creationId="{726F9883-4AA6-6D05-239A-2109BEB22140}"/>
          </ac:spMkLst>
        </pc:spChg>
        <pc:spChg chg="del">
          <ac:chgData name="Gomez, Daniela (Alliance Bioversity-CIAT)" userId="c94e5fda-a43d-46f7-b351-499384532572" providerId="ADAL" clId="{3259796A-8793-4E76-89FA-1E618C1BC8DD}" dt="2023-10-30T17:59:28.168" v="84" actId="478"/>
          <ac:spMkLst>
            <pc:docMk/>
            <pc:sldMk cId="4287176161" sldId="284"/>
            <ac:spMk id="11" creationId="{707F2B40-2BB5-7172-BDED-A4342DAEBE70}"/>
          </ac:spMkLst>
        </pc:spChg>
        <pc:spChg chg="del">
          <ac:chgData name="Gomez, Daniela (Alliance Bioversity-CIAT)" userId="c94e5fda-a43d-46f7-b351-499384532572" providerId="ADAL" clId="{3259796A-8793-4E76-89FA-1E618C1BC8DD}" dt="2023-10-30T17:59:28.168" v="84" actId="478"/>
          <ac:spMkLst>
            <pc:docMk/>
            <pc:sldMk cId="4287176161" sldId="284"/>
            <ac:spMk id="13" creationId="{C62B0741-870D-5723-14FB-B1A3BF1DC221}"/>
          </ac:spMkLst>
        </pc:spChg>
        <pc:spChg chg="del">
          <ac:chgData name="Gomez, Daniela (Alliance Bioversity-CIAT)" userId="c94e5fda-a43d-46f7-b351-499384532572" providerId="ADAL" clId="{3259796A-8793-4E76-89FA-1E618C1BC8DD}" dt="2023-10-30T17:59:28.168" v="84" actId="478"/>
          <ac:spMkLst>
            <pc:docMk/>
            <pc:sldMk cId="4287176161" sldId="284"/>
            <ac:spMk id="15" creationId="{BC482CBE-E16C-4099-69BC-E5799428173E}"/>
          </ac:spMkLst>
        </pc:spChg>
        <pc:spChg chg="mod">
          <ac:chgData name="Gomez, Daniela (Alliance Bioversity-CIAT)" userId="c94e5fda-a43d-46f7-b351-499384532572" providerId="ADAL" clId="{3259796A-8793-4E76-89FA-1E618C1BC8DD}" dt="2023-11-16T16:34:50.291" v="378" actId="20577"/>
          <ac:spMkLst>
            <pc:docMk/>
            <pc:sldMk cId="4287176161" sldId="284"/>
            <ac:spMk id="17" creationId="{D2B59B80-0F54-4137-EF91-DEB5CA313D11}"/>
          </ac:spMkLst>
        </pc:spChg>
        <pc:picChg chg="add del mod">
          <ac:chgData name="Gomez, Daniela (Alliance Bioversity-CIAT)" userId="c94e5fda-a43d-46f7-b351-499384532572" providerId="ADAL" clId="{3259796A-8793-4E76-89FA-1E618C1BC8DD}" dt="2023-11-09T14:55:29.086" v="157" actId="478"/>
          <ac:picMkLst>
            <pc:docMk/>
            <pc:sldMk cId="4287176161" sldId="284"/>
            <ac:picMk id="3" creationId="{4745447C-AF12-2372-57A9-2DCF950D1684}"/>
          </ac:picMkLst>
        </pc:picChg>
        <pc:picChg chg="add mod">
          <ac:chgData name="Gomez, Daniela (Alliance Bioversity-CIAT)" userId="c94e5fda-a43d-46f7-b351-499384532572" providerId="ADAL" clId="{3259796A-8793-4E76-89FA-1E618C1BC8DD}" dt="2023-11-09T14:55:46.047" v="164" actId="1076"/>
          <ac:picMkLst>
            <pc:docMk/>
            <pc:sldMk cId="4287176161" sldId="284"/>
            <ac:picMk id="4" creationId="{0589D4AE-1931-A3E2-9D6D-413C31996642}"/>
          </ac:picMkLst>
        </pc:picChg>
        <pc:picChg chg="del">
          <ac:chgData name="Gomez, Daniela (Alliance Bioversity-CIAT)" userId="c94e5fda-a43d-46f7-b351-499384532572" providerId="ADAL" clId="{3259796A-8793-4E76-89FA-1E618C1BC8DD}" dt="2023-10-30T17:59:28.168" v="84" actId="478"/>
          <ac:picMkLst>
            <pc:docMk/>
            <pc:sldMk cId="4287176161" sldId="284"/>
            <ac:picMk id="4" creationId="{97D69735-9DDC-2A83-AA32-41C4C1C3D850}"/>
          </ac:picMkLst>
        </pc:picChg>
        <pc:picChg chg="del">
          <ac:chgData name="Gomez, Daniela (Alliance Bioversity-CIAT)" userId="c94e5fda-a43d-46f7-b351-499384532572" providerId="ADAL" clId="{3259796A-8793-4E76-89FA-1E618C1BC8DD}" dt="2023-10-30T17:59:28.168" v="84" actId="478"/>
          <ac:picMkLst>
            <pc:docMk/>
            <pc:sldMk cId="4287176161" sldId="284"/>
            <ac:picMk id="5" creationId="{92314211-CE2E-242D-B7FF-790DFF243D6C}"/>
          </ac:picMkLst>
        </pc:picChg>
        <pc:picChg chg="del">
          <ac:chgData name="Gomez, Daniela (Alliance Bioversity-CIAT)" userId="c94e5fda-a43d-46f7-b351-499384532572" providerId="ADAL" clId="{3259796A-8793-4E76-89FA-1E618C1BC8DD}" dt="2023-10-30T17:59:28.168" v="84" actId="478"/>
          <ac:picMkLst>
            <pc:docMk/>
            <pc:sldMk cId="4287176161" sldId="284"/>
            <ac:picMk id="6" creationId="{A6D62C2B-7C2F-0A0A-5E43-5431056BF978}"/>
          </ac:picMkLst>
        </pc:picChg>
        <pc:picChg chg="del">
          <ac:chgData name="Gomez, Daniela (Alliance Bioversity-CIAT)" userId="c94e5fda-a43d-46f7-b351-499384532572" providerId="ADAL" clId="{3259796A-8793-4E76-89FA-1E618C1BC8DD}" dt="2023-10-30T17:59:28.168" v="84" actId="478"/>
          <ac:picMkLst>
            <pc:docMk/>
            <pc:sldMk cId="4287176161" sldId="284"/>
            <ac:picMk id="7" creationId="{B5E1661D-01FE-928F-1DF5-232770CF5A04}"/>
          </ac:picMkLst>
        </pc:picChg>
      </pc:sldChg>
      <pc:sldChg chg="addSp delSp modSp add mod ord">
        <pc:chgData name="Gomez, Daniela (Alliance Bioversity-CIAT)" userId="c94e5fda-a43d-46f7-b351-499384532572" providerId="ADAL" clId="{3259796A-8793-4E76-89FA-1E618C1BC8DD}" dt="2023-11-16T16:34:54.221" v="380" actId="20577"/>
        <pc:sldMkLst>
          <pc:docMk/>
          <pc:sldMk cId="538812795" sldId="285"/>
        </pc:sldMkLst>
        <pc:spChg chg="mod">
          <ac:chgData name="Gomez, Daniela (Alliance Bioversity-CIAT)" userId="c94e5fda-a43d-46f7-b351-499384532572" providerId="ADAL" clId="{3259796A-8793-4E76-89FA-1E618C1BC8DD}" dt="2023-11-16T16:34:54.221" v="380" actId="20577"/>
          <ac:spMkLst>
            <pc:docMk/>
            <pc:sldMk cId="538812795" sldId="285"/>
            <ac:spMk id="17" creationId="{D2B59B80-0F54-4137-EF91-DEB5CA313D11}"/>
          </ac:spMkLst>
        </pc:spChg>
        <pc:picChg chg="del">
          <ac:chgData name="Gomez, Daniela (Alliance Bioversity-CIAT)" userId="c94e5fda-a43d-46f7-b351-499384532572" providerId="ADAL" clId="{3259796A-8793-4E76-89FA-1E618C1BC8DD}" dt="2023-10-30T18:02:43.078" v="113" actId="478"/>
          <ac:picMkLst>
            <pc:docMk/>
            <pc:sldMk cId="538812795" sldId="285"/>
            <ac:picMk id="3" creationId="{4745447C-AF12-2372-57A9-2DCF950D1684}"/>
          </ac:picMkLst>
        </pc:picChg>
        <pc:picChg chg="add mod">
          <ac:chgData name="Gomez, Daniela (Alliance Bioversity-CIAT)" userId="c94e5fda-a43d-46f7-b351-499384532572" providerId="ADAL" clId="{3259796A-8793-4E76-89FA-1E618C1BC8DD}" dt="2023-11-09T14:56:07.992" v="172" actId="1076"/>
          <ac:picMkLst>
            <pc:docMk/>
            <pc:sldMk cId="538812795" sldId="285"/>
            <ac:picMk id="3" creationId="{A1564525-92B0-235E-37A3-B79C51D6CD17}"/>
          </ac:picMkLst>
        </pc:picChg>
        <pc:picChg chg="add del mod">
          <ac:chgData name="Gomez, Daniela (Alliance Bioversity-CIAT)" userId="c94e5fda-a43d-46f7-b351-499384532572" providerId="ADAL" clId="{3259796A-8793-4E76-89FA-1E618C1BC8DD}" dt="2023-11-09T14:55:49.792" v="165" actId="478"/>
          <ac:picMkLst>
            <pc:docMk/>
            <pc:sldMk cId="538812795" sldId="285"/>
            <ac:picMk id="4" creationId="{3F3C63EF-12FC-7FF1-0DCC-42C8B2C562F9}"/>
          </ac:picMkLst>
        </pc:picChg>
      </pc:sldChg>
      <pc:sldChg chg="addSp delSp modSp new mod">
        <pc:chgData name="Gomez, Daniela (Alliance Bioversity-CIAT)" userId="c94e5fda-a43d-46f7-b351-499384532572" providerId="ADAL" clId="{3259796A-8793-4E76-89FA-1E618C1BC8DD}" dt="2023-11-16T16:03:50.623" v="374" actId="20577"/>
        <pc:sldMkLst>
          <pc:docMk/>
          <pc:sldMk cId="538079865" sldId="286"/>
        </pc:sldMkLst>
        <pc:spChg chg="del">
          <ac:chgData name="Gomez, Daniela (Alliance Bioversity-CIAT)" userId="c94e5fda-a43d-46f7-b351-499384532572" providerId="ADAL" clId="{3259796A-8793-4E76-89FA-1E618C1BC8DD}" dt="2023-10-30T18:03:49.857" v="133" actId="478"/>
          <ac:spMkLst>
            <pc:docMk/>
            <pc:sldMk cId="538079865" sldId="286"/>
            <ac:spMk id="2" creationId="{C218C4DD-9341-0E1C-F545-EF144F7ACAE1}"/>
          </ac:spMkLst>
        </pc:spChg>
        <pc:spChg chg="del">
          <ac:chgData name="Gomez, Daniela (Alliance Bioversity-CIAT)" userId="c94e5fda-a43d-46f7-b351-499384532572" providerId="ADAL" clId="{3259796A-8793-4E76-89FA-1E618C1BC8DD}" dt="2023-10-30T18:03:48.548" v="132" actId="478"/>
          <ac:spMkLst>
            <pc:docMk/>
            <pc:sldMk cId="538079865" sldId="286"/>
            <ac:spMk id="3" creationId="{97448838-1A72-478C-B465-D9A37CC59906}"/>
          </ac:spMkLst>
        </pc:spChg>
        <pc:spChg chg="add mod">
          <ac:chgData name="Gomez, Daniela (Alliance Bioversity-CIAT)" userId="c94e5fda-a43d-46f7-b351-499384532572" providerId="ADAL" clId="{3259796A-8793-4E76-89FA-1E618C1BC8DD}" dt="2023-11-16T16:03:50.623" v="374" actId="20577"/>
          <ac:spMkLst>
            <pc:docMk/>
            <pc:sldMk cId="538079865" sldId="286"/>
            <ac:spMk id="4" creationId="{0A58DEAC-71E6-A0CB-10CE-65C2187D93E9}"/>
          </ac:spMkLst>
        </pc:spChg>
        <pc:picChg chg="add mod modCrop">
          <ac:chgData name="Gomez, Daniela (Alliance Bioversity-CIAT)" userId="c94e5fda-a43d-46f7-b351-499384532572" providerId="ADAL" clId="{3259796A-8793-4E76-89FA-1E618C1BC8DD}" dt="2023-10-30T18:04:13.632" v="139" actId="1076"/>
          <ac:picMkLst>
            <pc:docMk/>
            <pc:sldMk cId="538079865" sldId="286"/>
            <ac:picMk id="6" creationId="{6DDAD1D8-F373-89DC-E477-269C88F2B1F5}"/>
          </ac:picMkLst>
        </pc:picChg>
      </pc:sldChg>
      <pc:sldChg chg="addSp delSp modSp mod ord">
        <pc:chgData name="Gomez, Daniela (Alliance Bioversity-CIAT)" userId="c94e5fda-a43d-46f7-b351-499384532572" providerId="ADAL" clId="{3259796A-8793-4E76-89FA-1E618C1BC8DD}" dt="2023-11-16T16:34:57.364" v="382" actId="20577"/>
        <pc:sldMkLst>
          <pc:docMk/>
          <pc:sldMk cId="2030033983" sldId="287"/>
        </pc:sldMkLst>
        <pc:spChg chg="mod">
          <ac:chgData name="Gomez, Daniela (Alliance Bioversity-CIAT)" userId="c94e5fda-a43d-46f7-b351-499384532572" providerId="ADAL" clId="{3259796A-8793-4E76-89FA-1E618C1BC8DD}" dt="2023-11-16T16:34:57.364" v="382" actId="20577"/>
          <ac:spMkLst>
            <pc:docMk/>
            <pc:sldMk cId="2030033983" sldId="287"/>
            <ac:spMk id="19" creationId="{00000000-0000-0000-0000-000000000000}"/>
          </ac:spMkLst>
        </pc:spChg>
        <pc:picChg chg="add mod">
          <ac:chgData name="Gomez, Daniela (Alliance Bioversity-CIAT)" userId="c94e5fda-a43d-46f7-b351-499384532572" providerId="ADAL" clId="{3259796A-8793-4E76-89FA-1E618C1BC8DD}" dt="2023-11-14T19:29:00.582" v="180" actId="1076"/>
          <ac:picMkLst>
            <pc:docMk/>
            <pc:sldMk cId="2030033983" sldId="287"/>
            <ac:picMk id="3" creationId="{2519FF98-7275-E233-D924-39645C4E71F9}"/>
          </ac:picMkLst>
        </pc:picChg>
        <pc:picChg chg="add mod">
          <ac:chgData name="Gomez, Daniela (Alliance Bioversity-CIAT)" userId="c94e5fda-a43d-46f7-b351-499384532572" providerId="ADAL" clId="{3259796A-8793-4E76-89FA-1E618C1BC8DD}" dt="2023-11-14T19:29:32.565" v="187" actId="14100"/>
          <ac:picMkLst>
            <pc:docMk/>
            <pc:sldMk cId="2030033983" sldId="287"/>
            <ac:picMk id="5" creationId="{D2025FB3-3D52-4ECB-2457-96F209DBCDEF}"/>
          </ac:picMkLst>
        </pc:picChg>
        <pc:picChg chg="add mod">
          <ac:chgData name="Gomez, Daniela (Alliance Bioversity-CIAT)" userId="c94e5fda-a43d-46f7-b351-499384532572" providerId="ADAL" clId="{3259796A-8793-4E76-89FA-1E618C1BC8DD}" dt="2023-11-14T19:30:00.953" v="197" actId="1076"/>
          <ac:picMkLst>
            <pc:docMk/>
            <pc:sldMk cId="2030033983" sldId="287"/>
            <ac:picMk id="7" creationId="{55BCFF0D-EFF7-17D3-0352-D302BE9B2CA1}"/>
          </ac:picMkLst>
        </pc:picChg>
        <pc:picChg chg="del">
          <ac:chgData name="Gomez, Daniela (Alliance Bioversity-CIAT)" userId="c94e5fda-a43d-46f7-b351-499384532572" providerId="ADAL" clId="{3259796A-8793-4E76-89FA-1E618C1BC8DD}" dt="2023-11-14T19:29:05.977" v="181" actId="478"/>
          <ac:picMkLst>
            <pc:docMk/>
            <pc:sldMk cId="2030033983" sldId="287"/>
            <ac:picMk id="9" creationId="{6C33B34F-2CD2-8AD5-9FC8-F1C7655E9195}"/>
          </ac:picMkLst>
        </pc:picChg>
        <pc:picChg chg="add mod">
          <ac:chgData name="Gomez, Daniela (Alliance Bioversity-CIAT)" userId="c94e5fda-a43d-46f7-b351-499384532572" providerId="ADAL" clId="{3259796A-8793-4E76-89FA-1E618C1BC8DD}" dt="2023-11-14T19:30:29.277" v="205" actId="14100"/>
          <ac:picMkLst>
            <pc:docMk/>
            <pc:sldMk cId="2030033983" sldId="287"/>
            <ac:picMk id="10" creationId="{183DA739-A31D-2BC0-6F0C-2E7A033701E9}"/>
          </ac:picMkLst>
        </pc:picChg>
        <pc:picChg chg="del">
          <ac:chgData name="Gomez, Daniela (Alliance Bioversity-CIAT)" userId="c94e5fda-a43d-46f7-b351-499384532572" providerId="ADAL" clId="{3259796A-8793-4E76-89FA-1E618C1BC8DD}" dt="2023-11-14T19:28:51.907" v="179" actId="478"/>
          <ac:picMkLst>
            <pc:docMk/>
            <pc:sldMk cId="2030033983" sldId="287"/>
            <ac:picMk id="11" creationId="{AF52264A-F957-811F-D6B7-73D291C4D69D}"/>
          </ac:picMkLst>
        </pc:picChg>
        <pc:picChg chg="del">
          <ac:chgData name="Gomez, Daniela (Alliance Bioversity-CIAT)" userId="c94e5fda-a43d-46f7-b351-499384532572" providerId="ADAL" clId="{3259796A-8793-4E76-89FA-1E618C1BC8DD}" dt="2023-11-14T19:29:36.149" v="189" actId="478"/>
          <ac:picMkLst>
            <pc:docMk/>
            <pc:sldMk cId="2030033983" sldId="287"/>
            <ac:picMk id="14" creationId="{75055BD3-1C1A-EE63-437C-6A66469BCCCB}"/>
          </ac:picMkLst>
        </pc:picChg>
        <pc:picChg chg="del">
          <ac:chgData name="Gomez, Daniela (Alliance Bioversity-CIAT)" userId="c94e5fda-a43d-46f7-b351-499384532572" providerId="ADAL" clId="{3259796A-8793-4E76-89FA-1E618C1BC8DD}" dt="2023-11-14T19:29:35.393" v="188" actId="478"/>
          <ac:picMkLst>
            <pc:docMk/>
            <pc:sldMk cId="2030033983" sldId="287"/>
            <ac:picMk id="18" creationId="{1EA8F2B5-0DDA-7066-8A3A-9C89EEF9E24B}"/>
          </ac:picMkLst>
        </pc:picChg>
      </pc:sldChg>
    </pc:docChg>
  </pc:docChgLst>
  <pc:docChgLst>
    <pc:chgData name="Gomez, Daniela (Alliance Bioversity-CIAT)" userId="S::daniela.gomez@cgiar.org::c94e5fda-a43d-46f7-b351-499384532572" providerId="AD" clId="Web-{E2D1CBF2-46FA-06E4-444F-3ACCE5170FF8}"/>
    <pc:docChg chg="addSld delSld modSld sldOrd">
      <pc:chgData name="Gomez, Daniela (Alliance Bioversity-CIAT)" userId="S::daniela.gomez@cgiar.org::c94e5fda-a43d-46f7-b351-499384532572" providerId="AD" clId="Web-{E2D1CBF2-46FA-06E4-444F-3ACCE5170FF8}" dt="2023-10-24T21:02:24.498" v="704" actId="1076"/>
      <pc:docMkLst>
        <pc:docMk/>
      </pc:docMkLst>
      <pc:sldChg chg="addSp delSp modSp add del replId">
        <pc:chgData name="Gomez, Daniela (Alliance Bioversity-CIAT)" userId="S::daniela.gomez@cgiar.org::c94e5fda-a43d-46f7-b351-499384532572" providerId="AD" clId="Web-{E2D1CBF2-46FA-06E4-444F-3ACCE5170FF8}" dt="2023-10-24T18:11:49.279" v="104"/>
        <pc:sldMkLst>
          <pc:docMk/>
          <pc:sldMk cId="3642483257" sldId="266"/>
        </pc:sldMkLst>
        <pc:spChg chg="del">
          <ac:chgData name="Gomez, Daniela (Alliance Bioversity-CIAT)" userId="S::daniela.gomez@cgiar.org::c94e5fda-a43d-46f7-b351-499384532572" providerId="AD" clId="Web-{E2D1CBF2-46FA-06E4-444F-3ACCE5170FF8}" dt="2023-10-24T17:53:23.821" v="4"/>
          <ac:spMkLst>
            <pc:docMk/>
            <pc:sldMk cId="3642483257" sldId="266"/>
            <ac:spMk id="2" creationId="{00000000-0000-0000-0000-000000000000}"/>
          </ac:spMkLst>
        </pc:spChg>
        <pc:spChg chg="add del mod">
          <ac:chgData name="Gomez, Daniela (Alliance Bioversity-CIAT)" userId="S::daniela.gomez@cgiar.org::c94e5fda-a43d-46f7-b351-499384532572" providerId="AD" clId="Web-{E2D1CBF2-46FA-06E4-444F-3ACCE5170FF8}" dt="2023-10-24T17:53:27.306" v="9"/>
          <ac:spMkLst>
            <pc:docMk/>
            <pc:sldMk cId="3642483257" sldId="266"/>
            <ac:spMk id="4" creationId="{8117705D-4691-6415-2AD2-4350E8CF8AE5}"/>
          </ac:spMkLst>
        </pc:spChg>
        <pc:spChg chg="del">
          <ac:chgData name="Gomez, Daniela (Alliance Bioversity-CIAT)" userId="S::daniela.gomez@cgiar.org::c94e5fda-a43d-46f7-b351-499384532572" providerId="AD" clId="Web-{E2D1CBF2-46FA-06E4-444F-3ACCE5170FF8}" dt="2023-10-24T17:53:23.821" v="3"/>
          <ac:spMkLst>
            <pc:docMk/>
            <pc:sldMk cId="3642483257" sldId="266"/>
            <ac:spMk id="9" creationId="{00000000-0000-0000-0000-000000000000}"/>
          </ac:spMkLst>
        </pc:spChg>
        <pc:spChg chg="del">
          <ac:chgData name="Gomez, Daniela (Alliance Bioversity-CIAT)" userId="S::daniela.gomez@cgiar.org::c94e5fda-a43d-46f7-b351-499384532572" providerId="AD" clId="Web-{E2D1CBF2-46FA-06E4-444F-3ACCE5170FF8}" dt="2023-10-24T17:53:23.821" v="2"/>
          <ac:spMkLst>
            <pc:docMk/>
            <pc:sldMk cId="3642483257" sldId="266"/>
            <ac:spMk id="10" creationId="{00000000-0000-0000-0000-000000000000}"/>
          </ac:spMkLst>
        </pc:spChg>
        <pc:spChg chg="del">
          <ac:chgData name="Gomez, Daniela (Alliance Bioversity-CIAT)" userId="S::daniela.gomez@cgiar.org::c94e5fda-a43d-46f7-b351-499384532572" providerId="AD" clId="Web-{E2D1CBF2-46FA-06E4-444F-3ACCE5170FF8}" dt="2023-10-24T17:53:23.821" v="1"/>
          <ac:spMkLst>
            <pc:docMk/>
            <pc:sldMk cId="3642483257" sldId="266"/>
            <ac:spMk id="11" creationId="{00000000-0000-0000-0000-000000000000}"/>
          </ac:spMkLst>
        </pc:spChg>
        <pc:spChg chg="mod">
          <ac:chgData name="Gomez, Daniela (Alliance Bioversity-CIAT)" userId="S::daniela.gomez@cgiar.org::c94e5fda-a43d-46f7-b351-499384532572" providerId="AD" clId="Web-{E2D1CBF2-46FA-06E4-444F-3ACCE5170FF8}" dt="2023-10-24T17:56:01.014" v="53" actId="20577"/>
          <ac:spMkLst>
            <pc:docMk/>
            <pc:sldMk cId="3642483257" sldId="266"/>
            <ac:spMk id="15" creationId="{A331AB26-56D8-4BCA-8AAB-C188316A8DF2}"/>
          </ac:spMkLst>
        </pc:spChg>
        <pc:picChg chg="add mod">
          <ac:chgData name="Gomez, Daniela (Alliance Bioversity-CIAT)" userId="S::daniela.gomez@cgiar.org::c94e5fda-a43d-46f7-b351-499384532572" providerId="AD" clId="Web-{E2D1CBF2-46FA-06E4-444F-3ACCE5170FF8}" dt="2023-10-24T17:56:13.342" v="57" actId="1076"/>
          <ac:picMkLst>
            <pc:docMk/>
            <pc:sldMk cId="3642483257" sldId="266"/>
            <ac:picMk id="5" creationId="{9FD5CC45-BA46-C428-851E-DAC0DAA8860B}"/>
          </ac:picMkLst>
        </pc:picChg>
        <pc:picChg chg="del">
          <ac:chgData name="Gomez, Daniela (Alliance Bioversity-CIAT)" userId="S::daniela.gomez@cgiar.org::c94e5fda-a43d-46f7-b351-499384532572" providerId="AD" clId="Web-{E2D1CBF2-46FA-06E4-444F-3ACCE5170FF8}" dt="2023-10-24T17:53:23.946" v="8"/>
          <ac:picMkLst>
            <pc:docMk/>
            <pc:sldMk cId="3642483257" sldId="266"/>
            <ac:picMk id="6" creationId="{55B65189-6C90-404A-9EB8-23F7D8B7D084}"/>
          </ac:picMkLst>
        </pc:picChg>
        <pc:picChg chg="del">
          <ac:chgData name="Gomez, Daniela (Alliance Bioversity-CIAT)" userId="S::daniela.gomez@cgiar.org::c94e5fda-a43d-46f7-b351-499384532572" providerId="AD" clId="Web-{E2D1CBF2-46FA-06E4-444F-3ACCE5170FF8}" dt="2023-10-24T17:53:23.946" v="7"/>
          <ac:picMkLst>
            <pc:docMk/>
            <pc:sldMk cId="3642483257" sldId="266"/>
            <ac:picMk id="8" creationId="{C993572A-8FA3-4108-BDE7-52A86C99E9D1}"/>
          </ac:picMkLst>
        </pc:picChg>
        <pc:picChg chg="del">
          <ac:chgData name="Gomez, Daniela (Alliance Bioversity-CIAT)" userId="S::daniela.gomez@cgiar.org::c94e5fda-a43d-46f7-b351-499384532572" providerId="AD" clId="Web-{E2D1CBF2-46FA-06E4-444F-3ACCE5170FF8}" dt="2023-10-24T17:53:23.946" v="6"/>
          <ac:picMkLst>
            <pc:docMk/>
            <pc:sldMk cId="3642483257" sldId="266"/>
            <ac:picMk id="12" creationId="{A49E7808-AD64-4700-92B0-3D2562173D0E}"/>
          </ac:picMkLst>
        </pc:picChg>
        <pc:picChg chg="del">
          <ac:chgData name="Gomez, Daniela (Alliance Bioversity-CIAT)" userId="S::daniela.gomez@cgiar.org::c94e5fda-a43d-46f7-b351-499384532572" providerId="AD" clId="Web-{E2D1CBF2-46FA-06E4-444F-3ACCE5170FF8}" dt="2023-10-24T17:53:23.821" v="5"/>
          <ac:picMkLst>
            <pc:docMk/>
            <pc:sldMk cId="3642483257" sldId="266"/>
            <ac:picMk id="16" creationId="{10F85A64-7C91-4D25-AB98-06A38BB840B9}"/>
          </ac:picMkLst>
        </pc:picChg>
      </pc:sldChg>
      <pc:sldChg chg="addSp delSp modSp add replId">
        <pc:chgData name="Gomez, Daniela (Alliance Bioversity-CIAT)" userId="S::daniela.gomez@cgiar.org::c94e5fda-a43d-46f7-b351-499384532572" providerId="AD" clId="Web-{E2D1CBF2-46FA-06E4-444F-3ACCE5170FF8}" dt="2023-10-24T18:42:05.198" v="603" actId="20577"/>
        <pc:sldMkLst>
          <pc:docMk/>
          <pc:sldMk cId="744295684" sldId="267"/>
        </pc:sldMkLst>
        <pc:spChg chg="mod">
          <ac:chgData name="Gomez, Daniela (Alliance Bioversity-CIAT)" userId="S::daniela.gomez@cgiar.org::c94e5fda-a43d-46f7-b351-499384532572" providerId="AD" clId="Web-{E2D1CBF2-46FA-06E4-444F-3ACCE5170FF8}" dt="2023-10-24T18:42:05.198" v="603" actId="20577"/>
          <ac:spMkLst>
            <pc:docMk/>
            <pc:sldMk cId="744295684" sldId="267"/>
            <ac:spMk id="15" creationId="{A331AB26-56D8-4BCA-8AAB-C188316A8DF2}"/>
          </ac:spMkLst>
        </pc:spChg>
        <pc:picChg chg="add mod">
          <ac:chgData name="Gomez, Daniela (Alliance Bioversity-CIAT)" userId="S::daniela.gomez@cgiar.org::c94e5fda-a43d-46f7-b351-499384532572" providerId="AD" clId="Web-{E2D1CBF2-46FA-06E4-444F-3ACCE5170FF8}" dt="2023-10-24T17:57:17.797" v="67" actId="1076"/>
          <ac:picMkLst>
            <pc:docMk/>
            <pc:sldMk cId="744295684" sldId="267"/>
            <ac:picMk id="2" creationId="{9597CE08-9C2B-19DD-F95D-9F7E2E69A7EC}"/>
          </ac:picMkLst>
        </pc:picChg>
        <pc:picChg chg="del">
          <ac:chgData name="Gomez, Daniela (Alliance Bioversity-CIAT)" userId="S::daniela.gomez@cgiar.org::c94e5fda-a43d-46f7-b351-499384532572" providerId="AD" clId="Web-{E2D1CBF2-46FA-06E4-444F-3ACCE5170FF8}" dt="2023-10-24T17:56:43.156" v="59"/>
          <ac:picMkLst>
            <pc:docMk/>
            <pc:sldMk cId="744295684" sldId="267"/>
            <ac:picMk id="5" creationId="{9FD5CC45-BA46-C428-851E-DAC0DAA8860B}"/>
          </ac:picMkLst>
        </pc:picChg>
      </pc:sldChg>
      <pc:sldChg chg="addSp delSp modSp add replId">
        <pc:chgData name="Gomez, Daniela (Alliance Bioversity-CIAT)" userId="S::daniela.gomez@cgiar.org::c94e5fda-a43d-46f7-b351-499384532572" providerId="AD" clId="Web-{E2D1CBF2-46FA-06E4-444F-3ACCE5170FF8}" dt="2023-10-24T18:42:10.526" v="606" actId="20577"/>
        <pc:sldMkLst>
          <pc:docMk/>
          <pc:sldMk cId="1307993186" sldId="268"/>
        </pc:sldMkLst>
        <pc:spChg chg="mod">
          <ac:chgData name="Gomez, Daniela (Alliance Bioversity-CIAT)" userId="S::daniela.gomez@cgiar.org::c94e5fda-a43d-46f7-b351-499384532572" providerId="AD" clId="Web-{E2D1CBF2-46FA-06E4-444F-3ACCE5170FF8}" dt="2023-10-24T18:42:10.526" v="606" actId="20577"/>
          <ac:spMkLst>
            <pc:docMk/>
            <pc:sldMk cId="1307993186" sldId="268"/>
            <ac:spMk id="15" creationId="{A331AB26-56D8-4BCA-8AAB-C188316A8DF2}"/>
          </ac:spMkLst>
        </pc:spChg>
        <pc:picChg chg="del">
          <ac:chgData name="Gomez, Daniela (Alliance Bioversity-CIAT)" userId="S::daniela.gomez@cgiar.org::c94e5fda-a43d-46f7-b351-499384532572" providerId="AD" clId="Web-{E2D1CBF2-46FA-06E4-444F-3ACCE5170FF8}" dt="2023-10-24T17:58:11.299" v="87"/>
          <ac:picMkLst>
            <pc:docMk/>
            <pc:sldMk cId="1307993186" sldId="268"/>
            <ac:picMk id="2" creationId="{9597CE08-9C2B-19DD-F95D-9F7E2E69A7EC}"/>
          </ac:picMkLst>
        </pc:picChg>
        <pc:picChg chg="add mod">
          <ac:chgData name="Gomez, Daniela (Alliance Bioversity-CIAT)" userId="S::daniela.gomez@cgiar.org::c94e5fda-a43d-46f7-b351-499384532572" providerId="AD" clId="Web-{E2D1CBF2-46FA-06E4-444F-3ACCE5170FF8}" dt="2023-10-24T18:07:08.895" v="102" actId="1076"/>
          <ac:picMkLst>
            <pc:docMk/>
            <pc:sldMk cId="1307993186" sldId="268"/>
            <ac:picMk id="3" creationId="{CD71E691-7065-3E4B-5507-8C3EB8282628}"/>
          </ac:picMkLst>
        </pc:picChg>
      </pc:sldChg>
      <pc:sldChg chg="addSp delSp modSp add replId">
        <pc:chgData name="Gomez, Daniela (Alliance Bioversity-CIAT)" userId="S::daniela.gomez@cgiar.org::c94e5fda-a43d-46f7-b351-499384532572" providerId="AD" clId="Web-{E2D1CBF2-46FA-06E4-444F-3ACCE5170FF8}" dt="2023-10-24T18:42:16.354" v="612" actId="20577"/>
        <pc:sldMkLst>
          <pc:docMk/>
          <pc:sldMk cId="1495302232" sldId="269"/>
        </pc:sldMkLst>
        <pc:spChg chg="mod">
          <ac:chgData name="Gomez, Daniela (Alliance Bioversity-CIAT)" userId="S::daniela.gomez@cgiar.org::c94e5fda-a43d-46f7-b351-499384532572" providerId="AD" clId="Web-{E2D1CBF2-46FA-06E4-444F-3ACCE5170FF8}" dt="2023-10-24T18:42:16.354" v="612" actId="20577"/>
          <ac:spMkLst>
            <pc:docMk/>
            <pc:sldMk cId="1495302232" sldId="269"/>
            <ac:spMk id="15" creationId="{A331AB26-56D8-4BCA-8AAB-C188316A8DF2}"/>
          </ac:spMkLst>
        </pc:spChg>
        <pc:picChg chg="del">
          <ac:chgData name="Gomez, Daniela (Alliance Bioversity-CIAT)" userId="S::daniela.gomez@cgiar.org::c94e5fda-a43d-46f7-b351-499384532572" providerId="AD" clId="Web-{E2D1CBF2-46FA-06E4-444F-3ACCE5170FF8}" dt="2023-10-24T17:58:12.409" v="88"/>
          <ac:picMkLst>
            <pc:docMk/>
            <pc:sldMk cId="1495302232" sldId="269"/>
            <ac:picMk id="2" creationId="{9597CE08-9C2B-19DD-F95D-9F7E2E69A7EC}"/>
          </ac:picMkLst>
        </pc:picChg>
        <pc:picChg chg="add mod">
          <ac:chgData name="Gomez, Daniela (Alliance Bioversity-CIAT)" userId="S::daniela.gomez@cgiar.org::c94e5fda-a43d-46f7-b351-499384532572" providerId="AD" clId="Web-{E2D1CBF2-46FA-06E4-444F-3ACCE5170FF8}" dt="2023-10-24T17:59:00.988" v="100" actId="1076"/>
          <ac:picMkLst>
            <pc:docMk/>
            <pc:sldMk cId="1495302232" sldId="269"/>
            <ac:picMk id="3" creationId="{4DE8772E-4A3D-3956-B429-D4AF94224526}"/>
          </ac:picMkLst>
        </pc:picChg>
      </pc:sldChg>
      <pc:sldChg chg="modSp add replId">
        <pc:chgData name="Gomez, Daniela (Alliance Bioversity-CIAT)" userId="S::daniela.gomez@cgiar.org::c94e5fda-a43d-46f7-b351-499384532572" providerId="AD" clId="Web-{E2D1CBF2-46FA-06E4-444F-3ACCE5170FF8}" dt="2023-10-24T19:17:36.668" v="617" actId="1076"/>
        <pc:sldMkLst>
          <pc:docMk/>
          <pc:sldMk cId="2995284397" sldId="270"/>
        </pc:sldMkLst>
        <pc:spChg chg="mod">
          <ac:chgData name="Gomez, Daniela (Alliance Bioversity-CIAT)" userId="S::daniela.gomez@cgiar.org::c94e5fda-a43d-46f7-b351-499384532572" providerId="AD" clId="Web-{E2D1CBF2-46FA-06E4-444F-3ACCE5170FF8}" dt="2023-10-24T18:41:58.385" v="597" actId="20577"/>
          <ac:spMkLst>
            <pc:docMk/>
            <pc:sldMk cId="2995284397" sldId="270"/>
            <ac:spMk id="15" creationId="{A331AB26-56D8-4BCA-8AAB-C188316A8DF2}"/>
          </ac:spMkLst>
        </pc:spChg>
        <pc:picChg chg="mod">
          <ac:chgData name="Gomez, Daniela (Alliance Bioversity-CIAT)" userId="S::daniela.gomez@cgiar.org::c94e5fda-a43d-46f7-b351-499384532572" providerId="AD" clId="Web-{E2D1CBF2-46FA-06E4-444F-3ACCE5170FF8}" dt="2023-10-24T19:17:36.668" v="617" actId="1076"/>
          <ac:picMkLst>
            <pc:docMk/>
            <pc:sldMk cId="2995284397" sldId="270"/>
            <ac:picMk id="5" creationId="{9FD5CC45-BA46-C428-851E-DAC0DAA8860B}"/>
          </ac:picMkLst>
        </pc:picChg>
      </pc:sldChg>
      <pc:sldChg chg="addSp delSp modSp add">
        <pc:chgData name="Gomez, Daniela (Alliance Bioversity-CIAT)" userId="S::daniela.gomez@cgiar.org::c94e5fda-a43d-46f7-b351-499384532572" providerId="AD" clId="Web-{E2D1CBF2-46FA-06E4-444F-3ACCE5170FF8}" dt="2023-10-24T18:30:44.332" v="380" actId="1076"/>
        <pc:sldMkLst>
          <pc:docMk/>
          <pc:sldMk cId="3649580678" sldId="271"/>
        </pc:sldMkLst>
        <pc:spChg chg="del mod">
          <ac:chgData name="Gomez, Daniela (Alliance Bioversity-CIAT)" userId="S::daniela.gomez@cgiar.org::c94e5fda-a43d-46f7-b351-499384532572" providerId="AD" clId="Web-{E2D1CBF2-46FA-06E4-444F-3ACCE5170FF8}" dt="2023-10-24T18:22:09.346" v="310"/>
          <ac:spMkLst>
            <pc:docMk/>
            <pc:sldMk cId="3649580678" sldId="271"/>
            <ac:spMk id="10" creationId="{B9D50ACA-991F-3C26-7EB7-FB253D2DB314}"/>
          </ac:spMkLst>
        </pc:spChg>
        <pc:spChg chg="del mod">
          <ac:chgData name="Gomez, Daniela (Alliance Bioversity-CIAT)" userId="S::daniela.gomez@cgiar.org::c94e5fda-a43d-46f7-b351-499384532572" providerId="AD" clId="Web-{E2D1CBF2-46FA-06E4-444F-3ACCE5170FF8}" dt="2023-10-24T18:22:11.799" v="312"/>
          <ac:spMkLst>
            <pc:docMk/>
            <pc:sldMk cId="3649580678" sldId="271"/>
            <ac:spMk id="12" creationId="{C66DFD8E-0B84-85D1-2826-3C3BE2811F6D}"/>
          </ac:spMkLst>
        </pc:spChg>
        <pc:spChg chg="del mod">
          <ac:chgData name="Gomez, Daniela (Alliance Bioversity-CIAT)" userId="S::daniela.gomez@cgiar.org::c94e5fda-a43d-46f7-b351-499384532572" providerId="AD" clId="Web-{E2D1CBF2-46FA-06E4-444F-3ACCE5170FF8}" dt="2023-10-24T18:22:39.863" v="322"/>
          <ac:spMkLst>
            <pc:docMk/>
            <pc:sldMk cId="3649580678" sldId="271"/>
            <ac:spMk id="14" creationId="{9BE1694F-898F-7F79-CD53-3C8138054BB9}"/>
          </ac:spMkLst>
        </pc:spChg>
        <pc:spChg chg="mod">
          <ac:chgData name="Gomez, Daniela (Alliance Bioversity-CIAT)" userId="S::daniela.gomez@cgiar.org::c94e5fda-a43d-46f7-b351-499384532572" providerId="AD" clId="Web-{E2D1CBF2-46FA-06E4-444F-3ACCE5170FF8}" dt="2023-10-24T18:30:44.332" v="380" actId="1076"/>
          <ac:spMkLst>
            <pc:docMk/>
            <pc:sldMk cId="3649580678" sldId="271"/>
            <ac:spMk id="15" creationId="{2F928609-04EC-41C4-9C64-EE84E7B3A4EF}"/>
          </ac:spMkLst>
        </pc:spChg>
        <pc:spChg chg="mod">
          <ac:chgData name="Gomez, Daniela (Alliance Bioversity-CIAT)" userId="S::daniela.gomez@cgiar.org::c94e5fda-a43d-46f7-b351-499384532572" providerId="AD" clId="Web-{E2D1CBF2-46FA-06E4-444F-3ACCE5170FF8}" dt="2023-10-24T18:23:25.974" v="333" actId="1076"/>
          <ac:spMkLst>
            <pc:docMk/>
            <pc:sldMk cId="3649580678" sldId="271"/>
            <ac:spMk id="16" creationId="{21D3C806-19B5-46CC-A520-6799F02CADB1}"/>
          </ac:spMkLst>
        </pc:spChg>
        <pc:spChg chg="del mod">
          <ac:chgData name="Gomez, Daniela (Alliance Bioversity-CIAT)" userId="S::daniela.gomez@cgiar.org::c94e5fda-a43d-46f7-b351-499384532572" providerId="AD" clId="Web-{E2D1CBF2-46FA-06E4-444F-3ACCE5170FF8}" dt="2023-10-24T18:22:41.191" v="323"/>
          <ac:spMkLst>
            <pc:docMk/>
            <pc:sldMk cId="3649580678" sldId="271"/>
            <ac:spMk id="17" creationId="{A39A0B37-277B-A7E0-863B-1481F3431025}"/>
          </ac:spMkLst>
        </pc:spChg>
        <pc:spChg chg="mod">
          <ac:chgData name="Gomez, Daniela (Alliance Bioversity-CIAT)" userId="S::daniela.gomez@cgiar.org::c94e5fda-a43d-46f7-b351-499384532572" providerId="AD" clId="Web-{E2D1CBF2-46FA-06E4-444F-3ACCE5170FF8}" dt="2023-10-24T18:23:44.052" v="339" actId="1076"/>
          <ac:spMkLst>
            <pc:docMk/>
            <pc:sldMk cId="3649580678" sldId="271"/>
            <ac:spMk id="18" creationId="{BC977763-2458-4B95-B147-E7C71502CBD9}"/>
          </ac:spMkLst>
        </pc:spChg>
        <pc:spChg chg="del">
          <ac:chgData name="Gomez, Daniela (Alliance Bioversity-CIAT)" userId="S::daniela.gomez@cgiar.org::c94e5fda-a43d-46f7-b351-499384532572" providerId="AD" clId="Web-{E2D1CBF2-46FA-06E4-444F-3ACCE5170FF8}" dt="2023-10-24T18:18:50.043" v="157"/>
          <ac:spMkLst>
            <pc:docMk/>
            <pc:sldMk cId="3649580678" sldId="271"/>
            <ac:spMk id="19" creationId="{00000000-0000-0000-0000-000000000000}"/>
          </ac:spMkLst>
        </pc:spChg>
        <pc:spChg chg="del mod">
          <ac:chgData name="Gomez, Daniela (Alliance Bioversity-CIAT)" userId="S::daniela.gomez@cgiar.org::c94e5fda-a43d-46f7-b351-499384532572" providerId="AD" clId="Web-{E2D1CBF2-46FA-06E4-444F-3ACCE5170FF8}" dt="2023-10-24T18:22:41.972" v="324"/>
          <ac:spMkLst>
            <pc:docMk/>
            <pc:sldMk cId="3649580678" sldId="271"/>
            <ac:spMk id="20" creationId="{EF02A9F1-D297-7A56-EC6D-0047D9BB7D81}"/>
          </ac:spMkLst>
        </pc:spChg>
        <pc:spChg chg="del mod">
          <ac:chgData name="Gomez, Daniela (Alliance Bioversity-CIAT)" userId="S::daniela.gomez@cgiar.org::c94e5fda-a43d-46f7-b351-499384532572" providerId="AD" clId="Web-{E2D1CBF2-46FA-06E4-444F-3ACCE5170FF8}" dt="2023-10-24T18:22:07.002" v="308"/>
          <ac:spMkLst>
            <pc:docMk/>
            <pc:sldMk cId="3649580678" sldId="271"/>
            <ac:spMk id="21" creationId="{57FB3AAD-E745-46AE-ADDA-E4BAC7BA415A}"/>
          </ac:spMkLst>
        </pc:spChg>
        <pc:spChg chg="add mod">
          <ac:chgData name="Gomez, Daniela (Alliance Bioversity-CIAT)" userId="S::daniela.gomez@cgiar.org::c94e5fda-a43d-46f7-b351-499384532572" providerId="AD" clId="Web-{E2D1CBF2-46FA-06E4-444F-3ACCE5170FF8}" dt="2023-10-24T18:22:29.831" v="321" actId="20577"/>
          <ac:spMkLst>
            <pc:docMk/>
            <pc:sldMk cId="3649580678" sldId="271"/>
            <ac:spMk id="30" creationId="{D43F6902-EE86-346C-7DE6-0C27CD23F9E4}"/>
          </ac:spMkLst>
        </pc:spChg>
        <pc:grpChg chg="del">
          <ac:chgData name="Gomez, Daniela (Alliance Bioversity-CIAT)" userId="S::daniela.gomez@cgiar.org::c94e5fda-a43d-46f7-b351-499384532572" providerId="AD" clId="Web-{E2D1CBF2-46FA-06E4-444F-3ACCE5170FF8}" dt="2023-10-24T18:15:14.426" v="117"/>
          <ac:grpSpMkLst>
            <pc:docMk/>
            <pc:sldMk cId="3649580678" sldId="271"/>
            <ac:grpSpMk id="22" creationId="{D596A593-8D2F-2B5D-F998-2C2FD73204E0}"/>
          </ac:grpSpMkLst>
        </pc:grpChg>
        <pc:grpChg chg="add mod">
          <ac:chgData name="Gomez, Daniela (Alliance Bioversity-CIAT)" userId="S::daniela.gomez@cgiar.org::c94e5fda-a43d-46f7-b351-499384532572" providerId="AD" clId="Web-{E2D1CBF2-46FA-06E4-444F-3ACCE5170FF8}" dt="2023-10-24T18:23:22.723" v="331" actId="1076"/>
          <ac:grpSpMkLst>
            <pc:docMk/>
            <pc:sldMk cId="3649580678" sldId="271"/>
            <ac:grpSpMk id="25" creationId="{48A8DCA0-F2A9-CC2A-B2CA-36E864AE8EB3}"/>
          </ac:grpSpMkLst>
        </pc:grpChg>
        <pc:grpChg chg="mod">
          <ac:chgData name="Gomez, Daniela (Alliance Bioversity-CIAT)" userId="S::daniela.gomez@cgiar.org::c94e5fda-a43d-46f7-b351-499384532572" providerId="AD" clId="Web-{E2D1CBF2-46FA-06E4-444F-3ACCE5170FF8}" dt="2023-10-24T18:18:59.137" v="159" actId="1076"/>
          <ac:grpSpMkLst>
            <pc:docMk/>
            <pc:sldMk cId="3649580678" sldId="271"/>
            <ac:grpSpMk id="43" creationId="{02C4DEC6-E729-4E23-B41E-D4BA65D714EE}"/>
          </ac:grpSpMkLst>
        </pc:grpChg>
        <pc:picChg chg="del">
          <ac:chgData name="Gomez, Daniela (Alliance Bioversity-CIAT)" userId="S::daniela.gomez@cgiar.org::c94e5fda-a43d-46f7-b351-499384532572" providerId="AD" clId="Web-{E2D1CBF2-46FA-06E4-444F-3ACCE5170FF8}" dt="2023-10-24T18:14:44.785" v="112"/>
          <ac:picMkLst>
            <pc:docMk/>
            <pc:sldMk cId="3649580678" sldId="271"/>
            <ac:picMk id="2" creationId="{347F2C66-94EC-675F-58BB-6D8E83C669FB}"/>
          </ac:picMkLst>
        </pc:picChg>
        <pc:picChg chg="del">
          <ac:chgData name="Gomez, Daniela (Alliance Bioversity-CIAT)" userId="S::daniela.gomez@cgiar.org::c94e5fda-a43d-46f7-b351-499384532572" providerId="AD" clId="Web-{E2D1CBF2-46FA-06E4-444F-3ACCE5170FF8}" dt="2023-10-24T18:14:01.440" v="106"/>
          <ac:picMkLst>
            <pc:docMk/>
            <pc:sldMk cId="3649580678" sldId="271"/>
            <ac:picMk id="3" creationId="{F3196AE5-044C-2EE3-9381-067AABD3A5E7}"/>
          </ac:picMkLst>
        </pc:picChg>
        <pc:picChg chg="del">
          <ac:chgData name="Gomez, Daniela (Alliance Bioversity-CIAT)" userId="S::daniela.gomez@cgiar.org::c94e5fda-a43d-46f7-b351-499384532572" providerId="AD" clId="Web-{E2D1CBF2-46FA-06E4-444F-3ACCE5170FF8}" dt="2023-10-24T18:14:25.034" v="109"/>
          <ac:picMkLst>
            <pc:docMk/>
            <pc:sldMk cId="3649580678" sldId="271"/>
            <ac:picMk id="4" creationId="{AA0BAF4A-7210-009C-8D73-B156F1E8C5F0}"/>
          </ac:picMkLst>
        </pc:picChg>
        <pc:picChg chg="del">
          <ac:chgData name="Gomez, Daniela (Alliance Bioversity-CIAT)" userId="S::daniela.gomez@cgiar.org::c94e5fda-a43d-46f7-b351-499384532572" providerId="AD" clId="Web-{E2D1CBF2-46FA-06E4-444F-3ACCE5170FF8}" dt="2023-10-24T18:16:54.836" v="139"/>
          <ac:picMkLst>
            <pc:docMk/>
            <pc:sldMk cId="3649580678" sldId="271"/>
            <ac:picMk id="7" creationId="{9D2F6421-4178-582E-35AE-28067543262F}"/>
          </ac:picMkLst>
        </pc:picChg>
        <pc:picChg chg="del">
          <ac:chgData name="Gomez, Daniela (Alliance Bioversity-CIAT)" userId="S::daniela.gomez@cgiar.org::c94e5fda-a43d-46f7-b351-499384532572" providerId="AD" clId="Web-{E2D1CBF2-46FA-06E4-444F-3ACCE5170FF8}" dt="2023-10-24T18:17:23.571" v="142"/>
          <ac:picMkLst>
            <pc:docMk/>
            <pc:sldMk cId="3649580678" sldId="271"/>
            <ac:picMk id="8" creationId="{E86C50E2-0C82-E6D5-A587-248B5CEBE56E}"/>
          </ac:picMkLst>
        </pc:picChg>
        <pc:picChg chg="add mod">
          <ac:chgData name="Gomez, Daniela (Alliance Bioversity-CIAT)" userId="S::daniela.gomez@cgiar.org::c94e5fda-a43d-46f7-b351-499384532572" providerId="AD" clId="Web-{E2D1CBF2-46FA-06E4-444F-3ACCE5170FF8}" dt="2023-10-24T18:18:59.215" v="165" actId="1076"/>
          <ac:picMkLst>
            <pc:docMk/>
            <pc:sldMk cId="3649580678" sldId="271"/>
            <ac:picMk id="9" creationId="{61D66E06-64E6-B88E-9C61-434367BA8179}"/>
          </ac:picMkLst>
        </pc:picChg>
        <pc:picChg chg="add mod">
          <ac:chgData name="Gomez, Daniela (Alliance Bioversity-CIAT)" userId="S::daniela.gomez@cgiar.org::c94e5fda-a43d-46f7-b351-499384532572" providerId="AD" clId="Web-{E2D1CBF2-46FA-06E4-444F-3ACCE5170FF8}" dt="2023-10-24T18:22:19.096" v="315" actId="1076"/>
          <ac:picMkLst>
            <pc:docMk/>
            <pc:sldMk cId="3649580678" sldId="271"/>
            <ac:picMk id="11" creationId="{F3650E86-0410-1B96-BEB8-A81AD6EC9399}"/>
          </ac:picMkLst>
        </pc:picChg>
        <pc:picChg chg="add mod">
          <ac:chgData name="Gomez, Daniela (Alliance Bioversity-CIAT)" userId="S::daniela.gomez@cgiar.org::c94e5fda-a43d-46f7-b351-499384532572" providerId="AD" clId="Web-{E2D1CBF2-46FA-06E4-444F-3ACCE5170FF8}" dt="2023-10-24T18:23:22.567" v="329" actId="1076"/>
          <ac:picMkLst>
            <pc:docMk/>
            <pc:sldMk cId="3649580678" sldId="271"/>
            <ac:picMk id="13" creationId="{7AF75264-BDAB-0EFF-5441-05C76C354198}"/>
          </ac:picMkLst>
        </pc:picChg>
        <pc:picChg chg="add mod">
          <ac:chgData name="Gomez, Daniela (Alliance Bioversity-CIAT)" userId="S::daniela.gomez@cgiar.org::c94e5fda-a43d-46f7-b351-499384532572" providerId="AD" clId="Web-{E2D1CBF2-46FA-06E4-444F-3ACCE5170FF8}" dt="2023-10-24T18:16:07.256" v="130" actId="1076"/>
          <ac:picMkLst>
            <pc:docMk/>
            <pc:sldMk cId="3649580678" sldId="271"/>
            <ac:picMk id="23" creationId="{57248CD0-94B5-71CF-5E4C-C48AA1CB3829}"/>
          </ac:picMkLst>
        </pc:picChg>
        <pc:picChg chg="add mod modCrop">
          <ac:chgData name="Gomez, Daniela (Alliance Bioversity-CIAT)" userId="S::daniela.gomez@cgiar.org::c94e5fda-a43d-46f7-b351-499384532572" providerId="AD" clId="Web-{E2D1CBF2-46FA-06E4-444F-3ACCE5170FF8}" dt="2023-10-24T18:15:59.037" v="129" actId="1076"/>
          <ac:picMkLst>
            <pc:docMk/>
            <pc:sldMk cId="3649580678" sldId="271"/>
            <ac:picMk id="24" creationId="{E9AC10E1-F84E-70D5-D6E2-71B5096B8493}"/>
          </ac:picMkLst>
        </pc:picChg>
        <pc:picChg chg="add del mod">
          <ac:chgData name="Gomez, Daniela (Alliance Bioversity-CIAT)" userId="S::daniela.gomez@cgiar.org::c94e5fda-a43d-46f7-b351-499384532572" providerId="AD" clId="Web-{E2D1CBF2-46FA-06E4-444F-3ACCE5170FF8}" dt="2023-10-24T18:18:02.135" v="151"/>
          <ac:picMkLst>
            <pc:docMk/>
            <pc:sldMk cId="3649580678" sldId="271"/>
            <ac:picMk id="26" creationId="{2B1BC98A-2B7C-9E69-F9A2-7D64C8D9DE79}"/>
          </ac:picMkLst>
        </pc:picChg>
        <pc:picChg chg="add mod">
          <ac:chgData name="Gomez, Daniela (Alliance Bioversity-CIAT)" userId="S::daniela.gomez@cgiar.org::c94e5fda-a43d-46f7-b351-499384532572" providerId="AD" clId="Web-{E2D1CBF2-46FA-06E4-444F-3ACCE5170FF8}" dt="2023-10-24T18:23:42.427" v="337" actId="1076"/>
          <ac:picMkLst>
            <pc:docMk/>
            <pc:sldMk cId="3649580678" sldId="271"/>
            <ac:picMk id="27" creationId="{06D700EA-F89E-45FA-13B6-5B729D29AE47}"/>
          </ac:picMkLst>
        </pc:picChg>
        <pc:picChg chg="add mod">
          <ac:chgData name="Gomez, Daniela (Alliance Bioversity-CIAT)" userId="S::daniela.gomez@cgiar.org::c94e5fda-a43d-46f7-b351-499384532572" providerId="AD" clId="Web-{E2D1CBF2-46FA-06E4-444F-3ACCE5170FF8}" dt="2023-10-24T18:23:42.458" v="338" actId="1076"/>
          <ac:picMkLst>
            <pc:docMk/>
            <pc:sldMk cId="3649580678" sldId="271"/>
            <ac:picMk id="28" creationId="{19F6F117-39AA-ED17-83A4-8A6CCA8D4A32}"/>
          </ac:picMkLst>
        </pc:picChg>
      </pc:sldChg>
      <pc:sldChg chg="add del replId">
        <pc:chgData name="Gomez, Daniela (Alliance Bioversity-CIAT)" userId="S::daniela.gomez@cgiar.org::c94e5fda-a43d-46f7-b351-499384532572" providerId="AD" clId="Web-{E2D1CBF2-46FA-06E4-444F-3ACCE5170FF8}" dt="2023-10-24T18:17:30.337" v="145"/>
        <pc:sldMkLst>
          <pc:docMk/>
          <pc:sldMk cId="183222003" sldId="272"/>
        </pc:sldMkLst>
      </pc:sldChg>
      <pc:sldChg chg="addSp delSp modSp add replId">
        <pc:chgData name="Gomez, Daniela (Alliance Bioversity-CIAT)" userId="S::daniela.gomez@cgiar.org::c94e5fda-a43d-46f7-b351-499384532572" providerId="AD" clId="Web-{E2D1CBF2-46FA-06E4-444F-3ACCE5170FF8}" dt="2023-10-24T21:01:04.227" v="688" actId="20577"/>
        <pc:sldMkLst>
          <pc:docMk/>
          <pc:sldMk cId="717926230" sldId="272"/>
        </pc:sldMkLst>
        <pc:spChg chg="add mod">
          <ac:chgData name="Gomez, Daniela (Alliance Bioversity-CIAT)" userId="S::daniela.gomez@cgiar.org::c94e5fda-a43d-46f7-b351-499384532572" providerId="AD" clId="Web-{E2D1CBF2-46FA-06E4-444F-3ACCE5170FF8}" dt="2023-10-24T18:30:53.582" v="382" actId="1076"/>
          <ac:spMkLst>
            <pc:docMk/>
            <pc:sldMk cId="717926230" sldId="272"/>
            <ac:spMk id="8" creationId="{34F97646-EBFD-EEC9-A2B0-B9E92BD02D6F}"/>
          </ac:spMkLst>
        </pc:spChg>
        <pc:spChg chg="add mod">
          <ac:chgData name="Gomez, Daniela (Alliance Bioversity-CIAT)" userId="S::daniela.gomez@cgiar.org::c94e5fda-a43d-46f7-b351-499384532572" providerId="AD" clId="Web-{E2D1CBF2-46FA-06E4-444F-3ACCE5170FF8}" dt="2023-10-24T18:31:01.551" v="385" actId="20577"/>
          <ac:spMkLst>
            <pc:docMk/>
            <pc:sldMk cId="717926230" sldId="272"/>
            <ac:spMk id="9" creationId="{DAD493B3-7B01-EA70-A244-6E0D7EFFA43C}"/>
          </ac:spMkLst>
        </pc:spChg>
        <pc:spChg chg="add mod">
          <ac:chgData name="Gomez, Daniela (Alliance Bioversity-CIAT)" userId="S::daniela.gomez@cgiar.org::c94e5fda-a43d-46f7-b351-499384532572" providerId="AD" clId="Web-{E2D1CBF2-46FA-06E4-444F-3ACCE5170FF8}" dt="2023-10-24T18:31:11.582" v="388" actId="20577"/>
          <ac:spMkLst>
            <pc:docMk/>
            <pc:sldMk cId="717926230" sldId="272"/>
            <ac:spMk id="10" creationId="{56F9CADB-0876-80F9-41E8-6EBC7AC8F0B6}"/>
          </ac:spMkLst>
        </pc:spChg>
        <pc:spChg chg="add mod">
          <ac:chgData name="Gomez, Daniela (Alliance Bioversity-CIAT)" userId="S::daniela.gomez@cgiar.org::c94e5fda-a43d-46f7-b351-499384532572" providerId="AD" clId="Web-{E2D1CBF2-46FA-06E4-444F-3ACCE5170FF8}" dt="2023-10-24T18:31:19.989" v="391" actId="20577"/>
          <ac:spMkLst>
            <pc:docMk/>
            <pc:sldMk cId="717926230" sldId="272"/>
            <ac:spMk id="11" creationId="{66DCDA07-D514-1414-E278-9689972B507E}"/>
          </ac:spMkLst>
        </pc:spChg>
        <pc:spChg chg="mod">
          <ac:chgData name="Gomez, Daniela (Alliance Bioversity-CIAT)" userId="S::daniela.gomez@cgiar.org::c94e5fda-a43d-46f7-b351-499384532572" providerId="AD" clId="Web-{E2D1CBF2-46FA-06E4-444F-3ACCE5170FF8}" dt="2023-10-24T21:01:04.227" v="688" actId="20577"/>
          <ac:spMkLst>
            <pc:docMk/>
            <pc:sldMk cId="717926230" sldId="272"/>
            <ac:spMk id="15" creationId="{A331AB26-56D8-4BCA-8AAB-C188316A8DF2}"/>
          </ac:spMkLst>
        </pc:spChg>
        <pc:picChg chg="add mod">
          <ac:chgData name="Gomez, Daniela (Alliance Bioversity-CIAT)" userId="S::daniela.gomez@cgiar.org::c94e5fda-a43d-46f7-b351-499384532572" providerId="AD" clId="Web-{E2D1CBF2-46FA-06E4-444F-3ACCE5170FF8}" dt="2023-10-24T18:29:39.970" v="372" actId="14100"/>
          <ac:picMkLst>
            <pc:docMk/>
            <pc:sldMk cId="717926230" sldId="272"/>
            <ac:picMk id="2" creationId="{6FA3ABD7-6B93-DA80-EE42-183C9218571D}"/>
          </ac:picMkLst>
        </pc:picChg>
        <pc:picChg chg="add mod">
          <ac:chgData name="Gomez, Daniela (Alliance Bioversity-CIAT)" userId="S::daniela.gomez@cgiar.org::c94e5fda-a43d-46f7-b351-499384532572" providerId="AD" clId="Web-{E2D1CBF2-46FA-06E4-444F-3ACCE5170FF8}" dt="2023-10-24T18:29:22.470" v="367" actId="14100"/>
          <ac:picMkLst>
            <pc:docMk/>
            <pc:sldMk cId="717926230" sldId="272"/>
            <ac:picMk id="3" creationId="{F434D356-15E9-C242-58ED-8158C74E0CDA}"/>
          </ac:picMkLst>
        </pc:picChg>
        <pc:picChg chg="add mod">
          <ac:chgData name="Gomez, Daniela (Alliance Bioversity-CIAT)" userId="S::daniela.gomez@cgiar.org::c94e5fda-a43d-46f7-b351-499384532572" providerId="AD" clId="Web-{E2D1CBF2-46FA-06E4-444F-3ACCE5170FF8}" dt="2023-10-24T18:30:11.924" v="374" actId="1076"/>
          <ac:picMkLst>
            <pc:docMk/>
            <pc:sldMk cId="717926230" sldId="272"/>
            <ac:picMk id="4" creationId="{82A1B42F-8FD0-E48F-AA1B-EA1CDA752D68}"/>
          </ac:picMkLst>
        </pc:picChg>
        <pc:picChg chg="del">
          <ac:chgData name="Gomez, Daniela (Alliance Bioversity-CIAT)" userId="S::daniela.gomez@cgiar.org::c94e5fda-a43d-46f7-b351-499384532572" providerId="AD" clId="Web-{E2D1CBF2-46FA-06E4-444F-3ACCE5170FF8}" dt="2023-10-24T18:28:33.718" v="341"/>
          <ac:picMkLst>
            <pc:docMk/>
            <pc:sldMk cId="717926230" sldId="272"/>
            <ac:picMk id="5" creationId="{9FD5CC45-BA46-C428-851E-DAC0DAA8860B}"/>
          </ac:picMkLst>
        </pc:picChg>
        <pc:picChg chg="add mod">
          <ac:chgData name="Gomez, Daniela (Alliance Bioversity-CIAT)" userId="S::daniela.gomez@cgiar.org::c94e5fda-a43d-46f7-b351-499384532572" providerId="AD" clId="Web-{E2D1CBF2-46FA-06E4-444F-3ACCE5170FF8}" dt="2023-10-24T18:30:20.862" v="376" actId="1076"/>
          <ac:picMkLst>
            <pc:docMk/>
            <pc:sldMk cId="717926230" sldId="272"/>
            <ac:picMk id="6" creationId="{9CDD0532-27C6-553A-7D57-D2E1FC48F326}"/>
          </ac:picMkLst>
        </pc:picChg>
      </pc:sldChg>
      <pc:sldChg chg="addSp delSp modSp add ord replId">
        <pc:chgData name="Gomez, Daniela (Alliance Bioversity-CIAT)" userId="S::daniela.gomez@cgiar.org::c94e5fda-a43d-46f7-b351-499384532572" providerId="AD" clId="Web-{E2D1CBF2-46FA-06E4-444F-3ACCE5170FF8}" dt="2023-10-24T21:01:23.869" v="692" actId="1076"/>
        <pc:sldMkLst>
          <pc:docMk/>
          <pc:sldMk cId="4012007636" sldId="273"/>
        </pc:sldMkLst>
        <pc:spChg chg="mod">
          <ac:chgData name="Gomez, Daniela (Alliance Bioversity-CIAT)" userId="S::daniela.gomez@cgiar.org::c94e5fda-a43d-46f7-b351-499384532572" providerId="AD" clId="Web-{E2D1CBF2-46FA-06E4-444F-3ACCE5170FF8}" dt="2023-10-24T18:34:55.840" v="515" actId="1076"/>
          <ac:spMkLst>
            <pc:docMk/>
            <pc:sldMk cId="4012007636" sldId="273"/>
            <ac:spMk id="8" creationId="{34F97646-EBFD-EEC9-A2B0-B9E92BD02D6F}"/>
          </ac:spMkLst>
        </pc:spChg>
        <pc:spChg chg="mod">
          <ac:chgData name="Gomez, Daniela (Alliance Bioversity-CIAT)" userId="S::daniela.gomez@cgiar.org::c94e5fda-a43d-46f7-b351-499384532572" providerId="AD" clId="Web-{E2D1CBF2-46FA-06E4-444F-3ACCE5170FF8}" dt="2023-10-24T18:34:55.855" v="516" actId="1076"/>
          <ac:spMkLst>
            <pc:docMk/>
            <pc:sldMk cId="4012007636" sldId="273"/>
            <ac:spMk id="9" creationId="{DAD493B3-7B01-EA70-A244-6E0D7EFFA43C}"/>
          </ac:spMkLst>
        </pc:spChg>
        <pc:spChg chg="mod">
          <ac:chgData name="Gomez, Daniela (Alliance Bioversity-CIAT)" userId="S::daniela.gomez@cgiar.org::c94e5fda-a43d-46f7-b351-499384532572" providerId="AD" clId="Web-{E2D1CBF2-46FA-06E4-444F-3ACCE5170FF8}" dt="2023-10-24T18:34:55.855" v="517" actId="1076"/>
          <ac:spMkLst>
            <pc:docMk/>
            <pc:sldMk cId="4012007636" sldId="273"/>
            <ac:spMk id="10" creationId="{56F9CADB-0876-80F9-41E8-6EBC7AC8F0B6}"/>
          </ac:spMkLst>
        </pc:spChg>
        <pc:spChg chg="mod">
          <ac:chgData name="Gomez, Daniela (Alliance Bioversity-CIAT)" userId="S::daniela.gomez@cgiar.org::c94e5fda-a43d-46f7-b351-499384532572" providerId="AD" clId="Web-{E2D1CBF2-46FA-06E4-444F-3ACCE5170FF8}" dt="2023-10-24T18:34:55.855" v="518" actId="1076"/>
          <ac:spMkLst>
            <pc:docMk/>
            <pc:sldMk cId="4012007636" sldId="273"/>
            <ac:spMk id="11" creationId="{66DCDA07-D514-1414-E278-9689972B507E}"/>
          </ac:spMkLst>
        </pc:spChg>
        <pc:spChg chg="mod">
          <ac:chgData name="Gomez, Daniela (Alliance Bioversity-CIAT)" userId="S::daniela.gomez@cgiar.org::c94e5fda-a43d-46f7-b351-499384532572" providerId="AD" clId="Web-{E2D1CBF2-46FA-06E4-444F-3ACCE5170FF8}" dt="2023-10-24T21:01:23.869" v="692" actId="1076"/>
          <ac:spMkLst>
            <pc:docMk/>
            <pc:sldMk cId="4012007636" sldId="273"/>
            <ac:spMk id="15" creationId="{A331AB26-56D8-4BCA-8AAB-C188316A8DF2}"/>
          </ac:spMkLst>
        </pc:spChg>
        <pc:picChg chg="del">
          <ac:chgData name="Gomez, Daniela (Alliance Bioversity-CIAT)" userId="S::daniela.gomez@cgiar.org::c94e5fda-a43d-46f7-b351-499384532572" providerId="AD" clId="Web-{E2D1CBF2-46FA-06E4-444F-3ACCE5170FF8}" dt="2023-10-24T18:33:55.088" v="497"/>
          <ac:picMkLst>
            <pc:docMk/>
            <pc:sldMk cId="4012007636" sldId="273"/>
            <ac:picMk id="2" creationId="{6FA3ABD7-6B93-DA80-EE42-183C9218571D}"/>
          </ac:picMkLst>
        </pc:picChg>
        <pc:picChg chg="del">
          <ac:chgData name="Gomez, Daniela (Alliance Bioversity-CIAT)" userId="S::daniela.gomez@cgiar.org::c94e5fda-a43d-46f7-b351-499384532572" providerId="AD" clId="Web-{E2D1CBF2-46FA-06E4-444F-3ACCE5170FF8}" dt="2023-10-24T18:33:54.307" v="496"/>
          <ac:picMkLst>
            <pc:docMk/>
            <pc:sldMk cId="4012007636" sldId="273"/>
            <ac:picMk id="3" creationId="{F434D356-15E9-C242-58ED-8158C74E0CDA}"/>
          </ac:picMkLst>
        </pc:picChg>
        <pc:picChg chg="del">
          <ac:chgData name="Gomez, Daniela (Alliance Bioversity-CIAT)" userId="S::daniela.gomez@cgiar.org::c94e5fda-a43d-46f7-b351-499384532572" providerId="AD" clId="Web-{E2D1CBF2-46FA-06E4-444F-3ACCE5170FF8}" dt="2023-10-24T18:33:52.791" v="494"/>
          <ac:picMkLst>
            <pc:docMk/>
            <pc:sldMk cId="4012007636" sldId="273"/>
            <ac:picMk id="4" creationId="{82A1B42F-8FD0-E48F-AA1B-EA1CDA752D68}"/>
          </ac:picMkLst>
        </pc:picChg>
        <pc:picChg chg="add mod">
          <ac:chgData name="Gomez, Daniela (Alliance Bioversity-CIAT)" userId="S::daniela.gomez@cgiar.org::c94e5fda-a43d-46f7-b351-499384532572" providerId="AD" clId="Web-{E2D1CBF2-46FA-06E4-444F-3ACCE5170FF8}" dt="2023-10-24T18:35:36.591" v="530" actId="14100"/>
          <ac:picMkLst>
            <pc:docMk/>
            <pc:sldMk cId="4012007636" sldId="273"/>
            <ac:picMk id="5" creationId="{C1B39C1E-4E1F-B4F6-5C3B-5C14F9300D05}"/>
          </ac:picMkLst>
        </pc:picChg>
        <pc:picChg chg="del">
          <ac:chgData name="Gomez, Daniela (Alliance Bioversity-CIAT)" userId="S::daniela.gomez@cgiar.org::c94e5fda-a43d-46f7-b351-499384532572" providerId="AD" clId="Web-{E2D1CBF2-46FA-06E4-444F-3ACCE5170FF8}" dt="2023-10-24T18:33:53.807" v="495"/>
          <ac:picMkLst>
            <pc:docMk/>
            <pc:sldMk cId="4012007636" sldId="273"/>
            <ac:picMk id="6" creationId="{9CDD0532-27C6-553A-7D57-D2E1FC48F326}"/>
          </ac:picMkLst>
        </pc:picChg>
        <pc:picChg chg="add mod">
          <ac:chgData name="Gomez, Daniela (Alliance Bioversity-CIAT)" userId="S::daniela.gomez@cgiar.org::c94e5fda-a43d-46f7-b351-499384532572" providerId="AD" clId="Web-{E2D1CBF2-46FA-06E4-444F-3ACCE5170FF8}" dt="2023-10-24T18:35:08.746" v="525" actId="14100"/>
          <ac:picMkLst>
            <pc:docMk/>
            <pc:sldMk cId="4012007636" sldId="273"/>
            <ac:picMk id="7" creationId="{C9D74882-B7C4-9C82-36C2-39BA33DF19F3}"/>
          </ac:picMkLst>
        </pc:picChg>
        <pc:picChg chg="add mod">
          <ac:chgData name="Gomez, Daniela (Alliance Bioversity-CIAT)" userId="S::daniela.gomez@cgiar.org::c94e5fda-a43d-46f7-b351-499384532572" providerId="AD" clId="Web-{E2D1CBF2-46FA-06E4-444F-3ACCE5170FF8}" dt="2023-10-24T18:34:59.246" v="523" actId="14100"/>
          <ac:picMkLst>
            <pc:docMk/>
            <pc:sldMk cId="4012007636" sldId="273"/>
            <ac:picMk id="12" creationId="{B9129F79-0790-5B97-A83E-850F89821416}"/>
          </ac:picMkLst>
        </pc:picChg>
        <pc:picChg chg="add mod">
          <ac:chgData name="Gomez, Daniela (Alliance Bioversity-CIAT)" userId="S::daniela.gomez@cgiar.org::c94e5fda-a43d-46f7-b351-499384532572" providerId="AD" clId="Web-{E2D1CBF2-46FA-06E4-444F-3ACCE5170FF8}" dt="2023-10-24T18:35:25.950" v="528" actId="14100"/>
          <ac:picMkLst>
            <pc:docMk/>
            <pc:sldMk cId="4012007636" sldId="273"/>
            <ac:picMk id="13" creationId="{F03D023F-1EF8-E2E1-4C06-DFA1D1E176E8}"/>
          </ac:picMkLst>
        </pc:picChg>
      </pc:sldChg>
      <pc:sldChg chg="addSp delSp modSp add ord replId">
        <pc:chgData name="Gomez, Daniela (Alliance Bioversity-CIAT)" userId="S::daniela.gomez@cgiar.org::c94e5fda-a43d-46f7-b351-499384532572" providerId="AD" clId="Web-{E2D1CBF2-46FA-06E4-444F-3ACCE5170FF8}" dt="2023-10-24T21:02:07.372" v="698" actId="1076"/>
        <pc:sldMkLst>
          <pc:docMk/>
          <pc:sldMk cId="4260030243" sldId="274"/>
        </pc:sldMkLst>
        <pc:spChg chg="mod">
          <ac:chgData name="Gomez, Daniela (Alliance Bioversity-CIAT)" userId="S::daniela.gomez@cgiar.org::c94e5fda-a43d-46f7-b351-499384532572" providerId="AD" clId="Web-{E2D1CBF2-46FA-06E4-444F-3ACCE5170FF8}" dt="2023-10-24T21:02:07.372" v="698" actId="1076"/>
          <ac:spMkLst>
            <pc:docMk/>
            <pc:sldMk cId="4260030243" sldId="274"/>
            <ac:spMk id="15" creationId="{A331AB26-56D8-4BCA-8AAB-C188316A8DF2}"/>
          </ac:spMkLst>
        </pc:spChg>
        <pc:picChg chg="add mod">
          <ac:chgData name="Gomez, Daniela (Alliance Bioversity-CIAT)" userId="S::daniela.gomez@cgiar.org::c94e5fda-a43d-46f7-b351-499384532572" providerId="AD" clId="Web-{E2D1CBF2-46FA-06E4-444F-3ACCE5170FF8}" dt="2023-10-24T18:39:54.537" v="565" actId="14100"/>
          <ac:picMkLst>
            <pc:docMk/>
            <pc:sldMk cId="4260030243" sldId="274"/>
            <ac:picMk id="2" creationId="{2247DC30-B42E-243C-4BF9-D0E6250312A8}"/>
          </ac:picMkLst>
        </pc:picChg>
        <pc:picChg chg="add mod">
          <ac:chgData name="Gomez, Daniela (Alliance Bioversity-CIAT)" userId="S::daniela.gomez@cgiar.org::c94e5fda-a43d-46f7-b351-499384532572" providerId="AD" clId="Web-{E2D1CBF2-46FA-06E4-444F-3ACCE5170FF8}" dt="2023-10-24T18:39:37.349" v="561" actId="1076"/>
          <ac:picMkLst>
            <pc:docMk/>
            <pc:sldMk cId="4260030243" sldId="274"/>
            <ac:picMk id="3" creationId="{4DFC5984-3A3B-E1A9-81A4-177B29E1821A}"/>
          </ac:picMkLst>
        </pc:picChg>
        <pc:picChg chg="add mod">
          <ac:chgData name="Gomez, Daniela (Alliance Bioversity-CIAT)" userId="S::daniela.gomez@cgiar.org::c94e5fda-a43d-46f7-b351-499384532572" providerId="AD" clId="Web-{E2D1CBF2-46FA-06E4-444F-3ACCE5170FF8}" dt="2023-10-24T18:39:18.098" v="554" actId="14100"/>
          <ac:picMkLst>
            <pc:docMk/>
            <pc:sldMk cId="4260030243" sldId="274"/>
            <ac:picMk id="4" creationId="{04274E18-5C63-93DE-D94B-3473A649AD6D}"/>
          </ac:picMkLst>
        </pc:picChg>
        <pc:picChg chg="del">
          <ac:chgData name="Gomez, Daniela (Alliance Bioversity-CIAT)" userId="S::daniela.gomez@cgiar.org::c94e5fda-a43d-46f7-b351-499384532572" providerId="AD" clId="Web-{E2D1CBF2-46FA-06E4-444F-3ACCE5170FF8}" dt="2023-10-24T18:38:47.785" v="541"/>
          <ac:picMkLst>
            <pc:docMk/>
            <pc:sldMk cId="4260030243" sldId="274"/>
            <ac:picMk id="5" creationId="{C1B39C1E-4E1F-B4F6-5C3B-5C14F9300D05}"/>
          </ac:picMkLst>
        </pc:picChg>
        <pc:picChg chg="add mod">
          <ac:chgData name="Gomez, Daniela (Alliance Bioversity-CIAT)" userId="S::daniela.gomez@cgiar.org::c94e5fda-a43d-46f7-b351-499384532572" providerId="AD" clId="Web-{E2D1CBF2-46FA-06E4-444F-3ACCE5170FF8}" dt="2023-10-24T18:39:47.521" v="563" actId="14100"/>
          <ac:picMkLst>
            <pc:docMk/>
            <pc:sldMk cId="4260030243" sldId="274"/>
            <ac:picMk id="6" creationId="{C80D4F95-5EB0-57B0-D0F7-E9AFB3FE8198}"/>
          </ac:picMkLst>
        </pc:picChg>
        <pc:picChg chg="del">
          <ac:chgData name="Gomez, Daniela (Alliance Bioversity-CIAT)" userId="S::daniela.gomez@cgiar.org::c94e5fda-a43d-46f7-b351-499384532572" providerId="AD" clId="Web-{E2D1CBF2-46FA-06E4-444F-3ACCE5170FF8}" dt="2023-10-24T18:38:48.160" v="542"/>
          <ac:picMkLst>
            <pc:docMk/>
            <pc:sldMk cId="4260030243" sldId="274"/>
            <ac:picMk id="7" creationId="{C9D74882-B7C4-9C82-36C2-39BA33DF19F3}"/>
          </ac:picMkLst>
        </pc:picChg>
        <pc:picChg chg="del">
          <ac:chgData name="Gomez, Daniela (Alliance Bioversity-CIAT)" userId="S::daniela.gomez@cgiar.org::c94e5fda-a43d-46f7-b351-499384532572" providerId="AD" clId="Web-{E2D1CBF2-46FA-06E4-444F-3ACCE5170FF8}" dt="2023-10-24T18:38:46.925" v="539"/>
          <ac:picMkLst>
            <pc:docMk/>
            <pc:sldMk cId="4260030243" sldId="274"/>
            <ac:picMk id="12" creationId="{B9129F79-0790-5B97-A83E-850F89821416}"/>
          </ac:picMkLst>
        </pc:picChg>
        <pc:picChg chg="del">
          <ac:chgData name="Gomez, Daniela (Alliance Bioversity-CIAT)" userId="S::daniela.gomez@cgiar.org::c94e5fda-a43d-46f7-b351-499384532572" providerId="AD" clId="Web-{E2D1CBF2-46FA-06E4-444F-3ACCE5170FF8}" dt="2023-10-24T18:38:47.363" v="540"/>
          <ac:picMkLst>
            <pc:docMk/>
            <pc:sldMk cId="4260030243" sldId="274"/>
            <ac:picMk id="13" creationId="{F03D023F-1EF8-E2E1-4C06-DFA1D1E176E8}"/>
          </ac:picMkLst>
        </pc:picChg>
      </pc:sldChg>
      <pc:sldChg chg="addSp delSp modSp add ord replId">
        <pc:chgData name="Gomez, Daniela (Alliance Bioversity-CIAT)" userId="S::daniela.gomez@cgiar.org::c94e5fda-a43d-46f7-b351-499384532572" providerId="AD" clId="Web-{E2D1CBF2-46FA-06E4-444F-3ACCE5170FF8}" dt="2023-10-24T21:02:24.498" v="704" actId="1076"/>
        <pc:sldMkLst>
          <pc:docMk/>
          <pc:sldMk cId="1946445284" sldId="275"/>
        </pc:sldMkLst>
        <pc:spChg chg="mod">
          <ac:chgData name="Gomez, Daniela (Alliance Bioversity-CIAT)" userId="S::daniela.gomez@cgiar.org::c94e5fda-a43d-46f7-b351-499384532572" providerId="AD" clId="Web-{E2D1CBF2-46FA-06E4-444F-3ACCE5170FF8}" dt="2023-10-24T21:02:24.498" v="704" actId="1076"/>
          <ac:spMkLst>
            <pc:docMk/>
            <pc:sldMk cId="1946445284" sldId="275"/>
            <ac:spMk id="15" creationId="{A331AB26-56D8-4BCA-8AAB-C188316A8DF2}"/>
          </ac:spMkLst>
        </pc:spChg>
        <pc:picChg chg="add mod">
          <ac:chgData name="Gomez, Daniela (Alliance Bioversity-CIAT)" userId="S::daniela.gomez@cgiar.org::c94e5fda-a43d-46f7-b351-499384532572" providerId="AD" clId="Web-{E2D1CBF2-46FA-06E4-444F-3ACCE5170FF8}" dt="2023-10-24T18:41:29.415" v="595" actId="14100"/>
          <ac:picMkLst>
            <pc:docMk/>
            <pc:sldMk cId="1946445284" sldId="275"/>
            <ac:picMk id="2" creationId="{F180C2ED-D6BD-ECFD-86E6-FC2A38A1993A}"/>
          </ac:picMkLst>
        </pc:picChg>
        <pc:picChg chg="add mod">
          <ac:chgData name="Gomez, Daniela (Alliance Bioversity-CIAT)" userId="S::daniela.gomez@cgiar.org::c94e5fda-a43d-46f7-b351-499384532572" providerId="AD" clId="Web-{E2D1CBF2-46FA-06E4-444F-3ACCE5170FF8}" dt="2023-10-24T18:41:09.743" v="591" actId="14100"/>
          <ac:picMkLst>
            <pc:docMk/>
            <pc:sldMk cId="1946445284" sldId="275"/>
            <ac:picMk id="3" creationId="{2F3C45C0-A0E3-3478-2BAD-A702CE2FB1FE}"/>
          </ac:picMkLst>
        </pc:picChg>
        <pc:picChg chg="add mod">
          <ac:chgData name="Gomez, Daniela (Alliance Bioversity-CIAT)" userId="S::daniela.gomez@cgiar.org::c94e5fda-a43d-46f7-b351-499384532572" providerId="AD" clId="Web-{E2D1CBF2-46FA-06E4-444F-3ACCE5170FF8}" dt="2023-10-24T18:40:59.664" v="589" actId="14100"/>
          <ac:picMkLst>
            <pc:docMk/>
            <pc:sldMk cId="1946445284" sldId="275"/>
            <ac:picMk id="4" creationId="{63E5E3C8-D54B-369F-7176-A8623CEF10C2}"/>
          </ac:picMkLst>
        </pc:picChg>
        <pc:picChg chg="del">
          <ac:chgData name="Gomez, Daniela (Alliance Bioversity-CIAT)" userId="S::daniela.gomez@cgiar.org::c94e5fda-a43d-46f7-b351-499384532572" providerId="AD" clId="Web-{E2D1CBF2-46FA-06E4-444F-3ACCE5170FF8}" dt="2023-10-24T18:40:10.553" v="569"/>
          <ac:picMkLst>
            <pc:docMk/>
            <pc:sldMk cId="1946445284" sldId="275"/>
            <ac:picMk id="5" creationId="{C1B39C1E-4E1F-B4F6-5C3B-5C14F9300D05}"/>
          </ac:picMkLst>
        </pc:picChg>
        <pc:picChg chg="add mod">
          <ac:chgData name="Gomez, Daniela (Alliance Bioversity-CIAT)" userId="S::daniela.gomez@cgiar.org::c94e5fda-a43d-46f7-b351-499384532572" providerId="AD" clId="Web-{E2D1CBF2-46FA-06E4-444F-3ACCE5170FF8}" dt="2023-10-24T18:41:16.305" v="593" actId="14100"/>
          <ac:picMkLst>
            <pc:docMk/>
            <pc:sldMk cId="1946445284" sldId="275"/>
            <ac:picMk id="6" creationId="{BC38A370-DB3F-B2F0-D117-2ED30CF3A2AC}"/>
          </ac:picMkLst>
        </pc:picChg>
        <pc:picChg chg="del">
          <ac:chgData name="Gomez, Daniela (Alliance Bioversity-CIAT)" userId="S::daniela.gomez@cgiar.org::c94e5fda-a43d-46f7-b351-499384532572" providerId="AD" clId="Web-{E2D1CBF2-46FA-06E4-444F-3ACCE5170FF8}" dt="2023-10-24T18:40:10.163" v="568"/>
          <ac:picMkLst>
            <pc:docMk/>
            <pc:sldMk cId="1946445284" sldId="275"/>
            <ac:picMk id="7" creationId="{C9D74882-B7C4-9C82-36C2-39BA33DF19F3}"/>
          </ac:picMkLst>
        </pc:picChg>
        <pc:picChg chg="del">
          <ac:chgData name="Gomez, Daniela (Alliance Bioversity-CIAT)" userId="S::daniela.gomez@cgiar.org::c94e5fda-a43d-46f7-b351-499384532572" providerId="AD" clId="Web-{E2D1CBF2-46FA-06E4-444F-3ACCE5170FF8}" dt="2023-10-24T18:40:09.084" v="566"/>
          <ac:picMkLst>
            <pc:docMk/>
            <pc:sldMk cId="1946445284" sldId="275"/>
            <ac:picMk id="12" creationId="{B9129F79-0790-5B97-A83E-850F89821416}"/>
          </ac:picMkLst>
        </pc:picChg>
        <pc:picChg chg="del">
          <ac:chgData name="Gomez, Daniela (Alliance Bioversity-CIAT)" userId="S::daniela.gomez@cgiar.org::c94e5fda-a43d-46f7-b351-499384532572" providerId="AD" clId="Web-{E2D1CBF2-46FA-06E4-444F-3ACCE5170FF8}" dt="2023-10-24T18:40:09.569" v="567"/>
          <ac:picMkLst>
            <pc:docMk/>
            <pc:sldMk cId="1946445284" sldId="275"/>
            <ac:picMk id="13" creationId="{F03D023F-1EF8-E2E1-4C06-DFA1D1E176E8}"/>
          </ac:picMkLst>
        </pc:picChg>
      </pc:sldChg>
    </pc:docChg>
  </pc:docChgLst>
  <pc:docChgLst>
    <pc:chgData name="Vergara, Javier (CIAT)" userId="S::j.vergara@cgiar.org::1737bf23-10e4-4004-af57-20e81a1f7d95" providerId="AD" clId="Web-{09E33889-EFA0-EAB8-C3B7-397358047966}"/>
    <pc:docChg chg="modSld">
      <pc:chgData name="Vergara, Javier (CIAT)" userId="S::j.vergara@cgiar.org::1737bf23-10e4-4004-af57-20e81a1f7d95" providerId="AD" clId="Web-{09E33889-EFA0-EAB8-C3B7-397358047966}" dt="2019-04-24T12:27:18.257" v="26" actId="1076"/>
      <pc:docMkLst>
        <pc:docMk/>
      </pc:docMkLst>
      <pc:sldChg chg="modSp">
        <pc:chgData name="Vergara, Javier (CIAT)" userId="S::j.vergara@cgiar.org::1737bf23-10e4-4004-af57-20e81a1f7d95" providerId="AD" clId="Web-{09E33889-EFA0-EAB8-C3B7-397358047966}" dt="2019-04-24T12:27:18.257" v="26" actId="1076"/>
        <pc:sldMkLst>
          <pc:docMk/>
          <pc:sldMk cId="4268846717" sldId="263"/>
        </pc:sldMkLst>
        <pc:spChg chg="mod">
          <ac:chgData name="Vergara, Javier (CIAT)" userId="S::j.vergara@cgiar.org::1737bf23-10e4-4004-af57-20e81a1f7d95" providerId="AD" clId="Web-{09E33889-EFA0-EAB8-C3B7-397358047966}" dt="2019-04-24T12:27:18.257" v="26" actId="1076"/>
          <ac:spMkLst>
            <pc:docMk/>
            <pc:sldMk cId="4268846717" sldId="263"/>
            <ac:spMk id="3" creationId="{C4105DC1-8271-4B95-A636-619CDE6535F6}"/>
          </ac:spMkLst>
        </pc:spChg>
        <pc:spChg chg="mod">
          <ac:chgData name="Vergara, Javier (CIAT)" userId="S::j.vergara@cgiar.org::1737bf23-10e4-4004-af57-20e81a1f7d95" providerId="AD" clId="Web-{09E33889-EFA0-EAB8-C3B7-397358047966}" dt="2019-04-24T12:27:14.616" v="24" actId="1076"/>
          <ac:spMkLst>
            <pc:docMk/>
            <pc:sldMk cId="4268846717" sldId="263"/>
            <ac:spMk id="18" creationId="{0B81691F-14FD-4FF6-9182-87316D1768F0}"/>
          </ac:spMkLst>
        </pc:spChg>
        <pc:spChg chg="mod">
          <ac:chgData name="Vergara, Javier (CIAT)" userId="S::j.vergara@cgiar.org::1737bf23-10e4-4004-af57-20e81a1f7d95" providerId="AD" clId="Web-{09E33889-EFA0-EAB8-C3B7-397358047966}" dt="2019-04-24T12:27:14.523" v="16" actId="1076"/>
          <ac:spMkLst>
            <pc:docMk/>
            <pc:sldMk cId="4268846717" sldId="263"/>
            <ac:spMk id="20" creationId="{74C04F1A-97C0-4AE5-B250-C93CA5BE8901}"/>
          </ac:spMkLst>
        </pc:spChg>
        <pc:spChg chg="mod">
          <ac:chgData name="Vergara, Javier (CIAT)" userId="S::j.vergara@cgiar.org::1737bf23-10e4-4004-af57-20e81a1f7d95" providerId="AD" clId="Web-{09E33889-EFA0-EAB8-C3B7-397358047966}" dt="2019-04-24T12:27:14.538" v="17" actId="1076"/>
          <ac:spMkLst>
            <pc:docMk/>
            <pc:sldMk cId="4268846717" sldId="263"/>
            <ac:spMk id="21" creationId="{F97066A1-36AB-43B0-8803-469F24E054C8}"/>
          </ac:spMkLst>
        </pc:spChg>
        <pc:spChg chg="mod">
          <ac:chgData name="Vergara, Javier (CIAT)" userId="S::j.vergara@cgiar.org::1737bf23-10e4-4004-af57-20e81a1f7d95" providerId="AD" clId="Web-{09E33889-EFA0-EAB8-C3B7-397358047966}" dt="2019-04-24T12:27:14.616" v="25" actId="1076"/>
          <ac:spMkLst>
            <pc:docMk/>
            <pc:sldMk cId="4268846717" sldId="263"/>
            <ac:spMk id="22" creationId="{B34BA769-B227-4F2D-BFCA-74A3EB10B6CD}"/>
          </ac:spMkLst>
        </pc:spChg>
        <pc:spChg chg="mod">
          <ac:chgData name="Vergara, Javier (CIAT)" userId="S::j.vergara@cgiar.org::1737bf23-10e4-4004-af57-20e81a1f7d95" providerId="AD" clId="Web-{09E33889-EFA0-EAB8-C3B7-397358047966}" dt="2019-04-24T12:27:14.585" v="21" actId="1076"/>
          <ac:spMkLst>
            <pc:docMk/>
            <pc:sldMk cId="4268846717" sldId="263"/>
            <ac:spMk id="23" creationId="{5892EAC2-720C-4D29-9143-09860847058F}"/>
          </ac:spMkLst>
        </pc:spChg>
        <pc:spChg chg="mod">
          <ac:chgData name="Vergara, Javier (CIAT)" userId="S::j.vergara@cgiar.org::1737bf23-10e4-4004-af57-20e81a1f7d95" providerId="AD" clId="Web-{09E33889-EFA0-EAB8-C3B7-397358047966}" dt="2019-04-24T12:27:14.616" v="23" actId="1076"/>
          <ac:spMkLst>
            <pc:docMk/>
            <pc:sldMk cId="4268846717" sldId="263"/>
            <ac:spMk id="24" creationId="{B2894B70-0C9C-474A-B676-6381BDACF4AA}"/>
          </ac:spMkLst>
        </pc:spChg>
        <pc:picChg chg="mod">
          <ac:chgData name="Vergara, Javier (CIAT)" userId="S::j.vergara@cgiar.org::1737bf23-10e4-4004-af57-20e81a1f7d95" providerId="AD" clId="Web-{09E33889-EFA0-EAB8-C3B7-397358047966}" dt="2019-04-24T12:27:14.507" v="14" actId="1076"/>
          <ac:picMkLst>
            <pc:docMk/>
            <pc:sldMk cId="4268846717" sldId="263"/>
            <ac:picMk id="5" creationId="{738AF3C1-9A23-474B-BF3A-EE86B6AE3ABE}"/>
          </ac:picMkLst>
        </pc:picChg>
        <pc:picChg chg="mod">
          <ac:chgData name="Vergara, Javier (CIAT)" userId="S::j.vergara@cgiar.org::1737bf23-10e4-4004-af57-20e81a1f7d95" providerId="AD" clId="Web-{09E33889-EFA0-EAB8-C3B7-397358047966}" dt="2019-04-24T12:27:14.523" v="15" actId="1076"/>
          <ac:picMkLst>
            <pc:docMk/>
            <pc:sldMk cId="4268846717" sldId="263"/>
            <ac:picMk id="7" creationId="{ED18B229-E09F-46F0-A6D6-A159F99E9793}"/>
          </ac:picMkLst>
        </pc:picChg>
        <pc:picChg chg="mod">
          <ac:chgData name="Vergara, Javier (CIAT)" userId="S::j.vergara@cgiar.org::1737bf23-10e4-4004-af57-20e81a1f7d95" providerId="AD" clId="Web-{09E33889-EFA0-EAB8-C3B7-397358047966}" dt="2019-04-24T12:27:14.554" v="18" actId="1076"/>
          <ac:picMkLst>
            <pc:docMk/>
            <pc:sldMk cId="4268846717" sldId="263"/>
            <ac:picMk id="10" creationId="{ADE2B71A-612C-4DCC-95AE-89C52A2F0959}"/>
          </ac:picMkLst>
        </pc:picChg>
        <pc:picChg chg="mod">
          <ac:chgData name="Vergara, Javier (CIAT)" userId="S::j.vergara@cgiar.org::1737bf23-10e4-4004-af57-20e81a1f7d95" providerId="AD" clId="Web-{09E33889-EFA0-EAB8-C3B7-397358047966}" dt="2019-04-24T12:27:14.570" v="19" actId="1076"/>
          <ac:picMkLst>
            <pc:docMk/>
            <pc:sldMk cId="4268846717" sldId="263"/>
            <ac:picMk id="12" creationId="{FC20475A-1DCA-4EA5-8713-9BD7E78B0568}"/>
          </ac:picMkLst>
        </pc:picChg>
        <pc:picChg chg="mod">
          <ac:chgData name="Vergara, Javier (CIAT)" userId="S::j.vergara@cgiar.org::1737bf23-10e4-4004-af57-20e81a1f7d95" providerId="AD" clId="Web-{09E33889-EFA0-EAB8-C3B7-397358047966}" dt="2019-04-24T12:27:14.601" v="22" actId="1076"/>
          <ac:picMkLst>
            <pc:docMk/>
            <pc:sldMk cId="4268846717" sldId="263"/>
            <ac:picMk id="14" creationId="{3C7D780C-7E20-458B-BCAF-DFD005C0983C}"/>
          </ac:picMkLst>
        </pc:picChg>
        <pc:picChg chg="mod">
          <ac:chgData name="Vergara, Javier (CIAT)" userId="S::j.vergara@cgiar.org::1737bf23-10e4-4004-af57-20e81a1f7d95" providerId="AD" clId="Web-{09E33889-EFA0-EAB8-C3B7-397358047966}" dt="2019-04-24T12:27:14.585" v="20" actId="1076"/>
          <ac:picMkLst>
            <pc:docMk/>
            <pc:sldMk cId="4268846717" sldId="263"/>
            <ac:picMk id="25" creationId="{0CF6F019-5972-4758-B67F-D832016BE794}"/>
          </ac:picMkLst>
        </pc:picChg>
      </pc:sldChg>
    </pc:docChg>
  </pc:docChgLst>
  <pc:docChgLst>
    <pc:chgData name="Casas, Jorge Andres (Alliance Bioversity-CIAT)" userId="0214a199-ccc4-4ec8-9f54-9e3cc067bbad" providerId="ADAL" clId="{C4A3F957-80F5-411E-ACAE-8321A9B839DD}"/>
    <pc:docChg chg="custSel addSld modSld">
      <pc:chgData name="Casas, Jorge Andres (Alliance Bioversity-CIAT)" userId="0214a199-ccc4-4ec8-9f54-9e3cc067bbad" providerId="ADAL" clId="{C4A3F957-80F5-411E-ACAE-8321A9B839DD}" dt="2024-02-23T19:39:52.110" v="134"/>
      <pc:docMkLst>
        <pc:docMk/>
      </pc:docMkLst>
      <pc:sldChg chg="modSp">
        <pc:chgData name="Casas, Jorge Andres (Alliance Bioversity-CIAT)" userId="0214a199-ccc4-4ec8-9f54-9e3cc067bbad" providerId="ADAL" clId="{C4A3F957-80F5-411E-ACAE-8321A9B839DD}" dt="2024-02-23T19:39:52.110" v="134"/>
        <pc:sldMkLst>
          <pc:docMk/>
          <pc:sldMk cId="744295684" sldId="267"/>
        </pc:sldMkLst>
        <pc:spChg chg="mod">
          <ac:chgData name="Casas, Jorge Andres (Alliance Bioversity-CIAT)" userId="0214a199-ccc4-4ec8-9f54-9e3cc067bbad" providerId="ADAL" clId="{C4A3F957-80F5-411E-ACAE-8321A9B839DD}" dt="2024-02-23T19:39:52.110" v="134"/>
          <ac:spMkLst>
            <pc:docMk/>
            <pc:sldMk cId="744295684" sldId="267"/>
            <ac:spMk id="15" creationId="{A331AB26-56D8-4BCA-8AAB-C188316A8DF2}"/>
          </ac:spMkLst>
        </pc:spChg>
      </pc:sldChg>
      <pc:sldChg chg="modSp">
        <pc:chgData name="Casas, Jorge Andres (Alliance Bioversity-CIAT)" userId="0214a199-ccc4-4ec8-9f54-9e3cc067bbad" providerId="ADAL" clId="{C4A3F957-80F5-411E-ACAE-8321A9B839DD}" dt="2024-02-23T19:39:38.864" v="133"/>
        <pc:sldMkLst>
          <pc:docMk/>
          <pc:sldMk cId="1307993186" sldId="268"/>
        </pc:sldMkLst>
        <pc:spChg chg="mod">
          <ac:chgData name="Casas, Jorge Andres (Alliance Bioversity-CIAT)" userId="0214a199-ccc4-4ec8-9f54-9e3cc067bbad" providerId="ADAL" clId="{C4A3F957-80F5-411E-ACAE-8321A9B839DD}" dt="2024-02-23T19:39:38.864" v="133"/>
          <ac:spMkLst>
            <pc:docMk/>
            <pc:sldMk cId="1307993186" sldId="268"/>
            <ac:spMk id="15" creationId="{A331AB26-56D8-4BCA-8AAB-C188316A8DF2}"/>
          </ac:spMkLst>
        </pc:spChg>
      </pc:sldChg>
      <pc:sldChg chg="modSp">
        <pc:chgData name="Casas, Jorge Andres (Alliance Bioversity-CIAT)" userId="0214a199-ccc4-4ec8-9f54-9e3cc067bbad" providerId="ADAL" clId="{C4A3F957-80F5-411E-ACAE-8321A9B839DD}" dt="2024-02-23T19:39:52.110" v="134"/>
        <pc:sldMkLst>
          <pc:docMk/>
          <pc:sldMk cId="1495302232" sldId="269"/>
        </pc:sldMkLst>
        <pc:spChg chg="mod">
          <ac:chgData name="Casas, Jorge Andres (Alliance Bioversity-CIAT)" userId="0214a199-ccc4-4ec8-9f54-9e3cc067bbad" providerId="ADAL" clId="{C4A3F957-80F5-411E-ACAE-8321A9B839DD}" dt="2024-02-23T19:39:52.110" v="134"/>
          <ac:spMkLst>
            <pc:docMk/>
            <pc:sldMk cId="1495302232" sldId="269"/>
            <ac:spMk id="15" creationId="{A331AB26-56D8-4BCA-8AAB-C188316A8DF2}"/>
          </ac:spMkLst>
        </pc:spChg>
      </pc:sldChg>
      <pc:sldChg chg="modSp">
        <pc:chgData name="Casas, Jorge Andres (Alliance Bioversity-CIAT)" userId="0214a199-ccc4-4ec8-9f54-9e3cc067bbad" providerId="ADAL" clId="{C4A3F957-80F5-411E-ACAE-8321A9B839DD}" dt="2024-02-23T19:39:38.864" v="133"/>
        <pc:sldMkLst>
          <pc:docMk/>
          <pc:sldMk cId="2995284397" sldId="270"/>
        </pc:sldMkLst>
        <pc:spChg chg="mod">
          <ac:chgData name="Casas, Jorge Andres (Alliance Bioversity-CIAT)" userId="0214a199-ccc4-4ec8-9f54-9e3cc067bbad" providerId="ADAL" clId="{C4A3F957-80F5-411E-ACAE-8321A9B839DD}" dt="2024-02-23T19:39:38.864" v="133"/>
          <ac:spMkLst>
            <pc:docMk/>
            <pc:sldMk cId="2995284397" sldId="270"/>
            <ac:spMk id="15" creationId="{A331AB26-56D8-4BCA-8AAB-C188316A8DF2}"/>
          </ac:spMkLst>
        </pc:spChg>
      </pc:sldChg>
      <pc:sldChg chg="modSp">
        <pc:chgData name="Casas, Jorge Andres (Alliance Bioversity-CIAT)" userId="0214a199-ccc4-4ec8-9f54-9e3cc067bbad" providerId="ADAL" clId="{C4A3F957-80F5-411E-ACAE-8321A9B839DD}" dt="2024-02-23T19:39:38.864" v="133"/>
        <pc:sldMkLst>
          <pc:docMk/>
          <pc:sldMk cId="717926230" sldId="272"/>
        </pc:sldMkLst>
        <pc:spChg chg="mod">
          <ac:chgData name="Casas, Jorge Andres (Alliance Bioversity-CIAT)" userId="0214a199-ccc4-4ec8-9f54-9e3cc067bbad" providerId="ADAL" clId="{C4A3F957-80F5-411E-ACAE-8321A9B839DD}" dt="2024-02-23T19:39:38.864" v="133"/>
          <ac:spMkLst>
            <pc:docMk/>
            <pc:sldMk cId="717926230" sldId="272"/>
            <ac:spMk id="15" creationId="{A331AB26-56D8-4BCA-8AAB-C188316A8DF2}"/>
          </ac:spMkLst>
        </pc:spChg>
      </pc:sldChg>
      <pc:sldChg chg="modSp">
        <pc:chgData name="Casas, Jorge Andres (Alliance Bioversity-CIAT)" userId="0214a199-ccc4-4ec8-9f54-9e3cc067bbad" providerId="ADAL" clId="{C4A3F957-80F5-411E-ACAE-8321A9B839DD}" dt="2024-02-23T19:39:52.110" v="134"/>
        <pc:sldMkLst>
          <pc:docMk/>
          <pc:sldMk cId="4012007636" sldId="273"/>
        </pc:sldMkLst>
        <pc:spChg chg="mod">
          <ac:chgData name="Casas, Jorge Andres (Alliance Bioversity-CIAT)" userId="0214a199-ccc4-4ec8-9f54-9e3cc067bbad" providerId="ADAL" clId="{C4A3F957-80F5-411E-ACAE-8321A9B839DD}" dt="2024-02-23T19:39:52.110" v="134"/>
          <ac:spMkLst>
            <pc:docMk/>
            <pc:sldMk cId="4012007636" sldId="273"/>
            <ac:spMk id="15" creationId="{A331AB26-56D8-4BCA-8AAB-C188316A8DF2}"/>
          </ac:spMkLst>
        </pc:spChg>
      </pc:sldChg>
      <pc:sldChg chg="modSp">
        <pc:chgData name="Casas, Jorge Andres (Alliance Bioversity-CIAT)" userId="0214a199-ccc4-4ec8-9f54-9e3cc067bbad" providerId="ADAL" clId="{C4A3F957-80F5-411E-ACAE-8321A9B839DD}" dt="2024-02-23T19:39:38.864" v="133"/>
        <pc:sldMkLst>
          <pc:docMk/>
          <pc:sldMk cId="4260030243" sldId="274"/>
        </pc:sldMkLst>
        <pc:spChg chg="mod">
          <ac:chgData name="Casas, Jorge Andres (Alliance Bioversity-CIAT)" userId="0214a199-ccc4-4ec8-9f54-9e3cc067bbad" providerId="ADAL" clId="{C4A3F957-80F5-411E-ACAE-8321A9B839DD}" dt="2024-02-23T19:39:38.864" v="133"/>
          <ac:spMkLst>
            <pc:docMk/>
            <pc:sldMk cId="4260030243" sldId="274"/>
            <ac:spMk id="15" creationId="{A331AB26-56D8-4BCA-8AAB-C188316A8DF2}"/>
          </ac:spMkLst>
        </pc:spChg>
      </pc:sldChg>
      <pc:sldChg chg="modSp">
        <pc:chgData name="Casas, Jorge Andres (Alliance Bioversity-CIAT)" userId="0214a199-ccc4-4ec8-9f54-9e3cc067bbad" providerId="ADAL" clId="{C4A3F957-80F5-411E-ACAE-8321A9B839DD}" dt="2024-02-23T19:39:52.110" v="134"/>
        <pc:sldMkLst>
          <pc:docMk/>
          <pc:sldMk cId="1946445284" sldId="275"/>
        </pc:sldMkLst>
        <pc:spChg chg="mod">
          <ac:chgData name="Casas, Jorge Andres (Alliance Bioversity-CIAT)" userId="0214a199-ccc4-4ec8-9f54-9e3cc067bbad" providerId="ADAL" clId="{C4A3F957-80F5-411E-ACAE-8321A9B839DD}" dt="2024-02-23T19:39:52.110" v="134"/>
          <ac:spMkLst>
            <pc:docMk/>
            <pc:sldMk cId="1946445284" sldId="275"/>
            <ac:spMk id="15" creationId="{A331AB26-56D8-4BCA-8AAB-C188316A8DF2}"/>
          </ac:spMkLst>
        </pc:spChg>
      </pc:sldChg>
      <pc:sldChg chg="modSp">
        <pc:chgData name="Casas, Jorge Andres (Alliance Bioversity-CIAT)" userId="0214a199-ccc4-4ec8-9f54-9e3cc067bbad" providerId="ADAL" clId="{C4A3F957-80F5-411E-ACAE-8321A9B839DD}" dt="2024-02-23T19:39:38.864" v="133"/>
        <pc:sldMkLst>
          <pc:docMk/>
          <pc:sldMk cId="1605347520" sldId="276"/>
        </pc:sldMkLst>
        <pc:spChg chg="mod">
          <ac:chgData name="Casas, Jorge Andres (Alliance Bioversity-CIAT)" userId="0214a199-ccc4-4ec8-9f54-9e3cc067bbad" providerId="ADAL" clId="{C4A3F957-80F5-411E-ACAE-8321A9B839DD}" dt="2024-02-23T19:39:38.864" v="133"/>
          <ac:spMkLst>
            <pc:docMk/>
            <pc:sldMk cId="1605347520" sldId="276"/>
            <ac:spMk id="3" creationId="{7407D766-0A41-2817-44C1-014E1233DBD8}"/>
          </ac:spMkLst>
        </pc:spChg>
      </pc:sldChg>
      <pc:sldChg chg="modSp">
        <pc:chgData name="Casas, Jorge Andres (Alliance Bioversity-CIAT)" userId="0214a199-ccc4-4ec8-9f54-9e3cc067bbad" providerId="ADAL" clId="{C4A3F957-80F5-411E-ACAE-8321A9B839DD}" dt="2024-02-23T19:39:38.864" v="133"/>
        <pc:sldMkLst>
          <pc:docMk/>
          <pc:sldMk cId="529526858" sldId="277"/>
        </pc:sldMkLst>
        <pc:spChg chg="mod">
          <ac:chgData name="Casas, Jorge Andres (Alliance Bioversity-CIAT)" userId="0214a199-ccc4-4ec8-9f54-9e3cc067bbad" providerId="ADAL" clId="{C4A3F957-80F5-411E-ACAE-8321A9B839DD}" dt="2024-02-23T19:39:38.864" v="133"/>
          <ac:spMkLst>
            <pc:docMk/>
            <pc:sldMk cId="529526858" sldId="277"/>
            <ac:spMk id="15" creationId="{31521B25-5F28-A1FE-D2B4-E274D0C959D6}"/>
          </ac:spMkLst>
        </pc:spChg>
      </pc:sldChg>
      <pc:sldChg chg="modSp">
        <pc:chgData name="Casas, Jorge Andres (Alliance Bioversity-CIAT)" userId="0214a199-ccc4-4ec8-9f54-9e3cc067bbad" providerId="ADAL" clId="{C4A3F957-80F5-411E-ACAE-8321A9B839DD}" dt="2024-02-23T19:39:52.110" v="134"/>
        <pc:sldMkLst>
          <pc:docMk/>
          <pc:sldMk cId="2349917634" sldId="278"/>
        </pc:sldMkLst>
        <pc:spChg chg="mod">
          <ac:chgData name="Casas, Jorge Andres (Alliance Bioversity-CIAT)" userId="0214a199-ccc4-4ec8-9f54-9e3cc067bbad" providerId="ADAL" clId="{C4A3F957-80F5-411E-ACAE-8321A9B839DD}" dt="2024-02-23T19:39:52.110" v="134"/>
          <ac:spMkLst>
            <pc:docMk/>
            <pc:sldMk cId="2349917634" sldId="278"/>
            <ac:spMk id="4" creationId="{C72D4F93-3114-72B0-0158-44D107EEA4BC}"/>
          </ac:spMkLst>
        </pc:spChg>
      </pc:sldChg>
      <pc:sldChg chg="modSp">
        <pc:chgData name="Casas, Jorge Andres (Alliance Bioversity-CIAT)" userId="0214a199-ccc4-4ec8-9f54-9e3cc067bbad" providerId="ADAL" clId="{C4A3F957-80F5-411E-ACAE-8321A9B839DD}" dt="2024-02-23T19:39:52.110" v="134"/>
        <pc:sldMkLst>
          <pc:docMk/>
          <pc:sldMk cId="1807957567" sldId="279"/>
        </pc:sldMkLst>
        <pc:spChg chg="mod">
          <ac:chgData name="Casas, Jorge Andres (Alliance Bioversity-CIAT)" userId="0214a199-ccc4-4ec8-9f54-9e3cc067bbad" providerId="ADAL" clId="{C4A3F957-80F5-411E-ACAE-8321A9B839DD}" dt="2024-02-23T19:39:52.110" v="134"/>
          <ac:spMkLst>
            <pc:docMk/>
            <pc:sldMk cId="1807957567" sldId="279"/>
            <ac:spMk id="15" creationId="{91066358-8536-0832-6CC0-D39F72B4FDE1}"/>
          </ac:spMkLst>
        </pc:spChg>
      </pc:sldChg>
      <pc:sldChg chg="modSp">
        <pc:chgData name="Casas, Jorge Andres (Alliance Bioversity-CIAT)" userId="0214a199-ccc4-4ec8-9f54-9e3cc067bbad" providerId="ADAL" clId="{C4A3F957-80F5-411E-ACAE-8321A9B839DD}" dt="2024-02-23T19:39:38.864" v="133"/>
        <pc:sldMkLst>
          <pc:docMk/>
          <pc:sldMk cId="2805558929" sldId="280"/>
        </pc:sldMkLst>
        <pc:spChg chg="mod">
          <ac:chgData name="Casas, Jorge Andres (Alliance Bioversity-CIAT)" userId="0214a199-ccc4-4ec8-9f54-9e3cc067bbad" providerId="ADAL" clId="{C4A3F957-80F5-411E-ACAE-8321A9B839DD}" dt="2024-02-23T19:39:38.864" v="133"/>
          <ac:spMkLst>
            <pc:docMk/>
            <pc:sldMk cId="2805558929" sldId="280"/>
            <ac:spMk id="4" creationId="{590AD048-76EC-C177-43E5-9AD8C3E167C3}"/>
          </ac:spMkLst>
        </pc:spChg>
      </pc:sldChg>
      <pc:sldChg chg="modSp">
        <pc:chgData name="Casas, Jorge Andres (Alliance Bioversity-CIAT)" userId="0214a199-ccc4-4ec8-9f54-9e3cc067bbad" providerId="ADAL" clId="{C4A3F957-80F5-411E-ACAE-8321A9B839DD}" dt="2024-02-23T19:39:38.864" v="133"/>
        <pc:sldMkLst>
          <pc:docMk/>
          <pc:sldMk cId="4087503730" sldId="281"/>
        </pc:sldMkLst>
        <pc:spChg chg="mod">
          <ac:chgData name="Casas, Jorge Andres (Alliance Bioversity-CIAT)" userId="0214a199-ccc4-4ec8-9f54-9e3cc067bbad" providerId="ADAL" clId="{C4A3F957-80F5-411E-ACAE-8321A9B839DD}" dt="2024-02-23T19:39:38.864" v="133"/>
          <ac:spMkLst>
            <pc:docMk/>
            <pc:sldMk cId="4087503730" sldId="281"/>
            <ac:spMk id="15" creationId="{D81AF051-742B-510D-A937-84ABE8E2177F}"/>
          </ac:spMkLst>
        </pc:spChg>
      </pc:sldChg>
      <pc:sldChg chg="modSp">
        <pc:chgData name="Casas, Jorge Andres (Alliance Bioversity-CIAT)" userId="0214a199-ccc4-4ec8-9f54-9e3cc067bbad" providerId="ADAL" clId="{C4A3F957-80F5-411E-ACAE-8321A9B839DD}" dt="2024-02-23T19:39:52.110" v="134"/>
        <pc:sldMkLst>
          <pc:docMk/>
          <pc:sldMk cId="3263789347" sldId="282"/>
        </pc:sldMkLst>
        <pc:spChg chg="mod">
          <ac:chgData name="Casas, Jorge Andres (Alliance Bioversity-CIAT)" userId="0214a199-ccc4-4ec8-9f54-9e3cc067bbad" providerId="ADAL" clId="{C4A3F957-80F5-411E-ACAE-8321A9B839DD}" dt="2024-02-23T19:39:52.110" v="134"/>
          <ac:spMkLst>
            <pc:docMk/>
            <pc:sldMk cId="3263789347" sldId="282"/>
            <ac:spMk id="4" creationId="{D6EE8DF7-A8F4-1113-5585-FD01B8158FB7}"/>
          </ac:spMkLst>
        </pc:spChg>
      </pc:sldChg>
      <pc:sldChg chg="modSp">
        <pc:chgData name="Casas, Jorge Andres (Alliance Bioversity-CIAT)" userId="0214a199-ccc4-4ec8-9f54-9e3cc067bbad" providerId="ADAL" clId="{C4A3F957-80F5-411E-ACAE-8321A9B839DD}" dt="2024-02-23T19:39:52.110" v="134"/>
        <pc:sldMkLst>
          <pc:docMk/>
          <pc:sldMk cId="92458492" sldId="283"/>
        </pc:sldMkLst>
        <pc:spChg chg="mod">
          <ac:chgData name="Casas, Jorge Andres (Alliance Bioversity-CIAT)" userId="0214a199-ccc4-4ec8-9f54-9e3cc067bbad" providerId="ADAL" clId="{C4A3F957-80F5-411E-ACAE-8321A9B839DD}" dt="2024-02-23T19:39:52.110" v="134"/>
          <ac:spMkLst>
            <pc:docMk/>
            <pc:sldMk cId="92458492" sldId="283"/>
            <ac:spMk id="17" creationId="{D2B59B80-0F54-4137-EF91-DEB5CA313D11}"/>
          </ac:spMkLst>
        </pc:spChg>
      </pc:sldChg>
      <pc:sldChg chg="modSp mod">
        <pc:chgData name="Casas, Jorge Andres (Alliance Bioversity-CIAT)" userId="0214a199-ccc4-4ec8-9f54-9e3cc067bbad" providerId="ADAL" clId="{C4A3F957-80F5-411E-ACAE-8321A9B839DD}" dt="2024-02-23T19:28:17.859" v="10" actId="20577"/>
        <pc:sldMkLst>
          <pc:docMk/>
          <pc:sldMk cId="538812795" sldId="285"/>
        </pc:sldMkLst>
        <pc:spChg chg="mod">
          <ac:chgData name="Casas, Jorge Andres (Alliance Bioversity-CIAT)" userId="0214a199-ccc4-4ec8-9f54-9e3cc067bbad" providerId="ADAL" clId="{C4A3F957-80F5-411E-ACAE-8321A9B839DD}" dt="2024-02-23T19:28:17.859" v="10" actId="20577"/>
          <ac:spMkLst>
            <pc:docMk/>
            <pc:sldMk cId="538812795" sldId="285"/>
            <ac:spMk id="17" creationId="{D2B59B80-0F54-4137-EF91-DEB5CA313D11}"/>
          </ac:spMkLst>
        </pc:spChg>
      </pc:sldChg>
      <pc:sldChg chg="modSp">
        <pc:chgData name="Casas, Jorge Andres (Alliance Bioversity-CIAT)" userId="0214a199-ccc4-4ec8-9f54-9e3cc067bbad" providerId="ADAL" clId="{C4A3F957-80F5-411E-ACAE-8321A9B839DD}" dt="2024-02-23T19:39:52.110" v="134"/>
        <pc:sldMkLst>
          <pc:docMk/>
          <pc:sldMk cId="538079865" sldId="286"/>
        </pc:sldMkLst>
        <pc:spChg chg="mod">
          <ac:chgData name="Casas, Jorge Andres (Alliance Bioversity-CIAT)" userId="0214a199-ccc4-4ec8-9f54-9e3cc067bbad" providerId="ADAL" clId="{C4A3F957-80F5-411E-ACAE-8321A9B839DD}" dt="2024-02-23T19:39:52.110" v="134"/>
          <ac:spMkLst>
            <pc:docMk/>
            <pc:sldMk cId="538079865" sldId="286"/>
            <ac:spMk id="4" creationId="{0A58DEAC-71E6-A0CB-10CE-65C2187D93E9}"/>
          </ac:spMkLst>
        </pc:spChg>
      </pc:sldChg>
      <pc:sldChg chg="modSp mod">
        <pc:chgData name="Casas, Jorge Andres (Alliance Bioversity-CIAT)" userId="0214a199-ccc4-4ec8-9f54-9e3cc067bbad" providerId="ADAL" clId="{C4A3F957-80F5-411E-ACAE-8321A9B839DD}" dt="2024-02-23T19:31:08.401" v="14" actId="6549"/>
        <pc:sldMkLst>
          <pc:docMk/>
          <pc:sldMk cId="2030033983" sldId="287"/>
        </pc:sldMkLst>
        <pc:spChg chg="mod">
          <ac:chgData name="Casas, Jorge Andres (Alliance Bioversity-CIAT)" userId="0214a199-ccc4-4ec8-9f54-9e3cc067bbad" providerId="ADAL" clId="{C4A3F957-80F5-411E-ACAE-8321A9B839DD}" dt="2024-02-23T19:31:08.401" v="14" actId="6549"/>
          <ac:spMkLst>
            <pc:docMk/>
            <pc:sldMk cId="2030033983" sldId="287"/>
            <ac:spMk id="19" creationId="{00000000-0000-0000-0000-000000000000}"/>
          </ac:spMkLst>
        </pc:spChg>
      </pc:sldChg>
      <pc:sldChg chg="addSp delSp modSp new mod">
        <pc:chgData name="Casas, Jorge Andres (Alliance Bioversity-CIAT)" userId="0214a199-ccc4-4ec8-9f54-9e3cc067bbad" providerId="ADAL" clId="{C4A3F957-80F5-411E-ACAE-8321A9B839DD}" dt="2024-02-23T19:39:11.465" v="132" actId="20577"/>
        <pc:sldMkLst>
          <pc:docMk/>
          <pc:sldMk cId="3365217080" sldId="288"/>
        </pc:sldMkLst>
        <pc:spChg chg="del">
          <ac:chgData name="Casas, Jorge Andres (Alliance Bioversity-CIAT)" userId="0214a199-ccc4-4ec8-9f54-9e3cc067bbad" providerId="ADAL" clId="{C4A3F957-80F5-411E-ACAE-8321A9B839DD}" dt="2024-02-23T15:29:05.371" v="1" actId="478"/>
          <ac:spMkLst>
            <pc:docMk/>
            <pc:sldMk cId="3365217080" sldId="288"/>
            <ac:spMk id="2" creationId="{ED653305-A71E-7E13-FE20-275F70A979E3}"/>
          </ac:spMkLst>
        </pc:spChg>
        <pc:spChg chg="del">
          <ac:chgData name="Casas, Jorge Andres (Alliance Bioversity-CIAT)" userId="0214a199-ccc4-4ec8-9f54-9e3cc067bbad" providerId="ADAL" clId="{C4A3F957-80F5-411E-ACAE-8321A9B839DD}" dt="2024-02-23T15:29:05.371" v="1" actId="478"/>
          <ac:spMkLst>
            <pc:docMk/>
            <pc:sldMk cId="3365217080" sldId="288"/>
            <ac:spMk id="3" creationId="{E4EBE5E8-D896-9429-CD0A-9823F9A8A1C5}"/>
          </ac:spMkLst>
        </pc:spChg>
        <pc:spChg chg="add del mod">
          <ac:chgData name="Casas, Jorge Andres (Alliance Bioversity-CIAT)" userId="0214a199-ccc4-4ec8-9f54-9e3cc067bbad" providerId="ADAL" clId="{C4A3F957-80F5-411E-ACAE-8321A9B839DD}" dt="2024-02-23T15:29:12.956" v="4" actId="478"/>
          <ac:spMkLst>
            <pc:docMk/>
            <pc:sldMk cId="3365217080" sldId="288"/>
            <ac:spMk id="4" creationId="{7EFA0A56-0701-1B16-6898-B5425703D2B9}"/>
          </ac:spMkLst>
        </pc:spChg>
        <pc:spChg chg="add del mod">
          <ac:chgData name="Casas, Jorge Andres (Alliance Bioversity-CIAT)" userId="0214a199-ccc4-4ec8-9f54-9e3cc067bbad" providerId="ADAL" clId="{C4A3F957-80F5-411E-ACAE-8321A9B839DD}" dt="2024-02-23T15:29:11.144" v="3" actId="478"/>
          <ac:spMkLst>
            <pc:docMk/>
            <pc:sldMk cId="3365217080" sldId="288"/>
            <ac:spMk id="13" creationId="{3737AB3C-AF5C-CE5C-83F1-D266D105BDDE}"/>
          </ac:spMkLst>
        </pc:spChg>
        <pc:spChg chg="add del mod">
          <ac:chgData name="Casas, Jorge Andres (Alliance Bioversity-CIAT)" userId="0214a199-ccc4-4ec8-9f54-9e3cc067bbad" providerId="ADAL" clId="{C4A3F957-80F5-411E-ACAE-8321A9B839DD}" dt="2024-02-23T15:29:15.060" v="5" actId="478"/>
          <ac:spMkLst>
            <pc:docMk/>
            <pc:sldMk cId="3365217080" sldId="288"/>
            <ac:spMk id="15" creationId="{C92E6C60-4806-CAB3-C7F2-776B3660C19A}"/>
          </ac:spMkLst>
        </pc:spChg>
        <pc:spChg chg="add mod">
          <ac:chgData name="Casas, Jorge Andres (Alliance Bioversity-CIAT)" userId="0214a199-ccc4-4ec8-9f54-9e3cc067bbad" providerId="ADAL" clId="{C4A3F957-80F5-411E-ACAE-8321A9B839DD}" dt="2024-02-23T19:39:11.465" v="132" actId="20577"/>
          <ac:spMkLst>
            <pc:docMk/>
            <pc:sldMk cId="3365217080" sldId="288"/>
            <ac:spMk id="16" creationId="{7C81A13D-B66F-0301-30E7-71502095F22D}"/>
          </ac:spMkLst>
        </pc:spChg>
        <pc:picChg chg="add mod">
          <ac:chgData name="Casas, Jorge Andres (Alliance Bioversity-CIAT)" userId="0214a199-ccc4-4ec8-9f54-9e3cc067bbad" providerId="ADAL" clId="{C4A3F957-80F5-411E-ACAE-8321A9B839DD}" dt="2024-02-23T19:38:05.459" v="48" actId="1036"/>
          <ac:picMkLst>
            <pc:docMk/>
            <pc:sldMk cId="3365217080" sldId="288"/>
            <ac:picMk id="5" creationId="{E0412B99-BF1A-AA8F-A901-991A526E1478}"/>
          </ac:picMkLst>
        </pc:picChg>
        <pc:picChg chg="add mod">
          <ac:chgData name="Casas, Jorge Andres (Alliance Bioversity-CIAT)" userId="0214a199-ccc4-4ec8-9f54-9e3cc067bbad" providerId="ADAL" clId="{C4A3F957-80F5-411E-ACAE-8321A9B839DD}" dt="2024-02-23T19:38:05.459" v="48" actId="1036"/>
          <ac:picMkLst>
            <pc:docMk/>
            <pc:sldMk cId="3365217080" sldId="288"/>
            <ac:picMk id="6" creationId="{22405392-9B4F-E742-0A48-1600A4286F7C}"/>
          </ac:picMkLst>
        </pc:picChg>
        <pc:picChg chg="add mod">
          <ac:chgData name="Casas, Jorge Andres (Alliance Bioversity-CIAT)" userId="0214a199-ccc4-4ec8-9f54-9e3cc067bbad" providerId="ADAL" clId="{C4A3F957-80F5-411E-ACAE-8321A9B839DD}" dt="2024-02-23T19:38:05.459" v="48" actId="1036"/>
          <ac:picMkLst>
            <pc:docMk/>
            <pc:sldMk cId="3365217080" sldId="288"/>
            <ac:picMk id="7" creationId="{78C09006-1121-F608-6B5D-F3AE9664EAF3}"/>
          </ac:picMkLst>
        </pc:picChg>
        <pc:picChg chg="add mod">
          <ac:chgData name="Casas, Jorge Andres (Alliance Bioversity-CIAT)" userId="0214a199-ccc4-4ec8-9f54-9e3cc067bbad" providerId="ADAL" clId="{C4A3F957-80F5-411E-ACAE-8321A9B839DD}" dt="2024-02-23T19:38:05.459" v="48" actId="1036"/>
          <ac:picMkLst>
            <pc:docMk/>
            <pc:sldMk cId="3365217080" sldId="288"/>
            <ac:picMk id="8" creationId="{478FEA6B-C769-2126-44A3-AB145D4B85EE}"/>
          </ac:picMkLst>
        </pc:picChg>
        <pc:picChg chg="add mod">
          <ac:chgData name="Casas, Jorge Andres (Alliance Bioversity-CIAT)" userId="0214a199-ccc4-4ec8-9f54-9e3cc067bbad" providerId="ADAL" clId="{C4A3F957-80F5-411E-ACAE-8321A9B839DD}" dt="2024-02-23T19:38:05.459" v="48" actId="1036"/>
          <ac:picMkLst>
            <pc:docMk/>
            <pc:sldMk cId="3365217080" sldId="288"/>
            <ac:picMk id="9" creationId="{AA131FFD-9E02-B739-4B33-23AF6A896C83}"/>
          </ac:picMkLst>
        </pc:picChg>
        <pc:picChg chg="add mod">
          <ac:chgData name="Casas, Jorge Andres (Alliance Bioversity-CIAT)" userId="0214a199-ccc4-4ec8-9f54-9e3cc067bbad" providerId="ADAL" clId="{C4A3F957-80F5-411E-ACAE-8321A9B839DD}" dt="2024-02-23T19:38:05.459" v="48" actId="1036"/>
          <ac:picMkLst>
            <pc:docMk/>
            <pc:sldMk cId="3365217080" sldId="288"/>
            <ac:picMk id="10" creationId="{924FF3B9-F419-CAB0-202E-DBF3CED70F3A}"/>
          </ac:picMkLst>
        </pc:picChg>
        <pc:picChg chg="add mod">
          <ac:chgData name="Casas, Jorge Andres (Alliance Bioversity-CIAT)" userId="0214a199-ccc4-4ec8-9f54-9e3cc067bbad" providerId="ADAL" clId="{C4A3F957-80F5-411E-ACAE-8321A9B839DD}" dt="2024-02-23T19:38:05.459" v="48" actId="1036"/>
          <ac:picMkLst>
            <pc:docMk/>
            <pc:sldMk cId="3365217080" sldId="288"/>
            <ac:picMk id="11" creationId="{96593931-C770-C285-36DF-CD3E9C782653}"/>
          </ac:picMkLst>
        </pc:picChg>
        <pc:picChg chg="add mod">
          <ac:chgData name="Casas, Jorge Andres (Alliance Bioversity-CIAT)" userId="0214a199-ccc4-4ec8-9f54-9e3cc067bbad" providerId="ADAL" clId="{C4A3F957-80F5-411E-ACAE-8321A9B839DD}" dt="2024-02-23T19:38:05.459" v="48" actId="1036"/>
          <ac:picMkLst>
            <pc:docMk/>
            <pc:sldMk cId="3365217080" sldId="288"/>
            <ac:picMk id="12" creationId="{BD028332-F843-E1A5-CAFB-463FB0A26EE1}"/>
          </ac:picMkLst>
        </pc:picChg>
      </pc:sldChg>
    </pc:docChg>
  </pc:docChgLst>
  <pc:docChgLst>
    <pc:chgData name="Selvaraj, Michael (CIAT)" userId="S::m.selvaraj@cgiar.org::62d3ea7d-90b1-4df5-a311-114b51364b02" providerId="AD" clId="Web-{8C9D1162-54E0-C709-6212-223A73BC9212}"/>
    <pc:docChg chg="modSld">
      <pc:chgData name="Selvaraj, Michael (CIAT)" userId="S::m.selvaraj@cgiar.org::62d3ea7d-90b1-4df5-a311-114b51364b02" providerId="AD" clId="Web-{8C9D1162-54E0-C709-6212-223A73BC9212}" dt="2019-04-18T10:58:05.493" v="14" actId="20577"/>
      <pc:docMkLst>
        <pc:docMk/>
      </pc:docMkLst>
      <pc:sldChg chg="modSp">
        <pc:chgData name="Selvaraj, Michael (CIAT)" userId="S::m.selvaraj@cgiar.org::62d3ea7d-90b1-4df5-a311-114b51364b02" providerId="AD" clId="Web-{8C9D1162-54E0-C709-6212-223A73BC9212}" dt="2019-04-18T10:57:52.868" v="8" actId="20577"/>
        <pc:sldMkLst>
          <pc:docMk/>
          <pc:sldMk cId="4268846717" sldId="263"/>
        </pc:sldMkLst>
        <pc:spChg chg="mod">
          <ac:chgData name="Selvaraj, Michael (CIAT)" userId="S::m.selvaraj@cgiar.org::62d3ea7d-90b1-4df5-a311-114b51364b02" providerId="AD" clId="Web-{8C9D1162-54E0-C709-6212-223A73BC9212}" dt="2019-04-18T10:57:52.868" v="8" actId="20577"/>
          <ac:spMkLst>
            <pc:docMk/>
            <pc:sldMk cId="4268846717" sldId="263"/>
            <ac:spMk id="3" creationId="{C4105DC1-8271-4B95-A636-619CDE6535F6}"/>
          </ac:spMkLst>
        </pc:spChg>
      </pc:sldChg>
      <pc:sldChg chg="modSp">
        <pc:chgData name="Selvaraj, Michael (CIAT)" userId="S::m.selvaraj@cgiar.org::62d3ea7d-90b1-4df5-a311-114b51364b02" providerId="AD" clId="Web-{8C9D1162-54E0-C709-6212-223A73BC9212}" dt="2019-04-18T10:57:37.743" v="3" actId="20577"/>
        <pc:sldMkLst>
          <pc:docMk/>
          <pc:sldMk cId="1117611040" sldId="264"/>
        </pc:sldMkLst>
        <pc:spChg chg="mod">
          <ac:chgData name="Selvaraj, Michael (CIAT)" userId="S::m.selvaraj@cgiar.org::62d3ea7d-90b1-4df5-a311-114b51364b02" providerId="AD" clId="Web-{8C9D1162-54E0-C709-6212-223A73BC9212}" dt="2019-04-18T10:57:37.743" v="3" actId="20577"/>
          <ac:spMkLst>
            <pc:docMk/>
            <pc:sldMk cId="1117611040" sldId="264"/>
            <ac:spMk id="2" creationId="{00000000-0000-0000-0000-000000000000}"/>
          </ac:spMkLst>
        </pc:spChg>
      </pc:sldChg>
      <pc:sldChg chg="modSp">
        <pc:chgData name="Selvaraj, Michael (CIAT)" userId="S::m.selvaraj@cgiar.org::62d3ea7d-90b1-4df5-a311-114b51364b02" providerId="AD" clId="Web-{8C9D1162-54E0-C709-6212-223A73BC9212}" dt="2019-04-18T10:58:04.853" v="13" actId="20577"/>
        <pc:sldMkLst>
          <pc:docMk/>
          <pc:sldMk cId="324394477" sldId="265"/>
        </pc:sldMkLst>
        <pc:spChg chg="mod">
          <ac:chgData name="Selvaraj, Michael (CIAT)" userId="S::m.selvaraj@cgiar.org::62d3ea7d-90b1-4df5-a311-114b51364b02" providerId="AD" clId="Web-{8C9D1162-54E0-C709-6212-223A73BC9212}" dt="2019-04-18T10:58:04.853" v="13" actId="20577"/>
          <ac:spMkLst>
            <pc:docMk/>
            <pc:sldMk cId="324394477" sldId="265"/>
            <ac:spMk id="15" creationId="{A331AB26-56D8-4BCA-8AAB-C188316A8DF2}"/>
          </ac:spMkLst>
        </pc:spChg>
      </pc:sldChg>
    </pc:docChg>
  </pc:docChgLst>
  <pc:docChgLst>
    <pc:chgData name="Casas, Jorge Andres (Alliance Bioversity-CIAT)" userId="0214a199-ccc4-4ec8-9f54-9e3cc067bbad" providerId="ADAL" clId="{37E63AB7-4A5F-419F-8218-5EF19E7AF9E2}"/>
    <pc:docChg chg="modNotesMaster">
      <pc:chgData name="Casas, Jorge Andres (Alliance Bioversity-CIAT)" userId="0214a199-ccc4-4ec8-9f54-9e3cc067bbad" providerId="ADAL" clId="{37E63AB7-4A5F-419F-8218-5EF19E7AF9E2}" dt="2023-11-03T13:56:04.382" v="0"/>
      <pc:docMkLst>
        <pc:docMk/>
      </pc:docMkLst>
    </pc:docChg>
  </pc:docChgLst>
  <pc:docChgLst>
    <pc:chgData name="Vergara, Javier (CIAT)" userId="S::j.vergara@cgiar.org::1737bf23-10e4-4004-af57-20e81a1f7d95" providerId="AD" clId="Web-{6BAC3373-A75E-08DA-5E4D-73AAD3997492}"/>
    <pc:docChg chg="addSld delSld modSld">
      <pc:chgData name="Vergara, Javier (CIAT)" userId="S::j.vergara@cgiar.org::1737bf23-10e4-4004-af57-20e81a1f7d95" providerId="AD" clId="Web-{6BAC3373-A75E-08DA-5E4D-73AAD3997492}" dt="2019-04-08T06:16:49.630" v="248" actId="1076"/>
      <pc:docMkLst>
        <pc:docMk/>
      </pc:docMkLst>
      <pc:sldChg chg="modSp">
        <pc:chgData name="Vergara, Javier (CIAT)" userId="S::j.vergara@cgiar.org::1737bf23-10e4-4004-af57-20e81a1f7d95" providerId="AD" clId="Web-{6BAC3373-A75E-08DA-5E4D-73AAD3997492}" dt="2019-04-08T06:09:50.101" v="4" actId="14100"/>
        <pc:sldMkLst>
          <pc:docMk/>
          <pc:sldMk cId="4268846717" sldId="263"/>
        </pc:sldMkLst>
        <pc:picChg chg="mod">
          <ac:chgData name="Vergara, Javier (CIAT)" userId="S::j.vergara@cgiar.org::1737bf23-10e4-4004-af57-20e81a1f7d95" providerId="AD" clId="Web-{6BAC3373-A75E-08DA-5E4D-73AAD3997492}" dt="2019-04-08T06:09:50.101" v="4" actId="14100"/>
          <ac:picMkLst>
            <pc:docMk/>
            <pc:sldMk cId="4268846717" sldId="263"/>
            <ac:picMk id="17" creationId="{00000000-0000-0000-0000-000000000000}"/>
          </ac:picMkLst>
        </pc:picChg>
      </pc:sldChg>
      <pc:sldChg chg="addSp delSp modSp new">
        <pc:chgData name="Vergara, Javier (CIAT)" userId="S::j.vergara@cgiar.org::1737bf23-10e4-4004-af57-20e81a1f7d95" providerId="AD" clId="Web-{6BAC3373-A75E-08DA-5E4D-73AAD3997492}" dt="2019-04-08T06:16:49.630" v="248" actId="1076"/>
        <pc:sldMkLst>
          <pc:docMk/>
          <pc:sldMk cId="1117611040" sldId="264"/>
        </pc:sldMkLst>
        <pc:spChg chg="del">
          <ac:chgData name="Vergara, Javier (CIAT)" userId="S::j.vergara@cgiar.org::1737bf23-10e4-4004-af57-20e81a1f7d95" providerId="AD" clId="Web-{6BAC3373-A75E-08DA-5E4D-73AAD3997492}" dt="2019-04-08T06:10:11.617" v="6"/>
          <ac:spMkLst>
            <pc:docMk/>
            <pc:sldMk cId="1117611040" sldId="264"/>
            <ac:spMk id="3" creationId="{985FA322-AF0B-48FB-B3F1-7E2799544AB2}"/>
          </ac:spMkLst>
        </pc:spChg>
        <pc:spChg chg="add mod">
          <ac:chgData name="Vergara, Javier (CIAT)" userId="S::j.vergara@cgiar.org::1737bf23-10e4-4004-af57-20e81a1f7d95" providerId="AD" clId="Web-{6BAC3373-A75E-08DA-5E4D-73AAD3997492}" dt="2019-04-08T06:11:28.319" v="24" actId="1076"/>
          <ac:spMkLst>
            <pc:docMk/>
            <pc:sldMk cId="1117611040" sldId="264"/>
            <ac:spMk id="8" creationId="{9825BB65-79A6-4A02-AF28-230F124F498C}"/>
          </ac:spMkLst>
        </pc:spChg>
        <pc:spChg chg="add mod">
          <ac:chgData name="Vergara, Javier (CIAT)" userId="S::j.vergara@cgiar.org::1737bf23-10e4-4004-af57-20e81a1f7d95" providerId="AD" clId="Web-{6BAC3373-A75E-08DA-5E4D-73AAD3997492}" dt="2019-04-08T06:11:35.726" v="27" actId="20577"/>
          <ac:spMkLst>
            <pc:docMk/>
            <pc:sldMk cId="1117611040" sldId="264"/>
            <ac:spMk id="9" creationId="{6680D46E-C93C-411B-8686-106BE123D0E5}"/>
          </ac:spMkLst>
        </pc:spChg>
        <pc:spChg chg="add mod">
          <ac:chgData name="Vergara, Javier (CIAT)" userId="S::j.vergara@cgiar.org::1737bf23-10e4-4004-af57-20e81a1f7d95" providerId="AD" clId="Web-{6BAC3373-A75E-08DA-5E4D-73AAD3997492}" dt="2019-04-08T06:11:42.554" v="31" actId="20577"/>
          <ac:spMkLst>
            <pc:docMk/>
            <pc:sldMk cId="1117611040" sldId="264"/>
            <ac:spMk id="10" creationId="{E58F3034-09D8-4E32-AB7B-11AAC123BCCB}"/>
          </ac:spMkLst>
        </pc:spChg>
        <pc:spChg chg="add mod">
          <ac:chgData name="Vergara, Javier (CIAT)" userId="S::j.vergara@cgiar.org::1737bf23-10e4-4004-af57-20e81a1f7d95" providerId="AD" clId="Web-{6BAC3373-A75E-08DA-5E4D-73AAD3997492}" dt="2019-04-08T06:11:50.616" v="36" actId="20577"/>
          <ac:spMkLst>
            <pc:docMk/>
            <pc:sldMk cId="1117611040" sldId="264"/>
            <ac:spMk id="11" creationId="{93F0EB0A-A368-4AEB-8410-7A74313C5F7D}"/>
          </ac:spMkLst>
        </pc:spChg>
        <pc:spChg chg="add mod">
          <ac:chgData name="Vergara, Javier (CIAT)" userId="S::j.vergara@cgiar.org::1737bf23-10e4-4004-af57-20e81a1f7d95" providerId="AD" clId="Web-{6BAC3373-A75E-08DA-5E4D-73AAD3997492}" dt="2019-04-08T06:13:16.522" v="229" actId="20577"/>
          <ac:spMkLst>
            <pc:docMk/>
            <pc:sldMk cId="1117611040" sldId="264"/>
            <ac:spMk id="12" creationId="{0380B87A-5D9C-4073-9524-B60B7B7EE069}"/>
          </ac:spMkLst>
        </pc:spChg>
        <pc:picChg chg="add mod ord">
          <ac:chgData name="Vergara, Javier (CIAT)" userId="S::j.vergara@cgiar.org::1737bf23-10e4-4004-af57-20e81a1f7d95" providerId="AD" clId="Web-{6BAC3373-A75E-08DA-5E4D-73AAD3997492}" dt="2019-04-08T06:16:49.630" v="248" actId="1076"/>
          <ac:picMkLst>
            <pc:docMk/>
            <pc:sldMk cId="1117611040" sldId="264"/>
            <ac:picMk id="4" creationId="{09A2864C-9A5C-47CD-AD3F-4B2D3F04071E}"/>
          </ac:picMkLst>
        </pc:picChg>
        <pc:picChg chg="add mod">
          <ac:chgData name="Vergara, Javier (CIAT)" userId="S::j.vergara@cgiar.org::1737bf23-10e4-4004-af57-20e81a1f7d95" providerId="AD" clId="Web-{6BAC3373-A75E-08DA-5E4D-73AAD3997492}" dt="2019-04-08T06:16:41.723" v="245" actId="1076"/>
          <ac:picMkLst>
            <pc:docMk/>
            <pc:sldMk cId="1117611040" sldId="264"/>
            <ac:picMk id="6" creationId="{FA9DC823-AE4A-4B1A-8D4B-056D587CCAD4}"/>
          </ac:picMkLst>
        </pc:picChg>
        <pc:picChg chg="add mod">
          <ac:chgData name="Vergara, Javier (CIAT)" userId="S::j.vergara@cgiar.org::1737bf23-10e4-4004-af57-20e81a1f7d95" providerId="AD" clId="Web-{6BAC3373-A75E-08DA-5E4D-73AAD3997492}" dt="2019-04-08T06:16:01.051" v="235" actId="1076"/>
          <ac:picMkLst>
            <pc:docMk/>
            <pc:sldMk cId="1117611040" sldId="264"/>
            <ac:picMk id="13" creationId="{4F8BD1F3-FA77-454A-9F47-A3123007CCAE}"/>
          </ac:picMkLst>
        </pc:picChg>
        <pc:picChg chg="add mod">
          <ac:chgData name="Vergara, Javier (CIAT)" userId="S::j.vergara@cgiar.org::1737bf23-10e4-4004-af57-20e81a1f7d95" providerId="AD" clId="Web-{6BAC3373-A75E-08DA-5E4D-73AAD3997492}" dt="2019-04-08T06:16:18.145" v="239" actId="1076"/>
          <ac:picMkLst>
            <pc:docMk/>
            <pc:sldMk cId="1117611040" sldId="264"/>
            <ac:picMk id="15" creationId="{9FCFBBC3-8923-45C5-8637-32BAFF47D5C5}"/>
          </ac:picMkLst>
        </pc:picChg>
      </pc:sldChg>
    </pc:docChg>
  </pc:docChgLst>
  <pc:docChgLst>
    <pc:chgData name="Guest User" userId="S::urn:spo:anon#e12410dc68466febaef9ad7392753b62dde60c6ec21f80702afe71e6d1fcaf1f::" providerId="AD" clId="Web-{12A031E7-B2A7-3A85-43DD-462F6C1961B5}"/>
    <pc:docChg chg="modSld">
      <pc:chgData name="Guest User" userId="S::urn:spo:anon#e12410dc68466febaef9ad7392753b62dde60c6ec21f80702afe71e6d1fcaf1f::" providerId="AD" clId="Web-{12A031E7-B2A7-3A85-43DD-462F6C1961B5}" dt="2019-04-08T05:24:19.135" v="8" actId="14100"/>
      <pc:docMkLst>
        <pc:docMk/>
      </pc:docMkLst>
      <pc:sldChg chg="modSp">
        <pc:chgData name="Guest User" userId="S::urn:spo:anon#e12410dc68466febaef9ad7392753b62dde60c6ec21f80702afe71e6d1fcaf1f::" providerId="AD" clId="Web-{12A031E7-B2A7-3A85-43DD-462F6C1961B5}" dt="2019-04-08T05:24:19.135" v="8" actId="14100"/>
        <pc:sldMkLst>
          <pc:docMk/>
          <pc:sldMk cId="4268846717" sldId="263"/>
        </pc:sldMkLst>
        <pc:picChg chg="mod">
          <ac:chgData name="Guest User" userId="S::urn:spo:anon#e12410dc68466febaef9ad7392753b62dde60c6ec21f80702afe71e6d1fcaf1f::" providerId="AD" clId="Web-{12A031E7-B2A7-3A85-43DD-462F6C1961B5}" dt="2019-04-08T05:12:56.264" v="6" actId="14100"/>
          <ac:picMkLst>
            <pc:docMk/>
            <pc:sldMk cId="4268846717" sldId="263"/>
            <ac:picMk id="2" creationId="{B356A16D-3FA5-40B2-9B19-6EFF986F3416}"/>
          </ac:picMkLst>
        </pc:picChg>
        <pc:picChg chg="mod">
          <ac:chgData name="Guest User" userId="S::urn:spo:anon#e12410dc68466febaef9ad7392753b62dde60c6ec21f80702afe71e6d1fcaf1f::" providerId="AD" clId="Web-{12A031E7-B2A7-3A85-43DD-462F6C1961B5}" dt="2019-04-08T05:12:50.170" v="4" actId="14100"/>
          <ac:picMkLst>
            <pc:docMk/>
            <pc:sldMk cId="4268846717" sldId="263"/>
            <ac:picMk id="9" creationId="{8323EDC2-9D0B-47B4-B7A2-98BA8C6BE457}"/>
          </ac:picMkLst>
        </pc:picChg>
        <pc:picChg chg="mod">
          <ac:chgData name="Guest User" userId="S::urn:spo:anon#e12410dc68466febaef9ad7392753b62dde60c6ec21f80702afe71e6d1fcaf1f::" providerId="AD" clId="Web-{12A031E7-B2A7-3A85-43DD-462F6C1961B5}" dt="2019-04-08T05:10:13.655" v="1" actId="14100"/>
          <ac:picMkLst>
            <pc:docMk/>
            <pc:sldMk cId="4268846717" sldId="263"/>
            <ac:picMk id="15" creationId="{5610B0A4-CC2B-4CB1-8AF4-7D24C5539CAB}"/>
          </ac:picMkLst>
        </pc:picChg>
        <pc:picChg chg="mod">
          <ac:chgData name="Guest User" userId="S::urn:spo:anon#e12410dc68466febaef9ad7392753b62dde60c6ec21f80702afe71e6d1fcaf1f::" providerId="AD" clId="Web-{12A031E7-B2A7-3A85-43DD-462F6C1961B5}" dt="2019-04-08T05:24:19.135" v="8" actId="14100"/>
          <ac:picMkLst>
            <pc:docMk/>
            <pc:sldMk cId="4268846717" sldId="263"/>
            <ac:picMk id="17" creationId="{00000000-0000-0000-0000-000000000000}"/>
          </ac:picMkLst>
        </pc:picChg>
      </pc:sldChg>
    </pc:docChg>
  </pc:docChgLst>
  <pc:docChgLst>
    <pc:chgData name="Vergara, Javier (CIAT)" userId="S::j.vergara@cgiar.org::1737bf23-10e4-4004-af57-20e81a1f7d95" providerId="AD" clId="Web-{DD190364-8FAF-7E47-E448-FC47CA6AC1C1}"/>
    <pc:docChg chg="modSld">
      <pc:chgData name="Vergara, Javier (CIAT)" userId="S::j.vergara@cgiar.org::1737bf23-10e4-4004-af57-20e81a1f7d95" providerId="AD" clId="Web-{DD190364-8FAF-7E47-E448-FC47CA6AC1C1}" dt="2019-04-09T18:29:25.471" v="17" actId="1076"/>
      <pc:docMkLst>
        <pc:docMk/>
      </pc:docMkLst>
      <pc:sldChg chg="addSp delSp modSp">
        <pc:chgData name="Vergara, Javier (CIAT)" userId="S::j.vergara@cgiar.org::1737bf23-10e4-4004-af57-20e81a1f7d95" providerId="AD" clId="Web-{DD190364-8FAF-7E47-E448-FC47CA6AC1C1}" dt="2019-04-09T18:29:25.471" v="17" actId="1076"/>
        <pc:sldMkLst>
          <pc:docMk/>
          <pc:sldMk cId="1117611040" sldId="264"/>
        </pc:sldMkLst>
        <pc:spChg chg="del">
          <ac:chgData name="Vergara, Javier (CIAT)" userId="S::j.vergara@cgiar.org::1737bf23-10e4-4004-af57-20e81a1f7d95" providerId="AD" clId="Web-{DD190364-8FAF-7E47-E448-FC47CA6AC1C1}" dt="2019-04-09T18:28:38.143" v="9"/>
          <ac:spMkLst>
            <pc:docMk/>
            <pc:sldMk cId="1117611040" sldId="264"/>
            <ac:spMk id="2" creationId="{0BDADDF9-DBEB-4B53-865F-5207B09C354A}"/>
          </ac:spMkLst>
        </pc:spChg>
        <pc:spChg chg="mod">
          <ac:chgData name="Vergara, Javier (CIAT)" userId="S::j.vergara@cgiar.org::1737bf23-10e4-4004-af57-20e81a1f7d95" providerId="AD" clId="Web-{DD190364-8FAF-7E47-E448-FC47CA6AC1C1}" dt="2019-04-09T18:28:49.033" v="11" actId="1076"/>
          <ac:spMkLst>
            <pc:docMk/>
            <pc:sldMk cId="1117611040" sldId="264"/>
            <ac:spMk id="9" creationId="{6680D46E-C93C-411B-8686-106BE123D0E5}"/>
          </ac:spMkLst>
        </pc:spChg>
        <pc:spChg chg="mod">
          <ac:chgData name="Vergara, Javier (CIAT)" userId="S::j.vergara@cgiar.org::1737bf23-10e4-4004-af57-20e81a1f7d95" providerId="AD" clId="Web-{DD190364-8FAF-7E47-E448-FC47CA6AC1C1}" dt="2019-04-09T18:28:59.018" v="13" actId="1076"/>
          <ac:spMkLst>
            <pc:docMk/>
            <pc:sldMk cId="1117611040" sldId="264"/>
            <ac:spMk id="10" creationId="{E58F3034-09D8-4E32-AB7B-11AAC123BCCB}"/>
          </ac:spMkLst>
        </pc:spChg>
        <pc:spChg chg="mod">
          <ac:chgData name="Vergara, Javier (CIAT)" userId="S::j.vergara@cgiar.org::1737bf23-10e4-4004-af57-20e81a1f7d95" providerId="AD" clId="Web-{DD190364-8FAF-7E47-E448-FC47CA6AC1C1}" dt="2019-04-09T18:29:13.486" v="15" actId="1076"/>
          <ac:spMkLst>
            <pc:docMk/>
            <pc:sldMk cId="1117611040" sldId="264"/>
            <ac:spMk id="11" creationId="{93F0EB0A-A368-4AEB-8410-7A74313C5F7D}"/>
          </ac:spMkLst>
        </pc:spChg>
        <pc:spChg chg="mod">
          <ac:chgData name="Vergara, Javier (CIAT)" userId="S::j.vergara@cgiar.org::1737bf23-10e4-4004-af57-20e81a1f7d95" providerId="AD" clId="Web-{DD190364-8FAF-7E47-E448-FC47CA6AC1C1}" dt="2019-04-09T18:29:25.471" v="17" actId="1076"/>
          <ac:spMkLst>
            <pc:docMk/>
            <pc:sldMk cId="1117611040" sldId="264"/>
            <ac:spMk id="12" creationId="{0380B87A-5D9C-4073-9524-B60B7B7EE069}"/>
          </ac:spMkLst>
        </pc:spChg>
        <pc:spChg chg="add del mod">
          <ac:chgData name="Vergara, Javier (CIAT)" userId="S::j.vergara@cgiar.org::1737bf23-10e4-4004-af57-20e81a1f7d95" providerId="AD" clId="Web-{DD190364-8FAF-7E47-E448-FC47CA6AC1C1}" dt="2019-04-09T18:28:36.799" v="8"/>
          <ac:spMkLst>
            <pc:docMk/>
            <pc:sldMk cId="1117611040" sldId="264"/>
            <ac:spMk id="14" creationId="{ABA8167C-8360-4ABE-9090-286D222E8681}"/>
          </ac:spMkLst>
        </pc:spChg>
        <pc:picChg chg="add mod">
          <ac:chgData name="Vergara, Javier (CIAT)" userId="S::j.vergara@cgiar.org::1737bf23-10e4-4004-af57-20e81a1f7d95" providerId="AD" clId="Web-{DD190364-8FAF-7E47-E448-FC47CA6AC1C1}" dt="2019-04-09T18:28:41.284" v="10" actId="1076"/>
          <ac:picMkLst>
            <pc:docMk/>
            <pc:sldMk cId="1117611040" sldId="264"/>
            <ac:picMk id="3" creationId="{75E03708-41C2-4BD7-8091-70E67ED3BD5D}"/>
          </ac:picMkLst>
        </pc:picChg>
        <pc:picChg chg="del">
          <ac:chgData name="Vergara, Javier (CIAT)" userId="S::j.vergara@cgiar.org::1737bf23-10e4-4004-af57-20e81a1f7d95" providerId="AD" clId="Web-{DD190364-8FAF-7E47-E448-FC47CA6AC1C1}" dt="2019-04-09T18:28:32.705" v="7"/>
          <ac:picMkLst>
            <pc:docMk/>
            <pc:sldMk cId="1117611040" sldId="264"/>
            <ac:picMk id="4" creationId="{09A2864C-9A5C-47CD-AD3F-4B2D3F04071E}"/>
          </ac:picMkLst>
        </pc:picChg>
        <pc:picChg chg="mod">
          <ac:chgData name="Vergara, Javier (CIAT)" userId="S::j.vergara@cgiar.org::1737bf23-10e4-4004-af57-20e81a1f7d95" providerId="AD" clId="Web-{DD190364-8FAF-7E47-E448-FC47CA6AC1C1}" dt="2019-04-09T18:28:55.752" v="12" actId="1076"/>
          <ac:picMkLst>
            <pc:docMk/>
            <pc:sldMk cId="1117611040" sldId="264"/>
            <ac:picMk id="6" creationId="{FA9DC823-AE4A-4B1A-8D4B-056D587CCAD4}"/>
          </ac:picMkLst>
        </pc:picChg>
        <pc:picChg chg="mod">
          <ac:chgData name="Vergara, Javier (CIAT)" userId="S::j.vergara@cgiar.org::1737bf23-10e4-4004-af57-20e81a1f7d95" providerId="AD" clId="Web-{DD190364-8FAF-7E47-E448-FC47CA6AC1C1}" dt="2019-04-09T18:29:20.471" v="16" actId="1076"/>
          <ac:picMkLst>
            <pc:docMk/>
            <pc:sldMk cId="1117611040" sldId="264"/>
            <ac:picMk id="13" creationId="{4F8BD1F3-FA77-454A-9F47-A3123007CCAE}"/>
          </ac:picMkLst>
        </pc:picChg>
        <pc:picChg chg="mod">
          <ac:chgData name="Vergara, Javier (CIAT)" userId="S::j.vergara@cgiar.org::1737bf23-10e4-4004-af57-20e81a1f7d95" providerId="AD" clId="Web-{DD190364-8FAF-7E47-E448-FC47CA6AC1C1}" dt="2019-04-09T18:29:06.379" v="14" actId="1076"/>
          <ac:picMkLst>
            <pc:docMk/>
            <pc:sldMk cId="1117611040" sldId="264"/>
            <ac:picMk id="15" creationId="{9FCFBBC3-8923-45C5-8637-32BAFF47D5C5}"/>
          </ac:picMkLst>
        </pc:picChg>
      </pc:sldChg>
    </pc:docChg>
  </pc:docChgLst>
  <pc:docChgLst>
    <pc:chgData name="Vergara, Javier (CIAT)" userId="S::j.vergara@cgiar.org::1737bf23-10e4-4004-af57-20e81a1f7d95" providerId="AD" clId="Web-{B641D540-6174-5AAC-7022-371BC2DDCD3C}"/>
    <pc:docChg chg="modSld">
      <pc:chgData name="Vergara, Javier (CIAT)" userId="S::j.vergara@cgiar.org::1737bf23-10e4-4004-af57-20e81a1f7d95" providerId="AD" clId="Web-{B641D540-6174-5AAC-7022-371BC2DDCD3C}" dt="2019-04-23T21:31:38.451" v="115" actId="1076"/>
      <pc:docMkLst>
        <pc:docMk/>
      </pc:docMkLst>
      <pc:sldChg chg="addSp delSp modSp">
        <pc:chgData name="Vergara, Javier (CIAT)" userId="S::j.vergara@cgiar.org::1737bf23-10e4-4004-af57-20e81a1f7d95" providerId="AD" clId="Web-{B641D540-6174-5AAC-7022-371BC2DDCD3C}" dt="2019-04-23T21:31:38.451" v="115" actId="1076"/>
        <pc:sldMkLst>
          <pc:docMk/>
          <pc:sldMk cId="4268846717" sldId="263"/>
        </pc:sldMkLst>
        <pc:spChg chg="mod">
          <ac:chgData name="Vergara, Javier (CIAT)" userId="S::j.vergara@cgiar.org::1737bf23-10e4-4004-af57-20e81a1f7d95" providerId="AD" clId="Web-{B641D540-6174-5AAC-7022-371BC2DDCD3C}" dt="2019-04-23T21:29:21.076" v="87" actId="1076"/>
          <ac:spMkLst>
            <pc:docMk/>
            <pc:sldMk cId="4268846717" sldId="263"/>
            <ac:spMk id="18" creationId="{0B81691F-14FD-4FF6-9182-87316D1768F0}"/>
          </ac:spMkLst>
        </pc:spChg>
        <pc:spChg chg="mod">
          <ac:chgData name="Vergara, Javier (CIAT)" userId="S::j.vergara@cgiar.org::1737bf23-10e4-4004-af57-20e81a1f7d95" providerId="AD" clId="Web-{B641D540-6174-5AAC-7022-371BC2DDCD3C}" dt="2019-04-23T21:31:31.795" v="110" actId="1076"/>
          <ac:spMkLst>
            <pc:docMk/>
            <pc:sldMk cId="4268846717" sldId="263"/>
            <ac:spMk id="20" creationId="{74C04F1A-97C0-4AE5-B250-C93CA5BE8901}"/>
          </ac:spMkLst>
        </pc:spChg>
        <pc:spChg chg="mod">
          <ac:chgData name="Vergara, Javier (CIAT)" userId="S::j.vergara@cgiar.org::1737bf23-10e4-4004-af57-20e81a1f7d95" providerId="AD" clId="Web-{B641D540-6174-5AAC-7022-371BC2DDCD3C}" dt="2019-04-23T21:29:38.545" v="91" actId="1076"/>
          <ac:spMkLst>
            <pc:docMk/>
            <pc:sldMk cId="4268846717" sldId="263"/>
            <ac:spMk id="21" creationId="{F97066A1-36AB-43B0-8803-469F24E054C8}"/>
          </ac:spMkLst>
        </pc:spChg>
        <pc:spChg chg="mod">
          <ac:chgData name="Vergara, Javier (CIAT)" userId="S::j.vergara@cgiar.org::1737bf23-10e4-4004-af57-20e81a1f7d95" providerId="AD" clId="Web-{B641D540-6174-5AAC-7022-371BC2DDCD3C}" dt="2019-04-23T21:31:31.795" v="111" actId="1076"/>
          <ac:spMkLst>
            <pc:docMk/>
            <pc:sldMk cId="4268846717" sldId="263"/>
            <ac:spMk id="22" creationId="{B34BA769-B227-4F2D-BFCA-74A3EB10B6CD}"/>
          </ac:spMkLst>
        </pc:spChg>
        <pc:spChg chg="mod">
          <ac:chgData name="Vergara, Javier (CIAT)" userId="S::j.vergara@cgiar.org::1737bf23-10e4-4004-af57-20e81a1f7d95" providerId="AD" clId="Web-{B641D540-6174-5AAC-7022-371BC2DDCD3C}" dt="2019-04-23T21:29:29.482" v="90" actId="1076"/>
          <ac:spMkLst>
            <pc:docMk/>
            <pc:sldMk cId="4268846717" sldId="263"/>
            <ac:spMk id="23" creationId="{5892EAC2-720C-4D29-9143-09860847058F}"/>
          </ac:spMkLst>
        </pc:spChg>
        <pc:spChg chg="mod">
          <ac:chgData name="Vergara, Javier (CIAT)" userId="S::j.vergara@cgiar.org::1737bf23-10e4-4004-af57-20e81a1f7d95" providerId="AD" clId="Web-{B641D540-6174-5AAC-7022-371BC2DDCD3C}" dt="2019-04-23T21:31:31.795" v="112" actId="1076"/>
          <ac:spMkLst>
            <pc:docMk/>
            <pc:sldMk cId="4268846717" sldId="263"/>
            <ac:spMk id="24" creationId="{B2894B70-0C9C-474A-B676-6381BDACF4AA}"/>
          </ac:spMkLst>
        </pc:spChg>
        <pc:picChg chg="del">
          <ac:chgData name="Vergara, Javier (CIAT)" userId="S::j.vergara@cgiar.org::1737bf23-10e4-4004-af57-20e81a1f7d95" providerId="AD" clId="Web-{B641D540-6174-5AAC-7022-371BC2DDCD3C}" dt="2019-04-23T21:24:38.921" v="3"/>
          <ac:picMkLst>
            <pc:docMk/>
            <pc:sldMk cId="4268846717" sldId="263"/>
            <ac:picMk id="2" creationId="{B356A16D-3FA5-40B2-9B19-6EFF986F3416}"/>
          </ac:picMkLst>
        </pc:picChg>
        <pc:picChg chg="del">
          <ac:chgData name="Vergara, Javier (CIAT)" userId="S::j.vergara@cgiar.org::1737bf23-10e4-4004-af57-20e81a1f7d95" providerId="AD" clId="Web-{B641D540-6174-5AAC-7022-371BC2DDCD3C}" dt="2019-04-23T21:24:38.921" v="2"/>
          <ac:picMkLst>
            <pc:docMk/>
            <pc:sldMk cId="4268846717" sldId="263"/>
            <ac:picMk id="4" creationId="{17A02D8E-EEBD-4E26-9C79-F928D4878934}"/>
          </ac:picMkLst>
        </pc:picChg>
        <pc:picChg chg="add mod ord">
          <ac:chgData name="Vergara, Javier (CIAT)" userId="S::j.vergara@cgiar.org::1737bf23-10e4-4004-af57-20e81a1f7d95" providerId="AD" clId="Web-{B641D540-6174-5AAC-7022-371BC2DDCD3C}" dt="2019-04-23T21:29:05.779" v="51"/>
          <ac:picMkLst>
            <pc:docMk/>
            <pc:sldMk cId="4268846717" sldId="263"/>
            <ac:picMk id="5" creationId="{738AF3C1-9A23-474B-BF3A-EE86B6AE3ABE}"/>
          </ac:picMkLst>
        </pc:picChg>
        <pc:picChg chg="add mod ord">
          <ac:chgData name="Vergara, Javier (CIAT)" userId="S::j.vergara@cgiar.org::1737bf23-10e4-4004-af57-20e81a1f7d95" providerId="AD" clId="Web-{B641D540-6174-5AAC-7022-371BC2DDCD3C}" dt="2019-04-23T21:31:38.420" v="113" actId="1076"/>
          <ac:picMkLst>
            <pc:docMk/>
            <pc:sldMk cId="4268846717" sldId="263"/>
            <ac:picMk id="7" creationId="{ED18B229-E09F-46F0-A6D6-A159F99E9793}"/>
          </ac:picMkLst>
        </pc:picChg>
        <pc:picChg chg="del">
          <ac:chgData name="Vergara, Javier (CIAT)" userId="S::j.vergara@cgiar.org::1737bf23-10e4-4004-af57-20e81a1f7d95" providerId="AD" clId="Web-{B641D540-6174-5AAC-7022-371BC2DDCD3C}" dt="2019-04-23T21:24:38.921" v="1"/>
          <ac:picMkLst>
            <pc:docMk/>
            <pc:sldMk cId="4268846717" sldId="263"/>
            <ac:picMk id="9" creationId="{8323EDC2-9D0B-47B4-B7A2-98BA8C6BE457}"/>
          </ac:picMkLst>
        </pc:picChg>
        <pc:picChg chg="add mod ord">
          <ac:chgData name="Vergara, Javier (CIAT)" userId="S::j.vergara@cgiar.org::1737bf23-10e4-4004-af57-20e81a1f7d95" providerId="AD" clId="Web-{B641D540-6174-5AAC-7022-371BC2DDCD3C}" dt="2019-04-23T21:29:06.092" v="65"/>
          <ac:picMkLst>
            <pc:docMk/>
            <pc:sldMk cId="4268846717" sldId="263"/>
            <ac:picMk id="10" creationId="{ADE2B71A-612C-4DCC-95AE-89C52A2F0959}"/>
          </ac:picMkLst>
        </pc:picChg>
        <pc:picChg chg="add mod ord">
          <ac:chgData name="Vergara, Javier (CIAT)" userId="S::j.vergara@cgiar.org::1737bf23-10e4-4004-af57-20e81a1f7d95" providerId="AD" clId="Web-{B641D540-6174-5AAC-7022-371BC2DDCD3C}" dt="2019-04-23T21:31:38.435" v="114" actId="1076"/>
          <ac:picMkLst>
            <pc:docMk/>
            <pc:sldMk cId="4268846717" sldId="263"/>
            <ac:picMk id="12" creationId="{FC20475A-1DCA-4EA5-8713-9BD7E78B0568}"/>
          </ac:picMkLst>
        </pc:picChg>
        <pc:picChg chg="add mod ord">
          <ac:chgData name="Vergara, Javier (CIAT)" userId="S::j.vergara@cgiar.org::1737bf23-10e4-4004-af57-20e81a1f7d95" providerId="AD" clId="Web-{B641D540-6174-5AAC-7022-371BC2DDCD3C}" dt="2019-04-23T21:31:38.451" v="115" actId="1076"/>
          <ac:picMkLst>
            <pc:docMk/>
            <pc:sldMk cId="4268846717" sldId="263"/>
            <ac:picMk id="14" creationId="{3C7D780C-7E20-458B-BCAF-DFD005C0983C}"/>
          </ac:picMkLst>
        </pc:picChg>
        <pc:picChg chg="del">
          <ac:chgData name="Vergara, Javier (CIAT)" userId="S::j.vergara@cgiar.org::1737bf23-10e4-4004-af57-20e81a1f7d95" providerId="AD" clId="Web-{B641D540-6174-5AAC-7022-371BC2DDCD3C}" dt="2019-04-23T21:24:38.921" v="0"/>
          <ac:picMkLst>
            <pc:docMk/>
            <pc:sldMk cId="4268846717" sldId="263"/>
            <ac:picMk id="15" creationId="{5610B0A4-CC2B-4CB1-8AF4-7D24C5539CAB}"/>
          </ac:picMkLst>
        </pc:picChg>
        <pc:picChg chg="del">
          <ac:chgData name="Vergara, Javier (CIAT)" userId="S::j.vergara@cgiar.org::1737bf23-10e4-4004-af57-20e81a1f7d95" providerId="AD" clId="Web-{B641D540-6174-5AAC-7022-371BC2DDCD3C}" dt="2019-04-23T21:24:38.921" v="5"/>
          <ac:picMkLst>
            <pc:docMk/>
            <pc:sldMk cId="4268846717" sldId="263"/>
            <ac:picMk id="16" creationId="{00000000-0000-0000-0000-000000000000}"/>
          </ac:picMkLst>
        </pc:picChg>
        <pc:picChg chg="del">
          <ac:chgData name="Vergara, Javier (CIAT)" userId="S::j.vergara@cgiar.org::1737bf23-10e4-4004-af57-20e81a1f7d95" providerId="AD" clId="Web-{B641D540-6174-5AAC-7022-371BC2DDCD3C}" dt="2019-04-23T21:24:38.921" v="4"/>
          <ac:picMkLst>
            <pc:docMk/>
            <pc:sldMk cId="4268846717" sldId="263"/>
            <ac:picMk id="17" creationId="{00000000-0000-0000-0000-000000000000}"/>
          </ac:picMkLst>
        </pc:picChg>
        <pc:picChg chg="add mod ord">
          <ac:chgData name="Vergara, Javier (CIAT)" userId="S::j.vergara@cgiar.org::1737bf23-10e4-4004-af57-20e81a1f7d95" providerId="AD" clId="Web-{B641D540-6174-5AAC-7022-371BC2DDCD3C}" dt="2019-04-23T21:29:06.529" v="86"/>
          <ac:picMkLst>
            <pc:docMk/>
            <pc:sldMk cId="4268846717" sldId="263"/>
            <ac:picMk id="25" creationId="{0CF6F019-5972-4758-B67F-D832016BE794}"/>
          </ac:picMkLst>
        </pc:picChg>
      </pc:sldChg>
    </pc:docChg>
  </pc:docChgLst>
  <pc:docChgLst>
    <pc:chgData name="Vergara, Javier (CIAT)" userId="1737bf23-10e4-4004-af57-20e81a1f7d95" providerId="ADAL" clId="{A91EECBA-00AE-4E01-9C0A-45785F63E812}"/>
    <pc:docChg chg="undo custSel modSld">
      <pc:chgData name="Vergara, Javier (CIAT)" userId="1737bf23-10e4-4004-af57-20e81a1f7d95" providerId="ADAL" clId="{A91EECBA-00AE-4E01-9C0A-45785F63E812}" dt="2019-04-13T06:29:41.691" v="90" actId="1076"/>
      <pc:docMkLst>
        <pc:docMk/>
      </pc:docMkLst>
      <pc:sldChg chg="addSp delSp modSp">
        <pc:chgData name="Vergara, Javier (CIAT)" userId="1737bf23-10e4-4004-af57-20e81a1f7d95" providerId="ADAL" clId="{A91EECBA-00AE-4E01-9C0A-45785F63E812}" dt="2019-04-13T06:29:41.691" v="90" actId="1076"/>
        <pc:sldMkLst>
          <pc:docMk/>
          <pc:sldMk cId="4268846717" sldId="263"/>
        </pc:sldMkLst>
        <pc:spChg chg="del">
          <ac:chgData name="Vergara, Javier (CIAT)" userId="1737bf23-10e4-4004-af57-20e81a1f7d95" providerId="ADAL" clId="{A91EECBA-00AE-4E01-9C0A-45785F63E812}" dt="2019-04-13T06:26:42.544" v="41" actId="478"/>
          <ac:spMkLst>
            <pc:docMk/>
            <pc:sldMk cId="4268846717" sldId="263"/>
            <ac:spMk id="3" creationId="{37748CE2-390C-4236-BB57-F039494C0529}"/>
          </ac:spMkLst>
        </pc:spChg>
        <pc:spChg chg="del">
          <ac:chgData name="Vergara, Javier (CIAT)" userId="1737bf23-10e4-4004-af57-20e81a1f7d95" providerId="ADAL" clId="{A91EECBA-00AE-4E01-9C0A-45785F63E812}" dt="2019-04-13T06:26:52.743" v="47" actId="478"/>
          <ac:spMkLst>
            <pc:docMk/>
            <pc:sldMk cId="4268846717" sldId="263"/>
            <ac:spMk id="7" creationId="{BA444347-3E07-453F-A435-649EE86BE1D6}"/>
          </ac:spMkLst>
        </pc:spChg>
        <pc:spChg chg="del">
          <ac:chgData name="Vergara, Javier (CIAT)" userId="1737bf23-10e4-4004-af57-20e81a1f7d95" providerId="ADAL" clId="{A91EECBA-00AE-4E01-9C0A-45785F63E812}" dt="2019-04-13T06:26:40.940" v="40" actId="478"/>
          <ac:spMkLst>
            <pc:docMk/>
            <pc:sldMk cId="4268846717" sldId="263"/>
            <ac:spMk id="10" creationId="{00000000-0000-0000-0000-000000000000}"/>
          </ac:spMkLst>
        </pc:spChg>
        <pc:spChg chg="del">
          <ac:chgData name="Vergara, Javier (CIAT)" userId="1737bf23-10e4-4004-af57-20e81a1f7d95" providerId="ADAL" clId="{A91EECBA-00AE-4E01-9C0A-45785F63E812}" dt="2019-04-13T06:26:38.855" v="39" actId="478"/>
          <ac:spMkLst>
            <pc:docMk/>
            <pc:sldMk cId="4268846717" sldId="263"/>
            <ac:spMk id="11" creationId="{00000000-0000-0000-0000-000000000000}"/>
          </ac:spMkLst>
        </pc:spChg>
        <pc:spChg chg="del mod">
          <ac:chgData name="Vergara, Javier (CIAT)" userId="1737bf23-10e4-4004-af57-20e81a1f7d95" providerId="ADAL" clId="{A91EECBA-00AE-4E01-9C0A-45785F63E812}" dt="2019-04-13T06:26:49.106" v="45" actId="478"/>
          <ac:spMkLst>
            <pc:docMk/>
            <pc:sldMk cId="4268846717" sldId="263"/>
            <ac:spMk id="12" creationId="{64E9D1B0-3E66-4627-9C4A-850A6F0C1D13}"/>
          </ac:spMkLst>
        </pc:spChg>
        <pc:spChg chg="add mod">
          <ac:chgData name="Vergara, Javier (CIAT)" userId="1737bf23-10e4-4004-af57-20e81a1f7d95" providerId="ADAL" clId="{A91EECBA-00AE-4E01-9C0A-45785F63E812}" dt="2019-04-13T06:28:51.485" v="78" actId="1076"/>
          <ac:spMkLst>
            <pc:docMk/>
            <pc:sldMk cId="4268846717" sldId="263"/>
            <ac:spMk id="18" creationId="{0B81691F-14FD-4FF6-9182-87316D1768F0}"/>
          </ac:spMkLst>
        </pc:spChg>
        <pc:spChg chg="del">
          <ac:chgData name="Vergara, Javier (CIAT)" userId="1737bf23-10e4-4004-af57-20e81a1f7d95" providerId="ADAL" clId="{A91EECBA-00AE-4E01-9C0A-45785F63E812}" dt="2019-04-13T06:26:51.231" v="46" actId="478"/>
          <ac:spMkLst>
            <pc:docMk/>
            <pc:sldMk cId="4268846717" sldId="263"/>
            <ac:spMk id="19" creationId="{7966AAB4-0CB8-41B7-BCE2-38E71EC5DF5A}"/>
          </ac:spMkLst>
        </pc:spChg>
        <pc:spChg chg="add mod">
          <ac:chgData name="Vergara, Javier (CIAT)" userId="1737bf23-10e4-4004-af57-20e81a1f7d95" providerId="ADAL" clId="{A91EECBA-00AE-4E01-9C0A-45785F63E812}" dt="2019-04-13T06:28:56.788" v="79" actId="1076"/>
          <ac:spMkLst>
            <pc:docMk/>
            <pc:sldMk cId="4268846717" sldId="263"/>
            <ac:spMk id="20" creationId="{74C04F1A-97C0-4AE5-B250-C93CA5BE8901}"/>
          </ac:spMkLst>
        </pc:spChg>
        <pc:spChg chg="add mod">
          <ac:chgData name="Vergara, Javier (CIAT)" userId="1737bf23-10e4-4004-af57-20e81a1f7d95" providerId="ADAL" clId="{A91EECBA-00AE-4E01-9C0A-45785F63E812}" dt="2019-04-13T06:29:01.263" v="80" actId="1076"/>
          <ac:spMkLst>
            <pc:docMk/>
            <pc:sldMk cId="4268846717" sldId="263"/>
            <ac:spMk id="21" creationId="{F97066A1-36AB-43B0-8803-469F24E054C8}"/>
          </ac:spMkLst>
        </pc:spChg>
        <pc:spChg chg="add mod">
          <ac:chgData name="Vergara, Javier (CIAT)" userId="1737bf23-10e4-4004-af57-20e81a1f7d95" providerId="ADAL" clId="{A91EECBA-00AE-4E01-9C0A-45785F63E812}" dt="2019-04-13T06:29:12.983" v="81" actId="1076"/>
          <ac:spMkLst>
            <pc:docMk/>
            <pc:sldMk cId="4268846717" sldId="263"/>
            <ac:spMk id="22" creationId="{B34BA769-B227-4F2D-BFCA-74A3EB10B6CD}"/>
          </ac:spMkLst>
        </pc:spChg>
        <pc:spChg chg="add mod">
          <ac:chgData name="Vergara, Javier (CIAT)" userId="1737bf23-10e4-4004-af57-20e81a1f7d95" providerId="ADAL" clId="{A91EECBA-00AE-4E01-9C0A-45785F63E812}" dt="2019-04-13T06:29:41.691" v="90" actId="1076"/>
          <ac:spMkLst>
            <pc:docMk/>
            <pc:sldMk cId="4268846717" sldId="263"/>
            <ac:spMk id="23" creationId="{5892EAC2-720C-4D29-9143-09860847058F}"/>
          </ac:spMkLst>
        </pc:spChg>
        <pc:spChg chg="add mod">
          <ac:chgData name="Vergara, Javier (CIAT)" userId="1737bf23-10e4-4004-af57-20e81a1f7d95" providerId="ADAL" clId="{A91EECBA-00AE-4E01-9C0A-45785F63E812}" dt="2019-04-13T06:29:24.687" v="86" actId="20577"/>
          <ac:spMkLst>
            <pc:docMk/>
            <pc:sldMk cId="4268846717" sldId="263"/>
            <ac:spMk id="24" creationId="{B2894B70-0C9C-474A-B676-6381BDACF4AA}"/>
          </ac:spMkLst>
        </pc:spChg>
        <pc:picChg chg="mod">
          <ac:chgData name="Vergara, Javier (CIAT)" userId="1737bf23-10e4-4004-af57-20e81a1f7d95" providerId="ADAL" clId="{A91EECBA-00AE-4E01-9C0A-45785F63E812}" dt="2019-04-13T06:28:32.395" v="74" actId="14100"/>
          <ac:picMkLst>
            <pc:docMk/>
            <pc:sldMk cId="4268846717" sldId="263"/>
            <ac:picMk id="2" creationId="{B356A16D-3FA5-40B2-9B19-6EFF986F3416}"/>
          </ac:picMkLst>
        </pc:picChg>
        <pc:picChg chg="mod">
          <ac:chgData name="Vergara, Javier (CIAT)" userId="1737bf23-10e4-4004-af57-20e81a1f7d95" providerId="ADAL" clId="{A91EECBA-00AE-4E01-9C0A-45785F63E812}" dt="2019-04-13T06:27:52.855" v="65" actId="1076"/>
          <ac:picMkLst>
            <pc:docMk/>
            <pc:sldMk cId="4268846717" sldId="263"/>
            <ac:picMk id="4" creationId="{17A02D8E-EEBD-4E26-9C79-F928D4878934}"/>
          </ac:picMkLst>
        </pc:picChg>
        <pc:picChg chg="add del">
          <ac:chgData name="Vergara, Javier (CIAT)" userId="1737bf23-10e4-4004-af57-20e81a1f7d95" providerId="ADAL" clId="{A91EECBA-00AE-4E01-9C0A-45785F63E812}" dt="2019-04-13T06:28:36.889" v="76"/>
          <ac:picMkLst>
            <pc:docMk/>
            <pc:sldMk cId="4268846717" sldId="263"/>
            <ac:picMk id="5" creationId="{89D0DF00-05B2-4387-A806-A7DAA3516C14}"/>
          </ac:picMkLst>
        </pc:picChg>
        <pc:picChg chg="mod modCrop">
          <ac:chgData name="Vergara, Javier (CIAT)" userId="1737bf23-10e4-4004-af57-20e81a1f7d95" providerId="ADAL" clId="{A91EECBA-00AE-4E01-9C0A-45785F63E812}" dt="2019-04-13T06:28:27.509" v="72" actId="14100"/>
          <ac:picMkLst>
            <pc:docMk/>
            <pc:sldMk cId="4268846717" sldId="263"/>
            <ac:picMk id="9" creationId="{8323EDC2-9D0B-47B4-B7A2-98BA8C6BE457}"/>
          </ac:picMkLst>
        </pc:picChg>
        <pc:picChg chg="mod">
          <ac:chgData name="Vergara, Javier (CIAT)" userId="1737bf23-10e4-4004-af57-20e81a1f7d95" providerId="ADAL" clId="{A91EECBA-00AE-4E01-9C0A-45785F63E812}" dt="2019-04-13T06:27:51.396" v="64" actId="1076"/>
          <ac:picMkLst>
            <pc:docMk/>
            <pc:sldMk cId="4268846717" sldId="263"/>
            <ac:picMk id="15" creationId="{5610B0A4-CC2B-4CB1-8AF4-7D24C5539CAB}"/>
          </ac:picMkLst>
        </pc:picChg>
        <pc:picChg chg="mod">
          <ac:chgData name="Vergara, Javier (CIAT)" userId="1737bf23-10e4-4004-af57-20e81a1f7d95" providerId="ADAL" clId="{A91EECBA-00AE-4E01-9C0A-45785F63E812}" dt="2019-04-13T06:27:04.999" v="52" actId="14100"/>
          <ac:picMkLst>
            <pc:docMk/>
            <pc:sldMk cId="4268846717" sldId="263"/>
            <ac:picMk id="16" creationId="{00000000-0000-0000-0000-000000000000}"/>
          </ac:picMkLst>
        </pc:picChg>
        <pc:picChg chg="add del mod">
          <ac:chgData name="Vergara, Javier (CIAT)" userId="1737bf23-10e4-4004-af57-20e81a1f7d95" providerId="ADAL" clId="{A91EECBA-00AE-4E01-9C0A-45785F63E812}" dt="2019-04-13T06:27:09.999" v="53" actId="1076"/>
          <ac:picMkLst>
            <pc:docMk/>
            <pc:sldMk cId="4268846717" sldId="263"/>
            <ac:picMk id="17" creationId="{00000000-0000-0000-0000-000000000000}"/>
          </ac:picMkLst>
        </pc:picChg>
      </pc:sldChg>
      <pc:sldChg chg="modSp">
        <pc:chgData name="Vergara, Javier (CIAT)" userId="1737bf23-10e4-4004-af57-20e81a1f7d95" providerId="ADAL" clId="{A91EECBA-00AE-4E01-9C0A-45785F63E812}" dt="2019-04-13T06:26:18.612" v="38" actId="1076"/>
        <pc:sldMkLst>
          <pc:docMk/>
          <pc:sldMk cId="1117611040" sldId="264"/>
        </pc:sldMkLst>
        <pc:spChg chg="mod">
          <ac:chgData name="Vergara, Javier (CIAT)" userId="1737bf23-10e4-4004-af57-20e81a1f7d95" providerId="ADAL" clId="{A91EECBA-00AE-4E01-9C0A-45785F63E812}" dt="2019-04-13T06:26:18.612" v="38" actId="1076"/>
          <ac:spMkLst>
            <pc:docMk/>
            <pc:sldMk cId="1117611040" sldId="264"/>
            <ac:spMk id="8" creationId="{9825BB65-79A6-4A02-AF28-230F124F498C}"/>
          </ac:spMkLst>
        </pc:spChg>
        <pc:spChg chg="mod">
          <ac:chgData name="Vergara, Javier (CIAT)" userId="1737bf23-10e4-4004-af57-20e81a1f7d95" providerId="ADAL" clId="{A91EECBA-00AE-4E01-9C0A-45785F63E812}" dt="2019-04-13T06:26:18.612" v="38" actId="1076"/>
          <ac:spMkLst>
            <pc:docMk/>
            <pc:sldMk cId="1117611040" sldId="264"/>
            <ac:spMk id="9" creationId="{6680D46E-C93C-411B-8686-106BE123D0E5}"/>
          </ac:spMkLst>
        </pc:spChg>
        <pc:spChg chg="mod">
          <ac:chgData name="Vergara, Javier (CIAT)" userId="1737bf23-10e4-4004-af57-20e81a1f7d95" providerId="ADAL" clId="{A91EECBA-00AE-4E01-9C0A-45785F63E812}" dt="2019-04-13T06:26:18.612" v="38" actId="1076"/>
          <ac:spMkLst>
            <pc:docMk/>
            <pc:sldMk cId="1117611040" sldId="264"/>
            <ac:spMk id="10" creationId="{E58F3034-09D8-4E32-AB7B-11AAC123BCCB}"/>
          </ac:spMkLst>
        </pc:spChg>
        <pc:spChg chg="mod">
          <ac:chgData name="Vergara, Javier (CIAT)" userId="1737bf23-10e4-4004-af57-20e81a1f7d95" providerId="ADAL" clId="{A91EECBA-00AE-4E01-9C0A-45785F63E812}" dt="2019-04-13T06:26:18.612" v="38" actId="1076"/>
          <ac:spMkLst>
            <pc:docMk/>
            <pc:sldMk cId="1117611040" sldId="264"/>
            <ac:spMk id="11" creationId="{93F0EB0A-A368-4AEB-8410-7A74313C5F7D}"/>
          </ac:spMkLst>
        </pc:spChg>
        <pc:picChg chg="mod modCrop">
          <ac:chgData name="Vergara, Javier (CIAT)" userId="1737bf23-10e4-4004-af57-20e81a1f7d95" providerId="ADAL" clId="{A91EECBA-00AE-4E01-9C0A-45785F63E812}" dt="2019-04-13T06:26:18.612" v="38" actId="1076"/>
          <ac:picMkLst>
            <pc:docMk/>
            <pc:sldMk cId="1117611040" sldId="264"/>
            <ac:picMk id="3" creationId="{75E03708-41C2-4BD7-8091-70E67ED3BD5D}"/>
          </ac:picMkLst>
        </pc:picChg>
        <pc:picChg chg="mod modCrop">
          <ac:chgData name="Vergara, Javier (CIAT)" userId="1737bf23-10e4-4004-af57-20e81a1f7d95" providerId="ADAL" clId="{A91EECBA-00AE-4E01-9C0A-45785F63E812}" dt="2019-04-13T06:26:18.612" v="38" actId="1076"/>
          <ac:picMkLst>
            <pc:docMk/>
            <pc:sldMk cId="1117611040" sldId="264"/>
            <ac:picMk id="6" creationId="{FA9DC823-AE4A-4B1A-8D4B-056D587CCAD4}"/>
          </ac:picMkLst>
        </pc:picChg>
        <pc:picChg chg="mod">
          <ac:chgData name="Vergara, Javier (CIAT)" userId="1737bf23-10e4-4004-af57-20e81a1f7d95" providerId="ADAL" clId="{A91EECBA-00AE-4E01-9C0A-45785F63E812}" dt="2019-04-13T06:26:18.612" v="38" actId="1076"/>
          <ac:picMkLst>
            <pc:docMk/>
            <pc:sldMk cId="1117611040" sldId="264"/>
            <ac:picMk id="13" creationId="{4F8BD1F3-FA77-454A-9F47-A3123007CCAE}"/>
          </ac:picMkLst>
        </pc:picChg>
        <pc:picChg chg="mod">
          <ac:chgData name="Vergara, Javier (CIAT)" userId="1737bf23-10e4-4004-af57-20e81a1f7d95" providerId="ADAL" clId="{A91EECBA-00AE-4E01-9C0A-45785F63E812}" dt="2019-04-13T06:26:18.612" v="38" actId="1076"/>
          <ac:picMkLst>
            <pc:docMk/>
            <pc:sldMk cId="1117611040" sldId="264"/>
            <ac:picMk id="15" creationId="{9FCFBBC3-8923-45C5-8637-32BAFF47D5C5}"/>
          </ac:picMkLst>
        </pc:picChg>
      </pc:sldChg>
    </pc:docChg>
  </pc:docChgLst>
  <pc:docChgLst>
    <pc:chgData name="Vergara, Javier (CIAT)" userId="S::j.vergara@cgiar.org::1737bf23-10e4-4004-af57-20e81a1f7d95" providerId="AD" clId="Web-{036CF0B4-8B26-F4C6-7D5C-D07A03AACB80}"/>
    <pc:docChg chg="addSld modSld">
      <pc:chgData name="Vergara, Javier (CIAT)" userId="S::j.vergara@cgiar.org::1737bf23-10e4-4004-af57-20e81a1f7d95" providerId="AD" clId="Web-{036CF0B4-8B26-F4C6-7D5C-D07A03AACB80}" dt="2019-04-17T19:35:25.523" v="204" actId="1076"/>
      <pc:docMkLst>
        <pc:docMk/>
      </pc:docMkLst>
      <pc:sldChg chg="addSp delSp modSp new">
        <pc:chgData name="Vergara, Javier (CIAT)" userId="S::j.vergara@cgiar.org::1737bf23-10e4-4004-af57-20e81a1f7d95" providerId="AD" clId="Web-{036CF0B4-8B26-F4C6-7D5C-D07A03AACB80}" dt="2019-04-17T19:35:25.523" v="204" actId="1076"/>
        <pc:sldMkLst>
          <pc:docMk/>
          <pc:sldMk cId="324394477" sldId="265"/>
        </pc:sldMkLst>
        <pc:spChg chg="del">
          <ac:chgData name="Vergara, Javier (CIAT)" userId="S::j.vergara@cgiar.org::1737bf23-10e4-4004-af57-20e81a1f7d95" providerId="AD" clId="Web-{036CF0B4-8B26-F4C6-7D5C-D07A03AACB80}" dt="2019-04-17T19:32:45.900" v="16"/>
          <ac:spMkLst>
            <pc:docMk/>
            <pc:sldMk cId="324394477" sldId="265"/>
            <ac:spMk id="2" creationId="{ADFFB055-F812-4486-8DB6-DA30E5F3D8B4}"/>
          </ac:spMkLst>
        </pc:spChg>
        <pc:spChg chg="del">
          <ac:chgData name="Vergara, Javier (CIAT)" userId="S::j.vergara@cgiar.org::1737bf23-10e4-4004-af57-20e81a1f7d95" providerId="AD" clId="Web-{036CF0B4-8B26-F4C6-7D5C-D07A03AACB80}" dt="2019-04-17T19:32:10.478" v="1"/>
          <ac:spMkLst>
            <pc:docMk/>
            <pc:sldMk cId="324394477" sldId="265"/>
            <ac:spMk id="3" creationId="{68B899B5-8192-4C76-94C7-879D3DD58C77}"/>
          </ac:spMkLst>
        </pc:spChg>
        <pc:spChg chg="add del mod">
          <ac:chgData name="Vergara, Javier (CIAT)" userId="S::j.vergara@cgiar.org::1737bf23-10e4-4004-af57-20e81a1f7d95" providerId="AD" clId="Web-{036CF0B4-8B26-F4C6-7D5C-D07A03AACB80}" dt="2019-04-17T19:32:38.634" v="14"/>
          <ac:spMkLst>
            <pc:docMk/>
            <pc:sldMk cId="324394477" sldId="265"/>
            <ac:spMk id="11" creationId="{9E520583-CA30-45F7-923F-1B2257E3FD76}"/>
          </ac:spMkLst>
        </pc:spChg>
        <pc:spChg chg="add mod">
          <ac:chgData name="Vergara, Javier (CIAT)" userId="S::j.vergara@cgiar.org::1737bf23-10e4-4004-af57-20e81a1f7d95" providerId="AD" clId="Web-{036CF0B4-8B26-F4C6-7D5C-D07A03AACB80}" dt="2019-04-17T19:35:06.180" v="198" actId="20577"/>
          <ac:spMkLst>
            <pc:docMk/>
            <pc:sldMk cId="324394477" sldId="265"/>
            <ac:spMk id="15" creationId="{A331AB26-56D8-4BCA-8AAB-C188316A8DF2}"/>
          </ac:spMkLst>
        </pc:spChg>
        <pc:picChg chg="add del mod ord">
          <ac:chgData name="Vergara, Javier (CIAT)" userId="S::j.vergara@cgiar.org::1737bf23-10e4-4004-af57-20e81a1f7d95" providerId="AD" clId="Web-{036CF0B4-8B26-F4C6-7D5C-D07A03AACB80}" dt="2019-04-17T19:32:34.462" v="13"/>
          <ac:picMkLst>
            <pc:docMk/>
            <pc:sldMk cId="324394477" sldId="265"/>
            <ac:picMk id="4" creationId="{3B6ABE79-677E-4420-A1B9-AB8C4CF24B7C}"/>
          </ac:picMkLst>
        </pc:picChg>
        <pc:picChg chg="add mod">
          <ac:chgData name="Vergara, Javier (CIAT)" userId="S::j.vergara@cgiar.org::1737bf23-10e4-4004-af57-20e81a1f7d95" providerId="AD" clId="Web-{036CF0B4-8B26-F4C6-7D5C-D07A03AACB80}" dt="2019-04-17T19:35:18.461" v="200" actId="1076"/>
          <ac:picMkLst>
            <pc:docMk/>
            <pc:sldMk cId="324394477" sldId="265"/>
            <ac:picMk id="6" creationId="{55B65189-6C90-404A-9EB8-23F7D8B7D084}"/>
          </ac:picMkLst>
        </pc:picChg>
        <pc:picChg chg="add mod">
          <ac:chgData name="Vergara, Javier (CIAT)" userId="S::j.vergara@cgiar.org::1737bf23-10e4-4004-af57-20e81a1f7d95" providerId="AD" clId="Web-{036CF0B4-8B26-F4C6-7D5C-D07A03AACB80}" dt="2019-04-17T19:35:18.492" v="201" actId="1076"/>
          <ac:picMkLst>
            <pc:docMk/>
            <pc:sldMk cId="324394477" sldId="265"/>
            <ac:picMk id="8" creationId="{C993572A-8FA3-4108-BDE7-52A86C99E9D1}"/>
          </ac:picMkLst>
        </pc:picChg>
        <pc:picChg chg="add mod ord">
          <ac:chgData name="Vergara, Javier (CIAT)" userId="S::j.vergara@cgiar.org::1737bf23-10e4-4004-af57-20e81a1f7d95" providerId="AD" clId="Web-{036CF0B4-8B26-F4C6-7D5C-D07A03AACB80}" dt="2019-04-17T19:35:18.508" v="202" actId="1076"/>
          <ac:picMkLst>
            <pc:docMk/>
            <pc:sldMk cId="324394477" sldId="265"/>
            <ac:picMk id="12" creationId="{A49E7808-AD64-4700-92B0-3D2562173D0E}"/>
          </ac:picMkLst>
        </pc:picChg>
        <pc:picChg chg="add mod">
          <ac:chgData name="Vergara, Javier (CIAT)" userId="S::j.vergara@cgiar.org::1737bf23-10e4-4004-af57-20e81a1f7d95" providerId="AD" clId="Web-{036CF0B4-8B26-F4C6-7D5C-D07A03AACB80}" dt="2019-04-17T19:35:25.523" v="204" actId="1076"/>
          <ac:picMkLst>
            <pc:docMk/>
            <pc:sldMk cId="324394477" sldId="265"/>
            <ac:picMk id="16" creationId="{10F85A64-7C91-4D25-AB98-06A38BB840B9}"/>
          </ac:picMkLst>
        </pc:picChg>
      </pc:sldChg>
    </pc:docChg>
  </pc:docChgLst>
  <pc:docChgLst>
    <pc:chgData name="Selvaraj, Michael (Alliance Bioversity-CIAT)" userId="62d3ea7d-90b1-4df5-a311-114b51364b02" providerId="ADAL" clId="{041056BC-B896-4F19-8236-384B4ACC2B0A}"/>
    <pc:docChg chg="delSld">
      <pc:chgData name="Selvaraj, Michael (Alliance Bioversity-CIAT)" userId="62d3ea7d-90b1-4df5-a311-114b51364b02" providerId="ADAL" clId="{041056BC-B896-4F19-8236-384B4ACC2B0A}" dt="2023-10-30T13:16:54.063" v="2" actId="2696"/>
      <pc:docMkLst>
        <pc:docMk/>
      </pc:docMkLst>
      <pc:sldChg chg="del">
        <pc:chgData name="Selvaraj, Michael (Alliance Bioversity-CIAT)" userId="62d3ea7d-90b1-4df5-a311-114b51364b02" providerId="ADAL" clId="{041056BC-B896-4F19-8236-384B4ACC2B0A}" dt="2023-10-25T15:01:02.461" v="0" actId="47"/>
        <pc:sldMkLst>
          <pc:docMk/>
          <pc:sldMk cId="4268846717" sldId="263"/>
        </pc:sldMkLst>
      </pc:sldChg>
      <pc:sldChg chg="del">
        <pc:chgData name="Selvaraj, Michael (Alliance Bioversity-CIAT)" userId="62d3ea7d-90b1-4df5-a311-114b51364b02" providerId="ADAL" clId="{041056BC-B896-4F19-8236-384B4ACC2B0A}" dt="2023-10-25T15:01:07.755" v="1" actId="47"/>
        <pc:sldMkLst>
          <pc:docMk/>
          <pc:sldMk cId="1117611040" sldId="264"/>
        </pc:sldMkLst>
      </pc:sldChg>
      <pc:sldChg chg="del">
        <pc:chgData name="Selvaraj, Michael (Alliance Bioversity-CIAT)" userId="62d3ea7d-90b1-4df5-a311-114b51364b02" providerId="ADAL" clId="{041056BC-B896-4F19-8236-384B4ACC2B0A}" dt="2023-10-30T13:16:54.063" v="2" actId="2696"/>
        <pc:sldMkLst>
          <pc:docMk/>
          <pc:sldMk cId="324394477" sldId="265"/>
        </pc:sldMkLst>
      </pc:sldChg>
    </pc:docChg>
  </pc:docChgLst>
  <pc:docChgLst>
    <pc:chgData name="Vergara, Javier (CIAT)" userId="S::j.vergara@cgiar.org::1737bf23-10e4-4004-af57-20e81a1f7d95" providerId="AD" clId="Web-{E1B79A11-25A2-EA91-444D-61254962428E}"/>
    <pc:docChg chg="modSld">
      <pc:chgData name="Vergara, Javier (CIAT)" userId="S::j.vergara@cgiar.org::1737bf23-10e4-4004-af57-20e81a1f7d95" providerId="AD" clId="Web-{E1B79A11-25A2-EA91-444D-61254962428E}" dt="2019-04-17T19:47:24.814" v="233" actId="20577"/>
      <pc:docMkLst>
        <pc:docMk/>
      </pc:docMkLst>
      <pc:sldChg chg="addSp modSp">
        <pc:chgData name="Vergara, Javier (CIAT)" userId="S::j.vergara@cgiar.org::1737bf23-10e4-4004-af57-20e81a1f7d95" providerId="AD" clId="Web-{E1B79A11-25A2-EA91-444D-61254962428E}" dt="2019-04-17T19:41:25.394" v="31" actId="14100"/>
        <pc:sldMkLst>
          <pc:docMk/>
          <pc:sldMk cId="4268846717" sldId="263"/>
        </pc:sldMkLst>
        <pc:spChg chg="add mod">
          <ac:chgData name="Vergara, Javier (CIAT)" userId="S::j.vergara@cgiar.org::1737bf23-10e4-4004-af57-20e81a1f7d95" providerId="AD" clId="Web-{E1B79A11-25A2-EA91-444D-61254962428E}" dt="2019-04-17T19:41:25.394" v="31" actId="14100"/>
          <ac:spMkLst>
            <pc:docMk/>
            <pc:sldMk cId="4268846717" sldId="263"/>
            <ac:spMk id="3" creationId="{C4105DC1-8271-4B95-A636-619CDE6535F6}"/>
          </ac:spMkLst>
        </pc:spChg>
        <pc:spChg chg="mod">
          <ac:chgData name="Vergara, Javier (CIAT)" userId="S::j.vergara@cgiar.org::1737bf23-10e4-4004-af57-20e81a1f7d95" providerId="AD" clId="Web-{E1B79A11-25A2-EA91-444D-61254962428E}" dt="2019-04-17T19:41:04.894" v="24" actId="1076"/>
          <ac:spMkLst>
            <pc:docMk/>
            <pc:sldMk cId="4268846717" sldId="263"/>
            <ac:spMk id="21" creationId="{F97066A1-36AB-43B0-8803-469F24E054C8}"/>
          </ac:spMkLst>
        </pc:spChg>
        <pc:spChg chg="mod">
          <ac:chgData name="Vergara, Javier (CIAT)" userId="S::j.vergara@cgiar.org::1737bf23-10e4-4004-af57-20e81a1f7d95" providerId="AD" clId="Web-{E1B79A11-25A2-EA91-444D-61254962428E}" dt="2019-04-17T19:41:04.894" v="25" actId="1076"/>
          <ac:spMkLst>
            <pc:docMk/>
            <pc:sldMk cId="4268846717" sldId="263"/>
            <ac:spMk id="22" creationId="{B34BA769-B227-4F2D-BFCA-74A3EB10B6CD}"/>
          </ac:spMkLst>
        </pc:spChg>
        <pc:spChg chg="mod">
          <ac:chgData name="Vergara, Javier (CIAT)" userId="S::j.vergara@cgiar.org::1737bf23-10e4-4004-af57-20e81a1f7d95" providerId="AD" clId="Web-{E1B79A11-25A2-EA91-444D-61254962428E}" dt="2019-04-17T19:41:17.222" v="28" actId="1076"/>
          <ac:spMkLst>
            <pc:docMk/>
            <pc:sldMk cId="4268846717" sldId="263"/>
            <ac:spMk id="23" creationId="{5892EAC2-720C-4D29-9143-09860847058F}"/>
          </ac:spMkLst>
        </pc:spChg>
        <pc:spChg chg="mod">
          <ac:chgData name="Vergara, Javier (CIAT)" userId="S::j.vergara@cgiar.org::1737bf23-10e4-4004-af57-20e81a1f7d95" providerId="AD" clId="Web-{E1B79A11-25A2-EA91-444D-61254962428E}" dt="2019-04-17T19:41:17.222" v="29" actId="1076"/>
          <ac:spMkLst>
            <pc:docMk/>
            <pc:sldMk cId="4268846717" sldId="263"/>
            <ac:spMk id="24" creationId="{B2894B70-0C9C-474A-B676-6381BDACF4AA}"/>
          </ac:spMkLst>
        </pc:spChg>
        <pc:picChg chg="mod">
          <ac:chgData name="Vergara, Javier (CIAT)" userId="S::j.vergara@cgiar.org::1737bf23-10e4-4004-af57-20e81a1f7d95" providerId="AD" clId="Web-{E1B79A11-25A2-EA91-444D-61254962428E}" dt="2019-04-17T19:41:04.863" v="22" actId="1076"/>
          <ac:picMkLst>
            <pc:docMk/>
            <pc:sldMk cId="4268846717" sldId="263"/>
            <ac:picMk id="2" creationId="{B356A16D-3FA5-40B2-9B19-6EFF986F3416}"/>
          </ac:picMkLst>
        </pc:picChg>
        <pc:picChg chg="mod">
          <ac:chgData name="Vergara, Javier (CIAT)" userId="S::j.vergara@cgiar.org::1737bf23-10e4-4004-af57-20e81a1f7d95" providerId="AD" clId="Web-{E1B79A11-25A2-EA91-444D-61254962428E}" dt="2019-04-17T19:41:04.878" v="23" actId="1076"/>
          <ac:picMkLst>
            <pc:docMk/>
            <pc:sldMk cId="4268846717" sldId="263"/>
            <ac:picMk id="4" creationId="{17A02D8E-EEBD-4E26-9C79-F928D4878934}"/>
          </ac:picMkLst>
        </pc:picChg>
        <pc:picChg chg="mod">
          <ac:chgData name="Vergara, Javier (CIAT)" userId="S::j.vergara@cgiar.org::1737bf23-10e4-4004-af57-20e81a1f7d95" providerId="AD" clId="Web-{E1B79A11-25A2-EA91-444D-61254962428E}" dt="2019-04-17T19:41:17.191" v="26" actId="1076"/>
          <ac:picMkLst>
            <pc:docMk/>
            <pc:sldMk cId="4268846717" sldId="263"/>
            <ac:picMk id="9" creationId="{8323EDC2-9D0B-47B4-B7A2-98BA8C6BE457}"/>
          </ac:picMkLst>
        </pc:picChg>
        <pc:picChg chg="mod">
          <ac:chgData name="Vergara, Javier (CIAT)" userId="S::j.vergara@cgiar.org::1737bf23-10e4-4004-af57-20e81a1f7d95" providerId="AD" clId="Web-{E1B79A11-25A2-EA91-444D-61254962428E}" dt="2019-04-17T19:41:17.206" v="27" actId="1076"/>
          <ac:picMkLst>
            <pc:docMk/>
            <pc:sldMk cId="4268846717" sldId="263"/>
            <ac:picMk id="15" creationId="{5610B0A4-CC2B-4CB1-8AF4-7D24C5539CAB}"/>
          </ac:picMkLst>
        </pc:picChg>
      </pc:sldChg>
      <pc:sldChg chg="modSp">
        <pc:chgData name="Vergara, Javier (CIAT)" userId="S::j.vergara@cgiar.org::1737bf23-10e4-4004-af57-20e81a1f7d95" providerId="AD" clId="Web-{E1B79A11-25A2-EA91-444D-61254962428E}" dt="2019-04-17T19:40:13.425" v="14" actId="20577"/>
        <pc:sldMkLst>
          <pc:docMk/>
          <pc:sldMk cId="1117611040" sldId="264"/>
        </pc:sldMkLst>
        <pc:spChg chg="mod">
          <ac:chgData name="Vergara, Javier (CIAT)" userId="S::j.vergara@cgiar.org::1737bf23-10e4-4004-af57-20e81a1f7d95" providerId="AD" clId="Web-{E1B79A11-25A2-EA91-444D-61254962428E}" dt="2019-04-17T19:40:13.425" v="14" actId="20577"/>
          <ac:spMkLst>
            <pc:docMk/>
            <pc:sldMk cId="1117611040" sldId="264"/>
            <ac:spMk id="2" creationId="{00000000-0000-0000-0000-000000000000}"/>
          </ac:spMkLst>
        </pc:spChg>
      </pc:sldChg>
      <pc:sldChg chg="modSp">
        <pc:chgData name="Vergara, Javier (CIAT)" userId="S::j.vergara@cgiar.org::1737bf23-10e4-4004-af57-20e81a1f7d95" providerId="AD" clId="Web-{E1B79A11-25A2-EA91-444D-61254962428E}" dt="2019-04-17T19:47:24.814" v="232" actId="20577"/>
        <pc:sldMkLst>
          <pc:docMk/>
          <pc:sldMk cId="324394477" sldId="265"/>
        </pc:sldMkLst>
        <pc:spChg chg="mod">
          <ac:chgData name="Vergara, Javier (CIAT)" userId="S::j.vergara@cgiar.org::1737bf23-10e4-4004-af57-20e81a1f7d95" providerId="AD" clId="Web-{E1B79A11-25A2-EA91-444D-61254962428E}" dt="2019-04-17T19:47:24.814" v="232" actId="20577"/>
          <ac:spMkLst>
            <pc:docMk/>
            <pc:sldMk cId="324394477" sldId="265"/>
            <ac:spMk id="15" creationId="{A331AB26-56D8-4BCA-8AAB-C188316A8DF2}"/>
          </ac:spMkLst>
        </pc:spChg>
      </pc:sldChg>
    </pc:docChg>
  </pc:docChgLst>
  <pc:docChgLst>
    <pc:chgData name="Vergara, Javier (CIAT)" userId="S::j.vergara@cgiar.org::1737bf23-10e4-4004-af57-20e81a1f7d95" providerId="AD" clId="Web-{6601F9A7-6473-67A1-188D-950B7C7FF017}"/>
    <pc:docChg chg="modSld">
      <pc:chgData name="Vergara, Javier (CIAT)" userId="S::j.vergara@cgiar.org::1737bf23-10e4-4004-af57-20e81a1f7d95" providerId="AD" clId="Web-{6601F9A7-6473-67A1-188D-950B7C7FF017}" dt="2019-04-11T20:57:41.960" v="15" actId="1076"/>
      <pc:docMkLst>
        <pc:docMk/>
      </pc:docMkLst>
      <pc:sldChg chg="modSp">
        <pc:chgData name="Vergara, Javier (CIAT)" userId="S::j.vergara@cgiar.org::1737bf23-10e4-4004-af57-20e81a1f7d95" providerId="AD" clId="Web-{6601F9A7-6473-67A1-188D-950B7C7FF017}" dt="2019-04-11T20:54:32.898" v="5" actId="14100"/>
        <pc:sldMkLst>
          <pc:docMk/>
          <pc:sldMk cId="4268846717" sldId="263"/>
        </pc:sldMkLst>
        <pc:picChg chg="mod ord">
          <ac:chgData name="Vergara, Javier (CIAT)" userId="S::j.vergara@cgiar.org::1737bf23-10e4-4004-af57-20e81a1f7d95" providerId="AD" clId="Web-{6601F9A7-6473-67A1-188D-950B7C7FF017}" dt="2019-04-11T20:54:32.898" v="5" actId="14100"/>
          <ac:picMkLst>
            <pc:docMk/>
            <pc:sldMk cId="4268846717" sldId="263"/>
            <ac:picMk id="16" creationId="{00000000-0000-0000-0000-000000000000}"/>
          </ac:picMkLst>
        </pc:picChg>
      </pc:sldChg>
      <pc:sldChg chg="delSp modSp modNotes">
        <pc:chgData name="Vergara, Javier (CIAT)" userId="S::j.vergara@cgiar.org::1737bf23-10e4-4004-af57-20e81a1f7d95" providerId="AD" clId="Web-{6601F9A7-6473-67A1-188D-950B7C7FF017}" dt="2019-04-11T20:57:41.960" v="15" actId="1076"/>
        <pc:sldMkLst>
          <pc:docMk/>
          <pc:sldMk cId="1117611040" sldId="264"/>
        </pc:sldMkLst>
        <pc:spChg chg="del mod">
          <ac:chgData name="Vergara, Javier (CIAT)" userId="S::j.vergara@cgiar.org::1737bf23-10e4-4004-af57-20e81a1f7d95" providerId="AD" clId="Web-{6601F9A7-6473-67A1-188D-950B7C7FF017}" dt="2019-04-11T20:55:08.258" v="9"/>
          <ac:spMkLst>
            <pc:docMk/>
            <pc:sldMk cId="1117611040" sldId="264"/>
            <ac:spMk id="12" creationId="{0380B87A-5D9C-4073-9524-B60B7B7EE069}"/>
          </ac:spMkLst>
        </pc:spChg>
        <pc:picChg chg="mod">
          <ac:chgData name="Vergara, Javier (CIAT)" userId="S::j.vergara@cgiar.org::1737bf23-10e4-4004-af57-20e81a1f7d95" providerId="AD" clId="Web-{6601F9A7-6473-67A1-188D-950B7C7FF017}" dt="2019-04-11T20:57:17.304" v="13" actId="1076"/>
          <ac:picMkLst>
            <pc:docMk/>
            <pc:sldMk cId="1117611040" sldId="264"/>
            <ac:picMk id="6" creationId="{FA9DC823-AE4A-4B1A-8D4B-056D587CCAD4}"/>
          </ac:picMkLst>
        </pc:picChg>
        <pc:picChg chg="mod">
          <ac:chgData name="Vergara, Javier (CIAT)" userId="S::j.vergara@cgiar.org::1737bf23-10e4-4004-af57-20e81a1f7d95" providerId="AD" clId="Web-{6601F9A7-6473-67A1-188D-950B7C7FF017}" dt="2019-04-11T20:57:41.960" v="15" actId="1076"/>
          <ac:picMkLst>
            <pc:docMk/>
            <pc:sldMk cId="1117611040" sldId="264"/>
            <ac:picMk id="15" creationId="{9FCFBBC3-8923-45C5-8637-32BAFF47D5C5}"/>
          </ac:picMkLst>
        </pc:picChg>
      </pc:sldChg>
    </pc:docChg>
  </pc:docChgLst>
  <pc:docChgLst>
    <pc:chgData name="Vergara, Javier (CIAT)" userId="S::j.vergara@cgiar.org::1737bf23-10e4-4004-af57-20e81a1f7d95" providerId="AD" clId="Web-{71C83B36-914B-71CE-7E7D-82AA67F66900}"/>
    <pc:docChg chg="delSld modSld">
      <pc:chgData name="Vergara, Javier (CIAT)" userId="S::j.vergara@cgiar.org::1737bf23-10e4-4004-af57-20e81a1f7d95" providerId="AD" clId="Web-{71C83B36-914B-71CE-7E7D-82AA67F66900}" dt="2019-03-26T21:26:46.260" v="16"/>
      <pc:docMkLst>
        <pc:docMk/>
      </pc:docMkLst>
    </pc:docChg>
  </pc:docChgLst>
  <pc:docChgLst>
    <pc:chgData name="Selvaraj, Michael (CIAT)" userId="S::m.selvaraj@cgiar.org::62d3ea7d-90b1-4df5-a311-114b51364b02" providerId="AD" clId="Web-{724D30E1-E7ED-2309-CA52-55C70890E2AE}"/>
    <pc:docChg chg="modSld">
      <pc:chgData name="Selvaraj, Michael (CIAT)" userId="S::m.selvaraj@cgiar.org::62d3ea7d-90b1-4df5-a311-114b51364b02" providerId="AD" clId="Web-{724D30E1-E7ED-2309-CA52-55C70890E2AE}" dt="2019-03-28T20:33:20.646" v="1" actId="1076"/>
      <pc:docMkLst>
        <pc:docMk/>
      </pc:docMkLst>
    </pc:docChg>
  </pc:docChgLst>
  <pc:docChgLst>
    <pc:chgData name="Vergara, Javier (CIAT)" userId="S::j.vergara@cgiar.org::1737bf23-10e4-4004-af57-20e81a1f7d95" providerId="AD" clId="Web-{2749865C-0708-46B9-7A29-DF34A911EC29}"/>
    <pc:docChg chg="modSld">
      <pc:chgData name="Vergara, Javier (CIAT)" userId="S::j.vergara@cgiar.org::1737bf23-10e4-4004-af57-20e81a1f7d95" providerId="AD" clId="Web-{2749865C-0708-46B9-7A29-DF34A911EC29}" dt="2019-04-13T06:19:51.571" v="23"/>
      <pc:docMkLst>
        <pc:docMk/>
      </pc:docMkLst>
      <pc:sldChg chg="modSp">
        <pc:chgData name="Vergara, Javier (CIAT)" userId="S::j.vergara@cgiar.org::1737bf23-10e4-4004-af57-20e81a1f7d95" providerId="AD" clId="Web-{2749865C-0708-46B9-7A29-DF34A911EC29}" dt="2019-04-13T06:19:51.571" v="23"/>
        <pc:sldMkLst>
          <pc:docMk/>
          <pc:sldMk cId="1117611040" sldId="264"/>
        </pc:sldMkLst>
        <pc:spChg chg="mod">
          <ac:chgData name="Vergara, Javier (CIAT)" userId="S::j.vergara@cgiar.org::1737bf23-10e4-4004-af57-20e81a1f7d95" providerId="AD" clId="Web-{2749865C-0708-46B9-7A29-DF34A911EC29}" dt="2019-04-13T06:19:51.555" v="20"/>
          <ac:spMkLst>
            <pc:docMk/>
            <pc:sldMk cId="1117611040" sldId="264"/>
            <ac:spMk id="8" creationId="{9825BB65-79A6-4A02-AF28-230F124F498C}"/>
          </ac:spMkLst>
        </pc:spChg>
        <pc:spChg chg="mod">
          <ac:chgData name="Vergara, Javier (CIAT)" userId="S::j.vergara@cgiar.org::1737bf23-10e4-4004-af57-20e81a1f7d95" providerId="AD" clId="Web-{2749865C-0708-46B9-7A29-DF34A911EC29}" dt="2019-04-13T06:19:51.555" v="21"/>
          <ac:spMkLst>
            <pc:docMk/>
            <pc:sldMk cId="1117611040" sldId="264"/>
            <ac:spMk id="9" creationId="{6680D46E-C93C-411B-8686-106BE123D0E5}"/>
          </ac:spMkLst>
        </pc:spChg>
        <pc:spChg chg="mod">
          <ac:chgData name="Vergara, Javier (CIAT)" userId="S::j.vergara@cgiar.org::1737bf23-10e4-4004-af57-20e81a1f7d95" providerId="AD" clId="Web-{2749865C-0708-46B9-7A29-DF34A911EC29}" dt="2019-04-13T06:19:51.571" v="23"/>
          <ac:spMkLst>
            <pc:docMk/>
            <pc:sldMk cId="1117611040" sldId="264"/>
            <ac:spMk id="10" creationId="{E58F3034-09D8-4E32-AB7B-11AAC123BCCB}"/>
          </ac:spMkLst>
        </pc:spChg>
        <pc:spChg chg="mod">
          <ac:chgData name="Vergara, Javier (CIAT)" userId="S::j.vergara@cgiar.org::1737bf23-10e4-4004-af57-20e81a1f7d95" providerId="AD" clId="Web-{2749865C-0708-46B9-7A29-DF34A911EC29}" dt="2019-04-13T06:19:51.555" v="22"/>
          <ac:spMkLst>
            <pc:docMk/>
            <pc:sldMk cId="1117611040" sldId="264"/>
            <ac:spMk id="11" creationId="{93F0EB0A-A368-4AEB-8410-7A74313C5F7D}"/>
          </ac:spMkLst>
        </pc:spChg>
      </pc:sldChg>
    </pc:docChg>
  </pc:docChgLst>
  <pc:docChgLst>
    <pc:chgData name="Gomez, Daniela (Alliance Bioversity-CIAT)" userId="S::daniela.gomez@cgiar.org::c94e5fda-a43d-46f7-b351-499384532572" providerId="AD" clId="Web-{01C4E04E-7ED2-942E-8D4B-9ED7DD5B7101}"/>
    <pc:docChg chg="addSld modSld">
      <pc:chgData name="Gomez, Daniela (Alliance Bioversity-CIAT)" userId="S::daniela.gomez@cgiar.org::c94e5fda-a43d-46f7-b351-499384532572" providerId="AD" clId="Web-{01C4E04E-7ED2-942E-8D4B-9ED7DD5B7101}" dt="2023-10-26T14:27:17.416" v="361" actId="20577"/>
      <pc:docMkLst>
        <pc:docMk/>
      </pc:docMkLst>
      <pc:sldChg chg="modSp">
        <pc:chgData name="Gomez, Daniela (Alliance Bioversity-CIAT)" userId="S::daniela.gomez@cgiar.org::c94e5fda-a43d-46f7-b351-499384532572" providerId="AD" clId="Web-{01C4E04E-7ED2-942E-8D4B-9ED7DD5B7101}" dt="2023-10-26T13:42:55.788" v="3" actId="20577"/>
        <pc:sldMkLst>
          <pc:docMk/>
          <pc:sldMk cId="324394477" sldId="265"/>
        </pc:sldMkLst>
        <pc:spChg chg="mod">
          <ac:chgData name="Gomez, Daniela (Alliance Bioversity-CIAT)" userId="S::daniela.gomez@cgiar.org::c94e5fda-a43d-46f7-b351-499384532572" providerId="AD" clId="Web-{01C4E04E-7ED2-942E-8D4B-9ED7DD5B7101}" dt="2023-10-26T13:42:55.788" v="3" actId="20577"/>
          <ac:spMkLst>
            <pc:docMk/>
            <pc:sldMk cId="324394477" sldId="265"/>
            <ac:spMk id="15" creationId="{A331AB26-56D8-4BCA-8AAB-C188316A8DF2}"/>
          </ac:spMkLst>
        </pc:spChg>
      </pc:sldChg>
      <pc:sldChg chg="modSp">
        <pc:chgData name="Gomez, Daniela (Alliance Bioversity-CIAT)" userId="S::daniela.gomez@cgiar.org::c94e5fda-a43d-46f7-b351-499384532572" providerId="AD" clId="Web-{01C4E04E-7ED2-942E-8D4B-9ED7DD5B7101}" dt="2023-10-26T14:15:21.439" v="206" actId="20577"/>
        <pc:sldMkLst>
          <pc:docMk/>
          <pc:sldMk cId="744295684" sldId="267"/>
        </pc:sldMkLst>
        <pc:spChg chg="mod">
          <ac:chgData name="Gomez, Daniela (Alliance Bioversity-CIAT)" userId="S::daniela.gomez@cgiar.org::c94e5fda-a43d-46f7-b351-499384532572" providerId="AD" clId="Web-{01C4E04E-7ED2-942E-8D4B-9ED7DD5B7101}" dt="2023-10-26T14:15:21.439" v="206" actId="20577"/>
          <ac:spMkLst>
            <pc:docMk/>
            <pc:sldMk cId="744295684" sldId="267"/>
            <ac:spMk id="15" creationId="{A331AB26-56D8-4BCA-8AAB-C188316A8DF2}"/>
          </ac:spMkLst>
        </pc:spChg>
      </pc:sldChg>
      <pc:sldChg chg="modSp">
        <pc:chgData name="Gomez, Daniela (Alliance Bioversity-CIAT)" userId="S::daniela.gomez@cgiar.org::c94e5fda-a43d-46f7-b351-499384532572" providerId="AD" clId="Web-{01C4E04E-7ED2-942E-8D4B-9ED7DD5B7101}" dt="2023-10-26T14:15:28.393" v="212" actId="20577"/>
        <pc:sldMkLst>
          <pc:docMk/>
          <pc:sldMk cId="1307993186" sldId="268"/>
        </pc:sldMkLst>
        <pc:spChg chg="mod">
          <ac:chgData name="Gomez, Daniela (Alliance Bioversity-CIAT)" userId="S::daniela.gomez@cgiar.org::c94e5fda-a43d-46f7-b351-499384532572" providerId="AD" clId="Web-{01C4E04E-7ED2-942E-8D4B-9ED7DD5B7101}" dt="2023-10-26T14:15:28.393" v="212" actId="20577"/>
          <ac:spMkLst>
            <pc:docMk/>
            <pc:sldMk cId="1307993186" sldId="268"/>
            <ac:spMk id="15" creationId="{A331AB26-56D8-4BCA-8AAB-C188316A8DF2}"/>
          </ac:spMkLst>
        </pc:spChg>
      </pc:sldChg>
      <pc:sldChg chg="modSp">
        <pc:chgData name="Gomez, Daniela (Alliance Bioversity-CIAT)" userId="S::daniela.gomez@cgiar.org::c94e5fda-a43d-46f7-b351-499384532572" providerId="AD" clId="Web-{01C4E04E-7ED2-942E-8D4B-9ED7DD5B7101}" dt="2023-10-26T14:15:36.987" v="215" actId="20577"/>
        <pc:sldMkLst>
          <pc:docMk/>
          <pc:sldMk cId="1495302232" sldId="269"/>
        </pc:sldMkLst>
        <pc:spChg chg="mod">
          <ac:chgData name="Gomez, Daniela (Alliance Bioversity-CIAT)" userId="S::daniela.gomez@cgiar.org::c94e5fda-a43d-46f7-b351-499384532572" providerId="AD" clId="Web-{01C4E04E-7ED2-942E-8D4B-9ED7DD5B7101}" dt="2023-10-26T14:15:36.987" v="215" actId="20577"/>
          <ac:spMkLst>
            <pc:docMk/>
            <pc:sldMk cId="1495302232" sldId="269"/>
            <ac:spMk id="15" creationId="{A331AB26-56D8-4BCA-8AAB-C188316A8DF2}"/>
          </ac:spMkLst>
        </pc:spChg>
      </pc:sldChg>
      <pc:sldChg chg="modSp">
        <pc:chgData name="Gomez, Daniela (Alliance Bioversity-CIAT)" userId="S::daniela.gomez@cgiar.org::c94e5fda-a43d-46f7-b351-499384532572" providerId="AD" clId="Web-{01C4E04E-7ED2-942E-8D4B-9ED7DD5B7101}" dt="2023-10-26T14:15:10.033" v="203" actId="20577"/>
        <pc:sldMkLst>
          <pc:docMk/>
          <pc:sldMk cId="2995284397" sldId="270"/>
        </pc:sldMkLst>
        <pc:spChg chg="mod">
          <ac:chgData name="Gomez, Daniela (Alliance Bioversity-CIAT)" userId="S::daniela.gomez@cgiar.org::c94e5fda-a43d-46f7-b351-499384532572" providerId="AD" clId="Web-{01C4E04E-7ED2-942E-8D4B-9ED7DD5B7101}" dt="2023-10-26T14:15:10.033" v="203" actId="20577"/>
          <ac:spMkLst>
            <pc:docMk/>
            <pc:sldMk cId="2995284397" sldId="270"/>
            <ac:spMk id="15" creationId="{A331AB26-56D8-4BCA-8AAB-C188316A8DF2}"/>
          </ac:spMkLst>
        </pc:spChg>
      </pc:sldChg>
      <pc:sldChg chg="modSp">
        <pc:chgData name="Gomez, Daniela (Alliance Bioversity-CIAT)" userId="S::daniela.gomez@cgiar.org::c94e5fda-a43d-46f7-b351-499384532572" providerId="AD" clId="Web-{01C4E04E-7ED2-942E-8D4B-9ED7DD5B7101}" dt="2023-10-26T13:42:22.631" v="1" actId="20577"/>
        <pc:sldMkLst>
          <pc:docMk/>
          <pc:sldMk cId="3649580678" sldId="271"/>
        </pc:sldMkLst>
        <pc:spChg chg="mod">
          <ac:chgData name="Gomez, Daniela (Alliance Bioversity-CIAT)" userId="S::daniela.gomez@cgiar.org::c94e5fda-a43d-46f7-b351-499384532572" providerId="AD" clId="Web-{01C4E04E-7ED2-942E-8D4B-9ED7DD5B7101}" dt="2023-10-26T13:42:22.631" v="1" actId="20577"/>
          <ac:spMkLst>
            <pc:docMk/>
            <pc:sldMk cId="3649580678" sldId="271"/>
            <ac:spMk id="30" creationId="{D43F6902-EE86-346C-7DE6-0C27CD23F9E4}"/>
          </ac:spMkLst>
        </pc:spChg>
      </pc:sldChg>
      <pc:sldChg chg="modSp">
        <pc:chgData name="Gomez, Daniela (Alliance Bioversity-CIAT)" userId="S::daniela.gomez@cgiar.org::c94e5fda-a43d-46f7-b351-499384532572" providerId="AD" clId="Web-{01C4E04E-7ED2-942E-8D4B-9ED7DD5B7101}" dt="2023-10-26T13:47:29.031" v="56" actId="20577"/>
        <pc:sldMkLst>
          <pc:docMk/>
          <pc:sldMk cId="717926230" sldId="272"/>
        </pc:sldMkLst>
        <pc:spChg chg="mod">
          <ac:chgData name="Gomez, Daniela (Alliance Bioversity-CIAT)" userId="S::daniela.gomez@cgiar.org::c94e5fda-a43d-46f7-b351-499384532572" providerId="AD" clId="Web-{01C4E04E-7ED2-942E-8D4B-9ED7DD5B7101}" dt="2023-10-26T13:47:29.031" v="56" actId="20577"/>
          <ac:spMkLst>
            <pc:docMk/>
            <pc:sldMk cId="717926230" sldId="272"/>
            <ac:spMk id="15" creationId="{A331AB26-56D8-4BCA-8AAB-C188316A8DF2}"/>
          </ac:spMkLst>
        </pc:spChg>
      </pc:sldChg>
      <pc:sldChg chg="modSp">
        <pc:chgData name="Gomez, Daniela (Alliance Bioversity-CIAT)" userId="S::daniela.gomez@cgiar.org::c94e5fda-a43d-46f7-b351-499384532572" providerId="AD" clId="Web-{01C4E04E-7ED2-942E-8D4B-9ED7DD5B7101}" dt="2023-10-26T13:46:57.327" v="44" actId="20577"/>
        <pc:sldMkLst>
          <pc:docMk/>
          <pc:sldMk cId="4012007636" sldId="273"/>
        </pc:sldMkLst>
        <pc:spChg chg="mod">
          <ac:chgData name="Gomez, Daniela (Alliance Bioversity-CIAT)" userId="S::daniela.gomez@cgiar.org::c94e5fda-a43d-46f7-b351-499384532572" providerId="AD" clId="Web-{01C4E04E-7ED2-942E-8D4B-9ED7DD5B7101}" dt="2023-10-26T13:46:57.327" v="44" actId="20577"/>
          <ac:spMkLst>
            <pc:docMk/>
            <pc:sldMk cId="4012007636" sldId="273"/>
            <ac:spMk id="15" creationId="{A331AB26-56D8-4BCA-8AAB-C188316A8DF2}"/>
          </ac:spMkLst>
        </pc:spChg>
      </pc:sldChg>
      <pc:sldChg chg="modSp">
        <pc:chgData name="Gomez, Daniela (Alliance Bioversity-CIAT)" userId="S::daniela.gomez@cgiar.org::c94e5fda-a43d-46f7-b351-499384532572" providerId="AD" clId="Web-{01C4E04E-7ED2-942E-8D4B-9ED7DD5B7101}" dt="2023-10-26T13:49:33.050" v="95" actId="20577"/>
        <pc:sldMkLst>
          <pc:docMk/>
          <pc:sldMk cId="4260030243" sldId="274"/>
        </pc:sldMkLst>
        <pc:spChg chg="mod">
          <ac:chgData name="Gomez, Daniela (Alliance Bioversity-CIAT)" userId="S::daniela.gomez@cgiar.org::c94e5fda-a43d-46f7-b351-499384532572" providerId="AD" clId="Web-{01C4E04E-7ED2-942E-8D4B-9ED7DD5B7101}" dt="2023-10-26T13:49:33.050" v="95" actId="20577"/>
          <ac:spMkLst>
            <pc:docMk/>
            <pc:sldMk cId="4260030243" sldId="274"/>
            <ac:spMk id="15" creationId="{A331AB26-56D8-4BCA-8AAB-C188316A8DF2}"/>
          </ac:spMkLst>
        </pc:spChg>
      </pc:sldChg>
      <pc:sldChg chg="modSp">
        <pc:chgData name="Gomez, Daniela (Alliance Bioversity-CIAT)" userId="S::daniela.gomez@cgiar.org::c94e5fda-a43d-46f7-b351-499384532572" providerId="AD" clId="Web-{01C4E04E-7ED2-942E-8D4B-9ED7DD5B7101}" dt="2023-10-26T14:25:56.960" v="345" actId="1076"/>
        <pc:sldMkLst>
          <pc:docMk/>
          <pc:sldMk cId="1946445284" sldId="275"/>
        </pc:sldMkLst>
        <pc:spChg chg="mod">
          <ac:chgData name="Gomez, Daniela (Alliance Bioversity-CIAT)" userId="S::daniela.gomez@cgiar.org::c94e5fda-a43d-46f7-b351-499384532572" providerId="AD" clId="Web-{01C4E04E-7ED2-942E-8D4B-9ED7DD5B7101}" dt="2023-10-26T14:25:56.960" v="345" actId="1076"/>
          <ac:spMkLst>
            <pc:docMk/>
            <pc:sldMk cId="1946445284" sldId="275"/>
            <ac:spMk id="15" creationId="{A331AB26-56D8-4BCA-8AAB-C188316A8DF2}"/>
          </ac:spMkLst>
        </pc:spChg>
      </pc:sldChg>
      <pc:sldChg chg="addSp delSp modSp new">
        <pc:chgData name="Gomez, Daniela (Alliance Bioversity-CIAT)" userId="S::daniela.gomez@cgiar.org::c94e5fda-a43d-46f7-b351-499384532572" providerId="AD" clId="Web-{01C4E04E-7ED2-942E-8D4B-9ED7DD5B7101}" dt="2023-10-26T14:15:46.487" v="220" actId="20577"/>
        <pc:sldMkLst>
          <pc:docMk/>
          <pc:sldMk cId="1605347520" sldId="276"/>
        </pc:sldMkLst>
        <pc:spChg chg="del">
          <ac:chgData name="Gomez, Daniela (Alliance Bioversity-CIAT)" userId="S::daniela.gomez@cgiar.org::c94e5fda-a43d-46f7-b351-499384532572" providerId="AD" clId="Web-{01C4E04E-7ED2-942E-8D4B-9ED7DD5B7101}" dt="2023-10-26T13:51:07.162" v="124"/>
          <ac:spMkLst>
            <pc:docMk/>
            <pc:sldMk cId="1605347520" sldId="276"/>
            <ac:spMk id="2" creationId="{8CE94D83-D9CF-A723-24C6-1A0A23313937}"/>
          </ac:spMkLst>
        </pc:spChg>
        <pc:spChg chg="add mod">
          <ac:chgData name="Gomez, Daniela (Alliance Bioversity-CIAT)" userId="S::daniela.gomez@cgiar.org::c94e5fda-a43d-46f7-b351-499384532572" providerId="AD" clId="Web-{01C4E04E-7ED2-942E-8D4B-9ED7DD5B7101}" dt="2023-10-26T14:15:46.487" v="220" actId="20577"/>
          <ac:spMkLst>
            <pc:docMk/>
            <pc:sldMk cId="1605347520" sldId="276"/>
            <ac:spMk id="3" creationId="{7407D766-0A41-2817-44C1-014E1233DBD8}"/>
          </ac:spMkLst>
        </pc:spChg>
        <pc:spChg chg="del">
          <ac:chgData name="Gomez, Daniela (Alliance Bioversity-CIAT)" userId="S::daniela.gomez@cgiar.org::c94e5fda-a43d-46f7-b351-499384532572" providerId="AD" clId="Web-{01C4E04E-7ED2-942E-8D4B-9ED7DD5B7101}" dt="2023-10-26T13:51:08.694" v="125"/>
          <ac:spMkLst>
            <pc:docMk/>
            <pc:sldMk cId="1605347520" sldId="276"/>
            <ac:spMk id="3" creationId="{C231DD52-B630-7F33-68EC-CF37E0F6AE4A}"/>
          </ac:spMkLst>
        </pc:spChg>
        <pc:picChg chg="add mod">
          <ac:chgData name="Gomez, Daniela (Alliance Bioversity-CIAT)" userId="S::daniela.gomez@cgiar.org::c94e5fda-a43d-46f7-b351-499384532572" providerId="AD" clId="Web-{01C4E04E-7ED2-942E-8D4B-9ED7DD5B7101}" dt="2023-10-26T14:13:56.874" v="182" actId="1076"/>
          <ac:picMkLst>
            <pc:docMk/>
            <pc:sldMk cId="1605347520" sldId="276"/>
            <ac:picMk id="4" creationId="{E2DDB425-0DBA-3A02-537E-6B3E1A46FAC7}"/>
          </ac:picMkLst>
        </pc:picChg>
      </pc:sldChg>
      <pc:sldChg chg="addSp delSp modSp new">
        <pc:chgData name="Gomez, Daniela (Alliance Bioversity-CIAT)" userId="S::daniela.gomez@cgiar.org::c94e5fda-a43d-46f7-b351-499384532572" providerId="AD" clId="Web-{01C4E04E-7ED2-942E-8D4B-9ED7DD5B7101}" dt="2023-10-26T14:26:31.008" v="349" actId="20577"/>
        <pc:sldMkLst>
          <pc:docMk/>
          <pc:sldMk cId="529526858" sldId="277"/>
        </pc:sldMkLst>
        <pc:spChg chg="del">
          <ac:chgData name="Gomez, Daniela (Alliance Bioversity-CIAT)" userId="S::daniela.gomez@cgiar.org::c94e5fda-a43d-46f7-b351-499384532572" providerId="AD" clId="Web-{01C4E04E-7ED2-942E-8D4B-9ED7DD5B7101}" dt="2023-10-26T13:51:18.132" v="133"/>
          <ac:spMkLst>
            <pc:docMk/>
            <pc:sldMk cId="529526858" sldId="277"/>
            <ac:spMk id="2" creationId="{AC79F343-299F-7C2D-6141-0B65AF911631}"/>
          </ac:spMkLst>
        </pc:spChg>
        <pc:spChg chg="add">
          <ac:chgData name="Gomez, Daniela (Alliance Bioversity-CIAT)" userId="S::daniela.gomez@cgiar.org::c94e5fda-a43d-46f7-b351-499384532572" providerId="AD" clId="Web-{01C4E04E-7ED2-942E-8D4B-9ED7DD5B7101}" dt="2023-10-26T14:20:27.324" v="253"/>
          <ac:spMkLst>
            <pc:docMk/>
            <pc:sldMk cId="529526858" sldId="277"/>
            <ac:spMk id="3" creationId="{8FB5BC53-AD23-B42C-4718-499B907F0BE5}"/>
          </ac:spMkLst>
        </pc:spChg>
        <pc:spChg chg="del">
          <ac:chgData name="Gomez, Daniela (Alliance Bioversity-CIAT)" userId="S::daniela.gomez@cgiar.org::c94e5fda-a43d-46f7-b351-499384532572" providerId="AD" clId="Web-{01C4E04E-7ED2-942E-8D4B-9ED7DD5B7101}" dt="2023-10-26T13:51:17.038" v="132"/>
          <ac:spMkLst>
            <pc:docMk/>
            <pc:sldMk cId="529526858" sldId="277"/>
            <ac:spMk id="3" creationId="{A1778666-E4AA-58FF-CA24-8B5864C7368A}"/>
          </ac:spMkLst>
        </pc:spChg>
        <pc:spChg chg="add">
          <ac:chgData name="Gomez, Daniela (Alliance Bioversity-CIAT)" userId="S::daniela.gomez@cgiar.org::c94e5fda-a43d-46f7-b351-499384532572" providerId="AD" clId="Web-{01C4E04E-7ED2-942E-8D4B-9ED7DD5B7101}" dt="2023-10-26T14:20:27.340" v="254"/>
          <ac:spMkLst>
            <pc:docMk/>
            <pc:sldMk cId="529526858" sldId="277"/>
            <ac:spMk id="9" creationId="{CFAAD78C-3DA7-0654-B9A0-641219C377A6}"/>
          </ac:spMkLst>
        </pc:spChg>
        <pc:spChg chg="add">
          <ac:chgData name="Gomez, Daniela (Alliance Bioversity-CIAT)" userId="S::daniela.gomez@cgiar.org::c94e5fda-a43d-46f7-b351-499384532572" providerId="AD" clId="Web-{01C4E04E-7ED2-942E-8D4B-9ED7DD5B7101}" dt="2023-10-26T14:20:27.340" v="255"/>
          <ac:spMkLst>
            <pc:docMk/>
            <pc:sldMk cId="529526858" sldId="277"/>
            <ac:spMk id="11" creationId="{F4C918E5-8850-6C21-CAAD-2032F9B86C59}"/>
          </ac:spMkLst>
        </pc:spChg>
        <pc:spChg chg="add">
          <ac:chgData name="Gomez, Daniela (Alliance Bioversity-CIAT)" userId="S::daniela.gomez@cgiar.org::c94e5fda-a43d-46f7-b351-499384532572" providerId="AD" clId="Web-{01C4E04E-7ED2-942E-8D4B-9ED7DD5B7101}" dt="2023-10-26T14:20:27.356" v="256"/>
          <ac:spMkLst>
            <pc:docMk/>
            <pc:sldMk cId="529526858" sldId="277"/>
            <ac:spMk id="13" creationId="{449B23B2-3678-8CB0-F0A0-B7EC29777264}"/>
          </ac:spMkLst>
        </pc:spChg>
        <pc:spChg chg="add mod">
          <ac:chgData name="Gomez, Daniela (Alliance Bioversity-CIAT)" userId="S::daniela.gomez@cgiar.org::c94e5fda-a43d-46f7-b351-499384532572" providerId="AD" clId="Web-{01C4E04E-7ED2-942E-8D4B-9ED7DD5B7101}" dt="2023-10-26T14:26:31.008" v="349" actId="20577"/>
          <ac:spMkLst>
            <pc:docMk/>
            <pc:sldMk cId="529526858" sldId="277"/>
            <ac:spMk id="15" creationId="{31521B25-5F28-A1FE-D2B4-E274D0C959D6}"/>
          </ac:spMkLst>
        </pc:spChg>
        <pc:picChg chg="add mod">
          <ac:chgData name="Gomez, Daniela (Alliance Bioversity-CIAT)" userId="S::daniela.gomez@cgiar.org::c94e5fda-a43d-46f7-b351-499384532572" providerId="AD" clId="Web-{01C4E04E-7ED2-942E-8D4B-9ED7DD5B7101}" dt="2023-10-26T14:21:08.279" v="277" actId="14100"/>
          <ac:picMkLst>
            <pc:docMk/>
            <pc:sldMk cId="529526858" sldId="277"/>
            <ac:picMk id="4" creationId="{09DBF7C0-2B0F-1AE8-CA3E-1E83ABC7D808}"/>
          </ac:picMkLst>
        </pc:picChg>
        <pc:picChg chg="add mod">
          <ac:chgData name="Gomez, Daniela (Alliance Bioversity-CIAT)" userId="S::daniela.gomez@cgiar.org::c94e5fda-a43d-46f7-b351-499384532572" providerId="AD" clId="Web-{01C4E04E-7ED2-942E-8D4B-9ED7DD5B7101}" dt="2023-10-26T14:20:59.091" v="275" actId="14100"/>
          <ac:picMkLst>
            <pc:docMk/>
            <pc:sldMk cId="529526858" sldId="277"/>
            <ac:picMk id="5" creationId="{B96DC4EA-3AF9-2806-C8C5-515A4AFC1A4D}"/>
          </ac:picMkLst>
        </pc:picChg>
        <pc:picChg chg="add mod">
          <ac:chgData name="Gomez, Daniela (Alliance Bioversity-CIAT)" userId="S::daniela.gomez@cgiar.org::c94e5fda-a43d-46f7-b351-499384532572" providerId="AD" clId="Web-{01C4E04E-7ED2-942E-8D4B-9ED7DD5B7101}" dt="2023-10-26T14:20:42.950" v="270" actId="14100"/>
          <ac:picMkLst>
            <pc:docMk/>
            <pc:sldMk cId="529526858" sldId="277"/>
            <ac:picMk id="6" creationId="{AE20FA49-8874-8082-BF38-B7D5B5ECCA44}"/>
          </ac:picMkLst>
        </pc:picChg>
        <pc:picChg chg="add mod">
          <ac:chgData name="Gomez, Daniela (Alliance Bioversity-CIAT)" userId="S::daniela.gomez@cgiar.org::c94e5fda-a43d-46f7-b351-499384532572" providerId="AD" clId="Web-{01C4E04E-7ED2-942E-8D4B-9ED7DD5B7101}" dt="2023-10-26T14:20:50.419" v="272" actId="14100"/>
          <ac:picMkLst>
            <pc:docMk/>
            <pc:sldMk cId="529526858" sldId="277"/>
            <ac:picMk id="7" creationId="{CAB6DED4-1698-6CD7-0882-B0BD094655DE}"/>
          </ac:picMkLst>
        </pc:picChg>
      </pc:sldChg>
      <pc:sldChg chg="addSp delSp modSp new">
        <pc:chgData name="Gomez, Daniela (Alliance Bioversity-CIAT)" userId="S::daniela.gomez@cgiar.org::c94e5fda-a43d-46f7-b351-499384532572" providerId="AD" clId="Web-{01C4E04E-7ED2-942E-8D4B-9ED7DD5B7101}" dt="2023-10-26T14:16:18.926" v="230" actId="1076"/>
        <pc:sldMkLst>
          <pc:docMk/>
          <pc:sldMk cId="2349917634" sldId="278"/>
        </pc:sldMkLst>
        <pc:spChg chg="del">
          <ac:chgData name="Gomez, Daniela (Alliance Bioversity-CIAT)" userId="S::daniela.gomez@cgiar.org::c94e5fda-a43d-46f7-b351-499384532572" providerId="AD" clId="Web-{01C4E04E-7ED2-942E-8D4B-9ED7DD5B7101}" dt="2023-10-26T13:51:20.897" v="135"/>
          <ac:spMkLst>
            <pc:docMk/>
            <pc:sldMk cId="2349917634" sldId="278"/>
            <ac:spMk id="2" creationId="{F78F7D49-8B1C-D9EA-34A0-CD54CD06B6EC}"/>
          </ac:spMkLst>
        </pc:spChg>
        <pc:spChg chg="del">
          <ac:chgData name="Gomez, Daniela (Alliance Bioversity-CIAT)" userId="S::daniela.gomez@cgiar.org::c94e5fda-a43d-46f7-b351-499384532572" providerId="AD" clId="Web-{01C4E04E-7ED2-942E-8D4B-9ED7DD5B7101}" dt="2023-10-26T13:51:19.694" v="134"/>
          <ac:spMkLst>
            <pc:docMk/>
            <pc:sldMk cId="2349917634" sldId="278"/>
            <ac:spMk id="3" creationId="{CDA86CF7-E250-C5BA-2F70-EE09D75FABA1}"/>
          </ac:spMkLst>
        </pc:spChg>
        <pc:spChg chg="add mod">
          <ac:chgData name="Gomez, Daniela (Alliance Bioversity-CIAT)" userId="S::daniela.gomez@cgiar.org::c94e5fda-a43d-46f7-b351-499384532572" providerId="AD" clId="Web-{01C4E04E-7ED2-942E-8D4B-9ED7DD5B7101}" dt="2023-10-26T14:16:14.097" v="228" actId="20577"/>
          <ac:spMkLst>
            <pc:docMk/>
            <pc:sldMk cId="2349917634" sldId="278"/>
            <ac:spMk id="4" creationId="{C72D4F93-3114-72B0-0158-44D107EEA4BC}"/>
          </ac:spMkLst>
        </pc:spChg>
        <pc:picChg chg="add mod">
          <ac:chgData name="Gomez, Daniela (Alliance Bioversity-CIAT)" userId="S::daniela.gomez@cgiar.org::c94e5fda-a43d-46f7-b351-499384532572" providerId="AD" clId="Web-{01C4E04E-7ED2-942E-8D4B-9ED7DD5B7101}" dt="2023-10-26T14:16:18.926" v="230" actId="1076"/>
          <ac:picMkLst>
            <pc:docMk/>
            <pc:sldMk cId="2349917634" sldId="278"/>
            <ac:picMk id="2" creationId="{7EBBD188-05F5-BE29-E6FB-F6421904E1F6}"/>
          </ac:picMkLst>
        </pc:picChg>
      </pc:sldChg>
      <pc:sldChg chg="addSp delSp modSp new">
        <pc:chgData name="Gomez, Daniela (Alliance Bioversity-CIAT)" userId="S::daniela.gomez@cgiar.org::c94e5fda-a43d-46f7-b351-499384532572" providerId="AD" clId="Web-{01C4E04E-7ED2-942E-8D4B-9ED7DD5B7101}" dt="2023-10-26T14:26:49.087" v="353" actId="20577"/>
        <pc:sldMkLst>
          <pc:docMk/>
          <pc:sldMk cId="1807957567" sldId="279"/>
        </pc:sldMkLst>
        <pc:spChg chg="del">
          <ac:chgData name="Gomez, Daniela (Alliance Bioversity-CIAT)" userId="S::daniela.gomez@cgiar.org::c94e5fda-a43d-46f7-b351-499384532572" providerId="AD" clId="Web-{01C4E04E-7ED2-942E-8D4B-9ED7DD5B7101}" dt="2023-10-26T13:51:25.460" v="137"/>
          <ac:spMkLst>
            <pc:docMk/>
            <pc:sldMk cId="1807957567" sldId="279"/>
            <ac:spMk id="2" creationId="{CAF4C798-0192-B541-F76F-C9D818EB7B9E}"/>
          </ac:spMkLst>
        </pc:spChg>
        <pc:spChg chg="del">
          <ac:chgData name="Gomez, Daniela (Alliance Bioversity-CIAT)" userId="S::daniela.gomez@cgiar.org::c94e5fda-a43d-46f7-b351-499384532572" providerId="AD" clId="Web-{01C4E04E-7ED2-942E-8D4B-9ED7DD5B7101}" dt="2023-10-26T13:51:23.835" v="136"/>
          <ac:spMkLst>
            <pc:docMk/>
            <pc:sldMk cId="1807957567" sldId="279"/>
            <ac:spMk id="3" creationId="{76FFBA59-83F2-F67A-3095-8E5B7E2F9E73}"/>
          </ac:spMkLst>
        </pc:spChg>
        <pc:spChg chg="add">
          <ac:chgData name="Gomez, Daniela (Alliance Bioversity-CIAT)" userId="S::daniela.gomez@cgiar.org::c94e5fda-a43d-46f7-b351-499384532572" providerId="AD" clId="Web-{01C4E04E-7ED2-942E-8D4B-9ED7DD5B7101}" dt="2023-10-26T14:20:30.528" v="257"/>
          <ac:spMkLst>
            <pc:docMk/>
            <pc:sldMk cId="1807957567" sldId="279"/>
            <ac:spMk id="7" creationId="{E6D05A7E-ECA3-4E6A-F76C-6CBD72B4E676}"/>
          </ac:spMkLst>
        </pc:spChg>
        <pc:spChg chg="add">
          <ac:chgData name="Gomez, Daniela (Alliance Bioversity-CIAT)" userId="S::daniela.gomez@cgiar.org::c94e5fda-a43d-46f7-b351-499384532572" providerId="AD" clId="Web-{01C4E04E-7ED2-942E-8D4B-9ED7DD5B7101}" dt="2023-10-26T14:20:30.528" v="258"/>
          <ac:spMkLst>
            <pc:docMk/>
            <pc:sldMk cId="1807957567" sldId="279"/>
            <ac:spMk id="9" creationId="{5ADBFA34-D660-B674-7A7A-57CC205AAC64}"/>
          </ac:spMkLst>
        </pc:spChg>
        <pc:spChg chg="add">
          <ac:chgData name="Gomez, Daniela (Alliance Bioversity-CIAT)" userId="S::daniela.gomez@cgiar.org::c94e5fda-a43d-46f7-b351-499384532572" providerId="AD" clId="Web-{01C4E04E-7ED2-942E-8D4B-9ED7DD5B7101}" dt="2023-10-26T14:20:30.543" v="259"/>
          <ac:spMkLst>
            <pc:docMk/>
            <pc:sldMk cId="1807957567" sldId="279"/>
            <ac:spMk id="11" creationId="{E12B7635-74B7-6A2D-154C-9C2FF22829AF}"/>
          </ac:spMkLst>
        </pc:spChg>
        <pc:spChg chg="add mod">
          <ac:chgData name="Gomez, Daniela (Alliance Bioversity-CIAT)" userId="S::daniela.gomez@cgiar.org::c94e5fda-a43d-46f7-b351-499384532572" providerId="AD" clId="Web-{01C4E04E-7ED2-942E-8D4B-9ED7DD5B7101}" dt="2023-10-26T14:23:16.033" v="293" actId="1076"/>
          <ac:spMkLst>
            <pc:docMk/>
            <pc:sldMk cId="1807957567" sldId="279"/>
            <ac:spMk id="13" creationId="{D086C108-9A80-4085-C524-35EA4B36A27A}"/>
          </ac:spMkLst>
        </pc:spChg>
        <pc:spChg chg="add mod">
          <ac:chgData name="Gomez, Daniela (Alliance Bioversity-CIAT)" userId="S::daniela.gomez@cgiar.org::c94e5fda-a43d-46f7-b351-499384532572" providerId="AD" clId="Web-{01C4E04E-7ED2-942E-8D4B-9ED7DD5B7101}" dt="2023-10-26T14:26:49.087" v="353" actId="20577"/>
          <ac:spMkLst>
            <pc:docMk/>
            <pc:sldMk cId="1807957567" sldId="279"/>
            <ac:spMk id="15" creationId="{91066358-8536-0832-6CC0-D39F72B4FDE1}"/>
          </ac:spMkLst>
        </pc:spChg>
        <pc:picChg chg="add mod">
          <ac:chgData name="Gomez, Daniela (Alliance Bioversity-CIAT)" userId="S::daniela.gomez@cgiar.org::c94e5fda-a43d-46f7-b351-499384532572" providerId="AD" clId="Web-{01C4E04E-7ED2-942E-8D4B-9ED7DD5B7101}" dt="2023-10-26T14:23:29.268" v="297" actId="14100"/>
          <ac:picMkLst>
            <pc:docMk/>
            <pc:sldMk cId="1807957567" sldId="279"/>
            <ac:picMk id="2" creationId="{A81F5B93-CE50-B819-DFE8-7E405C46E05F}"/>
          </ac:picMkLst>
        </pc:picChg>
        <pc:picChg chg="add mod">
          <ac:chgData name="Gomez, Daniela (Alliance Bioversity-CIAT)" userId="S::daniela.gomez@cgiar.org::c94e5fda-a43d-46f7-b351-499384532572" providerId="AD" clId="Web-{01C4E04E-7ED2-942E-8D4B-9ED7DD5B7101}" dt="2023-10-26T14:23:11.986" v="291" actId="14100"/>
          <ac:picMkLst>
            <pc:docMk/>
            <pc:sldMk cId="1807957567" sldId="279"/>
            <ac:picMk id="3" creationId="{929362FC-1D75-209F-9745-60685EF2F64A}"/>
          </ac:picMkLst>
        </pc:picChg>
        <pc:picChg chg="add mod">
          <ac:chgData name="Gomez, Daniela (Alliance Bioversity-CIAT)" userId="S::daniela.gomez@cgiar.org::c94e5fda-a43d-46f7-b351-499384532572" providerId="AD" clId="Web-{01C4E04E-7ED2-942E-8D4B-9ED7DD5B7101}" dt="2023-10-26T14:22:19.375" v="284" actId="14100"/>
          <ac:picMkLst>
            <pc:docMk/>
            <pc:sldMk cId="1807957567" sldId="279"/>
            <ac:picMk id="4" creationId="{6F739D19-B295-80D6-3944-1EA681936054}"/>
          </ac:picMkLst>
        </pc:picChg>
        <pc:picChg chg="add mod">
          <ac:chgData name="Gomez, Daniela (Alliance Bioversity-CIAT)" userId="S::daniela.gomez@cgiar.org::c94e5fda-a43d-46f7-b351-499384532572" providerId="AD" clId="Web-{01C4E04E-7ED2-942E-8D4B-9ED7DD5B7101}" dt="2023-10-26T14:22:27.141" v="286" actId="14100"/>
          <ac:picMkLst>
            <pc:docMk/>
            <pc:sldMk cId="1807957567" sldId="279"/>
            <ac:picMk id="5" creationId="{2FE9CBD1-92EE-7707-B707-543D2AFAFA70}"/>
          </ac:picMkLst>
        </pc:picChg>
      </pc:sldChg>
      <pc:sldChg chg="addSp delSp modSp new">
        <pc:chgData name="Gomez, Daniela (Alliance Bioversity-CIAT)" userId="S::daniela.gomez@cgiar.org::c94e5fda-a43d-46f7-b351-499384532572" providerId="AD" clId="Web-{01C4E04E-7ED2-942E-8D4B-9ED7DD5B7101}" dt="2023-10-26T14:16:51.239" v="238" actId="20577"/>
        <pc:sldMkLst>
          <pc:docMk/>
          <pc:sldMk cId="2805558929" sldId="280"/>
        </pc:sldMkLst>
        <pc:spChg chg="del">
          <ac:chgData name="Gomez, Daniela (Alliance Bioversity-CIAT)" userId="S::daniela.gomez@cgiar.org::c94e5fda-a43d-46f7-b351-499384532572" providerId="AD" clId="Web-{01C4E04E-7ED2-942E-8D4B-9ED7DD5B7101}" dt="2023-10-26T13:51:29.788" v="139"/>
          <ac:spMkLst>
            <pc:docMk/>
            <pc:sldMk cId="2805558929" sldId="280"/>
            <ac:spMk id="2" creationId="{28AA0776-BFD1-7FE9-2C0A-40DE86CDAFEA}"/>
          </ac:spMkLst>
        </pc:spChg>
        <pc:spChg chg="del">
          <ac:chgData name="Gomez, Daniela (Alliance Bioversity-CIAT)" userId="S::daniela.gomez@cgiar.org::c94e5fda-a43d-46f7-b351-499384532572" providerId="AD" clId="Web-{01C4E04E-7ED2-942E-8D4B-9ED7DD5B7101}" dt="2023-10-26T13:51:28.726" v="138"/>
          <ac:spMkLst>
            <pc:docMk/>
            <pc:sldMk cId="2805558929" sldId="280"/>
            <ac:spMk id="3" creationId="{6898A827-0160-E4B4-2E1A-3E64D6F51034}"/>
          </ac:spMkLst>
        </pc:spChg>
        <pc:spChg chg="add mod">
          <ac:chgData name="Gomez, Daniela (Alliance Bioversity-CIAT)" userId="S::daniela.gomez@cgiar.org::c94e5fda-a43d-46f7-b351-499384532572" providerId="AD" clId="Web-{01C4E04E-7ED2-942E-8D4B-9ED7DD5B7101}" dt="2023-10-26T14:16:51.239" v="238" actId="20577"/>
          <ac:spMkLst>
            <pc:docMk/>
            <pc:sldMk cId="2805558929" sldId="280"/>
            <ac:spMk id="4" creationId="{590AD048-76EC-C177-43E5-9AD8C3E167C3}"/>
          </ac:spMkLst>
        </pc:spChg>
        <pc:picChg chg="add mod">
          <ac:chgData name="Gomez, Daniela (Alliance Bioversity-CIAT)" userId="S::daniela.gomez@cgiar.org::c94e5fda-a43d-46f7-b351-499384532572" providerId="AD" clId="Web-{01C4E04E-7ED2-942E-8D4B-9ED7DD5B7101}" dt="2023-10-26T14:16:39.301" v="235" actId="1076"/>
          <ac:picMkLst>
            <pc:docMk/>
            <pc:sldMk cId="2805558929" sldId="280"/>
            <ac:picMk id="2" creationId="{492A5CA6-0065-69CB-6462-D429331116DE}"/>
          </ac:picMkLst>
        </pc:picChg>
      </pc:sldChg>
      <pc:sldChg chg="addSp delSp modSp new">
        <pc:chgData name="Gomez, Daniela (Alliance Bioversity-CIAT)" userId="S::daniela.gomez@cgiar.org::c94e5fda-a43d-46f7-b351-499384532572" providerId="AD" clId="Web-{01C4E04E-7ED2-942E-8D4B-9ED7DD5B7101}" dt="2023-10-26T14:27:03.869" v="357" actId="20577"/>
        <pc:sldMkLst>
          <pc:docMk/>
          <pc:sldMk cId="4087503730" sldId="281"/>
        </pc:sldMkLst>
        <pc:spChg chg="del">
          <ac:chgData name="Gomez, Daniela (Alliance Bioversity-CIAT)" userId="S::daniela.gomez@cgiar.org::c94e5fda-a43d-46f7-b351-499384532572" providerId="AD" clId="Web-{01C4E04E-7ED2-942E-8D4B-9ED7DD5B7101}" dt="2023-10-26T13:51:33.444" v="141"/>
          <ac:spMkLst>
            <pc:docMk/>
            <pc:sldMk cId="4087503730" sldId="281"/>
            <ac:spMk id="2" creationId="{1D200F95-A824-4FE9-17CC-EA0B5D01BBC9}"/>
          </ac:spMkLst>
        </pc:spChg>
        <pc:spChg chg="del">
          <ac:chgData name="Gomez, Daniela (Alliance Bioversity-CIAT)" userId="S::daniela.gomez@cgiar.org::c94e5fda-a43d-46f7-b351-499384532572" providerId="AD" clId="Web-{01C4E04E-7ED2-942E-8D4B-9ED7DD5B7101}" dt="2023-10-26T13:51:32.054" v="140"/>
          <ac:spMkLst>
            <pc:docMk/>
            <pc:sldMk cId="4087503730" sldId="281"/>
            <ac:spMk id="3" creationId="{8FAFDEC4-D662-2BCA-177F-3BDC98AEAFD4}"/>
          </ac:spMkLst>
        </pc:spChg>
        <pc:spChg chg="add mod">
          <ac:chgData name="Gomez, Daniela (Alliance Bioversity-CIAT)" userId="S::daniela.gomez@cgiar.org::c94e5fda-a43d-46f7-b351-499384532572" providerId="AD" clId="Web-{01C4E04E-7ED2-942E-8D4B-9ED7DD5B7101}" dt="2023-10-26T14:24:23.801" v="315" actId="1076"/>
          <ac:spMkLst>
            <pc:docMk/>
            <pc:sldMk cId="4087503730" sldId="281"/>
            <ac:spMk id="7" creationId="{0F7D3C5B-72AD-293F-2796-7186070D677B}"/>
          </ac:spMkLst>
        </pc:spChg>
        <pc:spChg chg="add mod">
          <ac:chgData name="Gomez, Daniela (Alliance Bioversity-CIAT)" userId="S::daniela.gomez@cgiar.org::c94e5fda-a43d-46f7-b351-499384532572" providerId="AD" clId="Web-{01C4E04E-7ED2-942E-8D4B-9ED7DD5B7101}" dt="2023-10-26T14:24:23.801" v="316" actId="1076"/>
          <ac:spMkLst>
            <pc:docMk/>
            <pc:sldMk cId="4087503730" sldId="281"/>
            <ac:spMk id="9" creationId="{C3CDA3C8-6316-F258-A275-42D3C35971D0}"/>
          </ac:spMkLst>
        </pc:spChg>
        <pc:spChg chg="add mod">
          <ac:chgData name="Gomez, Daniela (Alliance Bioversity-CIAT)" userId="S::daniela.gomez@cgiar.org::c94e5fda-a43d-46f7-b351-499384532572" providerId="AD" clId="Web-{01C4E04E-7ED2-942E-8D4B-9ED7DD5B7101}" dt="2023-10-26T14:24:23.801" v="317" actId="1076"/>
          <ac:spMkLst>
            <pc:docMk/>
            <pc:sldMk cId="4087503730" sldId="281"/>
            <ac:spMk id="11" creationId="{C31B13B6-FA9F-373D-EAAC-5814727D7BE8}"/>
          </ac:spMkLst>
        </pc:spChg>
        <pc:spChg chg="add mod">
          <ac:chgData name="Gomez, Daniela (Alliance Bioversity-CIAT)" userId="S::daniela.gomez@cgiar.org::c94e5fda-a43d-46f7-b351-499384532572" providerId="AD" clId="Web-{01C4E04E-7ED2-942E-8D4B-9ED7DD5B7101}" dt="2023-10-26T14:24:23.801" v="318" actId="1076"/>
          <ac:spMkLst>
            <pc:docMk/>
            <pc:sldMk cId="4087503730" sldId="281"/>
            <ac:spMk id="13" creationId="{E22C6B3A-6162-1D4A-7AFC-3F68DDA0380D}"/>
          </ac:spMkLst>
        </pc:spChg>
        <pc:spChg chg="add mod">
          <ac:chgData name="Gomez, Daniela (Alliance Bioversity-CIAT)" userId="S::daniela.gomez@cgiar.org::c94e5fda-a43d-46f7-b351-499384532572" providerId="AD" clId="Web-{01C4E04E-7ED2-942E-8D4B-9ED7DD5B7101}" dt="2023-10-26T14:27:03.869" v="357" actId="20577"/>
          <ac:spMkLst>
            <pc:docMk/>
            <pc:sldMk cId="4087503730" sldId="281"/>
            <ac:spMk id="15" creationId="{D81AF051-742B-510D-A937-84ABE8E2177F}"/>
          </ac:spMkLst>
        </pc:spChg>
        <pc:picChg chg="add mod">
          <ac:chgData name="Gomez, Daniela (Alliance Bioversity-CIAT)" userId="S::daniela.gomez@cgiar.org::c94e5fda-a43d-46f7-b351-499384532572" providerId="AD" clId="Web-{01C4E04E-7ED2-942E-8D4B-9ED7DD5B7101}" dt="2023-10-26T14:24:23.957" v="322" actId="1076"/>
          <ac:picMkLst>
            <pc:docMk/>
            <pc:sldMk cId="4087503730" sldId="281"/>
            <ac:picMk id="2" creationId="{3537FF88-C47C-D829-C484-E3C3AE35AEB3}"/>
          </ac:picMkLst>
        </pc:picChg>
        <pc:picChg chg="add mod">
          <ac:chgData name="Gomez, Daniela (Alliance Bioversity-CIAT)" userId="S::daniela.gomez@cgiar.org::c94e5fda-a43d-46f7-b351-499384532572" providerId="AD" clId="Web-{01C4E04E-7ED2-942E-8D4B-9ED7DD5B7101}" dt="2023-10-26T14:24:23.926" v="321" actId="1076"/>
          <ac:picMkLst>
            <pc:docMk/>
            <pc:sldMk cId="4087503730" sldId="281"/>
            <ac:picMk id="3" creationId="{53B96D3E-6860-B331-3D0C-F8B019B6D323}"/>
          </ac:picMkLst>
        </pc:picChg>
        <pc:picChg chg="add mod">
          <ac:chgData name="Gomez, Daniela (Alliance Bioversity-CIAT)" userId="S::daniela.gomez@cgiar.org::c94e5fda-a43d-46f7-b351-499384532572" providerId="AD" clId="Web-{01C4E04E-7ED2-942E-8D4B-9ED7DD5B7101}" dt="2023-10-26T14:24:23.848" v="319" actId="1076"/>
          <ac:picMkLst>
            <pc:docMk/>
            <pc:sldMk cId="4087503730" sldId="281"/>
            <ac:picMk id="4" creationId="{9B6A6DFC-BB37-9CBE-4028-C7A721FC2FBC}"/>
          </ac:picMkLst>
        </pc:picChg>
        <pc:picChg chg="add mod">
          <ac:chgData name="Gomez, Daniela (Alliance Bioversity-CIAT)" userId="S::daniela.gomez@cgiar.org::c94e5fda-a43d-46f7-b351-499384532572" providerId="AD" clId="Web-{01C4E04E-7ED2-942E-8D4B-9ED7DD5B7101}" dt="2023-10-26T14:24:23.895" v="320" actId="1076"/>
          <ac:picMkLst>
            <pc:docMk/>
            <pc:sldMk cId="4087503730" sldId="281"/>
            <ac:picMk id="5" creationId="{819295F8-03A6-95F7-EF7D-0B4725B9B487}"/>
          </ac:picMkLst>
        </pc:picChg>
      </pc:sldChg>
      <pc:sldChg chg="addSp delSp modSp new">
        <pc:chgData name="Gomez, Daniela (Alliance Bioversity-CIAT)" userId="S::daniela.gomez@cgiar.org::c94e5fda-a43d-46f7-b351-499384532572" providerId="AD" clId="Web-{01C4E04E-7ED2-942E-8D4B-9ED7DD5B7101}" dt="2023-10-26T14:17:37.897" v="247" actId="20577"/>
        <pc:sldMkLst>
          <pc:docMk/>
          <pc:sldMk cId="3263789347" sldId="282"/>
        </pc:sldMkLst>
        <pc:spChg chg="del">
          <ac:chgData name="Gomez, Daniela (Alliance Bioversity-CIAT)" userId="S::daniela.gomez@cgiar.org::c94e5fda-a43d-46f7-b351-499384532572" providerId="AD" clId="Web-{01C4E04E-7ED2-942E-8D4B-9ED7DD5B7101}" dt="2023-10-26T13:51:37.304" v="143"/>
          <ac:spMkLst>
            <pc:docMk/>
            <pc:sldMk cId="3263789347" sldId="282"/>
            <ac:spMk id="2" creationId="{5C012B9B-DB11-C1A9-CCB4-6AB718C30897}"/>
          </ac:spMkLst>
        </pc:spChg>
        <pc:spChg chg="del">
          <ac:chgData name="Gomez, Daniela (Alliance Bioversity-CIAT)" userId="S::daniela.gomez@cgiar.org::c94e5fda-a43d-46f7-b351-499384532572" providerId="AD" clId="Web-{01C4E04E-7ED2-942E-8D4B-9ED7DD5B7101}" dt="2023-10-26T13:51:36.460" v="142"/>
          <ac:spMkLst>
            <pc:docMk/>
            <pc:sldMk cId="3263789347" sldId="282"/>
            <ac:spMk id="3" creationId="{E9B26CC0-3B45-E68F-6107-AA449F12FA46}"/>
          </ac:spMkLst>
        </pc:spChg>
        <pc:spChg chg="add mod">
          <ac:chgData name="Gomez, Daniela (Alliance Bioversity-CIAT)" userId="S::daniela.gomez@cgiar.org::c94e5fda-a43d-46f7-b351-499384532572" providerId="AD" clId="Web-{01C4E04E-7ED2-942E-8D4B-9ED7DD5B7101}" dt="2023-10-26T14:17:37.897" v="247" actId="20577"/>
          <ac:spMkLst>
            <pc:docMk/>
            <pc:sldMk cId="3263789347" sldId="282"/>
            <ac:spMk id="4" creationId="{D6EE8DF7-A8F4-1113-5585-FD01B8158FB7}"/>
          </ac:spMkLst>
        </pc:spChg>
        <pc:picChg chg="add mod">
          <ac:chgData name="Gomez, Daniela (Alliance Bioversity-CIAT)" userId="S::daniela.gomez@cgiar.org::c94e5fda-a43d-46f7-b351-499384532572" providerId="AD" clId="Web-{01C4E04E-7ED2-942E-8D4B-9ED7DD5B7101}" dt="2023-10-26T14:17:23.912" v="244" actId="1076"/>
          <ac:picMkLst>
            <pc:docMk/>
            <pc:sldMk cId="3263789347" sldId="282"/>
            <ac:picMk id="2" creationId="{B5AF72F3-D5ED-1902-6135-282EC4FB012D}"/>
          </ac:picMkLst>
        </pc:picChg>
      </pc:sldChg>
      <pc:sldChg chg="addSp delSp modSp new">
        <pc:chgData name="Gomez, Daniela (Alliance Bioversity-CIAT)" userId="S::daniela.gomez@cgiar.org::c94e5fda-a43d-46f7-b351-499384532572" providerId="AD" clId="Web-{01C4E04E-7ED2-942E-8D4B-9ED7DD5B7101}" dt="2023-10-26T14:27:17.416" v="361" actId="20577"/>
        <pc:sldMkLst>
          <pc:docMk/>
          <pc:sldMk cId="92458492" sldId="283"/>
        </pc:sldMkLst>
        <pc:spChg chg="del">
          <ac:chgData name="Gomez, Daniela (Alliance Bioversity-CIAT)" userId="S::daniela.gomez@cgiar.org::c94e5fda-a43d-46f7-b351-499384532572" providerId="AD" clId="Web-{01C4E04E-7ED2-942E-8D4B-9ED7DD5B7101}" dt="2023-10-26T14:12:52.059" v="173"/>
          <ac:spMkLst>
            <pc:docMk/>
            <pc:sldMk cId="92458492" sldId="283"/>
            <ac:spMk id="2" creationId="{AEC442AB-9372-E057-8ABD-D992070A148D}"/>
          </ac:spMkLst>
        </pc:spChg>
        <pc:spChg chg="del">
          <ac:chgData name="Gomez, Daniela (Alliance Bioversity-CIAT)" userId="S::daniela.gomez@cgiar.org::c94e5fda-a43d-46f7-b351-499384532572" providerId="AD" clId="Web-{01C4E04E-7ED2-942E-8D4B-9ED7DD5B7101}" dt="2023-10-26T14:12:50.559" v="172"/>
          <ac:spMkLst>
            <pc:docMk/>
            <pc:sldMk cId="92458492" sldId="283"/>
            <ac:spMk id="3" creationId="{173F12C1-9B4A-F2E9-609C-C95A2149810F}"/>
          </ac:spMkLst>
        </pc:spChg>
        <pc:spChg chg="add">
          <ac:chgData name="Gomez, Daniela (Alliance Bioversity-CIAT)" userId="S::daniela.gomez@cgiar.org::c94e5fda-a43d-46f7-b351-499384532572" providerId="AD" clId="Web-{01C4E04E-7ED2-942E-8D4B-9ED7DD5B7101}" dt="2023-10-26T14:20:34.465" v="265"/>
          <ac:spMkLst>
            <pc:docMk/>
            <pc:sldMk cId="92458492" sldId="283"/>
            <ac:spMk id="9" creationId="{726F9883-4AA6-6D05-239A-2109BEB22140}"/>
          </ac:spMkLst>
        </pc:spChg>
        <pc:spChg chg="add">
          <ac:chgData name="Gomez, Daniela (Alliance Bioversity-CIAT)" userId="S::daniela.gomez@cgiar.org::c94e5fda-a43d-46f7-b351-499384532572" providerId="AD" clId="Web-{01C4E04E-7ED2-942E-8D4B-9ED7DD5B7101}" dt="2023-10-26T14:20:34.481" v="266"/>
          <ac:spMkLst>
            <pc:docMk/>
            <pc:sldMk cId="92458492" sldId="283"/>
            <ac:spMk id="11" creationId="{707F2B40-2BB5-7172-BDED-A4342DAEBE70}"/>
          </ac:spMkLst>
        </pc:spChg>
        <pc:spChg chg="add">
          <ac:chgData name="Gomez, Daniela (Alliance Bioversity-CIAT)" userId="S::daniela.gomez@cgiar.org::c94e5fda-a43d-46f7-b351-499384532572" providerId="AD" clId="Web-{01C4E04E-7ED2-942E-8D4B-9ED7DD5B7101}" dt="2023-10-26T14:20:34.481" v="267"/>
          <ac:spMkLst>
            <pc:docMk/>
            <pc:sldMk cId="92458492" sldId="283"/>
            <ac:spMk id="13" creationId="{C62B0741-870D-5723-14FB-B1A3BF1DC221}"/>
          </ac:spMkLst>
        </pc:spChg>
        <pc:spChg chg="add">
          <ac:chgData name="Gomez, Daniela (Alliance Bioversity-CIAT)" userId="S::daniela.gomez@cgiar.org::c94e5fda-a43d-46f7-b351-499384532572" providerId="AD" clId="Web-{01C4E04E-7ED2-942E-8D4B-9ED7DD5B7101}" dt="2023-10-26T14:20:34.481" v="268"/>
          <ac:spMkLst>
            <pc:docMk/>
            <pc:sldMk cId="92458492" sldId="283"/>
            <ac:spMk id="15" creationId="{BC482CBE-E16C-4099-69BC-E5799428173E}"/>
          </ac:spMkLst>
        </pc:spChg>
        <pc:spChg chg="add mod">
          <ac:chgData name="Gomez, Daniela (Alliance Bioversity-CIAT)" userId="S::daniela.gomez@cgiar.org::c94e5fda-a43d-46f7-b351-499384532572" providerId="AD" clId="Web-{01C4E04E-7ED2-942E-8D4B-9ED7DD5B7101}" dt="2023-10-26T14:27:17.416" v="361" actId="20577"/>
          <ac:spMkLst>
            <pc:docMk/>
            <pc:sldMk cId="92458492" sldId="283"/>
            <ac:spMk id="17" creationId="{D2B59B80-0F54-4137-EF91-DEB5CA313D11}"/>
          </ac:spMkLst>
        </pc:spChg>
        <pc:picChg chg="add mod">
          <ac:chgData name="Gomez, Daniela (Alliance Bioversity-CIAT)" userId="S::daniela.gomez@cgiar.org::c94e5fda-a43d-46f7-b351-499384532572" providerId="AD" clId="Web-{01C4E04E-7ED2-942E-8D4B-9ED7DD5B7101}" dt="2023-10-26T14:25:12.615" v="338" actId="14100"/>
          <ac:picMkLst>
            <pc:docMk/>
            <pc:sldMk cId="92458492" sldId="283"/>
            <ac:picMk id="4" creationId="{97D69735-9DDC-2A83-AA32-41C4C1C3D850}"/>
          </ac:picMkLst>
        </pc:picChg>
        <pc:picChg chg="add mod">
          <ac:chgData name="Gomez, Daniela (Alliance Bioversity-CIAT)" userId="S::daniela.gomez@cgiar.org::c94e5fda-a43d-46f7-b351-499384532572" providerId="AD" clId="Web-{01C4E04E-7ED2-942E-8D4B-9ED7DD5B7101}" dt="2023-10-26T14:24:59.427" v="334" actId="14100"/>
          <ac:picMkLst>
            <pc:docMk/>
            <pc:sldMk cId="92458492" sldId="283"/>
            <ac:picMk id="5" creationId="{92314211-CE2E-242D-B7FF-790DFF243D6C}"/>
          </ac:picMkLst>
        </pc:picChg>
        <pc:picChg chg="add mod">
          <ac:chgData name="Gomez, Daniela (Alliance Bioversity-CIAT)" userId="S::daniela.gomez@cgiar.org::c94e5fda-a43d-46f7-b351-499384532572" providerId="AD" clId="Web-{01C4E04E-7ED2-942E-8D4B-9ED7DD5B7101}" dt="2023-10-26T14:24:36.942" v="328" actId="14100"/>
          <ac:picMkLst>
            <pc:docMk/>
            <pc:sldMk cId="92458492" sldId="283"/>
            <ac:picMk id="6" creationId="{A6D62C2B-7C2F-0A0A-5E43-5431056BF978}"/>
          </ac:picMkLst>
        </pc:picChg>
        <pc:picChg chg="add mod">
          <ac:chgData name="Gomez, Daniela (Alliance Bioversity-CIAT)" userId="S::daniela.gomez@cgiar.org::c94e5fda-a43d-46f7-b351-499384532572" providerId="AD" clId="Web-{01C4E04E-7ED2-942E-8D4B-9ED7DD5B7101}" dt="2023-10-26T14:24:48.692" v="330" actId="14100"/>
          <ac:picMkLst>
            <pc:docMk/>
            <pc:sldMk cId="92458492" sldId="283"/>
            <ac:picMk id="7" creationId="{B5E1661D-01FE-928F-1DF5-232770CF5A04}"/>
          </ac:picMkLst>
        </pc:picChg>
      </pc:sldChg>
    </pc:docChg>
  </pc:docChgLst>
  <pc:docChgLst>
    <pc:chgData name="Gomez, Daniela (Alliance Bioversity-CIAT)" userId="c94e5fda-a43d-46f7-b351-499384532572" providerId="ADAL" clId="{F1480259-50A5-46B3-9145-8ECDAE4FEE01}"/>
    <pc:docChg chg="modSld">
      <pc:chgData name="Gomez, Daniela (Alliance Bioversity-CIAT)" userId="c94e5fda-a43d-46f7-b351-499384532572" providerId="ADAL" clId="{F1480259-50A5-46B3-9145-8ECDAE4FEE01}" dt="2024-02-23T18:54:33.300" v="5" actId="20577"/>
      <pc:docMkLst>
        <pc:docMk/>
      </pc:docMkLst>
      <pc:sldChg chg="modSp mod">
        <pc:chgData name="Gomez, Daniela (Alliance Bioversity-CIAT)" userId="c94e5fda-a43d-46f7-b351-499384532572" providerId="ADAL" clId="{F1480259-50A5-46B3-9145-8ECDAE4FEE01}" dt="2024-02-23T18:54:33.300" v="5" actId="20577"/>
        <pc:sldMkLst>
          <pc:docMk/>
          <pc:sldMk cId="4287176161" sldId="284"/>
        </pc:sldMkLst>
        <pc:spChg chg="mod">
          <ac:chgData name="Gomez, Daniela (Alliance Bioversity-CIAT)" userId="c94e5fda-a43d-46f7-b351-499384532572" providerId="ADAL" clId="{F1480259-50A5-46B3-9145-8ECDAE4FEE01}" dt="2024-02-23T18:54:33.300" v="5" actId="20577"/>
          <ac:spMkLst>
            <pc:docMk/>
            <pc:sldMk cId="4287176161" sldId="284"/>
            <ac:spMk id="17" creationId="{D2B59B80-0F54-4137-EF91-DEB5CA313D11}"/>
          </ac:spMkLst>
        </pc:spChg>
      </pc:sldChg>
    </pc:docChg>
  </pc:docChgLst>
  <pc:docChgLst>
    <pc:chgData name="Vergara, Javier (CIAT)" userId="S::j.vergara@cgiar.org::1737bf23-10e4-4004-af57-20e81a1f7d95" providerId="AD" clId="Web-{05190ADB-7930-1296-52A6-726F273762C4}"/>
    <pc:docChg chg="modSld sldOrd">
      <pc:chgData name="Vergara, Javier (CIAT)" userId="S::j.vergara@cgiar.org::1737bf23-10e4-4004-af57-20e81a1f7d95" providerId="AD" clId="Web-{05190ADB-7930-1296-52A6-726F273762C4}" dt="2019-03-27T16:44:09.552" v="4"/>
      <pc:docMkLst>
        <pc:docMk/>
      </pc:docMkLst>
      <pc:sldChg chg="modNotes">
        <pc:chgData name="Vergara, Javier (CIAT)" userId="S::j.vergara@cgiar.org::1737bf23-10e4-4004-af57-20e81a1f7d95" providerId="AD" clId="Web-{05190ADB-7930-1296-52A6-726F273762C4}" dt="2019-03-27T16:44:09.552" v="4"/>
        <pc:sldMkLst>
          <pc:docMk/>
          <pc:sldMk cId="4268846717" sldId="26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F5438075-9B0A-4BEE-86B9-269C99061940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8F91436B-E105-44CE-9D5B-37EDA65BC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8979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91436B-E105-44CE-9D5B-37EDA65BC3C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25902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91436B-E105-44CE-9D5B-37EDA65BC3CC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558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5A04E-9318-4D1C-8DB9-5C4D401BDC7C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BFB07-4C91-4BAF-AA65-465756D345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6635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5A04E-9318-4D1C-8DB9-5C4D401BDC7C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BFB07-4C91-4BAF-AA65-465756D345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172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5A04E-9318-4D1C-8DB9-5C4D401BDC7C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BFB07-4C91-4BAF-AA65-465756D345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7961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5A04E-9318-4D1C-8DB9-5C4D401BDC7C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BFB07-4C91-4BAF-AA65-465756D345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596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5A04E-9318-4D1C-8DB9-5C4D401BDC7C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BFB07-4C91-4BAF-AA65-465756D345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5679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5A04E-9318-4D1C-8DB9-5C4D401BDC7C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BFB07-4C91-4BAF-AA65-465756D345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232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5A04E-9318-4D1C-8DB9-5C4D401BDC7C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BFB07-4C91-4BAF-AA65-465756D345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6969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5A04E-9318-4D1C-8DB9-5C4D401BDC7C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BFB07-4C91-4BAF-AA65-465756D345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804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5A04E-9318-4D1C-8DB9-5C4D401BDC7C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BFB07-4C91-4BAF-AA65-465756D345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3036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5A04E-9318-4D1C-8DB9-5C4D401BDC7C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BFB07-4C91-4BAF-AA65-465756D345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142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A5A04E-9318-4D1C-8DB9-5C4D401BDC7C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BFB07-4C91-4BAF-AA65-465756D345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555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A5A04E-9318-4D1C-8DB9-5C4D401BDC7C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2BFB07-4C91-4BAF-AA65-465756D345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5170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Relationship Id="rId9" Type="http://schemas.openxmlformats.org/officeDocument/2006/relationships/image" Target="../media/image21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7.png"/><Relationship Id="rId4" Type="http://schemas.openxmlformats.org/officeDocument/2006/relationships/image" Target="../media/image36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1.png"/><Relationship Id="rId4" Type="http://schemas.openxmlformats.org/officeDocument/2006/relationships/image" Target="../media/image40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5.png"/><Relationship Id="rId4" Type="http://schemas.openxmlformats.org/officeDocument/2006/relationships/image" Target="../media/image44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9.png"/><Relationship Id="rId4" Type="http://schemas.openxmlformats.org/officeDocument/2006/relationships/image" Target="../media/image4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3.png"/><Relationship Id="rId4" Type="http://schemas.openxmlformats.org/officeDocument/2006/relationships/image" Target="../media/image52.png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png"/><Relationship Id="rId3" Type="http://schemas.openxmlformats.org/officeDocument/2006/relationships/image" Target="../media/image56.png"/><Relationship Id="rId7" Type="http://schemas.openxmlformats.org/officeDocument/2006/relationships/image" Target="../media/image60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9.png"/><Relationship Id="rId5" Type="http://schemas.openxmlformats.org/officeDocument/2006/relationships/image" Target="../media/image58.png"/><Relationship Id="rId4" Type="http://schemas.openxmlformats.org/officeDocument/2006/relationships/image" Target="../media/image57.png"/><Relationship Id="rId9" Type="http://schemas.openxmlformats.org/officeDocument/2006/relationships/image" Target="../media/image6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>
            <a:extLst>
              <a:ext uri="{FF2B5EF4-FFF2-40B4-BE49-F238E27FC236}">
                <a16:creationId xmlns:a16="http://schemas.microsoft.com/office/drawing/2014/main" id="{D2B59B80-0F54-4137-EF91-DEB5CA313D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282" y="6445538"/>
            <a:ext cx="121920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Times New Roman"/>
              </a:rPr>
              <a:t>Supplementary Figure </a:t>
            </a:r>
            <a:r>
              <a:rPr lang="en-US" sz="1400" b="1">
                <a:latin typeface="Times New Roman"/>
                <a:cs typeface="Times New Roman"/>
              </a:rPr>
              <a:t>1</a:t>
            </a:r>
            <a:r>
              <a:rPr lang="en-US" sz="1400" b="1">
                <a:latin typeface="Times New Roman"/>
                <a:cs typeface="Calibri"/>
              </a:rPr>
              <a:t>. </a:t>
            </a:r>
            <a:r>
              <a:rPr lang="en-US" sz="1400">
                <a:latin typeface="Times New Roman"/>
                <a:cs typeface="Calibri"/>
              </a:rPr>
              <a:t>YOLO NAS model evaluation indicators (loss and mAP@0.5) during training, for micro leaf annotations.</a:t>
            </a:r>
            <a:endParaRPr lang="en-US"/>
          </a:p>
        </p:txBody>
      </p:sp>
      <p:pic>
        <p:nvPicPr>
          <p:cNvPr id="4" name="Picture 3" descr="A graph of a graph&#10;&#10;Description automatically generated with medium confidence">
            <a:extLst>
              <a:ext uri="{FF2B5EF4-FFF2-40B4-BE49-F238E27FC236}">
                <a16:creationId xmlns:a16="http://schemas.microsoft.com/office/drawing/2014/main" id="{0589D4AE-1931-A3E2-9D6D-413C3199664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613" y="1073932"/>
            <a:ext cx="11088774" cy="47101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717616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92A5CA6-0065-69CB-6462-D429331116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0900" y="552450"/>
            <a:ext cx="10496550" cy="525145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590AD048-76EC-C177-43E5-9AD8C3E167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438033"/>
            <a:ext cx="121920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Times New Roman"/>
              </a:rPr>
              <a:t>Supplementary Figure </a:t>
            </a:r>
            <a:r>
              <a:rPr lang="en-US" sz="1400" b="1">
                <a:latin typeface="Times New Roman"/>
                <a:cs typeface="Times New Roman"/>
              </a:rPr>
              <a:t>10. </a:t>
            </a:r>
            <a:r>
              <a:rPr lang="en-US" sz="1400">
                <a:latin typeface="Times New Roman"/>
                <a:cs typeface="Times New Roman"/>
              </a:rPr>
              <a:t>YOLO v8 </a:t>
            </a:r>
            <a:r>
              <a:rPr lang="en-US" sz="1400">
                <a:latin typeface="Times New Roman"/>
                <a:ea typeface="+mn-lt"/>
                <a:cs typeface="Times New Roman"/>
              </a:rPr>
              <a:t>m</a:t>
            </a:r>
            <a:r>
              <a:rPr lang="en-US" sz="1400">
                <a:latin typeface="Times New Roman"/>
                <a:ea typeface="+mn-lt"/>
                <a:cs typeface="+mn-lt"/>
              </a:rPr>
              <a:t>odel evaluation indicators (loss, precision, recall, and mAP@0.5</a:t>
            </a:r>
            <a:r>
              <a:rPr lang="en-US" sz="1400">
                <a:latin typeface="Times New Roman"/>
                <a:ea typeface="+mn-lt"/>
                <a:cs typeface="Times New Roman"/>
              </a:rPr>
              <a:t>) during training, for micro leaf annotations.</a:t>
            </a:r>
            <a:endParaRPr lang="en-US">
              <a:ea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80555892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5AF72F3-D5ED-1902-6135-282EC4FB01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6300" y="533400"/>
            <a:ext cx="10439400" cy="522605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D6EE8DF7-A8F4-1113-5585-FD01B8158F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438033"/>
            <a:ext cx="121920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Times New Roman"/>
              </a:rPr>
              <a:t>Supplementary Figure </a:t>
            </a:r>
            <a:r>
              <a:rPr lang="en-US" sz="1400" b="1">
                <a:latin typeface="Times New Roman"/>
                <a:cs typeface="Times New Roman"/>
              </a:rPr>
              <a:t>11. </a:t>
            </a:r>
            <a:r>
              <a:rPr lang="en-US" sz="1400">
                <a:latin typeface="Times New Roman"/>
                <a:cs typeface="Times New Roman"/>
              </a:rPr>
              <a:t>YOLO v8 </a:t>
            </a:r>
            <a:r>
              <a:rPr lang="en-US" sz="1400">
                <a:latin typeface="Times New Roman"/>
                <a:ea typeface="+mn-lt"/>
                <a:cs typeface="Times New Roman"/>
              </a:rPr>
              <a:t>m</a:t>
            </a:r>
            <a:r>
              <a:rPr lang="en-US" sz="1400">
                <a:latin typeface="Times New Roman"/>
                <a:ea typeface="+mn-lt"/>
                <a:cs typeface="+mn-lt"/>
              </a:rPr>
              <a:t>odel evaluation indicators (loss, precision, recall, and mAP@0.5</a:t>
            </a:r>
            <a:r>
              <a:rPr lang="en-US" sz="1400">
                <a:latin typeface="Times New Roman"/>
                <a:ea typeface="+mn-lt"/>
                <a:cs typeface="Times New Roman"/>
              </a:rPr>
              <a:t>) during training, for micro pod annotations.</a:t>
            </a:r>
            <a:endParaRPr lang="en-US">
              <a:ea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26378934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Grupo 42">
            <a:extLst>
              <a:ext uri="{FF2B5EF4-FFF2-40B4-BE49-F238E27FC236}">
                <a16:creationId xmlns:a16="http://schemas.microsoft.com/office/drawing/2014/main" id="{02C4DEC6-E729-4E23-B41E-D4BA65D714EE}"/>
              </a:ext>
            </a:extLst>
          </p:cNvPr>
          <p:cNvGrpSpPr/>
          <p:nvPr/>
        </p:nvGrpSpPr>
        <p:grpSpPr>
          <a:xfrm>
            <a:off x="1186213" y="669377"/>
            <a:ext cx="6822771" cy="308930"/>
            <a:chOff x="1099127" y="1009852"/>
            <a:chExt cx="6822771" cy="308930"/>
          </a:xfrm>
        </p:grpSpPr>
        <p:sp>
          <p:nvSpPr>
            <p:cNvPr id="15" name="TextBox 6">
              <a:extLst>
                <a:ext uri="{FF2B5EF4-FFF2-40B4-BE49-F238E27FC236}">
                  <a16:creationId xmlns:a16="http://schemas.microsoft.com/office/drawing/2014/main" id="{2F928609-04EC-41C4-9C64-EE84E7B3A4EF}"/>
                </a:ext>
              </a:extLst>
            </p:cNvPr>
            <p:cNvSpPr txBox="1"/>
            <p:nvPr/>
          </p:nvSpPr>
          <p:spPr>
            <a:xfrm>
              <a:off x="1099127" y="1009852"/>
              <a:ext cx="282271" cy="307777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6" name="TextBox 7">
              <a:extLst>
                <a:ext uri="{FF2B5EF4-FFF2-40B4-BE49-F238E27FC236}">
                  <a16:creationId xmlns:a16="http://schemas.microsoft.com/office/drawing/2014/main" id="{21D3C806-19B5-46CC-A520-6799F02CADB1}"/>
                </a:ext>
              </a:extLst>
            </p:cNvPr>
            <p:cNvSpPr txBox="1"/>
            <p:nvPr/>
          </p:nvSpPr>
          <p:spPr>
            <a:xfrm>
              <a:off x="4270084" y="1009852"/>
              <a:ext cx="282271" cy="307777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18" name="TextBox 7">
              <a:extLst>
                <a:ext uri="{FF2B5EF4-FFF2-40B4-BE49-F238E27FC236}">
                  <a16:creationId xmlns:a16="http://schemas.microsoft.com/office/drawing/2014/main" id="{BC977763-2458-4B95-B147-E7C71502CBD9}"/>
                </a:ext>
              </a:extLst>
            </p:cNvPr>
            <p:cNvSpPr txBox="1"/>
            <p:nvPr/>
          </p:nvSpPr>
          <p:spPr>
            <a:xfrm>
              <a:off x="7639627" y="1011005"/>
              <a:ext cx="282271" cy="307777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US" sz="1400" b="1">
                  <a:latin typeface="Times New Roman"/>
                  <a:cs typeface="Times New Roman"/>
                </a:rPr>
                <a:t>c</a:t>
              </a:r>
              <a:endParaRPr 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9" name="Picture 8" descr="A graph with blue squares&#10;&#10;Description automatically generated">
            <a:extLst>
              <a:ext uri="{FF2B5EF4-FFF2-40B4-BE49-F238E27FC236}">
                <a16:creationId xmlns:a16="http://schemas.microsoft.com/office/drawing/2014/main" id="{61D66E06-64E6-B88E-9C61-434367BA81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79550" y="675459"/>
            <a:ext cx="2743200" cy="257338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F3650E86-0410-1B96-BEB8-A81AD6EC939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56006" y="3377513"/>
            <a:ext cx="2866744" cy="2655072"/>
          </a:xfrm>
          <a:prstGeom prst="rect">
            <a:avLst/>
          </a:prstGeom>
        </p:spPr>
      </p:pic>
      <p:pic>
        <p:nvPicPr>
          <p:cNvPr id="27" name="Picture 26" descr="A graph with blue squares&#10;&#10;Description automatically generated">
            <a:extLst>
              <a:ext uri="{FF2B5EF4-FFF2-40B4-BE49-F238E27FC236}">
                <a16:creationId xmlns:a16="http://schemas.microsoft.com/office/drawing/2014/main" id="{06D700EA-F89E-45FA-13B6-5B729D29AE4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924800" y="683158"/>
            <a:ext cx="2806700" cy="2583385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19F6F117-39AA-ED17-83A4-8A6CCA8D4A3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867848" y="3370625"/>
            <a:ext cx="2818561" cy="2653399"/>
          </a:xfrm>
          <a:prstGeom prst="rect">
            <a:avLst/>
          </a:prstGeom>
        </p:spPr>
      </p:pic>
      <p:sp>
        <p:nvSpPr>
          <p:cNvPr id="30" name="Rectangle 29">
            <a:extLst>
              <a:ext uri="{FF2B5EF4-FFF2-40B4-BE49-F238E27FC236}">
                <a16:creationId xmlns:a16="http://schemas.microsoft.com/office/drawing/2014/main" id="{D43F6902-EE86-346C-7DE6-0C27CD23F9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438033"/>
            <a:ext cx="121920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Times New Roman"/>
              </a:rPr>
              <a:t>Supplementary Figure 12</a:t>
            </a:r>
            <a:r>
              <a:rPr lang="en-US" sz="1400" b="1">
                <a:latin typeface="Times New Roman"/>
                <a:cs typeface="Calibri"/>
              </a:rPr>
              <a:t>. </a:t>
            </a:r>
            <a:r>
              <a:rPr lang="en-US" sz="1400">
                <a:latin typeface="Times New Roman"/>
                <a:cs typeface="Calibri"/>
              </a:rPr>
              <a:t>Confusion matrix using micro annotations</a:t>
            </a:r>
            <a:r>
              <a:rPr lang="en-US" sz="1400" b="1">
                <a:latin typeface="Times New Roman"/>
                <a:cs typeface="Calibri"/>
              </a:rPr>
              <a:t> </a:t>
            </a:r>
            <a:r>
              <a:rPr lang="en-US" sz="1400">
                <a:latin typeface="Times New Roman"/>
                <a:cs typeface="Calibri"/>
              </a:rPr>
              <a:t>for different models</a:t>
            </a:r>
            <a:r>
              <a:rPr lang="en-US" sz="1400" b="1">
                <a:latin typeface="Times New Roman"/>
                <a:cs typeface="Calibri"/>
              </a:rPr>
              <a:t> a. </a:t>
            </a:r>
            <a:r>
              <a:rPr lang="en-US" sz="1400">
                <a:latin typeface="Times New Roman"/>
                <a:cs typeface="Calibri"/>
              </a:rPr>
              <a:t>YOLO NAS model,  </a:t>
            </a:r>
            <a:r>
              <a:rPr lang="en-US" sz="1400" b="1">
                <a:latin typeface="Times New Roman"/>
                <a:cs typeface="Calibri"/>
              </a:rPr>
              <a:t>b.</a:t>
            </a:r>
            <a:r>
              <a:rPr lang="en-US" sz="1400">
                <a:latin typeface="Times New Roman"/>
                <a:cs typeface="Calibri"/>
              </a:rPr>
              <a:t> YOLO v7 model,  </a:t>
            </a:r>
            <a:r>
              <a:rPr lang="en-US" sz="1400" b="1">
                <a:latin typeface="Times New Roman"/>
                <a:cs typeface="Calibri"/>
              </a:rPr>
              <a:t>c. </a:t>
            </a:r>
            <a:r>
              <a:rPr lang="en-US" sz="1400">
                <a:latin typeface="Times New Roman"/>
                <a:cs typeface="Calibri"/>
              </a:rPr>
              <a:t>YOLO v8 model.</a:t>
            </a:r>
            <a:endParaRPr lang="en-US" sz="1400">
              <a:latin typeface="Times New Roman"/>
              <a:cs typeface="Times New Roman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9BD602EE-7E4F-842E-0588-A6179CE8AF45}"/>
              </a:ext>
            </a:extLst>
          </p:cNvPr>
          <p:cNvGrpSpPr/>
          <p:nvPr/>
        </p:nvGrpSpPr>
        <p:grpSpPr>
          <a:xfrm>
            <a:off x="4605758" y="655596"/>
            <a:ext cx="2933011" cy="2597166"/>
            <a:chOff x="4641850" y="677231"/>
            <a:chExt cx="2901950" cy="2569662"/>
          </a:xfrm>
        </p:grpSpPr>
        <p:pic>
          <p:nvPicPr>
            <p:cNvPr id="13" name="Picture 12" descr="A graph with blue squares&#10;&#10;Description automatically generated">
              <a:extLst>
                <a:ext uri="{FF2B5EF4-FFF2-40B4-BE49-F238E27FC236}">
                  <a16:creationId xmlns:a16="http://schemas.microsoft.com/office/drawing/2014/main" id="{7AF75264-BDAB-0EFF-5441-05C76C3541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b="94378"/>
            <a:stretch/>
          </p:blipFill>
          <p:spPr>
            <a:xfrm>
              <a:off x="4641850" y="677231"/>
              <a:ext cx="2901950" cy="145900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EC581DAF-D684-37DE-5611-00425234BC8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693033" y="887820"/>
              <a:ext cx="2747753" cy="2359073"/>
            </a:xfrm>
            <a:prstGeom prst="rect">
              <a:avLst/>
            </a:prstGeom>
          </p:spPr>
        </p:pic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D6F9AFED-EBA8-6CBF-6025-0AAD34311BAA}"/>
              </a:ext>
            </a:extLst>
          </p:cNvPr>
          <p:cNvGrpSpPr/>
          <p:nvPr/>
        </p:nvGrpSpPr>
        <p:grpSpPr>
          <a:xfrm>
            <a:off x="4605758" y="3395756"/>
            <a:ext cx="2875587" cy="2636829"/>
            <a:chOff x="4588905" y="3395756"/>
            <a:chExt cx="2875587" cy="2636829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DCAD54F4-A48B-F56C-B684-FD437FD4FB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93558"/>
            <a:stretch/>
          </p:blipFill>
          <p:spPr>
            <a:xfrm>
              <a:off x="4588905" y="3395756"/>
              <a:ext cx="2777164" cy="165705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D761F4E3-3444-8E18-212A-8D009974B38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665874" y="3637687"/>
              <a:ext cx="2798618" cy="239489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64958067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>
            <a:extLst>
              <a:ext uri="{FF2B5EF4-FFF2-40B4-BE49-F238E27FC236}">
                <a16:creationId xmlns:a16="http://schemas.microsoft.com/office/drawing/2014/main" id="{A331AB26-56D8-4BCA-8AAB-C188316A8D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286090"/>
            <a:ext cx="12192000" cy="7386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Times New Roman"/>
              </a:rPr>
              <a:t>Supplementary Figure </a:t>
            </a:r>
            <a:r>
              <a:rPr lang="en-US" sz="1400" b="1">
                <a:latin typeface="Times New Roman"/>
                <a:cs typeface="Times New Roman"/>
              </a:rPr>
              <a:t>13</a:t>
            </a:r>
            <a:r>
              <a:rPr lang="en-US" sz="1400" b="1">
                <a:latin typeface="Times New Roman"/>
                <a:cs typeface="Calibri"/>
              </a:rPr>
              <a:t>. </a:t>
            </a:r>
            <a:r>
              <a:rPr lang="en-US" sz="1400">
                <a:latin typeface="Times New Roman"/>
                <a:ea typeface="+mn-lt"/>
                <a:cs typeface="+mn-lt"/>
              </a:rPr>
              <a:t>Operation results curve for YOLO v7 model, using whole leaf annotations; </a:t>
            </a:r>
            <a:r>
              <a:rPr lang="en-US" sz="1400" b="1">
                <a:latin typeface="Times New Roman"/>
                <a:ea typeface="+mn-lt"/>
                <a:cs typeface="+mn-lt"/>
              </a:rPr>
              <a:t>(a)</a:t>
            </a:r>
            <a:r>
              <a:rPr lang="en-US" sz="1400">
                <a:latin typeface="Times New Roman"/>
                <a:ea typeface="+mn-lt"/>
                <a:cs typeface="+mn-lt"/>
              </a:rPr>
              <a:t> precision-recall curve, </a:t>
            </a:r>
            <a:r>
              <a:rPr lang="en-US" sz="1400" b="1">
                <a:latin typeface="Times New Roman"/>
                <a:ea typeface="+mn-lt"/>
                <a:cs typeface="+mn-lt"/>
              </a:rPr>
              <a:t>(b)</a:t>
            </a:r>
            <a:r>
              <a:rPr lang="en-US" sz="1400">
                <a:latin typeface="Times New Roman"/>
                <a:ea typeface="+mn-lt"/>
                <a:cs typeface="+mn-lt"/>
              </a:rPr>
              <a:t> </a:t>
            </a:r>
            <a:r>
              <a:rPr lang="en-US" sz="1400">
                <a:latin typeface="Times New Roman"/>
                <a:ea typeface="+mn-lt"/>
                <a:cs typeface="Times New Roman"/>
              </a:rPr>
              <a:t>recall</a:t>
            </a:r>
            <a:r>
              <a:rPr lang="en-US" sz="1400">
                <a:latin typeface="Times New Roman"/>
                <a:ea typeface="+mn-lt"/>
                <a:cs typeface="+mn-lt"/>
              </a:rPr>
              <a:t>-confidence curve, </a:t>
            </a:r>
            <a:r>
              <a:rPr lang="en-US" sz="1400" b="1">
                <a:latin typeface="Times New Roman"/>
                <a:ea typeface="+mn-lt"/>
                <a:cs typeface="+mn-lt"/>
              </a:rPr>
              <a:t>(c)</a:t>
            </a:r>
            <a:r>
              <a:rPr lang="en-US" sz="1400">
                <a:latin typeface="Times New Roman"/>
                <a:ea typeface="+mn-lt"/>
                <a:cs typeface="+mn-lt"/>
              </a:rPr>
              <a:t> precision-confidence </a:t>
            </a:r>
            <a:r>
              <a:rPr lang="en-US" sz="1400">
                <a:latin typeface="Times New Roman"/>
                <a:ea typeface="+mn-lt"/>
                <a:cs typeface="Times New Roman"/>
              </a:rPr>
              <a:t>curve, and 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d)</a:t>
            </a:r>
            <a:r>
              <a:rPr lang="en-US" sz="1400">
                <a:latin typeface="Times New Roman"/>
                <a:ea typeface="+mn-lt"/>
                <a:cs typeface="Times New Roman"/>
              </a:rPr>
              <a:t> F1-confidence curve.</a:t>
            </a:r>
            <a:endParaRPr lang="en-US">
              <a:cs typeface="Calibri"/>
            </a:endParaRPr>
          </a:p>
          <a:p>
            <a:endParaRPr lang="en-US" sz="1400">
              <a:latin typeface="Times New Roman"/>
              <a:ea typeface="Calibri"/>
              <a:cs typeface="Times New Roman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FA3ABD7-6B93-DA80-EE42-183C921857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00750" y="3517900"/>
            <a:ext cx="4000500" cy="26797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434D356-15E9-C242-58ED-8158C74E0CD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74800" y="3517900"/>
            <a:ext cx="4000500" cy="26797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82A1B42F-8FD0-E48F-AA1B-EA1CDA752D6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74800" y="749300"/>
            <a:ext cx="4000500" cy="2679700"/>
          </a:xfrm>
          <a:prstGeom prst="rect">
            <a:avLst/>
          </a:prstGeom>
        </p:spPr>
      </p:pic>
      <p:pic>
        <p:nvPicPr>
          <p:cNvPr id="6" name="Picture 5" descr="A graph of a number of different colored lines&#10;&#10;Description automatically generated">
            <a:extLst>
              <a:ext uri="{FF2B5EF4-FFF2-40B4-BE49-F238E27FC236}">
                <a16:creationId xmlns:a16="http://schemas.microsoft.com/office/drawing/2014/main" id="{9CDD0532-27C6-553A-7D57-D2E1FC48F32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00750" y="749300"/>
            <a:ext cx="4000500" cy="2679700"/>
          </a:xfrm>
          <a:prstGeom prst="rect">
            <a:avLst/>
          </a:prstGeom>
        </p:spPr>
      </p:pic>
      <p:sp>
        <p:nvSpPr>
          <p:cNvPr id="8" name="TextBox 6">
            <a:extLst>
              <a:ext uri="{FF2B5EF4-FFF2-40B4-BE49-F238E27FC236}">
                <a16:creationId xmlns:a16="http://schemas.microsoft.com/office/drawing/2014/main" id="{34F97646-EBFD-EEC9-A2B0-B9E92BD02D6F}"/>
              </a:ext>
            </a:extLst>
          </p:cNvPr>
          <p:cNvSpPr txBox="1"/>
          <p:nvPr/>
        </p:nvSpPr>
        <p:spPr>
          <a:xfrm>
            <a:off x="1294163" y="751927"/>
            <a:ext cx="282271" cy="307777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6">
            <a:extLst>
              <a:ext uri="{FF2B5EF4-FFF2-40B4-BE49-F238E27FC236}">
                <a16:creationId xmlns:a16="http://schemas.microsoft.com/office/drawing/2014/main" id="{DAD493B3-7B01-EA70-A244-6E0D7EFFA43C}"/>
              </a:ext>
            </a:extLst>
          </p:cNvPr>
          <p:cNvSpPr txBox="1"/>
          <p:nvPr/>
        </p:nvSpPr>
        <p:spPr>
          <a:xfrm>
            <a:off x="5783613" y="75192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b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6">
            <a:extLst>
              <a:ext uri="{FF2B5EF4-FFF2-40B4-BE49-F238E27FC236}">
                <a16:creationId xmlns:a16="http://schemas.microsoft.com/office/drawing/2014/main" id="{56F9CADB-0876-80F9-41E8-6EBC7AC8F0B6}"/>
              </a:ext>
            </a:extLst>
          </p:cNvPr>
          <p:cNvSpPr txBox="1"/>
          <p:nvPr/>
        </p:nvSpPr>
        <p:spPr>
          <a:xfrm>
            <a:off x="1294163" y="355862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c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6">
            <a:extLst>
              <a:ext uri="{FF2B5EF4-FFF2-40B4-BE49-F238E27FC236}">
                <a16:creationId xmlns:a16="http://schemas.microsoft.com/office/drawing/2014/main" id="{66DCDA07-D514-1414-E278-9689972B507E}"/>
              </a:ext>
            </a:extLst>
          </p:cNvPr>
          <p:cNvSpPr txBox="1"/>
          <p:nvPr/>
        </p:nvSpPr>
        <p:spPr>
          <a:xfrm>
            <a:off x="5783613" y="355862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d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792623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>
            <a:extLst>
              <a:ext uri="{FF2B5EF4-FFF2-40B4-BE49-F238E27FC236}">
                <a16:creationId xmlns:a16="http://schemas.microsoft.com/office/drawing/2014/main" id="{A331AB26-56D8-4BCA-8AAB-C188316A8D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900" y="6210119"/>
            <a:ext cx="12192000" cy="9541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Times New Roman"/>
              </a:rPr>
              <a:t>Supplementary Figure </a:t>
            </a:r>
            <a:r>
              <a:rPr lang="en-US" sz="1400" b="1">
                <a:latin typeface="Times New Roman"/>
                <a:cs typeface="Times New Roman"/>
              </a:rPr>
              <a:t>14</a:t>
            </a:r>
            <a:r>
              <a:rPr lang="en-US" sz="1400" b="1">
                <a:latin typeface="Times New Roman"/>
                <a:cs typeface="Calibri"/>
              </a:rPr>
              <a:t>. </a:t>
            </a:r>
            <a:r>
              <a:rPr lang="en-US" sz="1400">
                <a:latin typeface="Times New Roman"/>
                <a:ea typeface="+mn-lt"/>
                <a:cs typeface="Times New Roman"/>
              </a:rPr>
              <a:t>Operation results curve for YOLO v7 model, using whole pod annotations;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a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precision-recall curve,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b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recall-confidence curve, </a:t>
            </a:r>
            <a:endParaRPr lang="en-US"/>
          </a:p>
          <a:p>
            <a:r>
              <a:rPr lang="en-US" sz="1400" b="1">
                <a:latin typeface="Times New Roman"/>
                <a:ea typeface="+mn-lt"/>
                <a:cs typeface="Times New Roman"/>
              </a:rPr>
              <a:t>(c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precision-confidence curve, and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d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F1-confidence curve.</a:t>
            </a:r>
            <a:endParaRPr lang="en-US"/>
          </a:p>
          <a:p>
            <a:endParaRPr lang="en-US" sz="1400" b="1">
              <a:latin typeface="Times New Roman"/>
              <a:cs typeface="Calibri"/>
            </a:endParaRPr>
          </a:p>
          <a:p>
            <a:endParaRPr lang="en-US" sz="1400">
              <a:latin typeface="Times New Roman"/>
              <a:ea typeface="Calibri"/>
              <a:cs typeface="Times New Roman"/>
            </a:endParaRPr>
          </a:p>
        </p:txBody>
      </p:sp>
      <p:sp>
        <p:nvSpPr>
          <p:cNvPr id="8" name="TextBox 6">
            <a:extLst>
              <a:ext uri="{FF2B5EF4-FFF2-40B4-BE49-F238E27FC236}">
                <a16:creationId xmlns:a16="http://schemas.microsoft.com/office/drawing/2014/main" id="{34F97646-EBFD-EEC9-A2B0-B9E92BD02D6F}"/>
              </a:ext>
            </a:extLst>
          </p:cNvPr>
          <p:cNvSpPr txBox="1"/>
          <p:nvPr/>
        </p:nvSpPr>
        <p:spPr>
          <a:xfrm>
            <a:off x="1294163" y="567777"/>
            <a:ext cx="282271" cy="307777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6">
            <a:extLst>
              <a:ext uri="{FF2B5EF4-FFF2-40B4-BE49-F238E27FC236}">
                <a16:creationId xmlns:a16="http://schemas.microsoft.com/office/drawing/2014/main" id="{DAD493B3-7B01-EA70-A244-6E0D7EFFA43C}"/>
              </a:ext>
            </a:extLst>
          </p:cNvPr>
          <p:cNvSpPr txBox="1"/>
          <p:nvPr/>
        </p:nvSpPr>
        <p:spPr>
          <a:xfrm>
            <a:off x="5783613" y="56777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b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6">
            <a:extLst>
              <a:ext uri="{FF2B5EF4-FFF2-40B4-BE49-F238E27FC236}">
                <a16:creationId xmlns:a16="http://schemas.microsoft.com/office/drawing/2014/main" id="{56F9CADB-0876-80F9-41E8-6EBC7AC8F0B6}"/>
              </a:ext>
            </a:extLst>
          </p:cNvPr>
          <p:cNvSpPr txBox="1"/>
          <p:nvPr/>
        </p:nvSpPr>
        <p:spPr>
          <a:xfrm>
            <a:off x="1294163" y="336177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c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6">
            <a:extLst>
              <a:ext uri="{FF2B5EF4-FFF2-40B4-BE49-F238E27FC236}">
                <a16:creationId xmlns:a16="http://schemas.microsoft.com/office/drawing/2014/main" id="{66DCDA07-D514-1414-E278-9689972B507E}"/>
              </a:ext>
            </a:extLst>
          </p:cNvPr>
          <p:cNvSpPr txBox="1"/>
          <p:nvPr/>
        </p:nvSpPr>
        <p:spPr>
          <a:xfrm>
            <a:off x="5783613" y="336177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d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1B39C1E-4E1F-B4F6-5C3B-5C14F9300D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27750" y="3429000"/>
            <a:ext cx="3962400" cy="26416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9D74882-B7C4-9C82-36C2-39BA33DF19F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00200" y="3397250"/>
            <a:ext cx="3911600" cy="26035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B9129F79-0790-5B97-A83E-850F8982141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74800" y="565150"/>
            <a:ext cx="4032250" cy="26924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F03D023F-1EF8-E2E1-4C06-DFA1D1E176E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64250" y="565150"/>
            <a:ext cx="4025900" cy="269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200763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>
            <a:extLst>
              <a:ext uri="{FF2B5EF4-FFF2-40B4-BE49-F238E27FC236}">
                <a16:creationId xmlns:a16="http://schemas.microsoft.com/office/drawing/2014/main" id="{A331AB26-56D8-4BCA-8AAB-C188316A8D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4300" y="6267040"/>
            <a:ext cx="12192000" cy="7386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Times New Roman"/>
              </a:rPr>
              <a:t>Supplementary Figure </a:t>
            </a:r>
            <a:r>
              <a:rPr lang="en-US" sz="1400" b="1">
                <a:latin typeface="Times New Roman"/>
                <a:cs typeface="Times New Roman"/>
              </a:rPr>
              <a:t>15</a:t>
            </a:r>
            <a:r>
              <a:rPr lang="en-US" sz="1400" b="1">
                <a:latin typeface="Times New Roman"/>
                <a:cs typeface="Calibri"/>
              </a:rPr>
              <a:t>. </a:t>
            </a:r>
            <a:r>
              <a:rPr lang="en-US" sz="1400">
                <a:latin typeface="Times New Roman"/>
                <a:ea typeface="+mn-lt"/>
                <a:cs typeface="Times New Roman"/>
              </a:rPr>
              <a:t>Operation results curve for YOLO v7 model, using micro leaf annotations;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a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precision-recall curve,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b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recall-confidence curve, </a:t>
            </a:r>
            <a:endParaRPr lang="en-US"/>
          </a:p>
          <a:p>
            <a:r>
              <a:rPr lang="en-US" sz="1400" b="1">
                <a:latin typeface="Times New Roman"/>
                <a:ea typeface="+mn-lt"/>
                <a:cs typeface="Times New Roman"/>
              </a:rPr>
              <a:t>(c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precision-confidence curve, and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d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F1-confidence curve.</a:t>
            </a:r>
            <a:endParaRPr lang="en-US"/>
          </a:p>
          <a:p>
            <a:endParaRPr lang="en-US" sz="1400">
              <a:latin typeface="Times New Roman"/>
              <a:cs typeface="Times New Roman"/>
            </a:endParaRPr>
          </a:p>
        </p:txBody>
      </p:sp>
      <p:sp>
        <p:nvSpPr>
          <p:cNvPr id="8" name="TextBox 6">
            <a:extLst>
              <a:ext uri="{FF2B5EF4-FFF2-40B4-BE49-F238E27FC236}">
                <a16:creationId xmlns:a16="http://schemas.microsoft.com/office/drawing/2014/main" id="{34F97646-EBFD-EEC9-A2B0-B9E92BD02D6F}"/>
              </a:ext>
            </a:extLst>
          </p:cNvPr>
          <p:cNvSpPr txBox="1"/>
          <p:nvPr/>
        </p:nvSpPr>
        <p:spPr>
          <a:xfrm>
            <a:off x="1294163" y="567777"/>
            <a:ext cx="282271" cy="307777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6">
            <a:extLst>
              <a:ext uri="{FF2B5EF4-FFF2-40B4-BE49-F238E27FC236}">
                <a16:creationId xmlns:a16="http://schemas.microsoft.com/office/drawing/2014/main" id="{DAD493B3-7B01-EA70-A244-6E0D7EFFA43C}"/>
              </a:ext>
            </a:extLst>
          </p:cNvPr>
          <p:cNvSpPr txBox="1"/>
          <p:nvPr/>
        </p:nvSpPr>
        <p:spPr>
          <a:xfrm>
            <a:off x="5783613" y="56777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b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6">
            <a:extLst>
              <a:ext uri="{FF2B5EF4-FFF2-40B4-BE49-F238E27FC236}">
                <a16:creationId xmlns:a16="http://schemas.microsoft.com/office/drawing/2014/main" id="{56F9CADB-0876-80F9-41E8-6EBC7AC8F0B6}"/>
              </a:ext>
            </a:extLst>
          </p:cNvPr>
          <p:cNvSpPr txBox="1"/>
          <p:nvPr/>
        </p:nvSpPr>
        <p:spPr>
          <a:xfrm>
            <a:off x="1294163" y="336177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c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6">
            <a:extLst>
              <a:ext uri="{FF2B5EF4-FFF2-40B4-BE49-F238E27FC236}">
                <a16:creationId xmlns:a16="http://schemas.microsoft.com/office/drawing/2014/main" id="{66DCDA07-D514-1414-E278-9689972B507E}"/>
              </a:ext>
            </a:extLst>
          </p:cNvPr>
          <p:cNvSpPr txBox="1"/>
          <p:nvPr/>
        </p:nvSpPr>
        <p:spPr>
          <a:xfrm>
            <a:off x="5783613" y="336177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d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 descr="A graph of different colored lines&#10;&#10;Description automatically generated">
            <a:extLst>
              <a:ext uri="{FF2B5EF4-FFF2-40B4-BE49-F238E27FC236}">
                <a16:creationId xmlns:a16="http://schemas.microsoft.com/office/drawing/2014/main" id="{2247DC30-B42E-243C-4BF9-D0E6250312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0" y="3429000"/>
            <a:ext cx="4089400" cy="2711450"/>
          </a:xfrm>
          <a:prstGeom prst="rect">
            <a:avLst/>
          </a:prstGeom>
        </p:spPr>
      </p:pic>
      <p:pic>
        <p:nvPicPr>
          <p:cNvPr id="3" name="Picture 2" descr="A graph of different colored lines&#10;&#10;Description automatically generated">
            <a:extLst>
              <a:ext uri="{FF2B5EF4-FFF2-40B4-BE49-F238E27FC236}">
                <a16:creationId xmlns:a16="http://schemas.microsoft.com/office/drawing/2014/main" id="{4DFC5984-3A3B-E1A9-81A4-177B29E182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98600" y="3429000"/>
            <a:ext cx="4057650" cy="2711450"/>
          </a:xfrm>
          <a:prstGeom prst="rect">
            <a:avLst/>
          </a:prstGeom>
        </p:spPr>
      </p:pic>
      <p:pic>
        <p:nvPicPr>
          <p:cNvPr id="4" name="Picture 3" descr="A graph of different colored lines&#10;&#10;Description automatically generated">
            <a:extLst>
              <a:ext uri="{FF2B5EF4-FFF2-40B4-BE49-F238E27FC236}">
                <a16:creationId xmlns:a16="http://schemas.microsoft.com/office/drawing/2014/main" id="{04274E18-5C63-93DE-D94B-3473A649AD6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98600" y="565150"/>
            <a:ext cx="4121150" cy="2743200"/>
          </a:xfrm>
          <a:prstGeom prst="rect">
            <a:avLst/>
          </a:prstGeom>
        </p:spPr>
      </p:pic>
      <p:pic>
        <p:nvPicPr>
          <p:cNvPr id="6" name="Picture 5" descr="A graph of different colored lines&#10;&#10;Description automatically generated">
            <a:extLst>
              <a:ext uri="{FF2B5EF4-FFF2-40B4-BE49-F238E27FC236}">
                <a16:creationId xmlns:a16="http://schemas.microsoft.com/office/drawing/2014/main" id="{C80D4F95-5EB0-57B0-D0F7-E9AFB3FE819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64250" y="565150"/>
            <a:ext cx="4114800" cy="2743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003024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>
            <a:extLst>
              <a:ext uri="{FF2B5EF4-FFF2-40B4-BE49-F238E27FC236}">
                <a16:creationId xmlns:a16="http://schemas.microsoft.com/office/drawing/2014/main" id="{A331AB26-56D8-4BCA-8AAB-C188316A8D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282" y="6337817"/>
            <a:ext cx="12192000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Times New Roman"/>
              </a:rPr>
              <a:t>Supplementary Figure </a:t>
            </a:r>
            <a:r>
              <a:rPr lang="en-US" sz="1400" b="1">
                <a:latin typeface="Times New Roman"/>
                <a:cs typeface="Times New Roman"/>
              </a:rPr>
              <a:t>16</a:t>
            </a:r>
            <a:r>
              <a:rPr lang="en-US" sz="1400" b="1">
                <a:latin typeface="Times New Roman"/>
                <a:cs typeface="Calibri"/>
              </a:rPr>
              <a:t>. </a:t>
            </a:r>
            <a:r>
              <a:rPr lang="en-US" sz="1400">
                <a:latin typeface="Times New Roman"/>
                <a:ea typeface="+mn-lt"/>
                <a:cs typeface="Times New Roman"/>
              </a:rPr>
              <a:t>Operation results curve for YOLO v7 model, using micro pod annotations;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a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precision-recall curve,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b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recall-confidence curve, </a:t>
            </a:r>
            <a:endParaRPr lang="en-US"/>
          </a:p>
          <a:p>
            <a:r>
              <a:rPr lang="en-US" sz="1400" b="1">
                <a:latin typeface="Times New Roman"/>
                <a:ea typeface="+mn-lt"/>
                <a:cs typeface="Times New Roman"/>
              </a:rPr>
              <a:t>(c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precision-confidence curve, and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d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F1-confidence curve.</a:t>
            </a:r>
            <a:endParaRPr lang="en-US"/>
          </a:p>
        </p:txBody>
      </p:sp>
      <p:sp>
        <p:nvSpPr>
          <p:cNvPr id="8" name="TextBox 6">
            <a:extLst>
              <a:ext uri="{FF2B5EF4-FFF2-40B4-BE49-F238E27FC236}">
                <a16:creationId xmlns:a16="http://schemas.microsoft.com/office/drawing/2014/main" id="{34F97646-EBFD-EEC9-A2B0-B9E92BD02D6F}"/>
              </a:ext>
            </a:extLst>
          </p:cNvPr>
          <p:cNvSpPr txBox="1"/>
          <p:nvPr/>
        </p:nvSpPr>
        <p:spPr>
          <a:xfrm>
            <a:off x="1294163" y="567777"/>
            <a:ext cx="282271" cy="307777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6">
            <a:extLst>
              <a:ext uri="{FF2B5EF4-FFF2-40B4-BE49-F238E27FC236}">
                <a16:creationId xmlns:a16="http://schemas.microsoft.com/office/drawing/2014/main" id="{DAD493B3-7B01-EA70-A244-6E0D7EFFA43C}"/>
              </a:ext>
            </a:extLst>
          </p:cNvPr>
          <p:cNvSpPr txBox="1"/>
          <p:nvPr/>
        </p:nvSpPr>
        <p:spPr>
          <a:xfrm>
            <a:off x="5783613" y="56777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b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6">
            <a:extLst>
              <a:ext uri="{FF2B5EF4-FFF2-40B4-BE49-F238E27FC236}">
                <a16:creationId xmlns:a16="http://schemas.microsoft.com/office/drawing/2014/main" id="{56F9CADB-0876-80F9-41E8-6EBC7AC8F0B6}"/>
              </a:ext>
            </a:extLst>
          </p:cNvPr>
          <p:cNvSpPr txBox="1"/>
          <p:nvPr/>
        </p:nvSpPr>
        <p:spPr>
          <a:xfrm>
            <a:off x="1294163" y="336177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c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6">
            <a:extLst>
              <a:ext uri="{FF2B5EF4-FFF2-40B4-BE49-F238E27FC236}">
                <a16:creationId xmlns:a16="http://schemas.microsoft.com/office/drawing/2014/main" id="{66DCDA07-D514-1414-E278-9689972B507E}"/>
              </a:ext>
            </a:extLst>
          </p:cNvPr>
          <p:cNvSpPr txBox="1"/>
          <p:nvPr/>
        </p:nvSpPr>
        <p:spPr>
          <a:xfrm>
            <a:off x="5783613" y="336177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d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180C2ED-D6BD-ECFD-86E6-FC2A38A199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0" y="3429000"/>
            <a:ext cx="3943350" cy="26289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F3C45C0-A0E3-3478-2BAD-A702CE2FB1F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36700" y="3397250"/>
            <a:ext cx="4013200" cy="266065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3E5E3C8-D54B-369F-7176-A8623CEF10C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74800" y="615950"/>
            <a:ext cx="3975100" cy="26543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C38A370-DB3F-B2F0-D117-2ED30CF3A2A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57900" y="615950"/>
            <a:ext cx="3981450" cy="2654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644528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9DBF7C0-2B0F-1AE8-CA3E-1E83ABC7D8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62221" y="3364060"/>
            <a:ext cx="4032250" cy="269875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96DC4EA-3AF9-2806-C8C5-515A4AFC1A4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74800" y="3359150"/>
            <a:ext cx="4057650" cy="27051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E20FA49-8874-8082-BF38-B7D5B5ECCA4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74800" y="565150"/>
            <a:ext cx="4057650" cy="27051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AB6DED4-1698-6CD7-0882-B0BD094655D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96000" y="565150"/>
            <a:ext cx="4032250" cy="2705100"/>
          </a:xfrm>
          <a:prstGeom prst="rect">
            <a:avLst/>
          </a:prstGeom>
        </p:spPr>
      </p:pic>
      <p:sp>
        <p:nvSpPr>
          <p:cNvPr id="3" name="TextBox 6">
            <a:extLst>
              <a:ext uri="{FF2B5EF4-FFF2-40B4-BE49-F238E27FC236}">
                <a16:creationId xmlns:a16="http://schemas.microsoft.com/office/drawing/2014/main" id="{8FB5BC53-AD23-B42C-4718-499B907F0BE5}"/>
              </a:ext>
            </a:extLst>
          </p:cNvPr>
          <p:cNvSpPr txBox="1"/>
          <p:nvPr/>
        </p:nvSpPr>
        <p:spPr>
          <a:xfrm>
            <a:off x="1294163" y="567777"/>
            <a:ext cx="282271" cy="307777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6">
            <a:extLst>
              <a:ext uri="{FF2B5EF4-FFF2-40B4-BE49-F238E27FC236}">
                <a16:creationId xmlns:a16="http://schemas.microsoft.com/office/drawing/2014/main" id="{CFAAD78C-3DA7-0654-B9A0-641219C377A6}"/>
              </a:ext>
            </a:extLst>
          </p:cNvPr>
          <p:cNvSpPr txBox="1"/>
          <p:nvPr/>
        </p:nvSpPr>
        <p:spPr>
          <a:xfrm>
            <a:off x="5783613" y="56777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b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6">
            <a:extLst>
              <a:ext uri="{FF2B5EF4-FFF2-40B4-BE49-F238E27FC236}">
                <a16:creationId xmlns:a16="http://schemas.microsoft.com/office/drawing/2014/main" id="{F4C918E5-8850-6C21-CAAD-2032F9B86C59}"/>
              </a:ext>
            </a:extLst>
          </p:cNvPr>
          <p:cNvSpPr txBox="1"/>
          <p:nvPr/>
        </p:nvSpPr>
        <p:spPr>
          <a:xfrm>
            <a:off x="1294163" y="336177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c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6">
            <a:extLst>
              <a:ext uri="{FF2B5EF4-FFF2-40B4-BE49-F238E27FC236}">
                <a16:creationId xmlns:a16="http://schemas.microsoft.com/office/drawing/2014/main" id="{449B23B2-3678-8CB0-F0A0-B7EC29777264}"/>
              </a:ext>
            </a:extLst>
          </p:cNvPr>
          <p:cNvSpPr txBox="1"/>
          <p:nvPr/>
        </p:nvSpPr>
        <p:spPr>
          <a:xfrm>
            <a:off x="5783613" y="336177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d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1521B25-5F28-A1FE-D2B4-E274D0C959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282" y="6337817"/>
            <a:ext cx="12192000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Times New Roman"/>
              </a:rPr>
              <a:t>Supplementary Figure </a:t>
            </a:r>
            <a:r>
              <a:rPr lang="en-US" sz="1400" b="1">
                <a:latin typeface="Times New Roman"/>
                <a:cs typeface="Times New Roman"/>
              </a:rPr>
              <a:t>17</a:t>
            </a:r>
            <a:r>
              <a:rPr lang="en-US" sz="1400" b="1">
                <a:latin typeface="Times New Roman"/>
                <a:cs typeface="Calibri"/>
              </a:rPr>
              <a:t>. </a:t>
            </a:r>
            <a:r>
              <a:rPr lang="en-US" sz="1400">
                <a:latin typeface="Times New Roman"/>
                <a:ea typeface="+mn-lt"/>
                <a:cs typeface="Times New Roman"/>
              </a:rPr>
              <a:t>Operation results curve for YOLO v8 model, using whole leaf annotations;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a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precision-recall curve,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b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recall-confidence curve, </a:t>
            </a:r>
            <a:endParaRPr lang="en-US"/>
          </a:p>
          <a:p>
            <a:r>
              <a:rPr lang="en-US" sz="1400" b="1">
                <a:latin typeface="Times New Roman"/>
                <a:ea typeface="+mn-lt"/>
                <a:cs typeface="Times New Roman"/>
              </a:rPr>
              <a:t>(c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precision-confidence curve, and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d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F1-confidence curve.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52685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graph of a curve&#10;&#10;Description automatically generated">
            <a:extLst>
              <a:ext uri="{FF2B5EF4-FFF2-40B4-BE49-F238E27FC236}">
                <a16:creationId xmlns:a16="http://schemas.microsoft.com/office/drawing/2014/main" id="{A81F5B93-CE50-B819-DFE8-7E405C46E0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0" y="3359150"/>
            <a:ext cx="4013200" cy="267335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929362FC-1D75-209F-9745-60685EF2F64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74800" y="3359150"/>
            <a:ext cx="4013200" cy="267335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F739D19-B295-80D6-3944-1EA68193605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74800" y="615950"/>
            <a:ext cx="4013200" cy="2673350"/>
          </a:xfrm>
          <a:prstGeom prst="rect">
            <a:avLst/>
          </a:prstGeom>
        </p:spPr>
      </p:pic>
      <p:pic>
        <p:nvPicPr>
          <p:cNvPr id="5" name="Picture 4" descr="A graph of a curve&#10;&#10;Description automatically generated">
            <a:extLst>
              <a:ext uri="{FF2B5EF4-FFF2-40B4-BE49-F238E27FC236}">
                <a16:creationId xmlns:a16="http://schemas.microsoft.com/office/drawing/2014/main" id="{2FE9CBD1-92EE-7707-B707-543D2AFAFA7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96000" y="615950"/>
            <a:ext cx="4013200" cy="267335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6D05A7E-ECA3-4E6A-F76C-6CBD72B4E676}"/>
              </a:ext>
            </a:extLst>
          </p:cNvPr>
          <p:cNvSpPr txBox="1"/>
          <p:nvPr/>
        </p:nvSpPr>
        <p:spPr>
          <a:xfrm>
            <a:off x="1294163" y="567777"/>
            <a:ext cx="282271" cy="307777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6">
            <a:extLst>
              <a:ext uri="{FF2B5EF4-FFF2-40B4-BE49-F238E27FC236}">
                <a16:creationId xmlns:a16="http://schemas.microsoft.com/office/drawing/2014/main" id="{5ADBFA34-D660-B674-7A7A-57CC205AAC64}"/>
              </a:ext>
            </a:extLst>
          </p:cNvPr>
          <p:cNvSpPr txBox="1"/>
          <p:nvPr/>
        </p:nvSpPr>
        <p:spPr>
          <a:xfrm>
            <a:off x="5783613" y="56777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b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6">
            <a:extLst>
              <a:ext uri="{FF2B5EF4-FFF2-40B4-BE49-F238E27FC236}">
                <a16:creationId xmlns:a16="http://schemas.microsoft.com/office/drawing/2014/main" id="{E12B7635-74B7-6A2D-154C-9C2FF22829AF}"/>
              </a:ext>
            </a:extLst>
          </p:cNvPr>
          <p:cNvSpPr txBox="1"/>
          <p:nvPr/>
        </p:nvSpPr>
        <p:spPr>
          <a:xfrm>
            <a:off x="1294163" y="336177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c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6">
            <a:extLst>
              <a:ext uri="{FF2B5EF4-FFF2-40B4-BE49-F238E27FC236}">
                <a16:creationId xmlns:a16="http://schemas.microsoft.com/office/drawing/2014/main" id="{D086C108-9A80-4085-C524-35EA4B36A27A}"/>
              </a:ext>
            </a:extLst>
          </p:cNvPr>
          <p:cNvSpPr txBox="1"/>
          <p:nvPr/>
        </p:nvSpPr>
        <p:spPr>
          <a:xfrm>
            <a:off x="5783613" y="336177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d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91066358-8536-0832-6CC0-D39F72B4FD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282" y="6337817"/>
            <a:ext cx="12192000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Times New Roman"/>
              </a:rPr>
              <a:t>Supplementary Figure </a:t>
            </a:r>
            <a:r>
              <a:rPr lang="en-US" sz="1400" b="1">
                <a:latin typeface="Times New Roman"/>
                <a:cs typeface="Times New Roman"/>
              </a:rPr>
              <a:t>18</a:t>
            </a:r>
            <a:r>
              <a:rPr lang="en-US" sz="1400" b="1">
                <a:latin typeface="Times New Roman"/>
                <a:cs typeface="Calibri"/>
              </a:rPr>
              <a:t>. </a:t>
            </a:r>
            <a:r>
              <a:rPr lang="en-US" sz="1400">
                <a:latin typeface="Times New Roman"/>
                <a:ea typeface="+mn-lt"/>
                <a:cs typeface="Times New Roman"/>
              </a:rPr>
              <a:t>Operation results curve for YOLO v8 model, using whole pod annotations;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a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precision-recall curve,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b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recall-confidence curve, </a:t>
            </a:r>
            <a:endParaRPr lang="en-US"/>
          </a:p>
          <a:p>
            <a:r>
              <a:rPr lang="en-US" sz="1400" b="1">
                <a:latin typeface="Times New Roman"/>
                <a:ea typeface="+mn-lt"/>
                <a:cs typeface="Times New Roman"/>
              </a:rPr>
              <a:t>(c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precision-confidence curve, and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d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F1-confidence curve.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95756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graph of different colors&#10;&#10;Description automatically generated">
            <a:extLst>
              <a:ext uri="{FF2B5EF4-FFF2-40B4-BE49-F238E27FC236}">
                <a16:creationId xmlns:a16="http://schemas.microsoft.com/office/drawing/2014/main" id="{3537FF88-C47C-D829-C484-E3C3AE35AE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0" y="3321050"/>
            <a:ext cx="4210050" cy="2800350"/>
          </a:xfrm>
          <a:prstGeom prst="rect">
            <a:avLst/>
          </a:prstGeom>
        </p:spPr>
      </p:pic>
      <p:pic>
        <p:nvPicPr>
          <p:cNvPr id="3" name="Picture 2" descr="A graph of different colored lines&#10;&#10;Description automatically generated">
            <a:extLst>
              <a:ext uri="{FF2B5EF4-FFF2-40B4-BE49-F238E27FC236}">
                <a16:creationId xmlns:a16="http://schemas.microsoft.com/office/drawing/2014/main" id="{53B96D3E-6860-B331-3D0C-F8B019B6D32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74800" y="3321050"/>
            <a:ext cx="4210050" cy="2800350"/>
          </a:xfrm>
          <a:prstGeom prst="rect">
            <a:avLst/>
          </a:prstGeom>
        </p:spPr>
      </p:pic>
      <p:pic>
        <p:nvPicPr>
          <p:cNvPr id="4" name="Picture 3" descr="A graph of different colored lines&#10;&#10;Description automatically generated">
            <a:extLst>
              <a:ext uri="{FF2B5EF4-FFF2-40B4-BE49-F238E27FC236}">
                <a16:creationId xmlns:a16="http://schemas.microsoft.com/office/drawing/2014/main" id="{9B6A6DFC-BB37-9CBE-4028-C7A721FC2FB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74800" y="482600"/>
            <a:ext cx="4210050" cy="2800350"/>
          </a:xfrm>
          <a:prstGeom prst="rect">
            <a:avLst/>
          </a:prstGeom>
        </p:spPr>
      </p:pic>
      <p:pic>
        <p:nvPicPr>
          <p:cNvPr id="5" name="Picture 4" descr="A graph of different colors&#10;&#10;Description automatically generated">
            <a:extLst>
              <a:ext uri="{FF2B5EF4-FFF2-40B4-BE49-F238E27FC236}">
                <a16:creationId xmlns:a16="http://schemas.microsoft.com/office/drawing/2014/main" id="{819295F8-03A6-95F7-EF7D-0B4725B9B48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96000" y="482600"/>
            <a:ext cx="4159250" cy="280035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F7D3C5B-72AD-293F-2796-7186070D677B}"/>
              </a:ext>
            </a:extLst>
          </p:cNvPr>
          <p:cNvSpPr txBox="1"/>
          <p:nvPr/>
        </p:nvSpPr>
        <p:spPr>
          <a:xfrm>
            <a:off x="1294163" y="485227"/>
            <a:ext cx="282271" cy="307777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6">
            <a:extLst>
              <a:ext uri="{FF2B5EF4-FFF2-40B4-BE49-F238E27FC236}">
                <a16:creationId xmlns:a16="http://schemas.microsoft.com/office/drawing/2014/main" id="{C3CDA3C8-6316-F258-A275-42D3C35971D0}"/>
              </a:ext>
            </a:extLst>
          </p:cNvPr>
          <p:cNvSpPr txBox="1"/>
          <p:nvPr/>
        </p:nvSpPr>
        <p:spPr>
          <a:xfrm>
            <a:off x="5783613" y="48522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b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6">
            <a:extLst>
              <a:ext uri="{FF2B5EF4-FFF2-40B4-BE49-F238E27FC236}">
                <a16:creationId xmlns:a16="http://schemas.microsoft.com/office/drawing/2014/main" id="{C31B13B6-FA9F-373D-EAAC-5814727D7BE8}"/>
              </a:ext>
            </a:extLst>
          </p:cNvPr>
          <p:cNvSpPr txBox="1"/>
          <p:nvPr/>
        </p:nvSpPr>
        <p:spPr>
          <a:xfrm>
            <a:off x="1294163" y="327922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c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6">
            <a:extLst>
              <a:ext uri="{FF2B5EF4-FFF2-40B4-BE49-F238E27FC236}">
                <a16:creationId xmlns:a16="http://schemas.microsoft.com/office/drawing/2014/main" id="{E22C6B3A-6162-1D4A-7AFC-3F68DDA0380D}"/>
              </a:ext>
            </a:extLst>
          </p:cNvPr>
          <p:cNvSpPr txBox="1"/>
          <p:nvPr/>
        </p:nvSpPr>
        <p:spPr>
          <a:xfrm>
            <a:off x="5783613" y="327922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d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81AF051-742B-510D-A937-84ABE8E217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282" y="6337817"/>
            <a:ext cx="12192000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Times New Roman"/>
              </a:rPr>
              <a:t>Supplementary Figure </a:t>
            </a:r>
            <a:r>
              <a:rPr lang="en-US" sz="1400" b="1">
                <a:latin typeface="Times New Roman"/>
                <a:cs typeface="Times New Roman"/>
              </a:rPr>
              <a:t>19</a:t>
            </a:r>
            <a:r>
              <a:rPr lang="en-US" sz="1400" b="1">
                <a:latin typeface="Times New Roman"/>
                <a:cs typeface="Calibri"/>
              </a:rPr>
              <a:t>. </a:t>
            </a:r>
            <a:r>
              <a:rPr lang="en-US" sz="1400">
                <a:latin typeface="Times New Roman"/>
                <a:ea typeface="+mn-lt"/>
                <a:cs typeface="Times New Roman"/>
              </a:rPr>
              <a:t>Operation results curve for YOLO v8 model, using micro leaf annotations;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a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precision-recall curve,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b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recall-confidence curve, </a:t>
            </a:r>
            <a:endParaRPr lang="en-US"/>
          </a:p>
          <a:p>
            <a:r>
              <a:rPr lang="en-US" sz="1400" b="1">
                <a:latin typeface="Times New Roman"/>
                <a:ea typeface="+mn-lt"/>
                <a:cs typeface="Times New Roman"/>
              </a:rPr>
              <a:t>(c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precision-confidence curve, and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d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F1-confidence curve.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5037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>
            <a:extLst>
              <a:ext uri="{FF2B5EF4-FFF2-40B4-BE49-F238E27FC236}">
                <a16:creationId xmlns:a16="http://schemas.microsoft.com/office/drawing/2014/main" id="{D2B59B80-0F54-4137-EF91-DEB5CA313D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282" y="6445538"/>
            <a:ext cx="121920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Times New Roman"/>
              </a:rPr>
              <a:t>Supplementary Figure </a:t>
            </a:r>
            <a:r>
              <a:rPr lang="en-US" sz="1400" b="1">
                <a:latin typeface="Times New Roman"/>
                <a:cs typeface="Times New Roman"/>
              </a:rPr>
              <a:t>2</a:t>
            </a:r>
            <a:r>
              <a:rPr lang="en-US" sz="1400" b="1">
                <a:latin typeface="Times New Roman"/>
                <a:cs typeface="Calibri"/>
              </a:rPr>
              <a:t>. </a:t>
            </a:r>
            <a:r>
              <a:rPr lang="en-US" sz="1400">
                <a:latin typeface="Times New Roman"/>
                <a:cs typeface="Calibri"/>
              </a:rPr>
              <a:t>YOLO NAS model evaluation indicators (loss and mAP@0.5) during training, for micro pod annotations.</a:t>
            </a:r>
            <a:endParaRPr lang="en-US"/>
          </a:p>
        </p:txBody>
      </p:sp>
      <p:pic>
        <p:nvPicPr>
          <p:cNvPr id="3" name="Picture 2" descr="A graph of a graph&#10;&#10;Description automatically generated with medium confidence">
            <a:extLst>
              <a:ext uri="{FF2B5EF4-FFF2-40B4-BE49-F238E27FC236}">
                <a16:creationId xmlns:a16="http://schemas.microsoft.com/office/drawing/2014/main" id="{A1564525-92B0-235E-37A3-B79C51D6CD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1643" y="1211986"/>
            <a:ext cx="10828713" cy="45996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881279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7D69735-9DDC-2A83-AA32-41C4C1C3D8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0" y="3359150"/>
            <a:ext cx="4051300" cy="269875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2314211-CE2E-242D-B7FF-790DFF243D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74800" y="3359150"/>
            <a:ext cx="4051300" cy="269875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6D62C2B-7C2F-0A0A-5E43-5431056BF97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74800" y="565150"/>
            <a:ext cx="4051300" cy="269875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5E1661D-01FE-928F-1DF5-232770CF5A0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26150" y="565150"/>
            <a:ext cx="4025900" cy="2698750"/>
          </a:xfrm>
          <a:prstGeom prst="rect">
            <a:avLst/>
          </a:prstGeom>
        </p:spPr>
      </p:pic>
      <p:sp>
        <p:nvSpPr>
          <p:cNvPr id="9" name="TextBox 6">
            <a:extLst>
              <a:ext uri="{FF2B5EF4-FFF2-40B4-BE49-F238E27FC236}">
                <a16:creationId xmlns:a16="http://schemas.microsoft.com/office/drawing/2014/main" id="{726F9883-4AA6-6D05-239A-2109BEB22140}"/>
              </a:ext>
            </a:extLst>
          </p:cNvPr>
          <p:cNvSpPr txBox="1"/>
          <p:nvPr/>
        </p:nvSpPr>
        <p:spPr>
          <a:xfrm>
            <a:off x="1294163" y="567777"/>
            <a:ext cx="282271" cy="307777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1" name="TextBox 6">
            <a:extLst>
              <a:ext uri="{FF2B5EF4-FFF2-40B4-BE49-F238E27FC236}">
                <a16:creationId xmlns:a16="http://schemas.microsoft.com/office/drawing/2014/main" id="{707F2B40-2BB5-7172-BDED-A4342DAEBE70}"/>
              </a:ext>
            </a:extLst>
          </p:cNvPr>
          <p:cNvSpPr txBox="1"/>
          <p:nvPr/>
        </p:nvSpPr>
        <p:spPr>
          <a:xfrm>
            <a:off x="5783613" y="56777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b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6">
            <a:extLst>
              <a:ext uri="{FF2B5EF4-FFF2-40B4-BE49-F238E27FC236}">
                <a16:creationId xmlns:a16="http://schemas.microsoft.com/office/drawing/2014/main" id="{C62B0741-870D-5723-14FB-B1A3BF1DC221}"/>
              </a:ext>
            </a:extLst>
          </p:cNvPr>
          <p:cNvSpPr txBox="1"/>
          <p:nvPr/>
        </p:nvSpPr>
        <p:spPr>
          <a:xfrm>
            <a:off x="1294163" y="336177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c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6">
            <a:extLst>
              <a:ext uri="{FF2B5EF4-FFF2-40B4-BE49-F238E27FC236}">
                <a16:creationId xmlns:a16="http://schemas.microsoft.com/office/drawing/2014/main" id="{BC482CBE-E16C-4099-69BC-E5799428173E}"/>
              </a:ext>
            </a:extLst>
          </p:cNvPr>
          <p:cNvSpPr txBox="1"/>
          <p:nvPr/>
        </p:nvSpPr>
        <p:spPr>
          <a:xfrm>
            <a:off x="5783613" y="3361776"/>
            <a:ext cx="282271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d</a:t>
            </a:r>
            <a:endParaRPr 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D2B59B80-0F54-4137-EF91-DEB5CA313D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282" y="6337817"/>
            <a:ext cx="12192000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Times New Roman"/>
              </a:rPr>
              <a:t>Supplementary Figure </a:t>
            </a:r>
            <a:r>
              <a:rPr lang="en-US" sz="1400" b="1">
                <a:latin typeface="Times New Roman"/>
                <a:cs typeface="Times New Roman"/>
              </a:rPr>
              <a:t>20</a:t>
            </a:r>
            <a:r>
              <a:rPr lang="en-US" sz="1400" b="1">
                <a:latin typeface="Times New Roman"/>
                <a:cs typeface="Calibri"/>
              </a:rPr>
              <a:t>. </a:t>
            </a:r>
            <a:r>
              <a:rPr lang="en-US" sz="1400">
                <a:latin typeface="Times New Roman"/>
                <a:ea typeface="+mn-lt"/>
                <a:cs typeface="Times New Roman"/>
              </a:rPr>
              <a:t>Operation results curve for YOLO v8 model, using micro pod annotations;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a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precision-recall curve,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b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recall-confidence curve, </a:t>
            </a:r>
            <a:endParaRPr lang="en-US"/>
          </a:p>
          <a:p>
            <a:r>
              <a:rPr lang="en-US" sz="1400" b="1">
                <a:latin typeface="Times New Roman"/>
                <a:ea typeface="+mn-lt"/>
                <a:cs typeface="Times New Roman"/>
              </a:rPr>
              <a:t>(c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precision-confidence curve, and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d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F1-confidence curve.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58492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A58DEAC-71E6-A0CB-10CE-65C2187D93E9}"/>
              </a:ext>
            </a:extLst>
          </p:cNvPr>
          <p:cNvSpPr txBox="1"/>
          <p:nvPr/>
        </p:nvSpPr>
        <p:spPr>
          <a:xfrm>
            <a:off x="149909" y="6196544"/>
            <a:ext cx="11892182" cy="738664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</a:rPr>
              <a:t>Supplementary Figure </a:t>
            </a:r>
            <a:r>
              <a:rPr lang="en-US" sz="1400" b="1">
                <a:latin typeface="Times New Roman"/>
                <a:cs typeface="Times New Roman"/>
              </a:rPr>
              <a:t>21</a:t>
            </a:r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>
                <a:latin typeface="Times New Roman"/>
                <a:ea typeface="+mn-lt"/>
                <a:cs typeface="Times New Roman"/>
              </a:rPr>
              <a:t>Operation results curve for YOLO NAS model, using micro leaf and pod annotations;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a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precision-confidence curve,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b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recall-confidence curve,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c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precision-recall curve for leaf, and </a:t>
            </a:r>
            <a:r>
              <a:rPr lang="en-US" sz="1400" b="1">
                <a:latin typeface="Times New Roman"/>
                <a:ea typeface="+mn-lt"/>
                <a:cs typeface="Times New Roman"/>
              </a:rPr>
              <a:t>(d)</a:t>
            </a:r>
            <a:r>
              <a:rPr lang="en-US" sz="1400">
                <a:latin typeface="Times New Roman"/>
                <a:ea typeface="+mn-lt"/>
                <a:cs typeface="Times New Roman"/>
              </a:rPr>
              <a:t> precision-recall curve for pod.</a:t>
            </a:r>
            <a:endParaRPr lang="en-US" sz="1400"/>
          </a:p>
          <a:p>
            <a:endParaRPr lang="en-US" sz="1400">
              <a:ea typeface="Calibri" panose="020F0502020204030204"/>
              <a:cs typeface="Calibri"/>
            </a:endParaRPr>
          </a:p>
        </p:txBody>
      </p:sp>
      <p:pic>
        <p:nvPicPr>
          <p:cNvPr id="6" name="Picture 5" descr="A red and blue lines&#10;&#10;Description automatically generated">
            <a:extLst>
              <a:ext uri="{FF2B5EF4-FFF2-40B4-BE49-F238E27FC236}">
                <a16:creationId xmlns:a16="http://schemas.microsoft.com/office/drawing/2014/main" id="{6DDAD1D8-F373-89DC-E477-269C88F2B1F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32" r="9368"/>
          <a:stretch/>
        </p:blipFill>
        <p:spPr>
          <a:xfrm>
            <a:off x="406003" y="1762124"/>
            <a:ext cx="11379994" cy="2809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807986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0412B99-BF1A-AA8F-A901-991A526E14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935" y="462297"/>
            <a:ext cx="2844078" cy="264854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2405392-9B4F-E742-0A48-1600A4286F7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0934" y="3434868"/>
            <a:ext cx="2967619" cy="230537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8C09006-1121-F608-6B5D-F3AE9664EAF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02281" y="484325"/>
            <a:ext cx="2808898" cy="266320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78FEA6B-C769-2126-44A3-AB145D4B85E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02281" y="3470652"/>
            <a:ext cx="2967619" cy="233831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A131FFD-9E02-B739-4B33-23AF6A896C8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69900" y="462298"/>
            <a:ext cx="2808897" cy="268523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924FF3B9-F419-CAB0-202E-DBF3CED70F3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60007" y="3522249"/>
            <a:ext cx="2977512" cy="230537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96593931-C770-C285-36DF-CD3E9C78265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119362" y="460959"/>
            <a:ext cx="2864650" cy="2685235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BD028332-F843-E1A5-CAFB-463FB0A26EE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193173" y="3624002"/>
            <a:ext cx="2790839" cy="1334497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7C81A13D-B66F-0301-30E7-71502095F22D}"/>
              </a:ext>
            </a:extLst>
          </p:cNvPr>
          <p:cNvSpPr txBox="1"/>
          <p:nvPr/>
        </p:nvSpPr>
        <p:spPr>
          <a:xfrm>
            <a:off x="149909" y="6196544"/>
            <a:ext cx="11892182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</a:rPr>
              <a:t>Supplementary Figure </a:t>
            </a:r>
            <a:r>
              <a:rPr lang="en-US" sz="1400" b="1">
                <a:latin typeface="Times New Roman"/>
                <a:cs typeface="Times New Roman"/>
              </a:rPr>
              <a:t>22</a:t>
            </a:r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Real-time detection from the Tumaini CB Beta app in field conditions.</a:t>
            </a:r>
            <a:endParaRPr lang="en-US" sz="1400">
              <a:ea typeface="Calibri" panose="020F0502020204030204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3652170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Grupo 42">
            <a:extLst>
              <a:ext uri="{FF2B5EF4-FFF2-40B4-BE49-F238E27FC236}">
                <a16:creationId xmlns:a16="http://schemas.microsoft.com/office/drawing/2014/main" id="{02C4DEC6-E729-4E23-B41E-D4BA65D714EE}"/>
              </a:ext>
            </a:extLst>
          </p:cNvPr>
          <p:cNvGrpSpPr/>
          <p:nvPr/>
        </p:nvGrpSpPr>
        <p:grpSpPr>
          <a:xfrm>
            <a:off x="3594752" y="5625337"/>
            <a:ext cx="4833545" cy="324635"/>
            <a:chOff x="337127" y="1079702"/>
            <a:chExt cx="4833545" cy="324635"/>
          </a:xfrm>
        </p:grpSpPr>
        <p:sp>
          <p:nvSpPr>
            <p:cNvPr id="15" name="TextBox 6">
              <a:extLst>
                <a:ext uri="{FF2B5EF4-FFF2-40B4-BE49-F238E27FC236}">
                  <a16:creationId xmlns:a16="http://schemas.microsoft.com/office/drawing/2014/main" id="{2F928609-04EC-41C4-9C64-EE84E7B3A4EF}"/>
                </a:ext>
              </a:extLst>
            </p:cNvPr>
            <p:cNvSpPr txBox="1"/>
            <p:nvPr/>
          </p:nvSpPr>
          <p:spPr>
            <a:xfrm>
              <a:off x="337127" y="1079702"/>
              <a:ext cx="282271" cy="307777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6" name="TextBox 7">
              <a:extLst>
                <a:ext uri="{FF2B5EF4-FFF2-40B4-BE49-F238E27FC236}">
                  <a16:creationId xmlns:a16="http://schemas.microsoft.com/office/drawing/2014/main" id="{21D3C806-19B5-46CC-A520-6799F02CADB1}"/>
                </a:ext>
              </a:extLst>
            </p:cNvPr>
            <p:cNvSpPr txBox="1"/>
            <p:nvPr/>
          </p:nvSpPr>
          <p:spPr>
            <a:xfrm>
              <a:off x="4888401" y="1096560"/>
              <a:ext cx="282271" cy="307777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136959" y="6379424"/>
            <a:ext cx="11749133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</a:rPr>
              <a:t>Supplementary Figure </a:t>
            </a:r>
            <a:r>
              <a:rPr lang="en-US" sz="1400" b="1">
                <a:latin typeface="Times New Roman"/>
                <a:cs typeface="Times New Roman"/>
              </a:rPr>
              <a:t>3</a:t>
            </a:r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Total loss for different models, at micro annotations level; </a:t>
            </a:r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 Train loss for leaves and pods, </a:t>
            </a:r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Validation loss for leaves and pods</a:t>
            </a:r>
            <a:endParaRPr lang="en-US" sz="1400">
              <a:latin typeface="Times New Roman" panose="02020603050405020304" pitchFamily="18" charset="0"/>
              <a:ea typeface="Calibri"/>
              <a:cs typeface="Times New Roman" panose="02020603050405020304" pitchFamily="18" charset="0"/>
            </a:endParaRPr>
          </a:p>
        </p:txBody>
      </p:sp>
      <p:pic>
        <p:nvPicPr>
          <p:cNvPr id="3" name="Picture 2" descr="A graph of a train line&#10;&#10;Description automatically generated with medium confidence">
            <a:extLst>
              <a:ext uri="{FF2B5EF4-FFF2-40B4-BE49-F238E27FC236}">
                <a16:creationId xmlns:a16="http://schemas.microsoft.com/office/drawing/2014/main" id="{2519FF98-7275-E233-D924-39645C4E71F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9366" y="487088"/>
            <a:ext cx="4241338" cy="2461332"/>
          </a:xfrm>
          <a:prstGeom prst="rect">
            <a:avLst/>
          </a:prstGeom>
        </p:spPr>
      </p:pic>
      <p:pic>
        <p:nvPicPr>
          <p:cNvPr id="5" name="Picture 4" descr="A graph with red and blue lines&#10;&#10;Description automatically generated">
            <a:extLst>
              <a:ext uri="{FF2B5EF4-FFF2-40B4-BE49-F238E27FC236}">
                <a16:creationId xmlns:a16="http://schemas.microsoft.com/office/drawing/2014/main" id="{D2025FB3-3D52-4ECB-2457-96F209DBCDE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4912" y="488651"/>
            <a:ext cx="4201201" cy="2438039"/>
          </a:xfrm>
          <a:prstGeom prst="rect">
            <a:avLst/>
          </a:prstGeom>
        </p:spPr>
      </p:pic>
      <p:pic>
        <p:nvPicPr>
          <p:cNvPr id="7" name="Picture 6" descr="A graph with a red and blue line&#10;&#10;Description automatically generated">
            <a:extLst>
              <a:ext uri="{FF2B5EF4-FFF2-40B4-BE49-F238E27FC236}">
                <a16:creationId xmlns:a16="http://schemas.microsoft.com/office/drawing/2014/main" id="{55BCFF0D-EFF7-17D3-0352-D302BE9B2CA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9366" y="3092328"/>
            <a:ext cx="4285029" cy="2486686"/>
          </a:xfrm>
          <a:prstGeom prst="rect">
            <a:avLst/>
          </a:prstGeom>
        </p:spPr>
      </p:pic>
      <p:pic>
        <p:nvPicPr>
          <p:cNvPr id="10" name="Picture 9" descr="A graph with red and blue lines&#10;&#10;Description automatically generated">
            <a:extLst>
              <a:ext uri="{FF2B5EF4-FFF2-40B4-BE49-F238E27FC236}">
                <a16:creationId xmlns:a16="http://schemas.microsoft.com/office/drawing/2014/main" id="{183DA739-A31D-2BC0-6F0C-2E7A033701E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4912" y="3092329"/>
            <a:ext cx="4285029" cy="24866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00339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>
            <a:extLst>
              <a:ext uri="{FF2B5EF4-FFF2-40B4-BE49-F238E27FC236}">
                <a16:creationId xmlns:a16="http://schemas.microsoft.com/office/drawing/2014/main" id="{A331AB26-56D8-4BCA-8AAB-C188316A8D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438033"/>
            <a:ext cx="121920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Times New Roman"/>
              </a:rPr>
              <a:t>Supplementary Figure </a:t>
            </a:r>
            <a:r>
              <a:rPr lang="en-US" sz="1400" b="1">
                <a:latin typeface="Times New Roman"/>
                <a:cs typeface="Times New Roman"/>
              </a:rPr>
              <a:t>4</a:t>
            </a:r>
            <a:r>
              <a:rPr lang="en-US" sz="1400" b="1">
                <a:latin typeface="Times New Roman"/>
                <a:cs typeface="Calibri"/>
              </a:rPr>
              <a:t>. </a:t>
            </a:r>
            <a:r>
              <a:rPr lang="en-US" sz="1400">
                <a:latin typeface="Times New Roman"/>
                <a:ea typeface="+mn-lt"/>
                <a:cs typeface="Times New Roman"/>
              </a:rPr>
              <a:t>YOLOv7 m</a:t>
            </a:r>
            <a:r>
              <a:rPr lang="en-US" sz="1400">
                <a:latin typeface="Times New Roman"/>
                <a:ea typeface="+mn-lt"/>
                <a:cs typeface="+mn-lt"/>
              </a:rPr>
              <a:t>odel evaluation indicators (loss, precision, recall, and mAP@0.5</a:t>
            </a:r>
            <a:r>
              <a:rPr lang="en-US" sz="1400">
                <a:latin typeface="Times New Roman"/>
                <a:ea typeface="+mn-lt"/>
                <a:cs typeface="Times New Roman"/>
              </a:rPr>
              <a:t>) during training, for whole leaf annotations.</a:t>
            </a:r>
            <a:endParaRPr lang="en-US">
              <a:ea typeface="Calibri"/>
              <a:cs typeface="Calibri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FD5CC45-BA46-C428-851E-DAC0DAA886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7550" y="584200"/>
            <a:ext cx="10763250" cy="5384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52843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>
            <a:extLst>
              <a:ext uri="{FF2B5EF4-FFF2-40B4-BE49-F238E27FC236}">
                <a16:creationId xmlns:a16="http://schemas.microsoft.com/office/drawing/2014/main" id="{A331AB26-56D8-4BCA-8AAB-C188316A8D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438033"/>
            <a:ext cx="121920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Times New Roman"/>
              </a:rPr>
              <a:t>Supplementary Figure </a:t>
            </a:r>
            <a:r>
              <a:rPr lang="en-US" sz="1400" b="1">
                <a:latin typeface="Times New Roman"/>
                <a:cs typeface="Times New Roman"/>
              </a:rPr>
              <a:t>5. </a:t>
            </a:r>
            <a:r>
              <a:rPr lang="en-US" sz="1400">
                <a:latin typeface="Times New Roman"/>
                <a:cs typeface="Times New Roman"/>
              </a:rPr>
              <a:t>YOLO v7 </a:t>
            </a:r>
            <a:r>
              <a:rPr lang="en-US" sz="1400">
                <a:latin typeface="Times New Roman"/>
                <a:ea typeface="+mn-lt"/>
                <a:cs typeface="Times New Roman"/>
              </a:rPr>
              <a:t>m</a:t>
            </a:r>
            <a:r>
              <a:rPr lang="en-US" sz="1400">
                <a:latin typeface="Times New Roman"/>
                <a:ea typeface="+mn-lt"/>
                <a:cs typeface="+mn-lt"/>
              </a:rPr>
              <a:t>odel evaluation indicators (loss, precision, recall, and mAP@0.5</a:t>
            </a:r>
            <a:r>
              <a:rPr lang="en-US" sz="1400">
                <a:latin typeface="Times New Roman"/>
                <a:ea typeface="+mn-lt"/>
                <a:cs typeface="Times New Roman"/>
              </a:rPr>
              <a:t>) during training, for whole pod annotations.</a:t>
            </a:r>
            <a:endParaRPr lang="en-US">
              <a:ea typeface="Calibri"/>
              <a:cs typeface="Calibri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597CE08-9C2B-19DD-F95D-9F7E2E69A7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4850" y="742950"/>
            <a:ext cx="10725150" cy="5365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42956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>
            <a:extLst>
              <a:ext uri="{FF2B5EF4-FFF2-40B4-BE49-F238E27FC236}">
                <a16:creationId xmlns:a16="http://schemas.microsoft.com/office/drawing/2014/main" id="{A331AB26-56D8-4BCA-8AAB-C188316A8D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438033"/>
            <a:ext cx="121920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Times New Roman"/>
              </a:rPr>
              <a:t>Supplementary Figure </a:t>
            </a:r>
            <a:r>
              <a:rPr lang="en-US" sz="1400" b="1">
                <a:latin typeface="Times New Roman"/>
                <a:cs typeface="Times New Roman"/>
              </a:rPr>
              <a:t>6</a:t>
            </a:r>
            <a:r>
              <a:rPr lang="en-US" sz="1400" b="1">
                <a:latin typeface="Times New Roman"/>
                <a:cs typeface="Calibri"/>
              </a:rPr>
              <a:t>. </a:t>
            </a:r>
            <a:r>
              <a:rPr lang="en-US" sz="1400">
                <a:latin typeface="Times New Roman"/>
                <a:ea typeface="+mn-lt"/>
                <a:cs typeface="+mn-lt"/>
              </a:rPr>
              <a:t>YOLO v7 model evaluation indicators (loss, precision, recall, and mAP@0.5</a:t>
            </a:r>
            <a:r>
              <a:rPr lang="en-US" sz="1400">
                <a:latin typeface="Times New Roman"/>
                <a:ea typeface="+mn-lt"/>
                <a:cs typeface="Times New Roman"/>
              </a:rPr>
              <a:t>) during training, for micro leaf annotations.</a:t>
            </a:r>
            <a:endParaRPr lang="en-US">
              <a:ea typeface="Calibri"/>
              <a:cs typeface="Calibri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D71E691-7065-3E4B-5507-8C3EB82826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2150" y="730250"/>
            <a:ext cx="10801350" cy="54038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799318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>
            <a:extLst>
              <a:ext uri="{FF2B5EF4-FFF2-40B4-BE49-F238E27FC236}">
                <a16:creationId xmlns:a16="http://schemas.microsoft.com/office/drawing/2014/main" id="{A331AB26-56D8-4BCA-8AAB-C188316A8D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438033"/>
            <a:ext cx="121920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Times New Roman"/>
              </a:rPr>
              <a:t>Supplementary Figure </a:t>
            </a:r>
            <a:r>
              <a:rPr lang="en-US" sz="1400" b="1">
                <a:latin typeface="Times New Roman"/>
                <a:cs typeface="Times New Roman"/>
              </a:rPr>
              <a:t>7</a:t>
            </a:r>
            <a:r>
              <a:rPr lang="en-US" sz="1400" b="1">
                <a:latin typeface="Times New Roman"/>
                <a:cs typeface="Calibri"/>
              </a:rPr>
              <a:t>. </a:t>
            </a:r>
            <a:r>
              <a:rPr lang="en-US" sz="1400">
                <a:latin typeface="Times New Roman"/>
                <a:ea typeface="+mn-lt"/>
                <a:cs typeface="+mn-lt"/>
              </a:rPr>
              <a:t>YOLO v7 model evaluation indicators (loss, precision, recall, and mAP@0.5</a:t>
            </a:r>
            <a:r>
              <a:rPr lang="en-US" sz="1400">
                <a:latin typeface="Times New Roman"/>
                <a:ea typeface="+mn-lt"/>
                <a:cs typeface="Times New Roman"/>
              </a:rPr>
              <a:t>) during training, for micro pod annotations.</a:t>
            </a:r>
            <a:endParaRPr lang="en-US">
              <a:ea typeface="Calibri"/>
              <a:cs typeface="Calibri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DE8772E-4A3D-3956-B429-D4AF942245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2000" y="647700"/>
            <a:ext cx="10668000" cy="533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530223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2DDB425-0DBA-3A02-537E-6B3E1A46FA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7900" y="577850"/>
            <a:ext cx="10229850" cy="511810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7407D766-0A41-2817-44C1-014E1233DB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438033"/>
            <a:ext cx="121920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Times New Roman"/>
              </a:rPr>
              <a:t>Supplementary Figure </a:t>
            </a:r>
            <a:r>
              <a:rPr lang="en-US" sz="1400" b="1">
                <a:latin typeface="Times New Roman"/>
                <a:cs typeface="Times New Roman"/>
              </a:rPr>
              <a:t>8. </a:t>
            </a:r>
            <a:r>
              <a:rPr lang="en-US" sz="1400">
                <a:latin typeface="Times New Roman"/>
                <a:cs typeface="Times New Roman"/>
              </a:rPr>
              <a:t>YOLO v8 </a:t>
            </a:r>
            <a:r>
              <a:rPr lang="en-US" sz="1400">
                <a:latin typeface="Times New Roman"/>
                <a:ea typeface="+mn-lt"/>
                <a:cs typeface="Times New Roman"/>
              </a:rPr>
              <a:t>m</a:t>
            </a:r>
            <a:r>
              <a:rPr lang="en-US" sz="1400">
                <a:latin typeface="Times New Roman"/>
                <a:ea typeface="+mn-lt"/>
                <a:cs typeface="+mn-lt"/>
              </a:rPr>
              <a:t>odel evaluation indicators (loss, precision, recall, and mAP@0.5</a:t>
            </a:r>
            <a:r>
              <a:rPr lang="en-US" sz="1400">
                <a:latin typeface="Times New Roman"/>
                <a:ea typeface="+mn-lt"/>
                <a:cs typeface="Times New Roman"/>
              </a:rPr>
              <a:t>) during training, for whole leaf annotations.</a:t>
            </a:r>
            <a:endParaRPr lang="en-US">
              <a:ea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60534752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EBBD188-05F5-BE29-E6FB-F6421904E1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2350" y="781050"/>
            <a:ext cx="10153650" cy="50800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C72D4F93-3114-72B0-0158-44D107EEA4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438033"/>
            <a:ext cx="121920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Times New Roman"/>
              </a:rPr>
              <a:t>Supplementary Figure </a:t>
            </a:r>
            <a:r>
              <a:rPr lang="en-US" sz="1400" b="1">
                <a:latin typeface="Times New Roman"/>
                <a:cs typeface="Times New Roman"/>
              </a:rPr>
              <a:t>9. </a:t>
            </a:r>
            <a:r>
              <a:rPr lang="en-US" sz="1400">
                <a:latin typeface="Times New Roman"/>
                <a:cs typeface="Times New Roman"/>
              </a:rPr>
              <a:t>YOLO v8 </a:t>
            </a:r>
            <a:r>
              <a:rPr lang="en-US" sz="1400">
                <a:latin typeface="Times New Roman"/>
                <a:ea typeface="+mn-lt"/>
                <a:cs typeface="Times New Roman"/>
              </a:rPr>
              <a:t>m</a:t>
            </a:r>
            <a:r>
              <a:rPr lang="en-US" sz="1400">
                <a:latin typeface="Times New Roman"/>
                <a:ea typeface="+mn-lt"/>
                <a:cs typeface="+mn-lt"/>
              </a:rPr>
              <a:t>odel evaluation indicators (loss, precision, recall, and mAP@0.5</a:t>
            </a:r>
            <a:r>
              <a:rPr lang="en-US" sz="1400">
                <a:latin typeface="Times New Roman"/>
                <a:ea typeface="+mn-lt"/>
                <a:cs typeface="Times New Roman"/>
              </a:rPr>
              <a:t>) during training, for whole pod annotations.</a:t>
            </a:r>
            <a:endParaRPr lang="en-US">
              <a:ea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3499176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Application>Microsoft Office PowerPoint</Application>
  <PresentationFormat>Widescreen</PresentationFormat>
  <Slides>22</Slides>
  <Notes>2</Notes>
  <HiddenSlides>0</HiddenSlide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2</vt:i4>
      </vt:variant>
    </vt:vector>
  </HeadingPairs>
  <TitlesOfParts>
    <vt:vector size="23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rgara, Javier (CIAT)</dc:creator>
  <cp:revision>1</cp:revision>
  <cp:lastPrinted>2023-11-03T13:56:09Z</cp:lastPrinted>
  <dcterms:created xsi:type="dcterms:W3CDTF">2019-02-19T12:56:01Z</dcterms:created>
  <dcterms:modified xsi:type="dcterms:W3CDTF">2024-02-23T19:40:06Z</dcterms:modified>
</cp:coreProperties>
</file>